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  <p:sldMasterId id="2147483674" r:id="rId2"/>
  </p:sldMasterIdLst>
  <p:notesMasterIdLst>
    <p:notesMasterId r:id="rId17"/>
  </p:notesMasterIdLst>
  <p:sldIdLst>
    <p:sldId id="393" r:id="rId3"/>
    <p:sldId id="403" r:id="rId4"/>
    <p:sldId id="395" r:id="rId5"/>
    <p:sldId id="394" r:id="rId6"/>
    <p:sldId id="411" r:id="rId7"/>
    <p:sldId id="424" r:id="rId8"/>
    <p:sldId id="427" r:id="rId9"/>
    <p:sldId id="433" r:id="rId10"/>
    <p:sldId id="434" r:id="rId11"/>
    <p:sldId id="421" r:id="rId12"/>
    <p:sldId id="428" r:id="rId13"/>
    <p:sldId id="429" r:id="rId14"/>
    <p:sldId id="430" r:id="rId15"/>
    <p:sldId id="431" r:id="rId16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5" autoAdjust="0"/>
    <p:restoredTop sz="93690" autoAdjust="0"/>
  </p:normalViewPr>
  <p:slideViewPr>
    <p:cSldViewPr snapToGrid="0">
      <p:cViewPr>
        <p:scale>
          <a:sx n="60" d="100"/>
          <a:sy n="60" d="100"/>
        </p:scale>
        <p:origin x="1484" y="76"/>
      </p:cViewPr>
      <p:guideLst/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200" d="100"/>
        <a:sy n="200" d="100"/>
      </p:scale>
      <p:origin x="0" y="0"/>
    </p:cViewPr>
  </p:sorterViewPr>
  <p:notesViewPr>
    <p:cSldViewPr snapToGrid="0">
      <p:cViewPr varScale="1">
        <p:scale>
          <a:sx n="50" d="100"/>
          <a:sy n="50" d="100"/>
        </p:scale>
        <p:origin x="2708" y="28"/>
      </p:cViewPr>
      <p:guideLst/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6.xml"/><Relationship Id="rId13" Type="http://schemas.openxmlformats.org/officeDocument/2006/relationships/slide" Target="slides/slide11.xml"/><Relationship Id="rId18" Type="http://schemas.openxmlformats.org/officeDocument/2006/relationships/presProps" Target="presProps.xml"/><Relationship Id="rId3" Type="http://schemas.openxmlformats.org/officeDocument/2006/relationships/slide" Target="slides/slide1.xml"/><Relationship Id="rId21" Type="http://schemas.openxmlformats.org/officeDocument/2006/relationships/tableStyles" Target="tableStyles.xml"/><Relationship Id="rId7" Type="http://schemas.openxmlformats.org/officeDocument/2006/relationships/slide" Target="slides/slide5.xml"/><Relationship Id="rId12" Type="http://schemas.openxmlformats.org/officeDocument/2006/relationships/slide" Target="slides/slide10.xml"/><Relationship Id="rId17" Type="http://schemas.openxmlformats.org/officeDocument/2006/relationships/notesMaster" Target="notesMasters/notesMaster1.xml"/><Relationship Id="rId2" Type="http://schemas.openxmlformats.org/officeDocument/2006/relationships/slideMaster" Target="slideMasters/slideMaster2.xml"/><Relationship Id="rId16" Type="http://schemas.openxmlformats.org/officeDocument/2006/relationships/slide" Target="slides/slide14.xml"/><Relationship Id="rId20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4.xml"/><Relationship Id="rId11" Type="http://schemas.openxmlformats.org/officeDocument/2006/relationships/slide" Target="slides/slide9.xml"/><Relationship Id="rId5" Type="http://schemas.openxmlformats.org/officeDocument/2006/relationships/slide" Target="slides/slide3.xml"/><Relationship Id="rId15" Type="http://schemas.openxmlformats.org/officeDocument/2006/relationships/slide" Target="slides/slide13.xml"/><Relationship Id="rId10" Type="http://schemas.openxmlformats.org/officeDocument/2006/relationships/slide" Target="slides/slide8.xml"/><Relationship Id="rId19" Type="http://schemas.openxmlformats.org/officeDocument/2006/relationships/viewProps" Target="viewProps.xml"/><Relationship Id="rId4" Type="http://schemas.openxmlformats.org/officeDocument/2006/relationships/slide" Target="slides/slide2.xml"/><Relationship Id="rId9" Type="http://schemas.openxmlformats.org/officeDocument/2006/relationships/slide" Target="slides/slide7.xml"/><Relationship Id="rId14" Type="http://schemas.openxmlformats.org/officeDocument/2006/relationships/slide" Target="slides/slide12.xml"/><Relationship Id="rId22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ophry pines" userId="ce6f9b4c01b12c0e" providerId="LiveId" clId="{BE1FFF84-AC0B-447C-963C-68A454A9C860}"/>
    <pc:docChg chg="modSld">
      <pc:chgData name="ophry pines" userId="ce6f9b4c01b12c0e" providerId="LiveId" clId="{BE1FFF84-AC0B-447C-963C-68A454A9C860}" dt="2022-11-26T20:06:21.445" v="77" actId="1076"/>
      <pc:docMkLst>
        <pc:docMk/>
      </pc:docMkLst>
      <pc:sldChg chg="modSp mod">
        <pc:chgData name="ophry pines" userId="ce6f9b4c01b12c0e" providerId="LiveId" clId="{BE1FFF84-AC0B-447C-963C-68A454A9C860}" dt="2022-11-26T20:06:21.445" v="77" actId="1076"/>
        <pc:sldMkLst>
          <pc:docMk/>
          <pc:sldMk cId="2932986395" sldId="434"/>
        </pc:sldMkLst>
        <pc:spChg chg="mod">
          <ac:chgData name="ophry pines" userId="ce6f9b4c01b12c0e" providerId="LiveId" clId="{BE1FFF84-AC0B-447C-963C-68A454A9C860}" dt="2022-11-26T20:05:28.615" v="11" actId="1035"/>
          <ac:spMkLst>
            <pc:docMk/>
            <pc:sldMk cId="2932986395" sldId="434"/>
            <ac:spMk id="8" creationId="{2E70CF34-CF93-4B84-AB0E-E1EA8A21E765}"/>
          </ac:spMkLst>
        </pc:spChg>
        <pc:spChg chg="mod">
          <ac:chgData name="ophry pines" userId="ce6f9b4c01b12c0e" providerId="LiveId" clId="{BE1FFF84-AC0B-447C-963C-68A454A9C860}" dt="2022-11-26T20:05:28.615" v="11" actId="1035"/>
          <ac:spMkLst>
            <pc:docMk/>
            <pc:sldMk cId="2932986395" sldId="434"/>
            <ac:spMk id="9" creationId="{88293E30-0069-476A-AFF7-6FD2E1B2998F}"/>
          </ac:spMkLst>
        </pc:spChg>
        <pc:spChg chg="mod">
          <ac:chgData name="ophry pines" userId="ce6f9b4c01b12c0e" providerId="LiveId" clId="{BE1FFF84-AC0B-447C-963C-68A454A9C860}" dt="2022-11-26T20:05:28.615" v="11" actId="1035"/>
          <ac:spMkLst>
            <pc:docMk/>
            <pc:sldMk cId="2932986395" sldId="434"/>
            <ac:spMk id="10" creationId="{1D27116C-3578-4436-B099-466165F86529}"/>
          </ac:spMkLst>
        </pc:spChg>
        <pc:spChg chg="mod">
          <ac:chgData name="ophry pines" userId="ce6f9b4c01b12c0e" providerId="LiveId" clId="{BE1FFF84-AC0B-447C-963C-68A454A9C860}" dt="2022-11-26T20:05:28.615" v="11" actId="1035"/>
          <ac:spMkLst>
            <pc:docMk/>
            <pc:sldMk cId="2932986395" sldId="434"/>
            <ac:spMk id="11" creationId="{401E624B-03E0-4B88-B1D3-2C44F31DEB3E}"/>
          </ac:spMkLst>
        </pc:spChg>
        <pc:spChg chg="mod">
          <ac:chgData name="ophry pines" userId="ce6f9b4c01b12c0e" providerId="LiveId" clId="{BE1FFF84-AC0B-447C-963C-68A454A9C860}" dt="2022-11-26T20:05:28.615" v="11" actId="1035"/>
          <ac:spMkLst>
            <pc:docMk/>
            <pc:sldMk cId="2932986395" sldId="434"/>
            <ac:spMk id="12" creationId="{DD2B937B-D486-4550-82E0-6A7531028FAB}"/>
          </ac:spMkLst>
        </pc:spChg>
        <pc:spChg chg="mod">
          <ac:chgData name="ophry pines" userId="ce6f9b4c01b12c0e" providerId="LiveId" clId="{BE1FFF84-AC0B-447C-963C-68A454A9C860}" dt="2022-11-26T20:05:28.615" v="11" actId="1035"/>
          <ac:spMkLst>
            <pc:docMk/>
            <pc:sldMk cId="2932986395" sldId="434"/>
            <ac:spMk id="13" creationId="{3D0D37A9-8AA2-4E48-8727-64943B5976A8}"/>
          </ac:spMkLst>
        </pc:spChg>
        <pc:spChg chg="mod">
          <ac:chgData name="ophry pines" userId="ce6f9b4c01b12c0e" providerId="LiveId" clId="{BE1FFF84-AC0B-447C-963C-68A454A9C860}" dt="2022-11-26T20:05:28.615" v="11" actId="1035"/>
          <ac:spMkLst>
            <pc:docMk/>
            <pc:sldMk cId="2932986395" sldId="434"/>
            <ac:spMk id="14" creationId="{30BC4548-73AC-4DAA-8569-2D68FAF43DB2}"/>
          </ac:spMkLst>
        </pc:spChg>
        <pc:spChg chg="mod">
          <ac:chgData name="ophry pines" userId="ce6f9b4c01b12c0e" providerId="LiveId" clId="{BE1FFF84-AC0B-447C-963C-68A454A9C860}" dt="2022-11-26T20:05:28.615" v="11" actId="1035"/>
          <ac:spMkLst>
            <pc:docMk/>
            <pc:sldMk cId="2932986395" sldId="434"/>
            <ac:spMk id="15" creationId="{33E9FD9F-DD11-4CE7-98F6-01CF1AF9A7AE}"/>
          </ac:spMkLst>
        </pc:spChg>
        <pc:spChg chg="mod">
          <ac:chgData name="ophry pines" userId="ce6f9b4c01b12c0e" providerId="LiveId" clId="{BE1FFF84-AC0B-447C-963C-68A454A9C860}" dt="2022-11-26T20:05:28.615" v="11" actId="1035"/>
          <ac:spMkLst>
            <pc:docMk/>
            <pc:sldMk cId="2932986395" sldId="434"/>
            <ac:spMk id="16" creationId="{F3B28929-5A4D-4227-B2EA-58281A875E9F}"/>
          </ac:spMkLst>
        </pc:spChg>
        <pc:spChg chg="mod">
          <ac:chgData name="ophry pines" userId="ce6f9b4c01b12c0e" providerId="LiveId" clId="{BE1FFF84-AC0B-447C-963C-68A454A9C860}" dt="2022-11-26T20:05:28.615" v="11" actId="1035"/>
          <ac:spMkLst>
            <pc:docMk/>
            <pc:sldMk cId="2932986395" sldId="434"/>
            <ac:spMk id="17" creationId="{2470330E-2692-4076-AB54-C3CC1AB4CE80}"/>
          </ac:spMkLst>
        </pc:spChg>
        <pc:spChg chg="mod">
          <ac:chgData name="ophry pines" userId="ce6f9b4c01b12c0e" providerId="LiveId" clId="{BE1FFF84-AC0B-447C-963C-68A454A9C860}" dt="2022-11-26T20:05:28.615" v="11" actId="1035"/>
          <ac:spMkLst>
            <pc:docMk/>
            <pc:sldMk cId="2932986395" sldId="434"/>
            <ac:spMk id="18" creationId="{02C5002D-424F-48C4-80AE-A82A246269C5}"/>
          </ac:spMkLst>
        </pc:spChg>
        <pc:spChg chg="mod">
          <ac:chgData name="ophry pines" userId="ce6f9b4c01b12c0e" providerId="LiveId" clId="{BE1FFF84-AC0B-447C-963C-68A454A9C860}" dt="2022-11-26T20:05:28.615" v="11" actId="1035"/>
          <ac:spMkLst>
            <pc:docMk/>
            <pc:sldMk cId="2932986395" sldId="434"/>
            <ac:spMk id="19" creationId="{3846BDB1-6A4D-4B5A-9AD4-9BD227399068}"/>
          </ac:spMkLst>
        </pc:spChg>
        <pc:spChg chg="mod">
          <ac:chgData name="ophry pines" userId="ce6f9b4c01b12c0e" providerId="LiveId" clId="{BE1FFF84-AC0B-447C-963C-68A454A9C860}" dt="2022-11-26T20:05:28.615" v="11" actId="1035"/>
          <ac:spMkLst>
            <pc:docMk/>
            <pc:sldMk cId="2932986395" sldId="434"/>
            <ac:spMk id="20" creationId="{9E4DCE80-315B-4624-8285-118F18C87792}"/>
          </ac:spMkLst>
        </pc:spChg>
        <pc:spChg chg="mod">
          <ac:chgData name="ophry pines" userId="ce6f9b4c01b12c0e" providerId="LiveId" clId="{BE1FFF84-AC0B-447C-963C-68A454A9C860}" dt="2022-11-26T20:05:28.615" v="11" actId="1035"/>
          <ac:spMkLst>
            <pc:docMk/>
            <pc:sldMk cId="2932986395" sldId="434"/>
            <ac:spMk id="21" creationId="{43F5C54A-9F1F-4BE3-92E5-2D1FD79CB1CE}"/>
          </ac:spMkLst>
        </pc:spChg>
        <pc:spChg chg="mod">
          <ac:chgData name="ophry pines" userId="ce6f9b4c01b12c0e" providerId="LiveId" clId="{BE1FFF84-AC0B-447C-963C-68A454A9C860}" dt="2022-11-26T20:05:28.615" v="11" actId="1035"/>
          <ac:spMkLst>
            <pc:docMk/>
            <pc:sldMk cId="2932986395" sldId="434"/>
            <ac:spMk id="22" creationId="{E13FB885-DAED-4271-8999-AB5397E77047}"/>
          </ac:spMkLst>
        </pc:spChg>
        <pc:spChg chg="mod">
          <ac:chgData name="ophry pines" userId="ce6f9b4c01b12c0e" providerId="LiveId" clId="{BE1FFF84-AC0B-447C-963C-68A454A9C860}" dt="2022-11-26T20:05:28.615" v="11" actId="1035"/>
          <ac:spMkLst>
            <pc:docMk/>
            <pc:sldMk cId="2932986395" sldId="434"/>
            <ac:spMk id="23" creationId="{FA287FED-4DDC-4078-9B7A-7B23B7C1AA9A}"/>
          </ac:spMkLst>
        </pc:spChg>
        <pc:spChg chg="mod">
          <ac:chgData name="ophry pines" userId="ce6f9b4c01b12c0e" providerId="LiveId" clId="{BE1FFF84-AC0B-447C-963C-68A454A9C860}" dt="2022-11-26T20:05:28.615" v="11" actId="1035"/>
          <ac:spMkLst>
            <pc:docMk/>
            <pc:sldMk cId="2932986395" sldId="434"/>
            <ac:spMk id="25" creationId="{B8030771-BA27-401E-BA6D-B66CE2026AAB}"/>
          </ac:spMkLst>
        </pc:spChg>
        <pc:spChg chg="mod">
          <ac:chgData name="ophry pines" userId="ce6f9b4c01b12c0e" providerId="LiveId" clId="{BE1FFF84-AC0B-447C-963C-68A454A9C860}" dt="2022-11-26T20:05:28.615" v="11" actId="1035"/>
          <ac:spMkLst>
            <pc:docMk/>
            <pc:sldMk cId="2932986395" sldId="434"/>
            <ac:spMk id="27" creationId="{AD9BAC2B-4C36-49D3-BA90-B950BDFBFB08}"/>
          </ac:spMkLst>
        </pc:spChg>
        <pc:spChg chg="mod">
          <ac:chgData name="ophry pines" userId="ce6f9b4c01b12c0e" providerId="LiveId" clId="{BE1FFF84-AC0B-447C-963C-68A454A9C860}" dt="2022-11-26T20:05:28.615" v="11" actId="1035"/>
          <ac:spMkLst>
            <pc:docMk/>
            <pc:sldMk cId="2932986395" sldId="434"/>
            <ac:spMk id="29" creationId="{382183CE-3DBA-438B-A9B9-12B5353F0185}"/>
          </ac:spMkLst>
        </pc:spChg>
        <pc:spChg chg="mod">
          <ac:chgData name="ophry pines" userId="ce6f9b4c01b12c0e" providerId="LiveId" clId="{BE1FFF84-AC0B-447C-963C-68A454A9C860}" dt="2022-11-26T20:05:28.615" v="11" actId="1035"/>
          <ac:spMkLst>
            <pc:docMk/>
            <pc:sldMk cId="2932986395" sldId="434"/>
            <ac:spMk id="31" creationId="{86FE4A0C-803C-4EA2-BFDE-3D9AB86E88AB}"/>
          </ac:spMkLst>
        </pc:spChg>
        <pc:spChg chg="mod">
          <ac:chgData name="ophry pines" userId="ce6f9b4c01b12c0e" providerId="LiveId" clId="{BE1FFF84-AC0B-447C-963C-68A454A9C860}" dt="2022-11-26T20:05:28.615" v="11" actId="1035"/>
          <ac:spMkLst>
            <pc:docMk/>
            <pc:sldMk cId="2932986395" sldId="434"/>
            <ac:spMk id="32" creationId="{428534DB-40D0-4FFA-A11D-86690C8CC723}"/>
          </ac:spMkLst>
        </pc:spChg>
        <pc:spChg chg="mod">
          <ac:chgData name="ophry pines" userId="ce6f9b4c01b12c0e" providerId="LiveId" clId="{BE1FFF84-AC0B-447C-963C-68A454A9C860}" dt="2022-11-26T20:05:28.615" v="11" actId="1035"/>
          <ac:spMkLst>
            <pc:docMk/>
            <pc:sldMk cId="2932986395" sldId="434"/>
            <ac:spMk id="33" creationId="{CC08DAF6-C821-4609-897B-27B4CEF5F341}"/>
          </ac:spMkLst>
        </pc:spChg>
        <pc:spChg chg="mod">
          <ac:chgData name="ophry pines" userId="ce6f9b4c01b12c0e" providerId="LiveId" clId="{BE1FFF84-AC0B-447C-963C-68A454A9C860}" dt="2022-11-26T20:05:28.615" v="11" actId="1035"/>
          <ac:spMkLst>
            <pc:docMk/>
            <pc:sldMk cId="2932986395" sldId="434"/>
            <ac:spMk id="34" creationId="{E7D575A5-42A9-4964-8A5B-87150CF34B3D}"/>
          </ac:spMkLst>
        </pc:spChg>
        <pc:spChg chg="mod">
          <ac:chgData name="ophry pines" userId="ce6f9b4c01b12c0e" providerId="LiveId" clId="{BE1FFF84-AC0B-447C-963C-68A454A9C860}" dt="2022-11-26T20:05:28.615" v="11" actId="1035"/>
          <ac:spMkLst>
            <pc:docMk/>
            <pc:sldMk cId="2932986395" sldId="434"/>
            <ac:spMk id="35" creationId="{31AE0AF7-20C9-4E81-BF28-19707767F439}"/>
          </ac:spMkLst>
        </pc:spChg>
        <pc:spChg chg="mod">
          <ac:chgData name="ophry pines" userId="ce6f9b4c01b12c0e" providerId="LiveId" clId="{BE1FFF84-AC0B-447C-963C-68A454A9C860}" dt="2022-11-26T20:05:28.615" v="11" actId="1035"/>
          <ac:spMkLst>
            <pc:docMk/>
            <pc:sldMk cId="2932986395" sldId="434"/>
            <ac:spMk id="54" creationId="{0209665F-812F-4A2E-AE9C-A845D3EBCA3B}"/>
          </ac:spMkLst>
        </pc:spChg>
        <pc:spChg chg="mod">
          <ac:chgData name="ophry pines" userId="ce6f9b4c01b12c0e" providerId="LiveId" clId="{BE1FFF84-AC0B-447C-963C-68A454A9C860}" dt="2022-11-26T20:05:28.615" v="11" actId="1035"/>
          <ac:spMkLst>
            <pc:docMk/>
            <pc:sldMk cId="2932986395" sldId="434"/>
            <ac:spMk id="55" creationId="{22601A01-F0FB-4DD5-8B6D-99CAB766AA1A}"/>
          </ac:spMkLst>
        </pc:spChg>
        <pc:spChg chg="mod">
          <ac:chgData name="ophry pines" userId="ce6f9b4c01b12c0e" providerId="LiveId" clId="{BE1FFF84-AC0B-447C-963C-68A454A9C860}" dt="2022-11-26T20:05:28.615" v="11" actId="1035"/>
          <ac:spMkLst>
            <pc:docMk/>
            <pc:sldMk cId="2932986395" sldId="434"/>
            <ac:spMk id="56" creationId="{40B01856-552E-41E8-8E41-E7E19474AE6A}"/>
          </ac:spMkLst>
        </pc:spChg>
        <pc:spChg chg="mod">
          <ac:chgData name="ophry pines" userId="ce6f9b4c01b12c0e" providerId="LiveId" clId="{BE1FFF84-AC0B-447C-963C-68A454A9C860}" dt="2022-11-26T20:05:28.615" v="11" actId="1035"/>
          <ac:spMkLst>
            <pc:docMk/>
            <pc:sldMk cId="2932986395" sldId="434"/>
            <ac:spMk id="57" creationId="{D7657FA9-0413-44E3-8202-7136AEF7452C}"/>
          </ac:spMkLst>
        </pc:spChg>
        <pc:spChg chg="mod">
          <ac:chgData name="ophry pines" userId="ce6f9b4c01b12c0e" providerId="LiveId" clId="{BE1FFF84-AC0B-447C-963C-68A454A9C860}" dt="2022-11-26T20:05:28.615" v="11" actId="1035"/>
          <ac:spMkLst>
            <pc:docMk/>
            <pc:sldMk cId="2932986395" sldId="434"/>
            <ac:spMk id="58" creationId="{CF4776D4-57F6-43DB-A966-33507117AA08}"/>
          </ac:spMkLst>
        </pc:spChg>
        <pc:spChg chg="mod">
          <ac:chgData name="ophry pines" userId="ce6f9b4c01b12c0e" providerId="LiveId" clId="{BE1FFF84-AC0B-447C-963C-68A454A9C860}" dt="2022-11-26T20:05:28.615" v="11" actId="1035"/>
          <ac:spMkLst>
            <pc:docMk/>
            <pc:sldMk cId="2932986395" sldId="434"/>
            <ac:spMk id="59" creationId="{2832CB8D-084B-4EAA-9258-F06D09067E24}"/>
          </ac:spMkLst>
        </pc:spChg>
        <pc:spChg chg="mod">
          <ac:chgData name="ophry pines" userId="ce6f9b4c01b12c0e" providerId="LiveId" clId="{BE1FFF84-AC0B-447C-963C-68A454A9C860}" dt="2022-11-26T20:05:28.615" v="11" actId="1035"/>
          <ac:spMkLst>
            <pc:docMk/>
            <pc:sldMk cId="2932986395" sldId="434"/>
            <ac:spMk id="60" creationId="{AB91D2F2-5157-4074-91DD-0D0420062E75}"/>
          </ac:spMkLst>
        </pc:spChg>
        <pc:spChg chg="mod">
          <ac:chgData name="ophry pines" userId="ce6f9b4c01b12c0e" providerId="LiveId" clId="{BE1FFF84-AC0B-447C-963C-68A454A9C860}" dt="2022-11-26T20:05:28.615" v="11" actId="1035"/>
          <ac:spMkLst>
            <pc:docMk/>
            <pc:sldMk cId="2932986395" sldId="434"/>
            <ac:spMk id="61" creationId="{38B1A13C-5FF4-46C3-89C0-74C9E4ED1BBF}"/>
          </ac:spMkLst>
        </pc:spChg>
        <pc:spChg chg="mod">
          <ac:chgData name="ophry pines" userId="ce6f9b4c01b12c0e" providerId="LiveId" clId="{BE1FFF84-AC0B-447C-963C-68A454A9C860}" dt="2022-11-26T20:05:28.615" v="11" actId="1035"/>
          <ac:spMkLst>
            <pc:docMk/>
            <pc:sldMk cId="2932986395" sldId="434"/>
            <ac:spMk id="62" creationId="{B89E3114-ADB1-4D2C-B0BD-3FBB3573CB8B}"/>
          </ac:spMkLst>
        </pc:spChg>
        <pc:spChg chg="mod">
          <ac:chgData name="ophry pines" userId="ce6f9b4c01b12c0e" providerId="LiveId" clId="{BE1FFF84-AC0B-447C-963C-68A454A9C860}" dt="2022-11-26T20:05:28.615" v="11" actId="1035"/>
          <ac:spMkLst>
            <pc:docMk/>
            <pc:sldMk cId="2932986395" sldId="434"/>
            <ac:spMk id="63" creationId="{0F5EFBD4-D73F-4E33-B875-C39A7059599D}"/>
          </ac:spMkLst>
        </pc:spChg>
        <pc:spChg chg="mod">
          <ac:chgData name="ophry pines" userId="ce6f9b4c01b12c0e" providerId="LiveId" clId="{BE1FFF84-AC0B-447C-963C-68A454A9C860}" dt="2022-11-26T20:05:28.615" v="11" actId="1035"/>
          <ac:spMkLst>
            <pc:docMk/>
            <pc:sldMk cId="2932986395" sldId="434"/>
            <ac:spMk id="64" creationId="{A65FAADC-846F-4A3F-977E-8A93A85FE55C}"/>
          </ac:spMkLst>
        </pc:spChg>
        <pc:spChg chg="mod">
          <ac:chgData name="ophry pines" userId="ce6f9b4c01b12c0e" providerId="LiveId" clId="{BE1FFF84-AC0B-447C-963C-68A454A9C860}" dt="2022-11-26T20:05:28.615" v="11" actId="1035"/>
          <ac:spMkLst>
            <pc:docMk/>
            <pc:sldMk cId="2932986395" sldId="434"/>
            <ac:spMk id="71" creationId="{F018DAFF-FEF5-4B61-9EB5-F3E854C88461}"/>
          </ac:spMkLst>
        </pc:spChg>
        <pc:spChg chg="mod">
          <ac:chgData name="ophry pines" userId="ce6f9b4c01b12c0e" providerId="LiveId" clId="{BE1FFF84-AC0B-447C-963C-68A454A9C860}" dt="2022-11-26T20:05:28.615" v="11" actId="1035"/>
          <ac:spMkLst>
            <pc:docMk/>
            <pc:sldMk cId="2932986395" sldId="434"/>
            <ac:spMk id="72" creationId="{DF34A654-5197-40A9-90F8-50180CACC258}"/>
          </ac:spMkLst>
        </pc:spChg>
        <pc:spChg chg="mod">
          <ac:chgData name="ophry pines" userId="ce6f9b4c01b12c0e" providerId="LiveId" clId="{BE1FFF84-AC0B-447C-963C-68A454A9C860}" dt="2022-11-26T20:05:28.615" v="11" actId="1035"/>
          <ac:spMkLst>
            <pc:docMk/>
            <pc:sldMk cId="2932986395" sldId="434"/>
            <ac:spMk id="73" creationId="{821F3655-9F26-44F0-874A-1E225FCBE997}"/>
          </ac:spMkLst>
        </pc:spChg>
        <pc:spChg chg="mod">
          <ac:chgData name="ophry pines" userId="ce6f9b4c01b12c0e" providerId="LiveId" clId="{BE1FFF84-AC0B-447C-963C-68A454A9C860}" dt="2022-11-26T20:05:28.615" v="11" actId="1035"/>
          <ac:spMkLst>
            <pc:docMk/>
            <pc:sldMk cId="2932986395" sldId="434"/>
            <ac:spMk id="74" creationId="{C8044AF6-CD5E-487D-909A-E545AFB10134}"/>
          </ac:spMkLst>
        </pc:spChg>
        <pc:spChg chg="mod">
          <ac:chgData name="ophry pines" userId="ce6f9b4c01b12c0e" providerId="LiveId" clId="{BE1FFF84-AC0B-447C-963C-68A454A9C860}" dt="2022-11-26T20:05:28.615" v="11" actId="1035"/>
          <ac:spMkLst>
            <pc:docMk/>
            <pc:sldMk cId="2932986395" sldId="434"/>
            <ac:spMk id="76" creationId="{DE319043-6DF2-4F4D-A650-3D03CDB0E7A2}"/>
          </ac:spMkLst>
        </pc:spChg>
        <pc:spChg chg="mod">
          <ac:chgData name="ophry pines" userId="ce6f9b4c01b12c0e" providerId="LiveId" clId="{BE1FFF84-AC0B-447C-963C-68A454A9C860}" dt="2022-11-26T20:05:28.615" v="11" actId="1035"/>
          <ac:spMkLst>
            <pc:docMk/>
            <pc:sldMk cId="2932986395" sldId="434"/>
            <ac:spMk id="78" creationId="{38294FBE-D013-423C-B2D1-2945F37D1EFB}"/>
          </ac:spMkLst>
        </pc:spChg>
        <pc:spChg chg="mod">
          <ac:chgData name="ophry pines" userId="ce6f9b4c01b12c0e" providerId="LiveId" clId="{BE1FFF84-AC0B-447C-963C-68A454A9C860}" dt="2022-11-26T20:05:28.615" v="11" actId="1035"/>
          <ac:spMkLst>
            <pc:docMk/>
            <pc:sldMk cId="2932986395" sldId="434"/>
            <ac:spMk id="80" creationId="{6CBD901F-4B7F-43C9-91A2-F39397ED2A46}"/>
          </ac:spMkLst>
        </pc:spChg>
        <pc:spChg chg="mod">
          <ac:chgData name="ophry pines" userId="ce6f9b4c01b12c0e" providerId="LiveId" clId="{BE1FFF84-AC0B-447C-963C-68A454A9C860}" dt="2022-11-26T20:05:28.615" v="11" actId="1035"/>
          <ac:spMkLst>
            <pc:docMk/>
            <pc:sldMk cId="2932986395" sldId="434"/>
            <ac:spMk id="82" creationId="{03329C26-2508-47EB-B7AB-A0CA2BDE1797}"/>
          </ac:spMkLst>
        </pc:spChg>
        <pc:spChg chg="mod">
          <ac:chgData name="ophry pines" userId="ce6f9b4c01b12c0e" providerId="LiveId" clId="{BE1FFF84-AC0B-447C-963C-68A454A9C860}" dt="2022-11-26T20:05:28.615" v="11" actId="1035"/>
          <ac:spMkLst>
            <pc:docMk/>
            <pc:sldMk cId="2932986395" sldId="434"/>
            <ac:spMk id="96" creationId="{66C6BD33-A808-4BE5-BA35-02F7E266BC8C}"/>
          </ac:spMkLst>
        </pc:spChg>
        <pc:spChg chg="mod">
          <ac:chgData name="ophry pines" userId="ce6f9b4c01b12c0e" providerId="LiveId" clId="{BE1FFF84-AC0B-447C-963C-68A454A9C860}" dt="2022-11-26T20:05:28.615" v="11" actId="1035"/>
          <ac:spMkLst>
            <pc:docMk/>
            <pc:sldMk cId="2932986395" sldId="434"/>
            <ac:spMk id="97" creationId="{04FC67DF-9AEE-4210-BDD5-7987CC629D13}"/>
          </ac:spMkLst>
        </pc:spChg>
        <pc:spChg chg="mod">
          <ac:chgData name="ophry pines" userId="ce6f9b4c01b12c0e" providerId="LiveId" clId="{BE1FFF84-AC0B-447C-963C-68A454A9C860}" dt="2022-11-26T20:05:28.615" v="11" actId="1035"/>
          <ac:spMkLst>
            <pc:docMk/>
            <pc:sldMk cId="2932986395" sldId="434"/>
            <ac:spMk id="123" creationId="{71312576-6A64-4F44-A211-C9DB9C2D200B}"/>
          </ac:spMkLst>
        </pc:spChg>
        <pc:spChg chg="mod">
          <ac:chgData name="ophry pines" userId="ce6f9b4c01b12c0e" providerId="LiveId" clId="{BE1FFF84-AC0B-447C-963C-68A454A9C860}" dt="2022-11-26T20:06:21.445" v="77" actId="1076"/>
          <ac:spMkLst>
            <pc:docMk/>
            <pc:sldMk cId="2932986395" sldId="434"/>
            <ac:spMk id="143" creationId="{536AC4A5-6835-4F78-8912-67111FCAB228}"/>
          </ac:spMkLst>
        </pc:spChg>
        <pc:grpChg chg="mod">
          <ac:chgData name="ophry pines" userId="ce6f9b4c01b12c0e" providerId="LiveId" clId="{BE1FFF84-AC0B-447C-963C-68A454A9C860}" dt="2022-11-26T20:05:28.615" v="11" actId="1035"/>
          <ac:grpSpMkLst>
            <pc:docMk/>
            <pc:sldMk cId="2932986395" sldId="434"/>
            <ac:grpSpMk id="36" creationId="{578FBD17-8589-486E-9C73-996CD522A337}"/>
          </ac:grpSpMkLst>
        </pc:grpChg>
        <pc:grpChg chg="mod">
          <ac:chgData name="ophry pines" userId="ce6f9b4c01b12c0e" providerId="LiveId" clId="{BE1FFF84-AC0B-447C-963C-68A454A9C860}" dt="2022-11-26T20:05:28.615" v="11" actId="1035"/>
          <ac:grpSpMkLst>
            <pc:docMk/>
            <pc:sldMk cId="2932986395" sldId="434"/>
            <ac:grpSpMk id="83" creationId="{BA468D37-4795-4EEA-A587-16B92C1A6E82}"/>
          </ac:grpSpMkLst>
        </pc:grpChg>
        <pc:grpChg chg="mod">
          <ac:chgData name="ophry pines" userId="ce6f9b4c01b12c0e" providerId="LiveId" clId="{BE1FFF84-AC0B-447C-963C-68A454A9C860}" dt="2022-11-26T20:05:28.615" v="11" actId="1035"/>
          <ac:grpSpMkLst>
            <pc:docMk/>
            <pc:sldMk cId="2932986395" sldId="434"/>
            <ac:grpSpMk id="127" creationId="{23AA8EFE-7A9C-4B67-99E3-1BBF872795A1}"/>
          </ac:grpSpMkLst>
        </pc:grpChg>
        <pc:picChg chg="mod">
          <ac:chgData name="ophry pines" userId="ce6f9b4c01b12c0e" providerId="LiveId" clId="{BE1FFF84-AC0B-447C-963C-68A454A9C860}" dt="2022-11-26T20:05:28.615" v="11" actId="1035"/>
          <ac:picMkLst>
            <pc:docMk/>
            <pc:sldMk cId="2932986395" sldId="434"/>
            <ac:picMk id="145" creationId="{113AB3DC-5562-42D5-A9C6-0BC8EE78FC81}"/>
          </ac:picMkLst>
        </pc:picChg>
        <pc:picChg chg="mod">
          <ac:chgData name="ophry pines" userId="ce6f9b4c01b12c0e" providerId="LiveId" clId="{BE1FFF84-AC0B-447C-963C-68A454A9C860}" dt="2022-11-26T20:05:28.615" v="11" actId="1035"/>
          <ac:picMkLst>
            <pc:docMk/>
            <pc:sldMk cId="2932986395" sldId="434"/>
            <ac:picMk id="146" creationId="{CA6769BE-34A1-4914-8449-50876C16D987}"/>
          </ac:picMkLst>
        </pc:picChg>
        <pc:picChg chg="mod">
          <ac:chgData name="ophry pines" userId="ce6f9b4c01b12c0e" providerId="LiveId" clId="{BE1FFF84-AC0B-447C-963C-68A454A9C860}" dt="2022-11-26T20:05:28.615" v="11" actId="1035"/>
          <ac:picMkLst>
            <pc:docMk/>
            <pc:sldMk cId="2932986395" sldId="434"/>
            <ac:picMk id="147" creationId="{D182D016-8D01-4C09-86E7-3A5495676754}"/>
          </ac:picMkLst>
        </pc:picChg>
        <pc:picChg chg="mod">
          <ac:chgData name="ophry pines" userId="ce6f9b4c01b12c0e" providerId="LiveId" clId="{BE1FFF84-AC0B-447C-963C-68A454A9C860}" dt="2022-11-26T20:05:28.615" v="11" actId="1035"/>
          <ac:picMkLst>
            <pc:docMk/>
            <pc:sldMk cId="2932986395" sldId="434"/>
            <ac:picMk id="148" creationId="{2789ED3C-ECC0-4A3C-9612-5B277378D188}"/>
          </ac:picMkLst>
        </pc:picChg>
        <pc:picChg chg="mod">
          <ac:chgData name="ophry pines" userId="ce6f9b4c01b12c0e" providerId="LiveId" clId="{BE1FFF84-AC0B-447C-963C-68A454A9C860}" dt="2022-11-26T20:05:28.615" v="11" actId="1035"/>
          <ac:picMkLst>
            <pc:docMk/>
            <pc:sldMk cId="2932986395" sldId="434"/>
            <ac:picMk id="149" creationId="{27B1914C-5981-48E4-89BF-D9F70A420DA0}"/>
          </ac:picMkLst>
        </pc:picChg>
        <pc:picChg chg="mod">
          <ac:chgData name="ophry pines" userId="ce6f9b4c01b12c0e" providerId="LiveId" clId="{BE1FFF84-AC0B-447C-963C-68A454A9C860}" dt="2022-11-26T20:05:28.615" v="11" actId="1035"/>
          <ac:picMkLst>
            <pc:docMk/>
            <pc:sldMk cId="2932986395" sldId="434"/>
            <ac:picMk id="150" creationId="{9AD04C6A-BAFF-4C7D-9687-B174CD29A4E0}"/>
          </ac:picMkLst>
        </pc:picChg>
        <pc:picChg chg="mod">
          <ac:chgData name="ophry pines" userId="ce6f9b4c01b12c0e" providerId="LiveId" clId="{BE1FFF84-AC0B-447C-963C-68A454A9C860}" dt="2022-11-26T20:05:28.615" v="11" actId="1035"/>
          <ac:picMkLst>
            <pc:docMk/>
            <pc:sldMk cId="2932986395" sldId="434"/>
            <ac:picMk id="151" creationId="{6AD09C92-A0C2-4AF9-9E15-E6A27AC53798}"/>
          </ac:picMkLst>
        </pc:picChg>
        <pc:cxnChg chg="mod">
          <ac:chgData name="ophry pines" userId="ce6f9b4c01b12c0e" providerId="LiveId" clId="{BE1FFF84-AC0B-447C-963C-68A454A9C860}" dt="2022-11-26T20:05:28.615" v="11" actId="1035"/>
          <ac:cxnSpMkLst>
            <pc:docMk/>
            <pc:sldMk cId="2932986395" sldId="434"/>
            <ac:cxnSpMk id="6" creationId="{0BD86E7F-FDFC-446F-AC11-F568AB29ECC9}"/>
          </ac:cxnSpMkLst>
        </pc:cxnChg>
        <pc:cxnChg chg="mod">
          <ac:chgData name="ophry pines" userId="ce6f9b4c01b12c0e" providerId="LiveId" clId="{BE1FFF84-AC0B-447C-963C-68A454A9C860}" dt="2022-11-26T20:05:28.615" v="11" actId="1035"/>
          <ac:cxnSpMkLst>
            <pc:docMk/>
            <pc:sldMk cId="2932986395" sldId="434"/>
            <ac:cxnSpMk id="7" creationId="{150EF5EF-E6CB-4356-A5ED-2F70C19ED5D1}"/>
          </ac:cxnSpMkLst>
        </pc:cxnChg>
        <pc:cxnChg chg="mod">
          <ac:chgData name="ophry pines" userId="ce6f9b4c01b12c0e" providerId="LiveId" clId="{BE1FFF84-AC0B-447C-963C-68A454A9C860}" dt="2022-11-26T20:05:28.615" v="11" actId="1035"/>
          <ac:cxnSpMkLst>
            <pc:docMk/>
            <pc:sldMk cId="2932986395" sldId="434"/>
            <ac:cxnSpMk id="24" creationId="{B9C67558-2ABE-46D0-86F7-2D6E7BD9C7BB}"/>
          </ac:cxnSpMkLst>
        </pc:cxnChg>
        <pc:cxnChg chg="mod">
          <ac:chgData name="ophry pines" userId="ce6f9b4c01b12c0e" providerId="LiveId" clId="{BE1FFF84-AC0B-447C-963C-68A454A9C860}" dt="2022-11-26T20:05:28.615" v="11" actId="1035"/>
          <ac:cxnSpMkLst>
            <pc:docMk/>
            <pc:sldMk cId="2932986395" sldId="434"/>
            <ac:cxnSpMk id="26" creationId="{7EC0D440-7FD0-4C4B-8723-FBEDA1E4ACA6}"/>
          </ac:cxnSpMkLst>
        </pc:cxnChg>
        <pc:cxnChg chg="mod">
          <ac:chgData name="ophry pines" userId="ce6f9b4c01b12c0e" providerId="LiveId" clId="{BE1FFF84-AC0B-447C-963C-68A454A9C860}" dt="2022-11-26T20:05:28.615" v="11" actId="1035"/>
          <ac:cxnSpMkLst>
            <pc:docMk/>
            <pc:sldMk cId="2932986395" sldId="434"/>
            <ac:cxnSpMk id="28" creationId="{5E1E15E9-23A7-4FC1-8C2F-067D77BE9099}"/>
          </ac:cxnSpMkLst>
        </pc:cxnChg>
        <pc:cxnChg chg="mod">
          <ac:chgData name="ophry pines" userId="ce6f9b4c01b12c0e" providerId="LiveId" clId="{BE1FFF84-AC0B-447C-963C-68A454A9C860}" dt="2022-11-26T20:05:28.615" v="11" actId="1035"/>
          <ac:cxnSpMkLst>
            <pc:docMk/>
            <pc:sldMk cId="2932986395" sldId="434"/>
            <ac:cxnSpMk id="30" creationId="{78DF2F86-6C70-45A3-BD5C-35BA9CECFE38}"/>
          </ac:cxnSpMkLst>
        </pc:cxnChg>
        <pc:cxnChg chg="mod">
          <ac:chgData name="ophry pines" userId="ce6f9b4c01b12c0e" providerId="LiveId" clId="{BE1FFF84-AC0B-447C-963C-68A454A9C860}" dt="2022-11-26T20:05:28.615" v="11" actId="1035"/>
          <ac:cxnSpMkLst>
            <pc:docMk/>
            <pc:sldMk cId="2932986395" sldId="434"/>
            <ac:cxnSpMk id="65" creationId="{DED2D8D0-A197-4667-98F7-4D0C3E901C98}"/>
          </ac:cxnSpMkLst>
        </pc:cxnChg>
        <pc:cxnChg chg="mod">
          <ac:chgData name="ophry pines" userId="ce6f9b4c01b12c0e" providerId="LiveId" clId="{BE1FFF84-AC0B-447C-963C-68A454A9C860}" dt="2022-11-26T20:05:28.615" v="11" actId="1035"/>
          <ac:cxnSpMkLst>
            <pc:docMk/>
            <pc:sldMk cId="2932986395" sldId="434"/>
            <ac:cxnSpMk id="66" creationId="{267BE423-7016-409D-9EBD-03F7CC438802}"/>
          </ac:cxnSpMkLst>
        </pc:cxnChg>
        <pc:cxnChg chg="mod">
          <ac:chgData name="ophry pines" userId="ce6f9b4c01b12c0e" providerId="LiveId" clId="{BE1FFF84-AC0B-447C-963C-68A454A9C860}" dt="2022-11-26T20:05:28.615" v="11" actId="1035"/>
          <ac:cxnSpMkLst>
            <pc:docMk/>
            <pc:sldMk cId="2932986395" sldId="434"/>
            <ac:cxnSpMk id="67" creationId="{E432A8CE-2A06-4E22-BF60-949A5740E9FF}"/>
          </ac:cxnSpMkLst>
        </pc:cxnChg>
        <pc:cxnChg chg="mod">
          <ac:chgData name="ophry pines" userId="ce6f9b4c01b12c0e" providerId="LiveId" clId="{BE1FFF84-AC0B-447C-963C-68A454A9C860}" dt="2022-11-26T20:05:28.615" v="11" actId="1035"/>
          <ac:cxnSpMkLst>
            <pc:docMk/>
            <pc:sldMk cId="2932986395" sldId="434"/>
            <ac:cxnSpMk id="68" creationId="{C3BCFF71-A460-4E45-A870-F2AA88A52176}"/>
          </ac:cxnSpMkLst>
        </pc:cxnChg>
        <pc:cxnChg chg="mod">
          <ac:chgData name="ophry pines" userId="ce6f9b4c01b12c0e" providerId="LiveId" clId="{BE1FFF84-AC0B-447C-963C-68A454A9C860}" dt="2022-11-26T20:05:28.615" v="11" actId="1035"/>
          <ac:cxnSpMkLst>
            <pc:docMk/>
            <pc:sldMk cId="2932986395" sldId="434"/>
            <ac:cxnSpMk id="75" creationId="{CBD90A5E-2C63-464F-BCC4-899FFCE1DFE9}"/>
          </ac:cxnSpMkLst>
        </pc:cxnChg>
        <pc:cxnChg chg="mod">
          <ac:chgData name="ophry pines" userId="ce6f9b4c01b12c0e" providerId="LiveId" clId="{BE1FFF84-AC0B-447C-963C-68A454A9C860}" dt="2022-11-26T20:05:28.615" v="11" actId="1035"/>
          <ac:cxnSpMkLst>
            <pc:docMk/>
            <pc:sldMk cId="2932986395" sldId="434"/>
            <ac:cxnSpMk id="77" creationId="{81877BD0-0F47-4CAE-8379-294073C2897B}"/>
          </ac:cxnSpMkLst>
        </pc:cxnChg>
        <pc:cxnChg chg="mod">
          <ac:chgData name="ophry pines" userId="ce6f9b4c01b12c0e" providerId="LiveId" clId="{BE1FFF84-AC0B-447C-963C-68A454A9C860}" dt="2022-11-26T20:05:28.615" v="11" actId="1035"/>
          <ac:cxnSpMkLst>
            <pc:docMk/>
            <pc:sldMk cId="2932986395" sldId="434"/>
            <ac:cxnSpMk id="79" creationId="{0E713313-700B-41E2-9B5E-968FB15BD752}"/>
          </ac:cxnSpMkLst>
        </pc:cxnChg>
        <pc:cxnChg chg="mod">
          <ac:chgData name="ophry pines" userId="ce6f9b4c01b12c0e" providerId="LiveId" clId="{BE1FFF84-AC0B-447C-963C-68A454A9C860}" dt="2022-11-26T20:05:28.615" v="11" actId="1035"/>
          <ac:cxnSpMkLst>
            <pc:docMk/>
            <pc:sldMk cId="2932986395" sldId="434"/>
            <ac:cxnSpMk id="81" creationId="{9DF20986-A7C1-4705-98F4-69DFAB61F84D}"/>
          </ac:cxnSpMkLst>
        </pc:cxnChg>
        <pc:cxnChg chg="mod">
          <ac:chgData name="ophry pines" userId="ce6f9b4c01b12c0e" providerId="LiveId" clId="{BE1FFF84-AC0B-447C-963C-68A454A9C860}" dt="2022-11-26T20:05:28.615" v="11" actId="1035"/>
          <ac:cxnSpMkLst>
            <pc:docMk/>
            <pc:sldMk cId="2932986395" sldId="434"/>
            <ac:cxnSpMk id="115" creationId="{63C699C8-6A47-42F8-A24A-C8A83D90CB9A}"/>
          </ac:cxnSpMkLst>
        </pc:cxnChg>
        <pc:cxnChg chg="mod">
          <ac:chgData name="ophry pines" userId="ce6f9b4c01b12c0e" providerId="LiveId" clId="{BE1FFF84-AC0B-447C-963C-68A454A9C860}" dt="2022-11-26T20:05:28.615" v="11" actId="1035"/>
          <ac:cxnSpMkLst>
            <pc:docMk/>
            <pc:sldMk cId="2932986395" sldId="434"/>
            <ac:cxnSpMk id="116" creationId="{AA49CA9A-2C43-473E-BE0B-640A4DA539E4}"/>
          </ac:cxnSpMkLst>
        </pc:cxnChg>
        <pc:cxnChg chg="mod">
          <ac:chgData name="ophry pines" userId="ce6f9b4c01b12c0e" providerId="LiveId" clId="{BE1FFF84-AC0B-447C-963C-68A454A9C860}" dt="2022-11-26T20:05:28.615" v="11" actId="1035"/>
          <ac:cxnSpMkLst>
            <pc:docMk/>
            <pc:sldMk cId="2932986395" sldId="434"/>
            <ac:cxnSpMk id="117" creationId="{BBA7598B-E868-48B7-B2CA-22F51407BEB6}"/>
          </ac:cxnSpMkLst>
        </pc:cxnChg>
        <pc:cxnChg chg="mod">
          <ac:chgData name="ophry pines" userId="ce6f9b4c01b12c0e" providerId="LiveId" clId="{BE1FFF84-AC0B-447C-963C-68A454A9C860}" dt="2022-11-26T20:05:28.615" v="11" actId="1035"/>
          <ac:cxnSpMkLst>
            <pc:docMk/>
            <pc:sldMk cId="2932986395" sldId="434"/>
            <ac:cxnSpMk id="118" creationId="{607E38E5-A946-4B1F-91F0-913DBA3D86C5}"/>
          </ac:cxnSpMkLst>
        </pc:cxnChg>
        <pc:cxnChg chg="mod">
          <ac:chgData name="ophry pines" userId="ce6f9b4c01b12c0e" providerId="LiveId" clId="{BE1FFF84-AC0B-447C-963C-68A454A9C860}" dt="2022-11-26T20:05:28.615" v="11" actId="1035"/>
          <ac:cxnSpMkLst>
            <pc:docMk/>
            <pc:sldMk cId="2932986395" sldId="434"/>
            <ac:cxnSpMk id="119" creationId="{638527AF-1EBC-4D41-A961-54C11CF3D128}"/>
          </ac:cxnSpMkLst>
        </pc:cxnChg>
        <pc:cxnChg chg="mod">
          <ac:chgData name="ophry pines" userId="ce6f9b4c01b12c0e" providerId="LiveId" clId="{BE1FFF84-AC0B-447C-963C-68A454A9C860}" dt="2022-11-26T20:05:28.615" v="11" actId="1035"/>
          <ac:cxnSpMkLst>
            <pc:docMk/>
            <pc:sldMk cId="2932986395" sldId="434"/>
            <ac:cxnSpMk id="120" creationId="{F299DCF0-F4B2-4334-9B31-E8B9A3023884}"/>
          </ac:cxnSpMkLst>
        </pc:cxnChg>
        <pc:cxnChg chg="mod">
          <ac:chgData name="ophry pines" userId="ce6f9b4c01b12c0e" providerId="LiveId" clId="{BE1FFF84-AC0B-447C-963C-68A454A9C860}" dt="2022-11-26T20:05:28.615" v="11" actId="1035"/>
          <ac:cxnSpMkLst>
            <pc:docMk/>
            <pc:sldMk cId="2932986395" sldId="434"/>
            <ac:cxnSpMk id="121" creationId="{6EB3A1C2-EDD4-4689-8295-FE2C886BBC1E}"/>
          </ac:cxnSpMkLst>
        </pc:cxnChg>
        <pc:cxnChg chg="mod">
          <ac:chgData name="ophry pines" userId="ce6f9b4c01b12c0e" providerId="LiveId" clId="{BE1FFF84-AC0B-447C-963C-68A454A9C860}" dt="2022-11-26T20:05:28.615" v="11" actId="1035"/>
          <ac:cxnSpMkLst>
            <pc:docMk/>
            <pc:sldMk cId="2932986395" sldId="434"/>
            <ac:cxnSpMk id="122" creationId="{FD1A009C-C54E-48CE-9B91-1F09BC51C4B9}"/>
          </ac:cxnSpMkLst>
        </pc:cxnChg>
        <pc:cxnChg chg="mod">
          <ac:chgData name="ophry pines" userId="ce6f9b4c01b12c0e" providerId="LiveId" clId="{BE1FFF84-AC0B-447C-963C-68A454A9C860}" dt="2022-11-26T20:05:28.615" v="11" actId="1035"/>
          <ac:cxnSpMkLst>
            <pc:docMk/>
            <pc:sldMk cId="2932986395" sldId="434"/>
            <ac:cxnSpMk id="124" creationId="{7ED583BB-2C91-4CF8-8C91-56143CD898AC}"/>
          </ac:cxnSpMkLst>
        </pc:cxnChg>
        <pc:cxnChg chg="mod">
          <ac:chgData name="ophry pines" userId="ce6f9b4c01b12c0e" providerId="LiveId" clId="{BE1FFF84-AC0B-447C-963C-68A454A9C860}" dt="2022-11-26T20:05:28.615" v="11" actId="1035"/>
          <ac:cxnSpMkLst>
            <pc:docMk/>
            <pc:sldMk cId="2932986395" sldId="434"/>
            <ac:cxnSpMk id="125" creationId="{61E047B5-F1E3-4568-B63C-B3CE8EE65F63}"/>
          </ac:cxnSpMkLst>
        </pc:cxnChg>
        <pc:cxnChg chg="mod">
          <ac:chgData name="ophry pines" userId="ce6f9b4c01b12c0e" providerId="LiveId" clId="{BE1FFF84-AC0B-447C-963C-68A454A9C860}" dt="2022-11-26T20:05:28.615" v="11" actId="1035"/>
          <ac:cxnSpMkLst>
            <pc:docMk/>
            <pc:sldMk cId="2932986395" sldId="434"/>
            <ac:cxnSpMk id="126" creationId="{163DC7D3-1F28-463B-A13F-A31186E5CD1D}"/>
          </ac:cxnSpMkLst>
        </pc:cxnChg>
        <pc:cxnChg chg="mod">
          <ac:chgData name="ophry pines" userId="ce6f9b4c01b12c0e" providerId="LiveId" clId="{BE1FFF84-AC0B-447C-963C-68A454A9C860}" dt="2022-11-26T20:05:28.615" v="11" actId="1035"/>
          <ac:cxnSpMkLst>
            <pc:docMk/>
            <pc:sldMk cId="2932986395" sldId="434"/>
            <ac:cxnSpMk id="141" creationId="{6876384E-F36D-4E76-9CFE-631965BDBFD7}"/>
          </ac:cxnSpMkLst>
        </pc:cxn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SG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358E824-0227-4010-99AB-0FE960BD6950}" type="datetimeFigureOut">
              <a:rPr lang="en-SG" smtClean="0"/>
              <a:t>15/12/2022</a:t>
            </a:fld>
            <a:endParaRPr lang="en-SG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SG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G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SG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157B3E7-148F-41D7-A637-C67FFF947E82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141325508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SG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D570C329-D84D-4CB7-94AC-7660C4777138}" type="slidenum">
              <a:rPr kumimoji="0" lang="en-SG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pPr marL="0" marR="0" lvl="0" indent="0" algn="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5</a:t>
            </a:fld>
            <a:endParaRPr kumimoji="0" lang="en-SG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65671100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SG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D570C329-D84D-4CB7-94AC-7660C4777138}" type="slidenum">
              <a:rPr kumimoji="0" lang="en-SG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pPr marL="0" marR="0" lvl="0" indent="0" algn="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7</a:t>
            </a:fld>
            <a:endParaRPr kumimoji="0" lang="en-SG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784592598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SG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D570C329-D84D-4CB7-94AC-7660C4777138}" type="slidenum">
              <a:rPr kumimoji="0" lang="en-SG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pPr marL="0" marR="0" lvl="0" indent="0" algn="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8</a:t>
            </a:fld>
            <a:endParaRPr kumimoji="0" lang="en-SG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542357662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SG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D570C329-D84D-4CB7-94AC-7660C4777138}" type="slidenum">
              <a:rPr kumimoji="0" lang="en-SG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pPr marL="0" marR="0" lvl="0" indent="0" algn="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9</a:t>
            </a:fld>
            <a:endParaRPr kumimoji="0" lang="en-SG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508389256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SG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D570C329-D84D-4CB7-94AC-7660C4777138}" type="slidenum">
              <a:rPr kumimoji="0" lang="en-SG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pPr marL="0" marR="0" lvl="0" indent="0" algn="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11</a:t>
            </a:fld>
            <a:endParaRPr kumimoji="0" lang="en-SG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386892775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SG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D570C329-D84D-4CB7-94AC-7660C4777138}" type="slidenum">
              <a:rPr kumimoji="0" lang="en-SG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pPr marL="0" marR="0" lvl="0" indent="0" algn="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13</a:t>
            </a:fld>
            <a:endParaRPr kumimoji="0" lang="en-SG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86625419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SG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D570C329-D84D-4CB7-94AC-7660C4777138}" type="slidenum">
              <a:rPr kumimoji="0" lang="en-SG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pPr marL="0" marR="0" lvl="0" indent="0" algn="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14</a:t>
            </a:fld>
            <a:endParaRPr kumimoji="0" lang="en-SG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1203974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496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9"/>
            <a:ext cx="6858000" cy="1655762"/>
          </a:xfrm>
        </p:spPr>
        <p:txBody>
          <a:bodyPr/>
          <a:lstStyle>
            <a:lvl1pPr marL="0" indent="0" algn="ctr">
              <a:buNone/>
              <a:defRPr sz="1988"/>
            </a:lvl1pPr>
            <a:lvl2pPr marL="378653" indent="0" algn="ctr">
              <a:buNone/>
              <a:defRPr sz="1656"/>
            </a:lvl2pPr>
            <a:lvl3pPr marL="757306" indent="0" algn="ctr">
              <a:buNone/>
              <a:defRPr sz="1491"/>
            </a:lvl3pPr>
            <a:lvl4pPr marL="1135959" indent="0" algn="ctr">
              <a:buNone/>
              <a:defRPr sz="1325"/>
            </a:lvl4pPr>
            <a:lvl5pPr marL="1514612" indent="0" algn="ctr">
              <a:buNone/>
              <a:defRPr sz="1325"/>
            </a:lvl5pPr>
            <a:lvl6pPr marL="1893265" indent="0" algn="ctr">
              <a:buNone/>
              <a:defRPr sz="1325"/>
            </a:lvl6pPr>
            <a:lvl7pPr marL="2271918" indent="0" algn="ctr">
              <a:buNone/>
              <a:defRPr sz="1325"/>
            </a:lvl7pPr>
            <a:lvl8pPr marL="2650571" indent="0" algn="ctr">
              <a:buNone/>
              <a:defRPr sz="1325"/>
            </a:lvl8pPr>
            <a:lvl9pPr marL="3029224" indent="0" algn="ctr">
              <a:buNone/>
              <a:defRPr sz="1325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BFC4FA-B56E-470B-A370-1B03B265D41D}" type="datetimeFigureOut">
              <a:rPr lang="en-SG" smtClean="0"/>
              <a:t>15/12/2022</a:t>
            </a:fld>
            <a:endParaRPr lang="en-S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476105-B0AB-4B3B-AB76-FBDFC72EC3D4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12793878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BFC4FA-B56E-470B-A370-1B03B265D41D}" type="datetimeFigureOut">
              <a:rPr lang="en-SG" smtClean="0"/>
              <a:t>15/12/2022</a:t>
            </a:fld>
            <a:endParaRPr lang="en-S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476105-B0AB-4B3B-AB76-FBDFC72EC3D4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13503560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6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2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BFC4FA-B56E-470B-A370-1B03B265D41D}" type="datetimeFigureOut">
              <a:rPr lang="en-SG" smtClean="0"/>
              <a:t>15/12/2022</a:t>
            </a:fld>
            <a:endParaRPr lang="en-S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476105-B0AB-4B3B-AB76-FBDFC72EC3D4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129649246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81196" y="687475"/>
            <a:ext cx="7989752" cy="651600"/>
          </a:xfrm>
        </p:spPr>
        <p:txBody>
          <a:bodyPr anchor="ctr"/>
          <a:lstStyle>
            <a:lvl1pPr algn="ctr">
              <a:defRPr sz="2982" cap="none" baseline="0">
                <a:solidFill>
                  <a:schemeClr val="tx2"/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1203239390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_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Content Placeholder 2"/>
          <p:cNvSpPr>
            <a:spLocks noGrp="1"/>
          </p:cNvSpPr>
          <p:nvPr>
            <p:ph idx="1"/>
          </p:nvPr>
        </p:nvSpPr>
        <p:spPr>
          <a:xfrm>
            <a:off x="581196" y="2228011"/>
            <a:ext cx="7989752" cy="3630795"/>
          </a:xfrm>
        </p:spPr>
        <p:txBody>
          <a:bodyPr anchor="t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22" name="Title 21"/>
          <p:cNvSpPr>
            <a:spLocks noGrp="1"/>
          </p:cNvSpPr>
          <p:nvPr>
            <p:ph type="title"/>
          </p:nvPr>
        </p:nvSpPr>
        <p:spPr>
          <a:xfrm>
            <a:off x="581196" y="687475"/>
            <a:ext cx="7989752" cy="653055"/>
          </a:xfrm>
        </p:spPr>
        <p:txBody>
          <a:bodyPr/>
          <a:lstStyle>
            <a:lvl1pPr algn="ctr">
              <a:defRPr sz="2982" cap="none" baseline="0">
                <a:solidFill>
                  <a:schemeClr val="tx2"/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2710611887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C74BF43-0F17-48CB-8582-C315B0E3049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SG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F905C6C-9A72-41A6-A6E2-85BD4DA694D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SG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273A587-384F-4FB4-A59A-845943F596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BB2E93-A6F9-4EB8-A947-2377968DBC78}" type="datetimeFigureOut">
              <a:rPr lang="en-SG" smtClean="0"/>
              <a:t>15/12/2022</a:t>
            </a:fld>
            <a:endParaRPr lang="en-SG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0AF09E8-74BD-4790-A5C3-BEF16A1716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1BAB9AD-BDA1-4BC5-A8CA-11CCE2B8E0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492941-3FA4-4A83-B8E2-CB7E014681B0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2835774095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6F1DB1-DE17-452E-B18C-06CC356E7D6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SG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1BDEFE5-9E05-4C4C-A118-B62046B5758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G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921F9B8-ACD4-48D5-BEC0-D98393020F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BB2E93-A6F9-4EB8-A947-2377968DBC78}" type="datetimeFigureOut">
              <a:rPr lang="en-SG" smtClean="0"/>
              <a:t>15/12/2022</a:t>
            </a:fld>
            <a:endParaRPr lang="en-SG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C36A028-71EE-44C0-B27E-E79F93F6F7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5881112-B78D-4633-BAD0-538479B0C7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492941-3FA4-4A83-B8E2-CB7E014681B0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2378790708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9149118-20F5-495E-9F98-3547EEE19B0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SG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94B6E03-B39F-4D3E-AACC-E18D7E24F31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DF17722-07A7-4D01-8D4B-442823D0BC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BB2E93-A6F9-4EB8-A947-2377968DBC78}" type="datetimeFigureOut">
              <a:rPr lang="en-SG" smtClean="0"/>
              <a:t>15/12/2022</a:t>
            </a:fld>
            <a:endParaRPr lang="en-SG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C661BE4-4667-4495-93D3-842440FD9F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516C3F0-5728-4868-AF4A-215C6B09EC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492941-3FA4-4A83-B8E2-CB7E014681B0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3744560735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96665F4-AAE6-4285-BB82-DC5E976563D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SG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B6EB59C-7475-4399-B2A1-16B9FB2D2B2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G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75B4765-A03F-4D55-B8B9-74E37817140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G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7252156-BF62-4E66-A488-E77BA4C045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BB2E93-A6F9-4EB8-A947-2377968DBC78}" type="datetimeFigureOut">
              <a:rPr lang="en-SG" smtClean="0"/>
              <a:t>15/12/2022</a:t>
            </a:fld>
            <a:endParaRPr lang="en-SG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75E9A57-C0F0-4018-B3C7-D737CB52B6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318027E-3331-4442-AF2D-EE1E9533CE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492941-3FA4-4A83-B8E2-CB7E014681B0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212393464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B6BECFC-2092-4A5E-9C7B-029A53F8EF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SG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B3B78CB-F88C-414A-A181-F5F6570AAE8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7411F7B-A89F-49D1-AAF9-BBE9ABC3A3F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G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C68D99C-B226-461B-90BB-7753C677CD8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EBC67A4-A127-4738-8B67-60B64CC447C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G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392A125-F7A9-4438-B3ED-363FACD6A1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BB2E93-A6F9-4EB8-A947-2377968DBC78}" type="datetimeFigureOut">
              <a:rPr lang="en-SG" smtClean="0"/>
              <a:t>15/12/2022</a:t>
            </a:fld>
            <a:endParaRPr lang="en-SG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913CB3B-14B9-4146-8EDE-6F62934EBB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6FB8F62-A7B1-407F-AA16-AC26050A20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492941-3FA4-4A83-B8E2-CB7E014681B0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1876437038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9954FD1-4F3A-4A3F-88AD-66B14FF5DA1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SG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5DAB0C4-A029-4057-A72D-EE8C6C0AC1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BB2E93-A6F9-4EB8-A947-2377968DBC78}" type="datetimeFigureOut">
              <a:rPr lang="en-SG" smtClean="0"/>
              <a:t>15/12/2022</a:t>
            </a:fld>
            <a:endParaRPr lang="en-SG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292B5E7-2A81-473F-B40E-0AB87742E4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BBBFF45-D886-4C14-96CE-1B65DCABB3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492941-3FA4-4A83-B8E2-CB7E014681B0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2704246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BFC4FA-B56E-470B-A370-1B03B265D41D}" type="datetimeFigureOut">
              <a:rPr lang="en-SG" smtClean="0"/>
              <a:t>15/12/2022</a:t>
            </a:fld>
            <a:endParaRPr lang="en-S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476105-B0AB-4B3B-AB76-FBDFC72EC3D4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872784915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56DDF0B-D366-4265-9ACF-B24028DB8F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BB2E93-A6F9-4EB8-A947-2377968DBC78}" type="datetimeFigureOut">
              <a:rPr lang="en-SG" smtClean="0"/>
              <a:t>15/12/2022</a:t>
            </a:fld>
            <a:endParaRPr lang="en-SG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08918C3-32E0-40BF-B11E-6FD2C9CBCD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1FC2808-CD0E-4A84-8A64-D928C39AB2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492941-3FA4-4A83-B8E2-CB7E014681B0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3151733742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414A886-6BC1-4658-B459-E1DDD21EBE6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SG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64868AF-A1FB-41A5-99D8-D802D13BA87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G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64E551C-075D-4207-B0AB-F6453E78A09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2B5F4CA-1DB3-4693-AC55-C4FB241358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BB2E93-A6F9-4EB8-A947-2377968DBC78}" type="datetimeFigureOut">
              <a:rPr lang="en-SG" smtClean="0"/>
              <a:t>15/12/2022</a:t>
            </a:fld>
            <a:endParaRPr lang="en-SG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139BABA-ADB7-4F69-994C-D1E54373E7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FCD5349-8B5E-4ACB-8DCA-7E603C911B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492941-3FA4-4A83-B8E2-CB7E014681B0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1834842831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189B18E-B740-4C9F-BB9E-F682118237E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SG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8CF0E6D-C2C4-402A-BD5A-E70D327ED4B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lang="en-SG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DAF4D34-D352-4178-A76E-64CC9B1CE70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C8433EE-3294-443C-AD37-FE875EC01F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BB2E93-A6F9-4EB8-A947-2377968DBC78}" type="datetimeFigureOut">
              <a:rPr lang="en-SG" smtClean="0"/>
              <a:t>15/12/2022</a:t>
            </a:fld>
            <a:endParaRPr lang="en-SG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7AF3956-C284-4AD4-883A-DD16970D53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0AC70D0-06DC-47EF-8A1A-03C8C8E976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492941-3FA4-4A83-B8E2-CB7E014681B0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2332410684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0C99F65-A28C-42AD-BA46-5757F6CF99E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SG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E03D94C-B937-44B0-B349-989B8DE1893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G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D13116D-79DB-4CEF-B3E3-E0607E3F75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BB2E93-A6F9-4EB8-A947-2377968DBC78}" type="datetimeFigureOut">
              <a:rPr lang="en-SG" smtClean="0"/>
              <a:t>15/12/2022</a:t>
            </a:fld>
            <a:endParaRPr lang="en-SG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E3FFE09-60DF-4930-AE71-28F2A3BC5A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3A4C473-2599-457D-924B-1EC2C4744D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492941-3FA4-4A83-B8E2-CB7E014681B0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4117013863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DDC7EF7-DC76-4698-9DC7-3D52C3E5AE8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SG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5BADFB9-B881-4D8D-87EA-72FB3C64500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G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BEADAAD-583D-4D6D-BA1C-9733AA2AAF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BB2E93-A6F9-4EB8-A947-2377968DBC78}" type="datetimeFigureOut">
              <a:rPr lang="en-SG" smtClean="0"/>
              <a:t>15/12/2022</a:t>
            </a:fld>
            <a:endParaRPr lang="en-SG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B25A484-213E-4680-9116-BDF843E227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633CCA0-889B-4AE4-BD7A-DF62889205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492941-3FA4-4A83-B8E2-CB7E014681B0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95266193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81193" y="687475"/>
            <a:ext cx="7989752" cy="651600"/>
          </a:xfrm>
        </p:spPr>
        <p:txBody>
          <a:bodyPr anchor="ctr"/>
          <a:lstStyle>
            <a:lvl1pPr algn="ctr">
              <a:defRPr sz="2700" cap="none" baseline="0">
                <a:solidFill>
                  <a:schemeClr val="tx2"/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27015988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496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5"/>
            <a:ext cx="7886700" cy="1500187"/>
          </a:xfrm>
        </p:spPr>
        <p:txBody>
          <a:bodyPr/>
          <a:lstStyle>
            <a:lvl1pPr marL="0" indent="0">
              <a:buNone/>
              <a:defRPr sz="1988">
                <a:solidFill>
                  <a:schemeClr val="tx1"/>
                </a:solidFill>
              </a:defRPr>
            </a:lvl1pPr>
            <a:lvl2pPr marL="378653" indent="0">
              <a:buNone/>
              <a:defRPr sz="1656">
                <a:solidFill>
                  <a:schemeClr val="tx1">
                    <a:tint val="75000"/>
                  </a:schemeClr>
                </a:solidFill>
              </a:defRPr>
            </a:lvl2pPr>
            <a:lvl3pPr marL="757306" indent="0">
              <a:buNone/>
              <a:defRPr sz="1491">
                <a:solidFill>
                  <a:schemeClr val="tx1">
                    <a:tint val="75000"/>
                  </a:schemeClr>
                </a:solidFill>
              </a:defRPr>
            </a:lvl3pPr>
            <a:lvl4pPr marL="1135959" indent="0">
              <a:buNone/>
              <a:defRPr sz="1325">
                <a:solidFill>
                  <a:schemeClr val="tx1">
                    <a:tint val="75000"/>
                  </a:schemeClr>
                </a:solidFill>
              </a:defRPr>
            </a:lvl4pPr>
            <a:lvl5pPr marL="1514612" indent="0">
              <a:buNone/>
              <a:defRPr sz="1325">
                <a:solidFill>
                  <a:schemeClr val="tx1">
                    <a:tint val="75000"/>
                  </a:schemeClr>
                </a:solidFill>
              </a:defRPr>
            </a:lvl5pPr>
            <a:lvl6pPr marL="1893265" indent="0">
              <a:buNone/>
              <a:defRPr sz="1325">
                <a:solidFill>
                  <a:schemeClr val="tx1">
                    <a:tint val="75000"/>
                  </a:schemeClr>
                </a:solidFill>
              </a:defRPr>
            </a:lvl6pPr>
            <a:lvl7pPr marL="2271918" indent="0">
              <a:buNone/>
              <a:defRPr sz="1325">
                <a:solidFill>
                  <a:schemeClr val="tx1">
                    <a:tint val="75000"/>
                  </a:schemeClr>
                </a:solidFill>
              </a:defRPr>
            </a:lvl7pPr>
            <a:lvl8pPr marL="2650571" indent="0">
              <a:buNone/>
              <a:defRPr sz="1325">
                <a:solidFill>
                  <a:schemeClr val="tx1">
                    <a:tint val="75000"/>
                  </a:schemeClr>
                </a:solidFill>
              </a:defRPr>
            </a:lvl8pPr>
            <a:lvl9pPr marL="3029224" indent="0">
              <a:buNone/>
              <a:defRPr sz="1325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BFC4FA-B56E-470B-A370-1B03B265D41D}" type="datetimeFigureOut">
              <a:rPr lang="en-SG" smtClean="0"/>
              <a:t>15/12/2022</a:t>
            </a:fld>
            <a:endParaRPr lang="en-S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476105-B0AB-4B3B-AB76-FBDFC72EC3D4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10165089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BFC4FA-B56E-470B-A370-1B03B265D41D}" type="datetimeFigureOut">
              <a:rPr lang="en-SG" smtClean="0"/>
              <a:t>15/12/2022</a:t>
            </a:fld>
            <a:endParaRPr lang="en-SG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476105-B0AB-4B3B-AB76-FBDFC72EC3D4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4198594074"/>
      </p:ext>
    </p:extLst>
  </p:cSld>
  <p:clrMapOvr>
    <a:masterClrMapping/>
  </p:clrMapOvr>
  <p:extLst>
    <p:ext uri="{DCECCB84-F9BA-43D5-87BE-67443E8EF086}">
      <p15:sldGuideLst xmlns:p15="http://schemas.microsoft.com/office/powerpoint/2012/main"/>
    </p:ext>
  </p:extLst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7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4"/>
            <a:ext cx="3868340" cy="823912"/>
          </a:xfrm>
        </p:spPr>
        <p:txBody>
          <a:bodyPr anchor="b"/>
          <a:lstStyle>
            <a:lvl1pPr marL="0" indent="0">
              <a:buNone/>
              <a:defRPr sz="1988" b="1"/>
            </a:lvl1pPr>
            <a:lvl2pPr marL="378653" indent="0">
              <a:buNone/>
              <a:defRPr sz="1656" b="1"/>
            </a:lvl2pPr>
            <a:lvl3pPr marL="757306" indent="0">
              <a:buNone/>
              <a:defRPr sz="1491" b="1"/>
            </a:lvl3pPr>
            <a:lvl4pPr marL="1135959" indent="0">
              <a:buNone/>
              <a:defRPr sz="1325" b="1"/>
            </a:lvl4pPr>
            <a:lvl5pPr marL="1514612" indent="0">
              <a:buNone/>
              <a:defRPr sz="1325" b="1"/>
            </a:lvl5pPr>
            <a:lvl6pPr marL="1893265" indent="0">
              <a:buNone/>
              <a:defRPr sz="1325" b="1"/>
            </a:lvl6pPr>
            <a:lvl7pPr marL="2271918" indent="0">
              <a:buNone/>
              <a:defRPr sz="1325" b="1"/>
            </a:lvl7pPr>
            <a:lvl8pPr marL="2650571" indent="0">
              <a:buNone/>
              <a:defRPr sz="1325" b="1"/>
            </a:lvl8pPr>
            <a:lvl9pPr marL="3029224" indent="0">
              <a:buNone/>
              <a:defRPr sz="1325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2" y="1681164"/>
            <a:ext cx="3887391" cy="823912"/>
          </a:xfrm>
        </p:spPr>
        <p:txBody>
          <a:bodyPr anchor="b"/>
          <a:lstStyle>
            <a:lvl1pPr marL="0" indent="0">
              <a:buNone/>
              <a:defRPr sz="1988" b="1"/>
            </a:lvl1pPr>
            <a:lvl2pPr marL="378653" indent="0">
              <a:buNone/>
              <a:defRPr sz="1656" b="1"/>
            </a:lvl2pPr>
            <a:lvl3pPr marL="757306" indent="0">
              <a:buNone/>
              <a:defRPr sz="1491" b="1"/>
            </a:lvl3pPr>
            <a:lvl4pPr marL="1135959" indent="0">
              <a:buNone/>
              <a:defRPr sz="1325" b="1"/>
            </a:lvl4pPr>
            <a:lvl5pPr marL="1514612" indent="0">
              <a:buNone/>
              <a:defRPr sz="1325" b="1"/>
            </a:lvl5pPr>
            <a:lvl6pPr marL="1893265" indent="0">
              <a:buNone/>
              <a:defRPr sz="1325" b="1"/>
            </a:lvl6pPr>
            <a:lvl7pPr marL="2271918" indent="0">
              <a:buNone/>
              <a:defRPr sz="1325" b="1"/>
            </a:lvl7pPr>
            <a:lvl8pPr marL="2650571" indent="0">
              <a:buNone/>
              <a:defRPr sz="1325" b="1"/>
            </a:lvl8pPr>
            <a:lvl9pPr marL="3029224" indent="0">
              <a:buNone/>
              <a:defRPr sz="1325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2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BFC4FA-B56E-470B-A370-1B03B265D41D}" type="datetimeFigureOut">
              <a:rPr lang="en-SG" smtClean="0"/>
              <a:t>15/12/2022</a:t>
            </a:fld>
            <a:endParaRPr lang="en-SG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476105-B0AB-4B3B-AB76-FBDFC72EC3D4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579833059"/>
      </p:ext>
    </p:extLst>
  </p:cSld>
  <p:clrMapOvr>
    <a:masterClrMapping/>
  </p:clrMapOvr>
  <p:extLst>
    <p:ext uri="{DCECCB84-F9BA-43D5-87BE-67443E8EF086}">
      <p15:sldGuideLst xmlns:p15="http://schemas.microsoft.com/office/powerpoint/2012/main"/>
    </p:ext>
  </p:extLst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BFC4FA-B56E-470B-A370-1B03B265D41D}" type="datetimeFigureOut">
              <a:rPr lang="en-SG" smtClean="0"/>
              <a:t>15/12/2022</a:t>
            </a:fld>
            <a:endParaRPr lang="en-SG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476105-B0AB-4B3B-AB76-FBDFC72EC3D4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30328396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smtClean="0"/>
              <a:t>12/15/2022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685365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1"/>
            <a:ext cx="2949178" cy="1600200"/>
          </a:xfrm>
        </p:spPr>
        <p:txBody>
          <a:bodyPr anchor="b"/>
          <a:lstStyle>
            <a:lvl1pPr>
              <a:defRPr sz="265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7"/>
            <a:ext cx="4629150" cy="4873625"/>
          </a:xfrm>
        </p:spPr>
        <p:txBody>
          <a:bodyPr/>
          <a:lstStyle>
            <a:lvl1pPr>
              <a:defRPr sz="2650"/>
            </a:lvl1pPr>
            <a:lvl2pPr>
              <a:defRPr sz="2319"/>
            </a:lvl2pPr>
            <a:lvl3pPr>
              <a:defRPr sz="1988"/>
            </a:lvl3pPr>
            <a:lvl4pPr>
              <a:defRPr sz="1656"/>
            </a:lvl4pPr>
            <a:lvl5pPr>
              <a:defRPr sz="1656"/>
            </a:lvl5pPr>
            <a:lvl6pPr>
              <a:defRPr sz="1656"/>
            </a:lvl6pPr>
            <a:lvl7pPr>
              <a:defRPr sz="1656"/>
            </a:lvl7pPr>
            <a:lvl8pPr>
              <a:defRPr sz="1656"/>
            </a:lvl8pPr>
            <a:lvl9pPr>
              <a:defRPr sz="1656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325"/>
            </a:lvl1pPr>
            <a:lvl2pPr marL="378653" indent="0">
              <a:buNone/>
              <a:defRPr sz="1159"/>
            </a:lvl2pPr>
            <a:lvl3pPr marL="757306" indent="0">
              <a:buNone/>
              <a:defRPr sz="994"/>
            </a:lvl3pPr>
            <a:lvl4pPr marL="1135959" indent="0">
              <a:buNone/>
              <a:defRPr sz="828"/>
            </a:lvl4pPr>
            <a:lvl5pPr marL="1514612" indent="0">
              <a:buNone/>
              <a:defRPr sz="828"/>
            </a:lvl5pPr>
            <a:lvl6pPr marL="1893265" indent="0">
              <a:buNone/>
              <a:defRPr sz="828"/>
            </a:lvl6pPr>
            <a:lvl7pPr marL="2271918" indent="0">
              <a:buNone/>
              <a:defRPr sz="828"/>
            </a:lvl7pPr>
            <a:lvl8pPr marL="2650571" indent="0">
              <a:buNone/>
              <a:defRPr sz="828"/>
            </a:lvl8pPr>
            <a:lvl9pPr marL="3029224" indent="0">
              <a:buNone/>
              <a:defRPr sz="828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BFC4FA-B56E-470B-A370-1B03B265D41D}" type="datetimeFigureOut">
              <a:rPr lang="en-SG" smtClean="0"/>
              <a:t>15/12/2022</a:t>
            </a:fld>
            <a:endParaRPr lang="en-SG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476105-B0AB-4B3B-AB76-FBDFC72EC3D4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3079511237"/>
      </p:ext>
    </p:extLst>
  </p:cSld>
  <p:clrMapOvr>
    <a:masterClrMapping/>
  </p:clrMapOvr>
  <p:extLst>
    <p:ext uri="{DCECCB84-F9BA-43D5-87BE-67443E8EF086}">
      <p15:sldGuideLst xmlns:p15="http://schemas.microsoft.com/office/powerpoint/2012/main"/>
    </p:ext>
  </p:extLst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1"/>
            <a:ext cx="2949178" cy="1600200"/>
          </a:xfrm>
        </p:spPr>
        <p:txBody>
          <a:bodyPr anchor="b"/>
          <a:lstStyle>
            <a:lvl1pPr>
              <a:defRPr sz="265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7"/>
            <a:ext cx="4629150" cy="4873625"/>
          </a:xfrm>
        </p:spPr>
        <p:txBody>
          <a:bodyPr anchor="t"/>
          <a:lstStyle>
            <a:lvl1pPr marL="0" indent="0">
              <a:buNone/>
              <a:defRPr sz="2650"/>
            </a:lvl1pPr>
            <a:lvl2pPr marL="378653" indent="0">
              <a:buNone/>
              <a:defRPr sz="2319"/>
            </a:lvl2pPr>
            <a:lvl3pPr marL="757306" indent="0">
              <a:buNone/>
              <a:defRPr sz="1988"/>
            </a:lvl3pPr>
            <a:lvl4pPr marL="1135959" indent="0">
              <a:buNone/>
              <a:defRPr sz="1656"/>
            </a:lvl4pPr>
            <a:lvl5pPr marL="1514612" indent="0">
              <a:buNone/>
              <a:defRPr sz="1656"/>
            </a:lvl5pPr>
            <a:lvl6pPr marL="1893265" indent="0">
              <a:buNone/>
              <a:defRPr sz="1656"/>
            </a:lvl6pPr>
            <a:lvl7pPr marL="2271918" indent="0">
              <a:buNone/>
              <a:defRPr sz="1656"/>
            </a:lvl7pPr>
            <a:lvl8pPr marL="2650571" indent="0">
              <a:buNone/>
              <a:defRPr sz="1656"/>
            </a:lvl8pPr>
            <a:lvl9pPr marL="3029224" indent="0">
              <a:buNone/>
              <a:defRPr sz="1656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325"/>
            </a:lvl1pPr>
            <a:lvl2pPr marL="378653" indent="0">
              <a:buNone/>
              <a:defRPr sz="1159"/>
            </a:lvl2pPr>
            <a:lvl3pPr marL="757306" indent="0">
              <a:buNone/>
              <a:defRPr sz="994"/>
            </a:lvl3pPr>
            <a:lvl4pPr marL="1135959" indent="0">
              <a:buNone/>
              <a:defRPr sz="828"/>
            </a:lvl4pPr>
            <a:lvl5pPr marL="1514612" indent="0">
              <a:buNone/>
              <a:defRPr sz="828"/>
            </a:lvl5pPr>
            <a:lvl6pPr marL="1893265" indent="0">
              <a:buNone/>
              <a:defRPr sz="828"/>
            </a:lvl6pPr>
            <a:lvl7pPr marL="2271918" indent="0">
              <a:buNone/>
              <a:defRPr sz="828"/>
            </a:lvl7pPr>
            <a:lvl8pPr marL="2650571" indent="0">
              <a:buNone/>
              <a:defRPr sz="828"/>
            </a:lvl8pPr>
            <a:lvl9pPr marL="3029224" indent="0">
              <a:buNone/>
              <a:defRPr sz="828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BFC4FA-B56E-470B-A370-1B03B265D41D}" type="datetimeFigureOut">
              <a:rPr lang="en-SG" smtClean="0"/>
              <a:t>15/12/2022</a:t>
            </a:fld>
            <a:endParaRPr lang="en-SG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476105-B0AB-4B3B-AB76-FBDFC72EC3D4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30796067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theme" Target="../theme/theme1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1.xml"/><Relationship Id="rId13" Type="http://schemas.openxmlformats.org/officeDocument/2006/relationships/theme" Target="../theme/theme2.xml"/><Relationship Id="rId3" Type="http://schemas.openxmlformats.org/officeDocument/2006/relationships/slideLayout" Target="../slideLayouts/slideLayout16.xml"/><Relationship Id="rId7" Type="http://schemas.openxmlformats.org/officeDocument/2006/relationships/slideLayout" Target="../slideLayouts/slideLayout20.xml"/><Relationship Id="rId12" Type="http://schemas.openxmlformats.org/officeDocument/2006/relationships/slideLayout" Target="../slideLayouts/slideLayout25.xml"/><Relationship Id="rId2" Type="http://schemas.openxmlformats.org/officeDocument/2006/relationships/slideLayout" Target="../slideLayouts/slideLayout15.xml"/><Relationship Id="rId1" Type="http://schemas.openxmlformats.org/officeDocument/2006/relationships/slideLayout" Target="../slideLayouts/slideLayout14.xml"/><Relationship Id="rId6" Type="http://schemas.openxmlformats.org/officeDocument/2006/relationships/slideLayout" Target="../slideLayouts/slideLayout19.xml"/><Relationship Id="rId11" Type="http://schemas.openxmlformats.org/officeDocument/2006/relationships/slideLayout" Target="../slideLayouts/slideLayout24.xml"/><Relationship Id="rId5" Type="http://schemas.openxmlformats.org/officeDocument/2006/relationships/slideLayout" Target="../slideLayouts/slideLayout18.xml"/><Relationship Id="rId10" Type="http://schemas.openxmlformats.org/officeDocument/2006/relationships/slideLayout" Target="../slideLayouts/slideLayout23.xml"/><Relationship Id="rId4" Type="http://schemas.openxmlformats.org/officeDocument/2006/relationships/slideLayout" Target="../slideLayouts/slideLayout17.xml"/><Relationship Id="rId9" Type="http://schemas.openxmlformats.org/officeDocument/2006/relationships/slideLayout" Target="../slideLayouts/slideLayout2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7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2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BFC4FA-B56E-470B-A370-1B03B265D41D}" type="datetimeFigureOut">
              <a:rPr lang="en-SG" smtClean="0"/>
              <a:t>15/12/2022</a:t>
            </a:fld>
            <a:endParaRPr lang="en-S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2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S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2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476105-B0AB-4B3B-AB76-FBDFC72EC3D4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25279548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</p:sldLayoutIdLst>
  <p:txStyles>
    <p:titleStyle>
      <a:lvl1pPr algn="l" defTabSz="757306" rtl="0" eaLnBrk="1" latinLnBrk="0" hangingPunct="1">
        <a:lnSpc>
          <a:spcPct val="90000"/>
        </a:lnSpc>
        <a:spcBef>
          <a:spcPct val="0"/>
        </a:spcBef>
        <a:buNone/>
        <a:defRPr sz="364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9327" indent="-189327" algn="l" defTabSz="757306" rtl="0" eaLnBrk="1" latinLnBrk="0" hangingPunct="1">
        <a:lnSpc>
          <a:spcPct val="90000"/>
        </a:lnSpc>
        <a:spcBef>
          <a:spcPts val="828"/>
        </a:spcBef>
        <a:buFont typeface="Arial" panose="020B0604020202020204" pitchFamily="34" charset="0"/>
        <a:buChar char="•"/>
        <a:defRPr sz="2319" kern="1200">
          <a:solidFill>
            <a:schemeClr val="tx1"/>
          </a:solidFill>
          <a:latin typeface="+mn-lt"/>
          <a:ea typeface="+mn-ea"/>
          <a:cs typeface="+mn-cs"/>
        </a:defRPr>
      </a:lvl1pPr>
      <a:lvl2pPr marL="567980" indent="-189327" algn="l" defTabSz="757306" rtl="0" eaLnBrk="1" latinLnBrk="0" hangingPunct="1">
        <a:lnSpc>
          <a:spcPct val="90000"/>
        </a:lnSpc>
        <a:spcBef>
          <a:spcPts val="414"/>
        </a:spcBef>
        <a:buFont typeface="Arial" panose="020B0604020202020204" pitchFamily="34" charset="0"/>
        <a:buChar char="•"/>
        <a:defRPr sz="1988" kern="1200">
          <a:solidFill>
            <a:schemeClr val="tx1"/>
          </a:solidFill>
          <a:latin typeface="+mn-lt"/>
          <a:ea typeface="+mn-ea"/>
          <a:cs typeface="+mn-cs"/>
        </a:defRPr>
      </a:lvl2pPr>
      <a:lvl3pPr marL="946633" indent="-189327" algn="l" defTabSz="757306" rtl="0" eaLnBrk="1" latinLnBrk="0" hangingPunct="1">
        <a:lnSpc>
          <a:spcPct val="90000"/>
        </a:lnSpc>
        <a:spcBef>
          <a:spcPts val="414"/>
        </a:spcBef>
        <a:buFont typeface="Arial" panose="020B0604020202020204" pitchFamily="34" charset="0"/>
        <a:buChar char="•"/>
        <a:defRPr sz="1656" kern="1200">
          <a:solidFill>
            <a:schemeClr val="tx1"/>
          </a:solidFill>
          <a:latin typeface="+mn-lt"/>
          <a:ea typeface="+mn-ea"/>
          <a:cs typeface="+mn-cs"/>
        </a:defRPr>
      </a:lvl3pPr>
      <a:lvl4pPr marL="1325286" indent="-189327" algn="l" defTabSz="757306" rtl="0" eaLnBrk="1" latinLnBrk="0" hangingPunct="1">
        <a:lnSpc>
          <a:spcPct val="90000"/>
        </a:lnSpc>
        <a:spcBef>
          <a:spcPts val="414"/>
        </a:spcBef>
        <a:buFont typeface="Arial" panose="020B0604020202020204" pitchFamily="34" charset="0"/>
        <a:buChar char="•"/>
        <a:defRPr sz="1491" kern="1200">
          <a:solidFill>
            <a:schemeClr val="tx1"/>
          </a:solidFill>
          <a:latin typeface="+mn-lt"/>
          <a:ea typeface="+mn-ea"/>
          <a:cs typeface="+mn-cs"/>
        </a:defRPr>
      </a:lvl4pPr>
      <a:lvl5pPr marL="1703939" indent="-189327" algn="l" defTabSz="757306" rtl="0" eaLnBrk="1" latinLnBrk="0" hangingPunct="1">
        <a:lnSpc>
          <a:spcPct val="90000"/>
        </a:lnSpc>
        <a:spcBef>
          <a:spcPts val="414"/>
        </a:spcBef>
        <a:buFont typeface="Arial" panose="020B0604020202020204" pitchFamily="34" charset="0"/>
        <a:buChar char="•"/>
        <a:defRPr sz="1491" kern="1200">
          <a:solidFill>
            <a:schemeClr val="tx1"/>
          </a:solidFill>
          <a:latin typeface="+mn-lt"/>
          <a:ea typeface="+mn-ea"/>
          <a:cs typeface="+mn-cs"/>
        </a:defRPr>
      </a:lvl5pPr>
      <a:lvl6pPr marL="2082592" indent="-189327" algn="l" defTabSz="757306" rtl="0" eaLnBrk="1" latinLnBrk="0" hangingPunct="1">
        <a:lnSpc>
          <a:spcPct val="90000"/>
        </a:lnSpc>
        <a:spcBef>
          <a:spcPts val="414"/>
        </a:spcBef>
        <a:buFont typeface="Arial" panose="020B0604020202020204" pitchFamily="34" charset="0"/>
        <a:buChar char="•"/>
        <a:defRPr sz="1491" kern="1200">
          <a:solidFill>
            <a:schemeClr val="tx1"/>
          </a:solidFill>
          <a:latin typeface="+mn-lt"/>
          <a:ea typeface="+mn-ea"/>
          <a:cs typeface="+mn-cs"/>
        </a:defRPr>
      </a:lvl6pPr>
      <a:lvl7pPr marL="2461245" indent="-189327" algn="l" defTabSz="757306" rtl="0" eaLnBrk="1" latinLnBrk="0" hangingPunct="1">
        <a:lnSpc>
          <a:spcPct val="90000"/>
        </a:lnSpc>
        <a:spcBef>
          <a:spcPts val="414"/>
        </a:spcBef>
        <a:buFont typeface="Arial" panose="020B0604020202020204" pitchFamily="34" charset="0"/>
        <a:buChar char="•"/>
        <a:defRPr sz="1491" kern="1200">
          <a:solidFill>
            <a:schemeClr val="tx1"/>
          </a:solidFill>
          <a:latin typeface="+mn-lt"/>
          <a:ea typeface="+mn-ea"/>
          <a:cs typeface="+mn-cs"/>
        </a:defRPr>
      </a:lvl7pPr>
      <a:lvl8pPr marL="2839898" indent="-189327" algn="l" defTabSz="757306" rtl="0" eaLnBrk="1" latinLnBrk="0" hangingPunct="1">
        <a:lnSpc>
          <a:spcPct val="90000"/>
        </a:lnSpc>
        <a:spcBef>
          <a:spcPts val="414"/>
        </a:spcBef>
        <a:buFont typeface="Arial" panose="020B0604020202020204" pitchFamily="34" charset="0"/>
        <a:buChar char="•"/>
        <a:defRPr sz="1491" kern="1200">
          <a:solidFill>
            <a:schemeClr val="tx1"/>
          </a:solidFill>
          <a:latin typeface="+mn-lt"/>
          <a:ea typeface="+mn-ea"/>
          <a:cs typeface="+mn-cs"/>
        </a:defRPr>
      </a:lvl8pPr>
      <a:lvl9pPr marL="3218551" indent="-189327" algn="l" defTabSz="757306" rtl="0" eaLnBrk="1" latinLnBrk="0" hangingPunct="1">
        <a:lnSpc>
          <a:spcPct val="90000"/>
        </a:lnSpc>
        <a:spcBef>
          <a:spcPts val="414"/>
        </a:spcBef>
        <a:buFont typeface="Arial" panose="020B0604020202020204" pitchFamily="34" charset="0"/>
        <a:buChar char="•"/>
        <a:defRPr sz="149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7306" rtl="0" eaLnBrk="1" latinLnBrk="0" hangingPunct="1">
        <a:defRPr sz="1491" kern="1200">
          <a:solidFill>
            <a:schemeClr val="tx1"/>
          </a:solidFill>
          <a:latin typeface="+mn-lt"/>
          <a:ea typeface="+mn-ea"/>
          <a:cs typeface="+mn-cs"/>
        </a:defRPr>
      </a:lvl1pPr>
      <a:lvl2pPr marL="378653" algn="l" defTabSz="757306" rtl="0" eaLnBrk="1" latinLnBrk="0" hangingPunct="1">
        <a:defRPr sz="1491" kern="1200">
          <a:solidFill>
            <a:schemeClr val="tx1"/>
          </a:solidFill>
          <a:latin typeface="+mn-lt"/>
          <a:ea typeface="+mn-ea"/>
          <a:cs typeface="+mn-cs"/>
        </a:defRPr>
      </a:lvl2pPr>
      <a:lvl3pPr marL="757306" algn="l" defTabSz="757306" rtl="0" eaLnBrk="1" latinLnBrk="0" hangingPunct="1">
        <a:defRPr sz="1491" kern="1200">
          <a:solidFill>
            <a:schemeClr val="tx1"/>
          </a:solidFill>
          <a:latin typeface="+mn-lt"/>
          <a:ea typeface="+mn-ea"/>
          <a:cs typeface="+mn-cs"/>
        </a:defRPr>
      </a:lvl3pPr>
      <a:lvl4pPr marL="1135959" algn="l" defTabSz="757306" rtl="0" eaLnBrk="1" latinLnBrk="0" hangingPunct="1">
        <a:defRPr sz="1491" kern="1200">
          <a:solidFill>
            <a:schemeClr val="tx1"/>
          </a:solidFill>
          <a:latin typeface="+mn-lt"/>
          <a:ea typeface="+mn-ea"/>
          <a:cs typeface="+mn-cs"/>
        </a:defRPr>
      </a:lvl4pPr>
      <a:lvl5pPr marL="1514612" algn="l" defTabSz="757306" rtl="0" eaLnBrk="1" latinLnBrk="0" hangingPunct="1">
        <a:defRPr sz="1491" kern="1200">
          <a:solidFill>
            <a:schemeClr val="tx1"/>
          </a:solidFill>
          <a:latin typeface="+mn-lt"/>
          <a:ea typeface="+mn-ea"/>
          <a:cs typeface="+mn-cs"/>
        </a:defRPr>
      </a:lvl5pPr>
      <a:lvl6pPr marL="1893265" algn="l" defTabSz="757306" rtl="0" eaLnBrk="1" latinLnBrk="0" hangingPunct="1">
        <a:defRPr sz="1491" kern="1200">
          <a:solidFill>
            <a:schemeClr val="tx1"/>
          </a:solidFill>
          <a:latin typeface="+mn-lt"/>
          <a:ea typeface="+mn-ea"/>
          <a:cs typeface="+mn-cs"/>
        </a:defRPr>
      </a:lvl6pPr>
      <a:lvl7pPr marL="2271918" algn="l" defTabSz="757306" rtl="0" eaLnBrk="1" latinLnBrk="0" hangingPunct="1">
        <a:defRPr sz="1491" kern="1200">
          <a:solidFill>
            <a:schemeClr val="tx1"/>
          </a:solidFill>
          <a:latin typeface="+mn-lt"/>
          <a:ea typeface="+mn-ea"/>
          <a:cs typeface="+mn-cs"/>
        </a:defRPr>
      </a:lvl7pPr>
      <a:lvl8pPr marL="2650571" algn="l" defTabSz="757306" rtl="0" eaLnBrk="1" latinLnBrk="0" hangingPunct="1">
        <a:defRPr sz="1491" kern="1200">
          <a:solidFill>
            <a:schemeClr val="tx1"/>
          </a:solidFill>
          <a:latin typeface="+mn-lt"/>
          <a:ea typeface="+mn-ea"/>
          <a:cs typeface="+mn-cs"/>
        </a:defRPr>
      </a:lvl8pPr>
      <a:lvl9pPr marL="3029224" algn="l" defTabSz="757306" rtl="0" eaLnBrk="1" latinLnBrk="0" hangingPunct="1">
        <a:defRPr sz="149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  <p:extLst>
    <p:ext uri="{27BBF7A9-308A-43DC-89C8-2F10F3537804}">
      <p15:sldGuideLst xmlns:p15="http://schemas.microsoft.com/office/powerpoint/2012/main"/>
    </p:ext>
  </p:extLst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035FB67-0874-4D85-BAE7-A89DD3D4220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SG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0FB8C67-2AD6-4FD4-970B-A9D692A2F5C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G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450BA23-D39A-4B19-9AC3-E1AF679540B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BB2E93-A6F9-4EB8-A947-2377968DBC78}" type="datetimeFigureOut">
              <a:rPr lang="en-SG" smtClean="0"/>
              <a:t>15/12/2022</a:t>
            </a:fld>
            <a:endParaRPr lang="en-SG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EF781DE-0AE1-4293-A500-6E66FDF26EC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SG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44221C7-7970-4DF4-B3FA-CB8B903E98C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492941-3FA4-4A83-B8E2-CB7E014681B0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10838218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5" r:id="rId1"/>
    <p:sldLayoutId id="2147483676" r:id="rId2"/>
    <p:sldLayoutId id="2147483677" r:id="rId3"/>
    <p:sldLayoutId id="2147483678" r:id="rId4"/>
    <p:sldLayoutId id="2147483679" r:id="rId5"/>
    <p:sldLayoutId id="2147483680" r:id="rId6"/>
    <p:sldLayoutId id="2147483681" r:id="rId7"/>
    <p:sldLayoutId id="2147483682" r:id="rId8"/>
    <p:sldLayoutId id="2147483683" r:id="rId9"/>
    <p:sldLayoutId id="2147483684" r:id="rId10"/>
    <p:sldLayoutId id="2147483685" r:id="rId11"/>
    <p:sldLayoutId id="2147483686" r:id="rId12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2.xml"/><Relationship Id="rId5" Type="http://schemas.openxmlformats.org/officeDocument/2006/relationships/image" Target="../media/image4.jpg"/><Relationship Id="rId4" Type="http://schemas.openxmlformats.org/officeDocument/2006/relationships/image" Target="../media/image3.jpg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38.png"/><Relationship Id="rId2" Type="http://schemas.openxmlformats.org/officeDocument/2006/relationships/image" Target="../media/image37.png"/><Relationship Id="rId1" Type="http://schemas.openxmlformats.org/officeDocument/2006/relationships/slideLayout" Target="../slideLayouts/slideLayout12.xml"/><Relationship Id="rId4" Type="http://schemas.openxmlformats.org/officeDocument/2006/relationships/image" Target="../media/image39.pn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40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12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2.xml"/></Relationships>
</file>

<file path=ppt/slides/_rels/slide13.xml.rels><?xml version="1.0" encoding="UTF-8" standalone="yes"?>
<Relationships xmlns="http://schemas.openxmlformats.org/package/2006/relationships"><Relationship Id="rId8" Type="http://schemas.openxmlformats.org/officeDocument/2006/relationships/image" Target="../media/image46.png"/><Relationship Id="rId13" Type="http://schemas.openxmlformats.org/officeDocument/2006/relationships/image" Target="../media/image51.png"/><Relationship Id="rId3" Type="http://schemas.openxmlformats.org/officeDocument/2006/relationships/image" Target="../media/image41.png"/><Relationship Id="rId7" Type="http://schemas.openxmlformats.org/officeDocument/2006/relationships/image" Target="../media/image45.png"/><Relationship Id="rId12" Type="http://schemas.openxmlformats.org/officeDocument/2006/relationships/image" Target="../media/image50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12.xml"/><Relationship Id="rId6" Type="http://schemas.openxmlformats.org/officeDocument/2006/relationships/image" Target="../media/image44.png"/><Relationship Id="rId11" Type="http://schemas.openxmlformats.org/officeDocument/2006/relationships/image" Target="../media/image49.png"/><Relationship Id="rId5" Type="http://schemas.openxmlformats.org/officeDocument/2006/relationships/image" Target="../media/image43.png"/><Relationship Id="rId10" Type="http://schemas.openxmlformats.org/officeDocument/2006/relationships/image" Target="../media/image48.png"/><Relationship Id="rId4" Type="http://schemas.openxmlformats.org/officeDocument/2006/relationships/image" Target="../media/image42.png"/><Relationship Id="rId9" Type="http://schemas.openxmlformats.org/officeDocument/2006/relationships/image" Target="../media/image47.png"/><Relationship Id="rId14" Type="http://schemas.openxmlformats.org/officeDocument/2006/relationships/image" Target="../media/image52.png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1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5.xml"/><Relationship Id="rId4" Type="http://schemas.openxmlformats.org/officeDocument/2006/relationships/image" Target="../media/image7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7" Type="http://schemas.openxmlformats.org/officeDocument/2006/relationships/image" Target="../media/image13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12.xml"/><Relationship Id="rId6" Type="http://schemas.openxmlformats.org/officeDocument/2006/relationships/image" Target="../media/image12.png"/><Relationship Id="rId5" Type="http://schemas.openxmlformats.org/officeDocument/2006/relationships/image" Target="../media/image11.png"/><Relationship Id="rId4" Type="http://schemas.openxmlformats.org/officeDocument/2006/relationships/image" Target="../media/image10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2.xml"/><Relationship Id="rId6" Type="http://schemas.openxmlformats.org/officeDocument/2006/relationships/image" Target="../media/image17.png"/><Relationship Id="rId5" Type="http://schemas.openxmlformats.org/officeDocument/2006/relationships/image" Target="../media/image16.png"/><Relationship Id="rId4" Type="http://schemas.openxmlformats.org/officeDocument/2006/relationships/image" Target="../media/image15.png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6.xml"/><Relationship Id="rId5" Type="http://schemas.openxmlformats.org/officeDocument/2006/relationships/image" Target="../media/image20.png"/><Relationship Id="rId4" Type="http://schemas.openxmlformats.org/officeDocument/2006/relationships/image" Target="../media/image19.png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26.png"/><Relationship Id="rId3" Type="http://schemas.openxmlformats.org/officeDocument/2006/relationships/image" Target="../media/image21.png"/><Relationship Id="rId7" Type="http://schemas.openxmlformats.org/officeDocument/2006/relationships/image" Target="../media/image25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2.xml"/><Relationship Id="rId6" Type="http://schemas.openxmlformats.org/officeDocument/2006/relationships/image" Target="../media/image24.png"/><Relationship Id="rId11" Type="http://schemas.openxmlformats.org/officeDocument/2006/relationships/image" Target="../media/image29.png"/><Relationship Id="rId5" Type="http://schemas.openxmlformats.org/officeDocument/2006/relationships/image" Target="../media/image23.png"/><Relationship Id="rId10" Type="http://schemas.openxmlformats.org/officeDocument/2006/relationships/image" Target="../media/image28.png"/><Relationship Id="rId4" Type="http://schemas.openxmlformats.org/officeDocument/2006/relationships/image" Target="../media/image22.png"/><Relationship Id="rId9" Type="http://schemas.openxmlformats.org/officeDocument/2006/relationships/image" Target="../media/image27.png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35.png"/><Relationship Id="rId3" Type="http://schemas.openxmlformats.org/officeDocument/2006/relationships/image" Target="../media/image30.png"/><Relationship Id="rId7" Type="http://schemas.openxmlformats.org/officeDocument/2006/relationships/image" Target="../media/image34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2.xml"/><Relationship Id="rId6" Type="http://schemas.openxmlformats.org/officeDocument/2006/relationships/image" Target="../media/image33.png"/><Relationship Id="rId5" Type="http://schemas.openxmlformats.org/officeDocument/2006/relationships/image" Target="../media/image32.png"/><Relationship Id="rId4" Type="http://schemas.openxmlformats.org/officeDocument/2006/relationships/image" Target="../media/image31.png"/><Relationship Id="rId9" Type="http://schemas.openxmlformats.org/officeDocument/2006/relationships/image" Target="../media/image3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le 1">
            <a:extLst>
              <a:ext uri="{FF2B5EF4-FFF2-40B4-BE49-F238E27FC236}">
                <a16:creationId xmlns:a16="http://schemas.microsoft.com/office/drawing/2014/main" id="{4FD32FAE-ADF7-4D23-9D1F-36BAABB9218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919297" y="100941"/>
            <a:ext cx="7274699" cy="539669"/>
          </a:xfrm>
        </p:spPr>
        <p:txBody>
          <a:bodyPr vert="horz" lIns="0" tIns="37866" rIns="0" bIns="37866" rtlCol="0" anchor="ctr">
            <a:noAutofit/>
          </a:bodyPr>
          <a:lstStyle/>
          <a:p>
            <a:r>
              <a:rPr lang="en-SG" sz="1656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ure S1: </a:t>
            </a:r>
            <a:r>
              <a:rPr lang="en-SG" sz="1656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Ubiquitin conjugates are detected in mitochondrial fractions (glucose)</a:t>
            </a:r>
            <a:r>
              <a:rPr lang="en-SG" sz="1656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DD31B507-C708-4417-87A2-C7255062741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37486" y="1594844"/>
            <a:ext cx="1716753" cy="1373402"/>
          </a:xfrm>
          <a:prstGeom prst="rect">
            <a:avLst/>
          </a:prstGeom>
        </p:spPr>
      </p:pic>
      <p:grpSp>
        <p:nvGrpSpPr>
          <p:cNvPr id="10" name="Group 9">
            <a:extLst>
              <a:ext uri="{FF2B5EF4-FFF2-40B4-BE49-F238E27FC236}">
                <a16:creationId xmlns:a16="http://schemas.microsoft.com/office/drawing/2014/main" id="{904BE1DB-986E-4C74-801E-90DFE58F002C}"/>
              </a:ext>
            </a:extLst>
          </p:cNvPr>
          <p:cNvGrpSpPr/>
          <p:nvPr/>
        </p:nvGrpSpPr>
        <p:grpSpPr>
          <a:xfrm>
            <a:off x="1878369" y="1321868"/>
            <a:ext cx="861732" cy="274776"/>
            <a:chOff x="956440" y="2068799"/>
            <a:chExt cx="1040461" cy="331766"/>
          </a:xfrm>
        </p:grpSpPr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9F44E9A7-85D1-4014-BA46-879F97E68141}"/>
                </a:ext>
              </a:extLst>
            </p:cNvPr>
            <p:cNvSpPr txBox="1"/>
            <p:nvPr/>
          </p:nvSpPr>
          <p:spPr>
            <a:xfrm>
              <a:off x="956440" y="2073352"/>
              <a:ext cx="199697" cy="3268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378653"/>
              <a:r>
                <a:rPr lang="en-SG" sz="1159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T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0A7F95C8-E590-47CB-ABE9-B4328E66C497}"/>
                </a:ext>
              </a:extLst>
            </p:cNvPr>
            <p:cNvSpPr txBox="1"/>
            <p:nvPr/>
          </p:nvSpPr>
          <p:spPr>
            <a:xfrm>
              <a:off x="1255634" y="2073702"/>
              <a:ext cx="199697" cy="3268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378653"/>
              <a:r>
                <a:rPr lang="en-SG" sz="1159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27EBF87B-9732-4DDF-BC54-4AC0396E6264}"/>
                </a:ext>
              </a:extLst>
            </p:cNvPr>
            <p:cNvSpPr txBox="1"/>
            <p:nvPr/>
          </p:nvSpPr>
          <p:spPr>
            <a:xfrm>
              <a:off x="1392616" y="2068799"/>
              <a:ext cx="604285" cy="3268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378653"/>
              <a:r>
                <a:rPr lang="en-SG" sz="1159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</a:t>
              </a:r>
              <a:r>
                <a:rPr lang="en-SG" sz="1159" baseline="3000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x</a:t>
              </a:r>
            </a:p>
          </p:txBody>
        </p:sp>
      </p:grpSp>
      <p:sp>
        <p:nvSpPr>
          <p:cNvPr id="7" name="TextBox 6">
            <a:extLst>
              <a:ext uri="{FF2B5EF4-FFF2-40B4-BE49-F238E27FC236}">
                <a16:creationId xmlns:a16="http://schemas.microsoft.com/office/drawing/2014/main" id="{0A52809D-5D2E-403F-B985-99728FAD30E0}"/>
              </a:ext>
            </a:extLst>
          </p:cNvPr>
          <p:cNvSpPr txBox="1"/>
          <p:nvPr/>
        </p:nvSpPr>
        <p:spPr>
          <a:xfrm rot="17749173">
            <a:off x="1534311" y="1268683"/>
            <a:ext cx="523306" cy="2707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378653"/>
            <a:r>
              <a:rPr lang="en-SG" sz="1159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W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36FAF6EB-6752-4683-B74C-7DA95EFB8C66}"/>
              </a:ext>
            </a:extLst>
          </p:cNvPr>
          <p:cNvSpPr txBox="1"/>
          <p:nvPr/>
        </p:nvSpPr>
        <p:spPr>
          <a:xfrm rot="17749173">
            <a:off x="2701356" y="1313975"/>
            <a:ext cx="523306" cy="2707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378653"/>
            <a:r>
              <a:rPr lang="en-SG" sz="1159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W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57ED535C-6C0C-4B88-A6DE-72DEC2DC8821}"/>
              </a:ext>
            </a:extLst>
          </p:cNvPr>
          <p:cNvSpPr txBox="1"/>
          <p:nvPr/>
        </p:nvSpPr>
        <p:spPr>
          <a:xfrm>
            <a:off x="2974039" y="1321879"/>
            <a:ext cx="548246" cy="2707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378653"/>
            <a:r>
              <a:rPr lang="en-SG" sz="1159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r>
              <a:rPr lang="en-SG" sz="1159" baseline="300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5x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2AAFA523-1FE6-454A-AFEF-1C9B01257190}"/>
              </a:ext>
            </a:extLst>
          </p:cNvPr>
          <p:cNvSpPr txBox="1"/>
          <p:nvPr/>
        </p:nvSpPr>
        <p:spPr>
          <a:xfrm>
            <a:off x="3427247" y="2043980"/>
            <a:ext cx="672627" cy="2707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378653"/>
            <a:r>
              <a:rPr lang="en-SG" sz="1159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l-GR" sz="1159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en-SG" sz="1159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SG" sz="1159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Ub</a:t>
            </a:r>
            <a:endParaRPr lang="en-SG" sz="1159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92F3971A-E588-40E0-8A78-EEE65A61E88C}"/>
              </a:ext>
            </a:extLst>
          </p:cNvPr>
          <p:cNvSpPr txBox="1"/>
          <p:nvPr/>
        </p:nvSpPr>
        <p:spPr>
          <a:xfrm>
            <a:off x="3440358" y="2593599"/>
            <a:ext cx="837740" cy="2707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378653"/>
            <a:r>
              <a:rPr lang="en-SG" sz="1159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ono </a:t>
            </a:r>
            <a:r>
              <a:rPr lang="en-SG" sz="1159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Ub</a:t>
            </a:r>
            <a:endParaRPr lang="en-SG" sz="1159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4" name="Straight Connector 33">
            <a:extLst>
              <a:ext uri="{FF2B5EF4-FFF2-40B4-BE49-F238E27FC236}">
                <a16:creationId xmlns:a16="http://schemas.microsoft.com/office/drawing/2014/main" id="{A3D5DFE7-5939-4A4D-8C6B-FEA479C3AA2D}"/>
              </a:ext>
            </a:extLst>
          </p:cNvPr>
          <p:cNvCxnSpPr>
            <a:cxnSpLocks/>
          </p:cNvCxnSpPr>
          <p:nvPr/>
        </p:nvCxnSpPr>
        <p:spPr>
          <a:xfrm>
            <a:off x="3370301" y="2735432"/>
            <a:ext cx="119264" cy="0"/>
          </a:xfrm>
          <a:prstGeom prst="line">
            <a:avLst/>
          </a:prstGeom>
          <a:ln w="15875">
            <a:solidFill>
              <a:schemeClr val="tx1"/>
            </a:solidFill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TextBox 34">
            <a:extLst>
              <a:ext uri="{FF2B5EF4-FFF2-40B4-BE49-F238E27FC236}">
                <a16:creationId xmlns:a16="http://schemas.microsoft.com/office/drawing/2014/main" id="{79814C8E-2E1E-422D-B37B-4207370B1AA5}"/>
              </a:ext>
            </a:extLst>
          </p:cNvPr>
          <p:cNvSpPr txBox="1"/>
          <p:nvPr/>
        </p:nvSpPr>
        <p:spPr>
          <a:xfrm>
            <a:off x="2588300" y="3307390"/>
            <a:ext cx="948985" cy="2707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378653"/>
            <a:r>
              <a:rPr lang="en-SG" sz="1159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sp60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54A707B1-9E14-46FD-95C9-7C5764B5FEA6}"/>
              </a:ext>
            </a:extLst>
          </p:cNvPr>
          <p:cNvSpPr txBox="1"/>
          <p:nvPr/>
        </p:nvSpPr>
        <p:spPr>
          <a:xfrm>
            <a:off x="2599110" y="3546950"/>
            <a:ext cx="948985" cy="2707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378653"/>
            <a:r>
              <a:rPr lang="en-SG" sz="1159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xk1</a:t>
            </a:r>
          </a:p>
        </p:txBody>
      </p:sp>
      <p:grpSp>
        <p:nvGrpSpPr>
          <p:cNvPr id="37" name="Group 36">
            <a:extLst>
              <a:ext uri="{FF2B5EF4-FFF2-40B4-BE49-F238E27FC236}">
                <a16:creationId xmlns:a16="http://schemas.microsoft.com/office/drawing/2014/main" id="{E5AB0B87-9B7F-443E-8BBB-D2B65C16A94E}"/>
              </a:ext>
            </a:extLst>
          </p:cNvPr>
          <p:cNvGrpSpPr/>
          <p:nvPr/>
        </p:nvGrpSpPr>
        <p:grpSpPr>
          <a:xfrm>
            <a:off x="1356212" y="2004182"/>
            <a:ext cx="160639" cy="887418"/>
            <a:chOff x="73152" y="2407172"/>
            <a:chExt cx="193957" cy="1071475"/>
          </a:xfrm>
        </p:grpSpPr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C43077E4-2E25-40E1-BDDF-2EF39D3B5C90}"/>
                </a:ext>
              </a:extLst>
            </p:cNvPr>
            <p:cNvSpPr txBox="1"/>
            <p:nvPr/>
          </p:nvSpPr>
          <p:spPr>
            <a:xfrm>
              <a:off x="74519" y="2862372"/>
              <a:ext cx="179617" cy="169239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defTabSz="378653"/>
              <a:r>
                <a:rPr lang="en-SG" sz="91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0</a:t>
              </a: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3111E0B8-0817-4EAA-BB98-0F78EEE8204C}"/>
                </a:ext>
              </a:extLst>
            </p:cNvPr>
            <p:cNvSpPr txBox="1"/>
            <p:nvPr/>
          </p:nvSpPr>
          <p:spPr>
            <a:xfrm>
              <a:off x="73152" y="3018789"/>
              <a:ext cx="187332" cy="169239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defTabSz="378653"/>
              <a:r>
                <a:rPr lang="en-SG" sz="91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7</a:t>
              </a: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67D0E6E4-3388-4040-BE09-2EB7A01DC82A}"/>
                </a:ext>
              </a:extLst>
            </p:cNvPr>
            <p:cNvSpPr txBox="1"/>
            <p:nvPr/>
          </p:nvSpPr>
          <p:spPr>
            <a:xfrm>
              <a:off x="79777" y="3137742"/>
              <a:ext cx="187332" cy="169239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defTabSz="378653"/>
              <a:r>
                <a:rPr lang="en-SG" sz="91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1</a:t>
              </a: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439871F1-CE58-4C7D-9D14-EE68D0982F04}"/>
                </a:ext>
              </a:extLst>
            </p:cNvPr>
            <p:cNvSpPr txBox="1"/>
            <p:nvPr/>
          </p:nvSpPr>
          <p:spPr>
            <a:xfrm>
              <a:off x="138780" y="3309408"/>
              <a:ext cx="106212" cy="169239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defTabSz="378653"/>
              <a:r>
                <a:rPr lang="en-SG" sz="91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5</a:t>
              </a:r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BB707DBC-BA2F-4444-9254-53A8529ECE9A}"/>
                </a:ext>
              </a:extLst>
            </p:cNvPr>
            <p:cNvSpPr txBox="1"/>
            <p:nvPr/>
          </p:nvSpPr>
          <p:spPr>
            <a:xfrm>
              <a:off x="80867" y="2731392"/>
              <a:ext cx="179617" cy="169239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defTabSz="378653"/>
              <a:r>
                <a:rPr lang="en-SG" sz="91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35</a:t>
              </a: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C0179168-3F61-4A16-A516-DC98F9C635DC}"/>
                </a:ext>
              </a:extLst>
            </p:cNvPr>
            <p:cNvSpPr txBox="1"/>
            <p:nvPr/>
          </p:nvSpPr>
          <p:spPr>
            <a:xfrm>
              <a:off x="74771" y="2407172"/>
              <a:ext cx="182664" cy="169239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defTabSz="378653"/>
              <a:r>
                <a:rPr lang="en-SG" sz="91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75</a:t>
              </a:r>
            </a:p>
          </p:txBody>
        </p:sp>
      </p:grpSp>
      <p:grpSp>
        <p:nvGrpSpPr>
          <p:cNvPr id="44" name="Group 43">
            <a:extLst>
              <a:ext uri="{FF2B5EF4-FFF2-40B4-BE49-F238E27FC236}">
                <a16:creationId xmlns:a16="http://schemas.microsoft.com/office/drawing/2014/main" id="{A61D2AF5-7A72-4017-8049-5B1C97391FC4}"/>
              </a:ext>
            </a:extLst>
          </p:cNvPr>
          <p:cNvGrpSpPr/>
          <p:nvPr/>
        </p:nvGrpSpPr>
        <p:grpSpPr>
          <a:xfrm>
            <a:off x="1502870" y="2082515"/>
            <a:ext cx="119264" cy="735606"/>
            <a:chOff x="3556800" y="3136132"/>
            <a:chExt cx="144000" cy="888176"/>
          </a:xfrm>
        </p:grpSpPr>
        <p:cxnSp>
          <p:nvCxnSpPr>
            <p:cNvPr id="45" name="Straight Connector 44">
              <a:extLst>
                <a:ext uri="{FF2B5EF4-FFF2-40B4-BE49-F238E27FC236}">
                  <a16:creationId xmlns:a16="http://schemas.microsoft.com/office/drawing/2014/main" id="{35CD44AF-3D1D-4B90-A617-708B6D3DBF31}"/>
                </a:ext>
              </a:extLst>
            </p:cNvPr>
            <p:cNvCxnSpPr/>
            <p:nvPr/>
          </p:nvCxnSpPr>
          <p:spPr>
            <a:xfrm>
              <a:off x="3563158" y="3136132"/>
              <a:ext cx="135516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Straight Connector 45">
              <a:extLst>
                <a:ext uri="{FF2B5EF4-FFF2-40B4-BE49-F238E27FC236}">
                  <a16:creationId xmlns:a16="http://schemas.microsoft.com/office/drawing/2014/main" id="{8D31DADD-89F0-4CDD-92E9-D748B4AC73BA}"/>
                </a:ext>
              </a:extLst>
            </p:cNvPr>
            <p:cNvCxnSpPr/>
            <p:nvPr/>
          </p:nvCxnSpPr>
          <p:spPr>
            <a:xfrm>
              <a:off x="3563158" y="4024308"/>
              <a:ext cx="135516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Straight Connector 46">
              <a:extLst>
                <a:ext uri="{FF2B5EF4-FFF2-40B4-BE49-F238E27FC236}">
                  <a16:creationId xmlns:a16="http://schemas.microsoft.com/office/drawing/2014/main" id="{6661B0AF-DDB1-469A-A0B0-D166A7BC18AE}"/>
                </a:ext>
              </a:extLst>
            </p:cNvPr>
            <p:cNvCxnSpPr/>
            <p:nvPr/>
          </p:nvCxnSpPr>
          <p:spPr>
            <a:xfrm>
              <a:off x="3557905" y="3871911"/>
              <a:ext cx="135516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Straight Connector 47">
              <a:extLst>
                <a:ext uri="{FF2B5EF4-FFF2-40B4-BE49-F238E27FC236}">
                  <a16:creationId xmlns:a16="http://schemas.microsoft.com/office/drawing/2014/main" id="{F13BABA1-DC2C-4F76-B1D5-EA5792C387B4}"/>
                </a:ext>
              </a:extLst>
            </p:cNvPr>
            <p:cNvCxnSpPr/>
            <p:nvPr/>
          </p:nvCxnSpPr>
          <p:spPr>
            <a:xfrm>
              <a:off x="3557905" y="3756294"/>
              <a:ext cx="135516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Straight Connector 48">
              <a:extLst>
                <a:ext uri="{FF2B5EF4-FFF2-40B4-BE49-F238E27FC236}">
                  <a16:creationId xmlns:a16="http://schemas.microsoft.com/office/drawing/2014/main" id="{05A83212-01BD-4447-8232-DD0D3F74C043}"/>
                </a:ext>
              </a:extLst>
            </p:cNvPr>
            <p:cNvCxnSpPr>
              <a:cxnSpLocks/>
            </p:cNvCxnSpPr>
            <p:nvPr/>
          </p:nvCxnSpPr>
          <p:spPr>
            <a:xfrm>
              <a:off x="3556800" y="3613029"/>
              <a:ext cx="144000" cy="34576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0" name="Straight Connector 49">
              <a:extLst>
                <a:ext uri="{FF2B5EF4-FFF2-40B4-BE49-F238E27FC236}">
                  <a16:creationId xmlns:a16="http://schemas.microsoft.com/office/drawing/2014/main" id="{EF381D39-BD02-4EF8-87B8-B7719B7087C4}"/>
                </a:ext>
              </a:extLst>
            </p:cNvPr>
            <p:cNvCxnSpPr/>
            <p:nvPr/>
          </p:nvCxnSpPr>
          <p:spPr>
            <a:xfrm>
              <a:off x="3557906" y="3472517"/>
              <a:ext cx="135516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3" name="Right Brace 52">
            <a:extLst>
              <a:ext uri="{FF2B5EF4-FFF2-40B4-BE49-F238E27FC236}">
                <a16:creationId xmlns:a16="http://schemas.microsoft.com/office/drawing/2014/main" id="{F752BD33-D67B-48E9-8324-8AF399DC8CA8}"/>
              </a:ext>
            </a:extLst>
          </p:cNvPr>
          <p:cNvSpPr/>
          <p:nvPr/>
        </p:nvSpPr>
        <p:spPr>
          <a:xfrm>
            <a:off x="3215748" y="3372455"/>
            <a:ext cx="144617" cy="357791"/>
          </a:xfrm>
          <a:prstGeom prst="rightBrac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 defTabSz="378653"/>
            <a:endParaRPr lang="en-SG" sz="1491">
              <a:solidFill>
                <a:prstClr val="black"/>
              </a:solidFill>
              <a:latin typeface="Calibri" panose="020F0502020204030204"/>
            </a:endParaRP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1C4D608D-0C1F-4F88-ACBF-ADBDDC38F322}"/>
              </a:ext>
            </a:extLst>
          </p:cNvPr>
          <p:cNvSpPr txBox="1"/>
          <p:nvPr/>
        </p:nvSpPr>
        <p:spPr>
          <a:xfrm>
            <a:off x="3347545" y="3429000"/>
            <a:ext cx="708531" cy="2707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378653"/>
            <a:r>
              <a:rPr lang="en-SG" sz="1159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Control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4CA8A9D4-8F0F-433D-ABF7-01653AFD2E06}"/>
              </a:ext>
            </a:extLst>
          </p:cNvPr>
          <p:cNvSpPr txBox="1"/>
          <p:nvPr/>
        </p:nvSpPr>
        <p:spPr>
          <a:xfrm>
            <a:off x="2027063" y="4333371"/>
            <a:ext cx="165393" cy="2707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378653"/>
            <a:r>
              <a:rPr lang="en-SG" sz="1159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3B962572-8DDC-4B41-9930-03E26643610A}"/>
              </a:ext>
            </a:extLst>
          </p:cNvPr>
          <p:cNvSpPr txBox="1"/>
          <p:nvPr/>
        </p:nvSpPr>
        <p:spPr>
          <a:xfrm>
            <a:off x="2338575" y="4333060"/>
            <a:ext cx="165393" cy="2707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378653"/>
            <a:r>
              <a:rPr lang="en-SG" sz="1159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56660FF9-20E9-4185-B17D-CFA5CB964310}"/>
              </a:ext>
            </a:extLst>
          </p:cNvPr>
          <p:cNvSpPr txBox="1"/>
          <p:nvPr/>
        </p:nvSpPr>
        <p:spPr>
          <a:xfrm>
            <a:off x="2631740" y="4337413"/>
            <a:ext cx="165393" cy="2707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378653"/>
            <a:r>
              <a:rPr lang="en-SG" sz="1159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5ACEC34B-B79E-4E46-BE5F-57102F56A393}"/>
              </a:ext>
            </a:extLst>
          </p:cNvPr>
          <p:cNvSpPr txBox="1"/>
          <p:nvPr/>
        </p:nvSpPr>
        <p:spPr>
          <a:xfrm>
            <a:off x="2830086" y="4337411"/>
            <a:ext cx="505792" cy="2707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378653"/>
            <a:r>
              <a:rPr lang="en-SG" sz="1159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r>
              <a:rPr lang="en-SG" sz="1159" baseline="300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5x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2F8690F0-4417-47C9-99FB-46FF7A26D27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639350" y="4615008"/>
            <a:ext cx="1509732" cy="1913674"/>
          </a:xfrm>
          <a:prstGeom prst="rect">
            <a:avLst/>
          </a:prstGeom>
        </p:spPr>
      </p:pic>
      <p:sp>
        <p:nvSpPr>
          <p:cNvPr id="61" name="TextBox 60">
            <a:extLst>
              <a:ext uri="{FF2B5EF4-FFF2-40B4-BE49-F238E27FC236}">
                <a16:creationId xmlns:a16="http://schemas.microsoft.com/office/drawing/2014/main" id="{C0E02FF7-69BC-4332-A323-95C7DCB7F792}"/>
              </a:ext>
            </a:extLst>
          </p:cNvPr>
          <p:cNvSpPr txBox="1"/>
          <p:nvPr/>
        </p:nvSpPr>
        <p:spPr>
          <a:xfrm rot="17749173">
            <a:off x="1582049" y="4288885"/>
            <a:ext cx="523306" cy="2707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378653"/>
            <a:r>
              <a:rPr lang="en-SG" sz="1159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W</a:t>
            </a:r>
          </a:p>
        </p:txBody>
      </p:sp>
      <p:grpSp>
        <p:nvGrpSpPr>
          <p:cNvPr id="52" name="Group 51">
            <a:extLst>
              <a:ext uri="{FF2B5EF4-FFF2-40B4-BE49-F238E27FC236}">
                <a16:creationId xmlns:a16="http://schemas.microsoft.com/office/drawing/2014/main" id="{BAE8A971-B3D8-4471-9F09-AEE8F35A8F52}"/>
              </a:ext>
            </a:extLst>
          </p:cNvPr>
          <p:cNvGrpSpPr/>
          <p:nvPr/>
        </p:nvGrpSpPr>
        <p:grpSpPr>
          <a:xfrm>
            <a:off x="1312087" y="4609396"/>
            <a:ext cx="316252" cy="1935939"/>
            <a:chOff x="5049156" y="2342982"/>
            <a:chExt cx="381845" cy="2337467"/>
          </a:xfrm>
        </p:grpSpPr>
        <p:grpSp>
          <p:nvGrpSpPr>
            <p:cNvPr id="55" name="Group 54">
              <a:extLst>
                <a:ext uri="{FF2B5EF4-FFF2-40B4-BE49-F238E27FC236}">
                  <a16:creationId xmlns:a16="http://schemas.microsoft.com/office/drawing/2014/main" id="{8B95E622-30A7-47A2-919A-90A5A9B08642}"/>
                </a:ext>
              </a:extLst>
            </p:cNvPr>
            <p:cNvGrpSpPr/>
            <p:nvPr/>
          </p:nvGrpSpPr>
          <p:grpSpPr>
            <a:xfrm>
              <a:off x="5049156" y="2342982"/>
              <a:ext cx="309899" cy="2337467"/>
              <a:chOff x="15900" y="2407171"/>
              <a:chExt cx="309899" cy="2337467"/>
            </a:xfrm>
          </p:grpSpPr>
          <p:sp>
            <p:nvSpPr>
              <p:cNvPr id="72" name="TextBox 71">
                <a:extLst>
                  <a:ext uri="{FF2B5EF4-FFF2-40B4-BE49-F238E27FC236}">
                    <a16:creationId xmlns:a16="http://schemas.microsoft.com/office/drawing/2014/main" id="{C13B470B-4A51-4924-BF4D-C340F00DC177}"/>
                  </a:ext>
                </a:extLst>
              </p:cNvPr>
              <p:cNvSpPr txBox="1"/>
              <p:nvPr/>
            </p:nvSpPr>
            <p:spPr>
              <a:xfrm>
                <a:off x="85406" y="2873258"/>
                <a:ext cx="179616" cy="169239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defTabSz="378653"/>
                <a:r>
                  <a:rPr lang="en-SG" sz="911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5</a:t>
                </a:r>
              </a:p>
            </p:txBody>
          </p:sp>
          <p:sp>
            <p:nvSpPr>
              <p:cNvPr id="73" name="TextBox 72">
                <a:extLst>
                  <a:ext uri="{FF2B5EF4-FFF2-40B4-BE49-F238E27FC236}">
                    <a16:creationId xmlns:a16="http://schemas.microsoft.com/office/drawing/2014/main" id="{9D8632B1-897E-4156-BC57-33FAA77A9F71}"/>
                  </a:ext>
                </a:extLst>
              </p:cNvPr>
              <p:cNvSpPr txBox="1"/>
              <p:nvPr/>
            </p:nvSpPr>
            <p:spPr>
              <a:xfrm>
                <a:off x="73152" y="3486876"/>
                <a:ext cx="187332" cy="169239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defTabSz="378653"/>
                <a:r>
                  <a:rPr lang="en-SG" sz="911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5</a:t>
                </a:r>
              </a:p>
            </p:txBody>
          </p:sp>
          <p:sp>
            <p:nvSpPr>
              <p:cNvPr id="74" name="TextBox 73">
                <a:extLst>
                  <a:ext uri="{FF2B5EF4-FFF2-40B4-BE49-F238E27FC236}">
                    <a16:creationId xmlns:a16="http://schemas.microsoft.com/office/drawing/2014/main" id="{9056EE1C-5A07-495E-8CDA-915636B3C840}"/>
                  </a:ext>
                </a:extLst>
              </p:cNvPr>
              <p:cNvSpPr txBox="1"/>
              <p:nvPr/>
            </p:nvSpPr>
            <p:spPr>
              <a:xfrm>
                <a:off x="79777" y="4063026"/>
                <a:ext cx="187332" cy="169239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defTabSz="378653"/>
                <a:r>
                  <a:rPr lang="en-SG" sz="911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5</a:t>
                </a:r>
              </a:p>
            </p:txBody>
          </p:sp>
          <p:sp>
            <p:nvSpPr>
              <p:cNvPr id="75" name="TextBox 74">
                <a:extLst>
                  <a:ext uri="{FF2B5EF4-FFF2-40B4-BE49-F238E27FC236}">
                    <a16:creationId xmlns:a16="http://schemas.microsoft.com/office/drawing/2014/main" id="{E693D3FC-6EAC-48E5-B49C-E75A2649E66B}"/>
                  </a:ext>
                </a:extLst>
              </p:cNvPr>
              <p:cNvSpPr txBox="1"/>
              <p:nvPr/>
            </p:nvSpPr>
            <p:spPr>
              <a:xfrm>
                <a:off x="68545" y="4575399"/>
                <a:ext cx="187332" cy="169239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defTabSz="378653"/>
                <a:r>
                  <a:rPr lang="en-SG" sz="911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</a:t>
                </a:r>
              </a:p>
            </p:txBody>
          </p:sp>
          <p:sp>
            <p:nvSpPr>
              <p:cNvPr id="76" name="TextBox 75">
                <a:extLst>
                  <a:ext uri="{FF2B5EF4-FFF2-40B4-BE49-F238E27FC236}">
                    <a16:creationId xmlns:a16="http://schemas.microsoft.com/office/drawing/2014/main" id="{5AF931D5-26B5-4D5D-B066-2D14A9D5A84D}"/>
                  </a:ext>
                </a:extLst>
              </p:cNvPr>
              <p:cNvSpPr txBox="1"/>
              <p:nvPr/>
            </p:nvSpPr>
            <p:spPr>
              <a:xfrm>
                <a:off x="85406" y="2709616"/>
                <a:ext cx="240393" cy="169239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defTabSz="378653"/>
                <a:r>
                  <a:rPr lang="en-SG" sz="911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0</a:t>
                </a:r>
              </a:p>
            </p:txBody>
          </p:sp>
          <p:sp>
            <p:nvSpPr>
              <p:cNvPr id="77" name="TextBox 76">
                <a:extLst>
                  <a:ext uri="{FF2B5EF4-FFF2-40B4-BE49-F238E27FC236}">
                    <a16:creationId xmlns:a16="http://schemas.microsoft.com/office/drawing/2014/main" id="{92D71437-28F8-4112-90BF-9FDEC0BC396E}"/>
                  </a:ext>
                </a:extLst>
              </p:cNvPr>
              <p:cNvSpPr txBox="1"/>
              <p:nvPr/>
            </p:nvSpPr>
            <p:spPr>
              <a:xfrm>
                <a:off x="15900" y="2407171"/>
                <a:ext cx="241534" cy="169239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defTabSz="378653"/>
                <a:r>
                  <a:rPr lang="en-SG" sz="911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50</a:t>
                </a:r>
              </a:p>
            </p:txBody>
          </p:sp>
        </p:grpSp>
        <p:grpSp>
          <p:nvGrpSpPr>
            <p:cNvPr id="60" name="Group 59">
              <a:extLst>
                <a:ext uri="{FF2B5EF4-FFF2-40B4-BE49-F238E27FC236}">
                  <a16:creationId xmlns:a16="http://schemas.microsoft.com/office/drawing/2014/main" id="{A08ABBBE-441A-41AC-A4EF-6A0D8B70A0F8}"/>
                </a:ext>
              </a:extLst>
            </p:cNvPr>
            <p:cNvGrpSpPr/>
            <p:nvPr/>
          </p:nvGrpSpPr>
          <p:grpSpPr>
            <a:xfrm>
              <a:off x="5284598" y="2437571"/>
              <a:ext cx="146403" cy="2140035"/>
              <a:chOff x="3557905" y="3136132"/>
              <a:chExt cx="146403" cy="2140035"/>
            </a:xfrm>
          </p:grpSpPr>
          <p:cxnSp>
            <p:nvCxnSpPr>
              <p:cNvPr id="67" name="Straight Connector 66">
                <a:extLst>
                  <a:ext uri="{FF2B5EF4-FFF2-40B4-BE49-F238E27FC236}">
                    <a16:creationId xmlns:a16="http://schemas.microsoft.com/office/drawing/2014/main" id="{8DF11F55-30EA-4087-A315-C595EFD3942A}"/>
                  </a:ext>
                </a:extLst>
              </p:cNvPr>
              <p:cNvCxnSpPr/>
              <p:nvPr/>
            </p:nvCxnSpPr>
            <p:spPr>
              <a:xfrm>
                <a:off x="3563158" y="3136132"/>
                <a:ext cx="135516" cy="0"/>
              </a:xfrm>
              <a:prstGeom prst="line">
                <a:avLst/>
              </a:prstGeom>
              <a:ln w="158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8" name="Straight Connector 67">
                <a:extLst>
                  <a:ext uri="{FF2B5EF4-FFF2-40B4-BE49-F238E27FC236}">
                    <a16:creationId xmlns:a16="http://schemas.microsoft.com/office/drawing/2014/main" id="{AA253B99-9DD9-46E8-83F5-6311D3AF62BC}"/>
                  </a:ext>
                </a:extLst>
              </p:cNvPr>
              <p:cNvCxnSpPr/>
              <p:nvPr/>
            </p:nvCxnSpPr>
            <p:spPr>
              <a:xfrm>
                <a:off x="3563158" y="5276167"/>
                <a:ext cx="135516" cy="0"/>
              </a:xfrm>
              <a:prstGeom prst="line">
                <a:avLst/>
              </a:prstGeom>
              <a:ln w="158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9" name="Straight Connector 68">
                <a:extLst>
                  <a:ext uri="{FF2B5EF4-FFF2-40B4-BE49-F238E27FC236}">
                    <a16:creationId xmlns:a16="http://schemas.microsoft.com/office/drawing/2014/main" id="{408D67F1-473D-47B3-9348-2A4564DC051B}"/>
                  </a:ext>
                </a:extLst>
              </p:cNvPr>
              <p:cNvCxnSpPr/>
              <p:nvPr/>
            </p:nvCxnSpPr>
            <p:spPr>
              <a:xfrm>
                <a:off x="3557905" y="4775429"/>
                <a:ext cx="135516" cy="0"/>
              </a:xfrm>
              <a:prstGeom prst="line">
                <a:avLst/>
              </a:prstGeom>
              <a:ln w="158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0" name="Straight Connector 69">
                <a:extLst>
                  <a:ext uri="{FF2B5EF4-FFF2-40B4-BE49-F238E27FC236}">
                    <a16:creationId xmlns:a16="http://schemas.microsoft.com/office/drawing/2014/main" id="{5176104A-80F5-46DE-BBE1-874C1BADE6E0}"/>
                  </a:ext>
                </a:extLst>
              </p:cNvPr>
              <p:cNvCxnSpPr/>
              <p:nvPr/>
            </p:nvCxnSpPr>
            <p:spPr>
              <a:xfrm>
                <a:off x="3557905" y="4191725"/>
                <a:ext cx="135516" cy="0"/>
              </a:xfrm>
              <a:prstGeom prst="line">
                <a:avLst/>
              </a:prstGeom>
              <a:ln w="158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1" name="Straight Connector 70">
                <a:extLst>
                  <a:ext uri="{FF2B5EF4-FFF2-40B4-BE49-F238E27FC236}">
                    <a16:creationId xmlns:a16="http://schemas.microsoft.com/office/drawing/2014/main" id="{3A50A6C2-6C26-4709-8950-A0625AB4172E}"/>
                  </a:ext>
                </a:extLst>
              </p:cNvPr>
              <p:cNvCxnSpPr/>
              <p:nvPr/>
            </p:nvCxnSpPr>
            <p:spPr>
              <a:xfrm>
                <a:off x="3568792" y="3418088"/>
                <a:ext cx="135516" cy="0"/>
              </a:xfrm>
              <a:prstGeom prst="line">
                <a:avLst/>
              </a:prstGeom>
              <a:ln w="158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62" name="Straight Connector 61">
              <a:extLst>
                <a:ext uri="{FF2B5EF4-FFF2-40B4-BE49-F238E27FC236}">
                  <a16:creationId xmlns:a16="http://schemas.microsoft.com/office/drawing/2014/main" id="{FF0C48F6-9A27-4650-8768-A047DCDC3758}"/>
                </a:ext>
              </a:extLst>
            </p:cNvPr>
            <p:cNvCxnSpPr/>
            <p:nvPr/>
          </p:nvCxnSpPr>
          <p:spPr>
            <a:xfrm>
              <a:off x="5295483" y="2610670"/>
              <a:ext cx="135516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08FA2FD8-0B11-4A8F-AD9B-82491A49CB7C}"/>
                </a:ext>
              </a:extLst>
            </p:cNvPr>
            <p:cNvSpPr txBox="1"/>
            <p:nvPr/>
          </p:nvSpPr>
          <p:spPr>
            <a:xfrm>
              <a:off x="5049853" y="2514800"/>
              <a:ext cx="298315" cy="169239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defTabSz="378653"/>
              <a:r>
                <a:rPr lang="en-SG" sz="91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</a:p>
          </p:txBody>
        </p:sp>
        <p:cxnSp>
          <p:nvCxnSpPr>
            <p:cNvPr id="64" name="Straight Connector 63">
              <a:extLst>
                <a:ext uri="{FF2B5EF4-FFF2-40B4-BE49-F238E27FC236}">
                  <a16:creationId xmlns:a16="http://schemas.microsoft.com/office/drawing/2014/main" id="{CFCC782D-091D-4022-8DB8-120E7BB1FE57}"/>
                </a:ext>
              </a:extLst>
            </p:cNvPr>
            <p:cNvCxnSpPr/>
            <p:nvPr/>
          </p:nvCxnSpPr>
          <p:spPr>
            <a:xfrm>
              <a:off x="5295482" y="2894446"/>
              <a:ext cx="135516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CC78A72C-68FC-4DC5-AE7E-07F37862E565}"/>
                </a:ext>
              </a:extLst>
            </p:cNvPr>
            <p:cNvSpPr txBox="1"/>
            <p:nvPr/>
          </p:nvSpPr>
          <p:spPr>
            <a:xfrm>
              <a:off x="5106410" y="3139655"/>
              <a:ext cx="187332" cy="169239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defTabSz="378653"/>
              <a:r>
                <a:rPr lang="en-SG" sz="91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35</a:t>
              </a:r>
            </a:p>
          </p:txBody>
        </p:sp>
        <p:cxnSp>
          <p:nvCxnSpPr>
            <p:cNvPr id="66" name="Straight Connector 65">
              <a:extLst>
                <a:ext uri="{FF2B5EF4-FFF2-40B4-BE49-F238E27FC236}">
                  <a16:creationId xmlns:a16="http://schemas.microsoft.com/office/drawing/2014/main" id="{C038AF14-E6AD-4129-880E-CE6775370AC5}"/>
                </a:ext>
              </a:extLst>
            </p:cNvPr>
            <p:cNvCxnSpPr/>
            <p:nvPr/>
          </p:nvCxnSpPr>
          <p:spPr>
            <a:xfrm>
              <a:off x="5295481" y="3221019"/>
              <a:ext cx="135516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79" name="TextBox 78">
            <a:extLst>
              <a:ext uri="{FF2B5EF4-FFF2-40B4-BE49-F238E27FC236}">
                <a16:creationId xmlns:a16="http://schemas.microsoft.com/office/drawing/2014/main" id="{C30ADA6F-6B97-4773-BDC9-2F4B80D241B1}"/>
              </a:ext>
            </a:extLst>
          </p:cNvPr>
          <p:cNvSpPr txBox="1"/>
          <p:nvPr/>
        </p:nvSpPr>
        <p:spPr>
          <a:xfrm>
            <a:off x="3334530" y="5336605"/>
            <a:ext cx="1258037" cy="4490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378653"/>
            <a:r>
              <a:rPr lang="en-SG" sz="1159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oomassie</a:t>
            </a:r>
            <a:r>
              <a:rPr lang="en-SG" sz="1159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blue staining </a:t>
            </a: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1BCCBA8E-DABD-405D-A45B-BA45CFD7DF28}"/>
              </a:ext>
            </a:extLst>
          </p:cNvPr>
          <p:cNvGrpSpPr/>
          <p:nvPr/>
        </p:nvGrpSpPr>
        <p:grpSpPr>
          <a:xfrm>
            <a:off x="1650564" y="3060193"/>
            <a:ext cx="906681" cy="1197665"/>
            <a:chOff x="1044636" y="3694900"/>
            <a:chExt cx="1094733" cy="1446070"/>
          </a:xfrm>
        </p:grpSpPr>
        <p:grpSp>
          <p:nvGrpSpPr>
            <p:cNvPr id="22" name="Group 21">
              <a:extLst>
                <a:ext uri="{FF2B5EF4-FFF2-40B4-BE49-F238E27FC236}">
                  <a16:creationId xmlns:a16="http://schemas.microsoft.com/office/drawing/2014/main" id="{BA44F976-A9F9-41FA-9FD1-A924CD3D753B}"/>
                </a:ext>
              </a:extLst>
            </p:cNvPr>
            <p:cNvGrpSpPr/>
            <p:nvPr/>
          </p:nvGrpSpPr>
          <p:grpSpPr>
            <a:xfrm>
              <a:off x="1044636" y="3694900"/>
              <a:ext cx="1094733" cy="1446070"/>
              <a:chOff x="3382498" y="4883179"/>
              <a:chExt cx="1094733" cy="1446070"/>
            </a:xfrm>
          </p:grpSpPr>
          <p:pic>
            <p:nvPicPr>
              <p:cNvPr id="24" name="Picture 23" descr="A close up of electronics&#10;&#10;Description generated with high confidence">
                <a:extLst>
                  <a:ext uri="{FF2B5EF4-FFF2-40B4-BE49-F238E27FC236}">
                    <a16:creationId xmlns:a16="http://schemas.microsoft.com/office/drawing/2014/main" id="{9D238C80-BEC2-4DC0-9A52-CE3806E5D05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l="11548" t="46298" r="67739" b="46148"/>
              <a:stretch/>
            </p:blipFill>
            <p:spPr>
              <a:xfrm>
                <a:off x="3382498" y="5577295"/>
                <a:ext cx="1005696" cy="274251"/>
              </a:xfrm>
              <a:prstGeom prst="rect">
                <a:avLst/>
              </a:prstGeom>
            </p:spPr>
          </p:pic>
          <p:grpSp>
            <p:nvGrpSpPr>
              <p:cNvPr id="25" name="Group 24">
                <a:extLst>
                  <a:ext uri="{FF2B5EF4-FFF2-40B4-BE49-F238E27FC236}">
                    <a16:creationId xmlns:a16="http://schemas.microsoft.com/office/drawing/2014/main" id="{990B187F-C1A5-4D68-BC37-B72AE4FB0A35}"/>
                  </a:ext>
                </a:extLst>
              </p:cNvPr>
              <p:cNvGrpSpPr/>
              <p:nvPr/>
            </p:nvGrpSpPr>
            <p:grpSpPr>
              <a:xfrm>
                <a:off x="3453455" y="4883179"/>
                <a:ext cx="1023776" cy="327215"/>
                <a:chOff x="924541" y="2054923"/>
                <a:chExt cx="1023776" cy="327215"/>
              </a:xfrm>
            </p:grpSpPr>
            <p:sp>
              <p:nvSpPr>
                <p:cNvPr id="29" name="TextBox 28">
                  <a:extLst>
                    <a:ext uri="{FF2B5EF4-FFF2-40B4-BE49-F238E27FC236}">
                      <a16:creationId xmlns:a16="http://schemas.microsoft.com/office/drawing/2014/main" id="{4E403E27-8156-4ED8-8245-64B5E658700B}"/>
                    </a:ext>
                  </a:extLst>
                </p:cNvPr>
                <p:cNvSpPr txBox="1"/>
                <p:nvPr/>
              </p:nvSpPr>
              <p:spPr>
                <a:xfrm>
                  <a:off x="924541" y="2054924"/>
                  <a:ext cx="199697" cy="32686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 defTabSz="378653"/>
                  <a:r>
                    <a:rPr lang="en-SG" sz="1159" dirty="0">
                      <a:solidFill>
                        <a:prstClr val="black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T</a:t>
                  </a:r>
                </a:p>
              </p:txBody>
            </p:sp>
            <p:sp>
              <p:nvSpPr>
                <p:cNvPr id="30" name="TextBox 29">
                  <a:extLst>
                    <a:ext uri="{FF2B5EF4-FFF2-40B4-BE49-F238E27FC236}">
                      <a16:creationId xmlns:a16="http://schemas.microsoft.com/office/drawing/2014/main" id="{2DDE298D-41C9-4181-A230-A4B6E0378765}"/>
                    </a:ext>
                  </a:extLst>
                </p:cNvPr>
                <p:cNvSpPr txBox="1"/>
                <p:nvPr/>
              </p:nvSpPr>
              <p:spPr>
                <a:xfrm>
                  <a:off x="1213575" y="2055274"/>
                  <a:ext cx="199697" cy="32686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 defTabSz="378653"/>
                  <a:r>
                    <a:rPr lang="en-SG" sz="1159" dirty="0">
                      <a:solidFill>
                        <a:prstClr val="black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</a:t>
                  </a:r>
                </a:p>
              </p:txBody>
            </p:sp>
            <p:sp>
              <p:nvSpPr>
                <p:cNvPr id="31" name="TextBox 30">
                  <a:extLst>
                    <a:ext uri="{FF2B5EF4-FFF2-40B4-BE49-F238E27FC236}">
                      <a16:creationId xmlns:a16="http://schemas.microsoft.com/office/drawing/2014/main" id="{FA14E8A0-18A5-4FBE-B3CC-E69C9785B187}"/>
                    </a:ext>
                  </a:extLst>
                </p:cNvPr>
                <p:cNvSpPr txBox="1"/>
                <p:nvPr/>
              </p:nvSpPr>
              <p:spPr>
                <a:xfrm>
                  <a:off x="1413272" y="2054923"/>
                  <a:ext cx="535045" cy="32686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 defTabSz="378653"/>
                  <a:r>
                    <a:rPr lang="en-SG" sz="1159" dirty="0">
                      <a:solidFill>
                        <a:prstClr val="black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M</a:t>
                  </a:r>
                  <a:r>
                    <a:rPr lang="en-SG" sz="1159" baseline="30000" dirty="0">
                      <a:solidFill>
                        <a:prstClr val="black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x</a:t>
                  </a:r>
                </a:p>
              </p:txBody>
            </p:sp>
          </p:grpSp>
          <p:grpSp>
            <p:nvGrpSpPr>
              <p:cNvPr id="26" name="Group 25">
                <a:extLst>
                  <a:ext uri="{FF2B5EF4-FFF2-40B4-BE49-F238E27FC236}">
                    <a16:creationId xmlns:a16="http://schemas.microsoft.com/office/drawing/2014/main" id="{0CE0899A-92C7-46EC-AF30-D006789C3759}"/>
                  </a:ext>
                </a:extLst>
              </p:cNvPr>
              <p:cNvGrpSpPr/>
              <p:nvPr/>
            </p:nvGrpSpPr>
            <p:grpSpPr>
              <a:xfrm>
                <a:off x="3416194" y="5970853"/>
                <a:ext cx="936000" cy="358396"/>
                <a:chOff x="935420" y="3195145"/>
                <a:chExt cx="1114098" cy="358396"/>
              </a:xfrm>
            </p:grpSpPr>
            <p:cxnSp>
              <p:nvCxnSpPr>
                <p:cNvPr id="27" name="Straight Connector 26">
                  <a:extLst>
                    <a:ext uri="{FF2B5EF4-FFF2-40B4-BE49-F238E27FC236}">
                      <a16:creationId xmlns:a16="http://schemas.microsoft.com/office/drawing/2014/main" id="{18C1715A-9C80-4074-B168-24F8D2825DC8}"/>
                    </a:ext>
                  </a:extLst>
                </p:cNvPr>
                <p:cNvCxnSpPr/>
                <p:nvPr/>
              </p:nvCxnSpPr>
              <p:spPr>
                <a:xfrm>
                  <a:off x="935420" y="3195145"/>
                  <a:ext cx="1114098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8" name="TextBox 27">
                  <a:extLst>
                    <a:ext uri="{FF2B5EF4-FFF2-40B4-BE49-F238E27FC236}">
                      <a16:creationId xmlns:a16="http://schemas.microsoft.com/office/drawing/2014/main" id="{FBFCBA15-7E19-4FD1-8E25-6E7DA27BBE45}"/>
                    </a:ext>
                  </a:extLst>
                </p:cNvPr>
                <p:cNvSpPr txBox="1"/>
                <p:nvPr/>
              </p:nvSpPr>
              <p:spPr>
                <a:xfrm>
                  <a:off x="1156138" y="3226678"/>
                  <a:ext cx="588576" cy="32686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 defTabSz="378653"/>
                  <a:r>
                    <a:rPr lang="en-SG" sz="1159" dirty="0">
                      <a:solidFill>
                        <a:prstClr val="black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Glu</a:t>
                  </a:r>
                </a:p>
              </p:txBody>
            </p:sp>
          </p:grpSp>
        </p:grpSp>
        <p:pic>
          <p:nvPicPr>
            <p:cNvPr id="80" name="Picture 79" descr="A picture containing appliance, white&#10;&#10;Description generated with high confidence">
              <a:extLst>
                <a:ext uri="{FF2B5EF4-FFF2-40B4-BE49-F238E27FC236}">
                  <a16:creationId xmlns:a16="http://schemas.microsoft.com/office/drawing/2014/main" id="{6099A033-F9B3-443E-8035-F4D97D22929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9258" t="37306" r="70056" b="55157"/>
            <a:stretch/>
          </p:blipFill>
          <p:spPr>
            <a:xfrm>
              <a:off x="1046322" y="4022724"/>
              <a:ext cx="1004400" cy="273600"/>
            </a:xfrm>
            <a:prstGeom prst="rect">
              <a:avLst/>
            </a:prstGeom>
          </p:spPr>
        </p:pic>
      </p:grpSp>
      <p:cxnSp>
        <p:nvCxnSpPr>
          <p:cNvPr id="81" name="Straight Connector 80">
            <a:extLst>
              <a:ext uri="{FF2B5EF4-FFF2-40B4-BE49-F238E27FC236}">
                <a16:creationId xmlns:a16="http://schemas.microsoft.com/office/drawing/2014/main" id="{A3D5DFE7-5939-4A4D-8C6B-FEA479C3AA2D}"/>
              </a:ext>
            </a:extLst>
          </p:cNvPr>
          <p:cNvCxnSpPr>
            <a:cxnSpLocks/>
          </p:cNvCxnSpPr>
          <p:nvPr/>
        </p:nvCxnSpPr>
        <p:spPr>
          <a:xfrm>
            <a:off x="2512476" y="3364795"/>
            <a:ext cx="119264" cy="0"/>
          </a:xfrm>
          <a:prstGeom prst="line">
            <a:avLst/>
          </a:prstGeom>
          <a:ln w="15875">
            <a:solidFill>
              <a:schemeClr val="tx1"/>
            </a:solidFill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2" name="Straight Connector 81">
            <a:extLst>
              <a:ext uri="{FF2B5EF4-FFF2-40B4-BE49-F238E27FC236}">
                <a16:creationId xmlns:a16="http://schemas.microsoft.com/office/drawing/2014/main" id="{A3D5DFE7-5939-4A4D-8C6B-FEA479C3AA2D}"/>
              </a:ext>
            </a:extLst>
          </p:cNvPr>
          <p:cNvCxnSpPr>
            <a:cxnSpLocks/>
          </p:cNvCxnSpPr>
          <p:nvPr/>
        </p:nvCxnSpPr>
        <p:spPr>
          <a:xfrm>
            <a:off x="2512476" y="3435854"/>
            <a:ext cx="119264" cy="0"/>
          </a:xfrm>
          <a:prstGeom prst="line">
            <a:avLst/>
          </a:prstGeom>
          <a:ln w="15875">
            <a:solidFill>
              <a:schemeClr val="tx1"/>
            </a:solidFill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" name="Straight Connector 82">
            <a:extLst>
              <a:ext uri="{FF2B5EF4-FFF2-40B4-BE49-F238E27FC236}">
                <a16:creationId xmlns:a16="http://schemas.microsoft.com/office/drawing/2014/main" id="{A3D5DFE7-5939-4A4D-8C6B-FEA479C3AA2D}"/>
              </a:ext>
            </a:extLst>
          </p:cNvPr>
          <p:cNvCxnSpPr>
            <a:cxnSpLocks/>
          </p:cNvCxnSpPr>
          <p:nvPr/>
        </p:nvCxnSpPr>
        <p:spPr>
          <a:xfrm>
            <a:off x="2512476" y="3698771"/>
            <a:ext cx="119264" cy="0"/>
          </a:xfrm>
          <a:prstGeom prst="line">
            <a:avLst/>
          </a:prstGeom>
          <a:ln w="15875">
            <a:solidFill>
              <a:schemeClr val="tx1"/>
            </a:solidFill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4" name="TextBox 83">
            <a:extLst>
              <a:ext uri="{FF2B5EF4-FFF2-40B4-BE49-F238E27FC236}">
                <a16:creationId xmlns:a16="http://schemas.microsoft.com/office/drawing/2014/main" id="{2AAFA523-1FE6-454A-AFEF-1C9B01257190}"/>
              </a:ext>
            </a:extLst>
          </p:cNvPr>
          <p:cNvSpPr txBox="1"/>
          <p:nvPr/>
        </p:nvSpPr>
        <p:spPr>
          <a:xfrm>
            <a:off x="2555663" y="3243677"/>
            <a:ext cx="297706" cy="2707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378653"/>
            <a:r>
              <a:rPr lang="en-SG" sz="1159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59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en-SG" sz="1159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74967114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" name="Picture 29">
            <a:extLst>
              <a:ext uri="{FF2B5EF4-FFF2-40B4-BE49-F238E27FC236}">
                <a16:creationId xmlns:a16="http://schemas.microsoft.com/office/drawing/2014/main" id="{5F568E3B-970C-4109-9E2F-268863053EC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255010" y="3374115"/>
            <a:ext cx="2115645" cy="414040"/>
          </a:xfrm>
          <a:prstGeom prst="rect">
            <a:avLst/>
          </a:prstGeom>
        </p:spPr>
      </p:pic>
      <p:cxnSp>
        <p:nvCxnSpPr>
          <p:cNvPr id="31" name="Straight Connector 30">
            <a:extLst>
              <a:ext uri="{FF2B5EF4-FFF2-40B4-BE49-F238E27FC236}">
                <a16:creationId xmlns:a16="http://schemas.microsoft.com/office/drawing/2014/main" id="{29EA34F6-D15A-4F3D-B20A-8AF77F3E7566}"/>
              </a:ext>
            </a:extLst>
          </p:cNvPr>
          <p:cNvCxnSpPr>
            <a:cxnSpLocks/>
          </p:cNvCxnSpPr>
          <p:nvPr/>
        </p:nvCxnSpPr>
        <p:spPr>
          <a:xfrm>
            <a:off x="3235195" y="1553305"/>
            <a:ext cx="894479" cy="818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TextBox 31">
            <a:extLst>
              <a:ext uri="{FF2B5EF4-FFF2-40B4-BE49-F238E27FC236}">
                <a16:creationId xmlns:a16="http://schemas.microsoft.com/office/drawing/2014/main" id="{3DD19AFC-566A-4D31-81C8-9D9D7025D839}"/>
              </a:ext>
            </a:extLst>
          </p:cNvPr>
          <p:cNvSpPr txBox="1"/>
          <p:nvPr/>
        </p:nvSpPr>
        <p:spPr>
          <a:xfrm>
            <a:off x="3467280" y="1215344"/>
            <a:ext cx="517058" cy="2962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378653"/>
            <a:r>
              <a:rPr lang="en-US" sz="1325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yto</a:t>
            </a:r>
            <a:endParaRPr lang="en-US" sz="1325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2AD2CB52-BCBA-4BBB-8024-CF8F552D162B}"/>
              </a:ext>
            </a:extLst>
          </p:cNvPr>
          <p:cNvCxnSpPr>
            <a:cxnSpLocks/>
          </p:cNvCxnSpPr>
          <p:nvPr/>
        </p:nvCxnSpPr>
        <p:spPr>
          <a:xfrm>
            <a:off x="4428988" y="1550501"/>
            <a:ext cx="894479" cy="818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TextBox 33">
            <a:extLst>
              <a:ext uri="{FF2B5EF4-FFF2-40B4-BE49-F238E27FC236}">
                <a16:creationId xmlns:a16="http://schemas.microsoft.com/office/drawing/2014/main" id="{4D945C9A-7263-469D-BAAE-C5A41E55FBCA}"/>
              </a:ext>
            </a:extLst>
          </p:cNvPr>
          <p:cNvSpPr txBox="1"/>
          <p:nvPr/>
        </p:nvSpPr>
        <p:spPr>
          <a:xfrm>
            <a:off x="4735046" y="1214186"/>
            <a:ext cx="517058" cy="2962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378653"/>
            <a:r>
              <a:rPr lang="en-US" sz="1325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ito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BB099A18-62A4-4774-882F-035176B15559}"/>
              </a:ext>
            </a:extLst>
          </p:cNvPr>
          <p:cNvSpPr txBox="1"/>
          <p:nvPr/>
        </p:nvSpPr>
        <p:spPr>
          <a:xfrm rot="16200000">
            <a:off x="4410854" y="2974260"/>
            <a:ext cx="419432" cy="270715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defTabSz="378653"/>
            <a:r>
              <a:rPr lang="en-SG" sz="1159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Δrad6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099B80BA-0862-4203-A879-DBC38F0A50BA}"/>
              </a:ext>
            </a:extLst>
          </p:cNvPr>
          <p:cNvSpPr txBox="1"/>
          <p:nvPr/>
        </p:nvSpPr>
        <p:spPr>
          <a:xfrm rot="16200000">
            <a:off x="4103674" y="2970736"/>
            <a:ext cx="423652" cy="270715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defTabSz="378653"/>
            <a:r>
              <a:rPr lang="en-SG" sz="1159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W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34A2B8CF-5012-4B93-9D19-A2392C911617}"/>
              </a:ext>
            </a:extLst>
          </p:cNvPr>
          <p:cNvSpPr txBox="1"/>
          <p:nvPr/>
        </p:nvSpPr>
        <p:spPr>
          <a:xfrm rot="16200000">
            <a:off x="4212322" y="2486743"/>
            <a:ext cx="578636" cy="2707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378653"/>
            <a:r>
              <a:rPr lang="en-SG" sz="1159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mpty</a:t>
            </a:r>
          </a:p>
        </p:txBody>
      </p:sp>
      <p:cxnSp>
        <p:nvCxnSpPr>
          <p:cNvPr id="38" name="Straight Connector 37">
            <a:extLst>
              <a:ext uri="{FF2B5EF4-FFF2-40B4-BE49-F238E27FC236}">
                <a16:creationId xmlns:a16="http://schemas.microsoft.com/office/drawing/2014/main" id="{D51B95B5-D820-4624-8AFC-6249BB144631}"/>
              </a:ext>
            </a:extLst>
          </p:cNvPr>
          <p:cNvCxnSpPr/>
          <p:nvPr/>
        </p:nvCxnSpPr>
        <p:spPr>
          <a:xfrm>
            <a:off x="4409664" y="2905028"/>
            <a:ext cx="238528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9" name="TextBox 38">
            <a:extLst>
              <a:ext uri="{FF2B5EF4-FFF2-40B4-BE49-F238E27FC236}">
                <a16:creationId xmlns:a16="http://schemas.microsoft.com/office/drawing/2014/main" id="{D1355EDC-0D42-4C01-8E90-8875008F6EDB}"/>
              </a:ext>
            </a:extLst>
          </p:cNvPr>
          <p:cNvSpPr txBox="1"/>
          <p:nvPr/>
        </p:nvSpPr>
        <p:spPr>
          <a:xfrm rot="16200000">
            <a:off x="4264783" y="2972843"/>
            <a:ext cx="419432" cy="270715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defTabSz="378653"/>
            <a:r>
              <a:rPr lang="en-SG" sz="1159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AAEE7BB0-5522-4AED-812F-990F72BC6117}"/>
              </a:ext>
            </a:extLst>
          </p:cNvPr>
          <p:cNvSpPr txBox="1"/>
          <p:nvPr/>
        </p:nvSpPr>
        <p:spPr>
          <a:xfrm rot="16200000">
            <a:off x="3924408" y="2972842"/>
            <a:ext cx="419432" cy="270715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defTabSz="378653"/>
            <a:r>
              <a:rPr lang="en-SG" sz="1159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Δrad6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56083F2F-302E-48EC-8315-5DABF4FA5EA7}"/>
              </a:ext>
            </a:extLst>
          </p:cNvPr>
          <p:cNvSpPr txBox="1"/>
          <p:nvPr/>
        </p:nvSpPr>
        <p:spPr>
          <a:xfrm rot="16200000">
            <a:off x="3725876" y="2485326"/>
            <a:ext cx="578636" cy="2707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378653"/>
            <a:r>
              <a:rPr lang="en-SG" sz="1159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mpty</a:t>
            </a:r>
          </a:p>
        </p:txBody>
      </p:sp>
      <p:cxnSp>
        <p:nvCxnSpPr>
          <p:cNvPr id="42" name="Straight Connector 41">
            <a:extLst>
              <a:ext uri="{FF2B5EF4-FFF2-40B4-BE49-F238E27FC236}">
                <a16:creationId xmlns:a16="http://schemas.microsoft.com/office/drawing/2014/main" id="{F204CAF3-3D1D-4D59-9045-AC59DFA42AA6}"/>
              </a:ext>
            </a:extLst>
          </p:cNvPr>
          <p:cNvCxnSpPr/>
          <p:nvPr/>
        </p:nvCxnSpPr>
        <p:spPr>
          <a:xfrm>
            <a:off x="3923217" y="2903610"/>
            <a:ext cx="238528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3" name="TextBox 42">
            <a:extLst>
              <a:ext uri="{FF2B5EF4-FFF2-40B4-BE49-F238E27FC236}">
                <a16:creationId xmlns:a16="http://schemas.microsoft.com/office/drawing/2014/main" id="{F29DBA94-F8B5-48A0-9249-BE9431535013}"/>
              </a:ext>
            </a:extLst>
          </p:cNvPr>
          <p:cNvSpPr txBox="1"/>
          <p:nvPr/>
        </p:nvSpPr>
        <p:spPr>
          <a:xfrm rot="16200000">
            <a:off x="3778336" y="2971425"/>
            <a:ext cx="419432" cy="270715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defTabSz="378653"/>
            <a:r>
              <a:rPr lang="en-SG" sz="1159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00C7EE1A-EF9C-4215-80D8-BD03A9532119}"/>
              </a:ext>
            </a:extLst>
          </p:cNvPr>
          <p:cNvSpPr txBox="1"/>
          <p:nvPr/>
        </p:nvSpPr>
        <p:spPr>
          <a:xfrm rot="16200000">
            <a:off x="4745748" y="2982862"/>
            <a:ext cx="420682" cy="270715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defTabSz="378653"/>
            <a:r>
              <a:rPr lang="el-GR" sz="1159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SG" sz="1159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ad6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60872592-6482-4302-BE4F-4F2CB950E421}"/>
              </a:ext>
            </a:extLst>
          </p:cNvPr>
          <p:cNvSpPr txBox="1"/>
          <p:nvPr/>
        </p:nvSpPr>
        <p:spPr>
          <a:xfrm rot="16200000">
            <a:off x="4623768" y="3015128"/>
            <a:ext cx="361829" cy="270715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defTabSz="378653"/>
            <a:r>
              <a:rPr lang="en-SG" sz="1159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90269A27-DF11-4FE1-89CB-E3BBB9F695BB}"/>
              </a:ext>
            </a:extLst>
          </p:cNvPr>
          <p:cNvSpPr txBox="1"/>
          <p:nvPr/>
        </p:nvSpPr>
        <p:spPr>
          <a:xfrm rot="16200000">
            <a:off x="4251103" y="2028947"/>
            <a:ext cx="1265215" cy="400110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defTabSz="378653">
              <a:lnSpc>
                <a:spcPts val="1159"/>
              </a:lnSpc>
            </a:pPr>
            <a:r>
              <a:rPr lang="en-SG" sz="1159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reSu9-Rad6(C88A)-</a:t>
            </a:r>
            <a:r>
              <a:rPr lang="el-GR" sz="1159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en-SG" sz="1159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SL17</a:t>
            </a:r>
          </a:p>
        </p:txBody>
      </p:sp>
      <p:cxnSp>
        <p:nvCxnSpPr>
          <p:cNvPr id="47" name="Straight Connector 46">
            <a:extLst>
              <a:ext uri="{FF2B5EF4-FFF2-40B4-BE49-F238E27FC236}">
                <a16:creationId xmlns:a16="http://schemas.microsoft.com/office/drawing/2014/main" id="{BC7EE622-7B11-4AD2-8568-5B162302C8FD}"/>
              </a:ext>
            </a:extLst>
          </p:cNvPr>
          <p:cNvCxnSpPr/>
          <p:nvPr/>
        </p:nvCxnSpPr>
        <p:spPr>
          <a:xfrm>
            <a:off x="4767474" y="2900070"/>
            <a:ext cx="238528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8" name="TextBox 47">
            <a:extLst>
              <a:ext uri="{FF2B5EF4-FFF2-40B4-BE49-F238E27FC236}">
                <a16:creationId xmlns:a16="http://schemas.microsoft.com/office/drawing/2014/main" id="{406F7A56-78D9-47E4-A449-187D08627C79}"/>
              </a:ext>
            </a:extLst>
          </p:cNvPr>
          <p:cNvSpPr txBox="1"/>
          <p:nvPr/>
        </p:nvSpPr>
        <p:spPr>
          <a:xfrm rot="16200000">
            <a:off x="3622514" y="2982862"/>
            <a:ext cx="420682" cy="270715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defTabSz="378653"/>
            <a:r>
              <a:rPr lang="el-GR" sz="1159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SG" sz="1159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ad6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C4A431E0-DD85-4325-86C1-0081FB07E4D5}"/>
              </a:ext>
            </a:extLst>
          </p:cNvPr>
          <p:cNvSpPr txBox="1"/>
          <p:nvPr/>
        </p:nvSpPr>
        <p:spPr>
          <a:xfrm rot="16200000">
            <a:off x="3500534" y="2998109"/>
            <a:ext cx="361829" cy="270715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defTabSz="378653"/>
            <a:r>
              <a:rPr lang="en-SG" sz="1159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BED03991-21D4-4EED-A7BA-2F29016D2DC4}"/>
              </a:ext>
            </a:extLst>
          </p:cNvPr>
          <p:cNvSpPr txBox="1"/>
          <p:nvPr/>
        </p:nvSpPr>
        <p:spPr>
          <a:xfrm rot="16200000">
            <a:off x="3127868" y="2011928"/>
            <a:ext cx="1265215" cy="400110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defTabSz="378653">
              <a:lnSpc>
                <a:spcPts val="1159"/>
              </a:lnSpc>
            </a:pPr>
            <a:r>
              <a:rPr lang="en-SG" sz="1159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reSu9-Rad6(C88A)-</a:t>
            </a:r>
            <a:r>
              <a:rPr lang="el-GR" sz="1159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en-SG" sz="1159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SL17</a:t>
            </a:r>
          </a:p>
        </p:txBody>
      </p:sp>
      <p:cxnSp>
        <p:nvCxnSpPr>
          <p:cNvPr id="51" name="Straight Connector 50">
            <a:extLst>
              <a:ext uri="{FF2B5EF4-FFF2-40B4-BE49-F238E27FC236}">
                <a16:creationId xmlns:a16="http://schemas.microsoft.com/office/drawing/2014/main" id="{E00BA983-3888-46A0-90D2-3047C224461D}"/>
              </a:ext>
            </a:extLst>
          </p:cNvPr>
          <p:cNvCxnSpPr/>
          <p:nvPr/>
        </p:nvCxnSpPr>
        <p:spPr>
          <a:xfrm>
            <a:off x="3644240" y="2900070"/>
            <a:ext cx="238528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2" name="TextBox 51">
            <a:extLst>
              <a:ext uri="{FF2B5EF4-FFF2-40B4-BE49-F238E27FC236}">
                <a16:creationId xmlns:a16="http://schemas.microsoft.com/office/drawing/2014/main" id="{3992F289-FACA-4B9E-B5A1-2A14C4A56091}"/>
              </a:ext>
            </a:extLst>
          </p:cNvPr>
          <p:cNvSpPr txBox="1"/>
          <p:nvPr/>
        </p:nvSpPr>
        <p:spPr>
          <a:xfrm rot="16200000">
            <a:off x="5052079" y="2991371"/>
            <a:ext cx="420682" cy="270715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defTabSz="378653"/>
            <a:r>
              <a:rPr lang="el-GR" sz="1159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SG" sz="1159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ad6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84C2A218-3312-409D-B90E-89FF916581E3}"/>
              </a:ext>
            </a:extLst>
          </p:cNvPr>
          <p:cNvSpPr txBox="1"/>
          <p:nvPr/>
        </p:nvSpPr>
        <p:spPr>
          <a:xfrm rot="16200000">
            <a:off x="4930099" y="3015128"/>
            <a:ext cx="361829" cy="270715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defTabSz="378653"/>
            <a:r>
              <a:rPr lang="en-SG" sz="1159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A049BD45-11E4-4475-A285-7DB1CE2B00C2}"/>
              </a:ext>
            </a:extLst>
          </p:cNvPr>
          <p:cNvSpPr txBox="1"/>
          <p:nvPr/>
        </p:nvSpPr>
        <p:spPr>
          <a:xfrm rot="16200000">
            <a:off x="4763685" y="2252217"/>
            <a:ext cx="818673" cy="400110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defTabSz="378653">
              <a:lnSpc>
                <a:spcPts val="1159"/>
              </a:lnSpc>
            </a:pPr>
            <a:r>
              <a:rPr lang="en-SG" sz="1159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reSu9-Rad6-</a:t>
            </a:r>
            <a:r>
              <a:rPr lang="el-GR" sz="1159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en-SG" sz="1159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SL17</a:t>
            </a:r>
          </a:p>
        </p:txBody>
      </p:sp>
      <p:cxnSp>
        <p:nvCxnSpPr>
          <p:cNvPr id="55" name="Straight Connector 54">
            <a:extLst>
              <a:ext uri="{FF2B5EF4-FFF2-40B4-BE49-F238E27FC236}">
                <a16:creationId xmlns:a16="http://schemas.microsoft.com/office/drawing/2014/main" id="{0F28CE16-6C29-4D69-A764-6F6B6EB81DDF}"/>
              </a:ext>
            </a:extLst>
          </p:cNvPr>
          <p:cNvCxnSpPr/>
          <p:nvPr/>
        </p:nvCxnSpPr>
        <p:spPr>
          <a:xfrm>
            <a:off x="5073805" y="2900070"/>
            <a:ext cx="238528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6" name="TextBox 55">
            <a:extLst>
              <a:ext uri="{FF2B5EF4-FFF2-40B4-BE49-F238E27FC236}">
                <a16:creationId xmlns:a16="http://schemas.microsoft.com/office/drawing/2014/main" id="{266700FE-C9A4-4AA5-BEAD-FA90F761FA29}"/>
              </a:ext>
            </a:extLst>
          </p:cNvPr>
          <p:cNvSpPr txBox="1"/>
          <p:nvPr/>
        </p:nvSpPr>
        <p:spPr>
          <a:xfrm rot="16200000">
            <a:off x="3272222" y="2989953"/>
            <a:ext cx="420682" cy="270715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defTabSz="378653"/>
            <a:r>
              <a:rPr lang="el-GR" sz="1159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SG" sz="1159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ad6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018085AB-F07C-4B69-A0A6-0E9E0A176278}"/>
              </a:ext>
            </a:extLst>
          </p:cNvPr>
          <p:cNvSpPr txBox="1"/>
          <p:nvPr/>
        </p:nvSpPr>
        <p:spPr>
          <a:xfrm rot="16200000">
            <a:off x="3150243" y="3013710"/>
            <a:ext cx="361829" cy="270715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defTabSz="378653"/>
            <a:r>
              <a:rPr lang="en-SG" sz="1159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C58EB281-77AB-4AB3-96ED-1D7F603B720B}"/>
              </a:ext>
            </a:extLst>
          </p:cNvPr>
          <p:cNvSpPr txBox="1"/>
          <p:nvPr/>
        </p:nvSpPr>
        <p:spPr>
          <a:xfrm rot="16200000">
            <a:off x="3001556" y="2251508"/>
            <a:ext cx="817255" cy="400110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defTabSz="378653">
              <a:lnSpc>
                <a:spcPts val="1159"/>
              </a:lnSpc>
            </a:pPr>
            <a:r>
              <a:rPr lang="en-SG" sz="1159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reSu9-Rad6-</a:t>
            </a:r>
            <a:r>
              <a:rPr lang="el-GR" sz="1159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en-SG" sz="1159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SL17</a:t>
            </a:r>
          </a:p>
        </p:txBody>
      </p:sp>
      <p:cxnSp>
        <p:nvCxnSpPr>
          <p:cNvPr id="59" name="Straight Connector 58">
            <a:extLst>
              <a:ext uri="{FF2B5EF4-FFF2-40B4-BE49-F238E27FC236}">
                <a16:creationId xmlns:a16="http://schemas.microsoft.com/office/drawing/2014/main" id="{7B43BC9E-AE33-4AD0-BACD-886EC13F8678}"/>
              </a:ext>
            </a:extLst>
          </p:cNvPr>
          <p:cNvCxnSpPr/>
          <p:nvPr/>
        </p:nvCxnSpPr>
        <p:spPr>
          <a:xfrm>
            <a:off x="3293948" y="2898652"/>
            <a:ext cx="238528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0" name="TextBox 59">
            <a:extLst>
              <a:ext uri="{FF2B5EF4-FFF2-40B4-BE49-F238E27FC236}">
                <a16:creationId xmlns:a16="http://schemas.microsoft.com/office/drawing/2014/main" id="{91AFDD52-0E46-4B26-92D1-13707766DC24}"/>
              </a:ext>
            </a:extLst>
          </p:cNvPr>
          <p:cNvSpPr txBox="1"/>
          <p:nvPr/>
        </p:nvSpPr>
        <p:spPr>
          <a:xfrm>
            <a:off x="2936137" y="3344154"/>
            <a:ext cx="197458" cy="270715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defTabSz="378653"/>
            <a:r>
              <a:rPr lang="en-SG" sz="1159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8</a:t>
            </a:r>
          </a:p>
        </p:txBody>
      </p:sp>
      <p:cxnSp>
        <p:nvCxnSpPr>
          <p:cNvPr id="61" name="Straight Connector 60">
            <a:extLst>
              <a:ext uri="{FF2B5EF4-FFF2-40B4-BE49-F238E27FC236}">
                <a16:creationId xmlns:a16="http://schemas.microsoft.com/office/drawing/2014/main" id="{C468C285-52F9-41E9-873D-E443AAB4DC12}"/>
              </a:ext>
            </a:extLst>
          </p:cNvPr>
          <p:cNvCxnSpPr/>
          <p:nvPr/>
        </p:nvCxnSpPr>
        <p:spPr>
          <a:xfrm>
            <a:off x="3122931" y="3486717"/>
            <a:ext cx="112237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Straight Connector 61">
            <a:extLst>
              <a:ext uri="{FF2B5EF4-FFF2-40B4-BE49-F238E27FC236}">
                <a16:creationId xmlns:a16="http://schemas.microsoft.com/office/drawing/2014/main" id="{87552E73-8AE9-4D75-9E43-6516FA202CAF}"/>
              </a:ext>
            </a:extLst>
          </p:cNvPr>
          <p:cNvCxnSpPr/>
          <p:nvPr/>
        </p:nvCxnSpPr>
        <p:spPr>
          <a:xfrm>
            <a:off x="3122926" y="3622866"/>
            <a:ext cx="112237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3" name="TextBox 62">
            <a:extLst>
              <a:ext uri="{FF2B5EF4-FFF2-40B4-BE49-F238E27FC236}">
                <a16:creationId xmlns:a16="http://schemas.microsoft.com/office/drawing/2014/main" id="{8ECB8DBC-5948-47C6-A8C2-EE1432DE410B}"/>
              </a:ext>
            </a:extLst>
          </p:cNvPr>
          <p:cNvSpPr txBox="1"/>
          <p:nvPr/>
        </p:nvSpPr>
        <p:spPr>
          <a:xfrm>
            <a:off x="2936137" y="3478879"/>
            <a:ext cx="196040" cy="270715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defTabSz="378653"/>
            <a:r>
              <a:rPr lang="en-SG" sz="1159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35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A194A485-0294-40CF-AD5B-A4A62DB80268}"/>
              </a:ext>
            </a:extLst>
          </p:cNvPr>
          <p:cNvSpPr txBox="1"/>
          <p:nvPr/>
        </p:nvSpPr>
        <p:spPr>
          <a:xfrm>
            <a:off x="2868675" y="3173642"/>
            <a:ext cx="273056" cy="270715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defTabSz="378653"/>
            <a:r>
              <a:rPr lang="en-SG" sz="1159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en-SG" sz="1159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5" name="Picture 64">
            <a:extLst>
              <a:ext uri="{FF2B5EF4-FFF2-40B4-BE49-F238E27FC236}">
                <a16:creationId xmlns:a16="http://schemas.microsoft.com/office/drawing/2014/main" id="{B96E26E8-EB3D-4D8C-9C9F-DA9BCBD7C0E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235170" y="3879397"/>
            <a:ext cx="2115645" cy="212069"/>
          </a:xfrm>
          <a:prstGeom prst="rect">
            <a:avLst/>
          </a:prstGeom>
        </p:spPr>
      </p:pic>
      <p:pic>
        <p:nvPicPr>
          <p:cNvPr id="66" name="Picture 65">
            <a:extLst>
              <a:ext uri="{FF2B5EF4-FFF2-40B4-BE49-F238E27FC236}">
                <a16:creationId xmlns:a16="http://schemas.microsoft.com/office/drawing/2014/main" id="{4B656037-D6D4-421B-8895-7338AE4FB53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243672" y="4177093"/>
            <a:ext cx="2105546" cy="217119"/>
          </a:xfrm>
          <a:prstGeom prst="rect">
            <a:avLst/>
          </a:prstGeom>
        </p:spPr>
      </p:pic>
      <p:sp>
        <p:nvSpPr>
          <p:cNvPr id="67" name="TextBox 66">
            <a:extLst>
              <a:ext uri="{FF2B5EF4-FFF2-40B4-BE49-F238E27FC236}">
                <a16:creationId xmlns:a16="http://schemas.microsoft.com/office/drawing/2014/main" id="{C6CACFEC-1946-4175-96F5-EC8DBE5FF338}"/>
              </a:ext>
            </a:extLst>
          </p:cNvPr>
          <p:cNvSpPr txBox="1"/>
          <p:nvPr/>
        </p:nvSpPr>
        <p:spPr>
          <a:xfrm>
            <a:off x="5353629" y="3840347"/>
            <a:ext cx="60468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378653"/>
            <a:r>
              <a:rPr lang="en-SG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co1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F7A0129C-0426-437E-B3D6-78CF5B5EB107}"/>
              </a:ext>
            </a:extLst>
          </p:cNvPr>
          <p:cNvSpPr txBox="1"/>
          <p:nvPr/>
        </p:nvSpPr>
        <p:spPr>
          <a:xfrm>
            <a:off x="5353629" y="4140451"/>
            <a:ext cx="60468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378653"/>
            <a:r>
              <a:rPr lang="en-SG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xk1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141B9571-E1F1-4769-9FAB-EED8C668D8B6}"/>
              </a:ext>
            </a:extLst>
          </p:cNvPr>
          <p:cNvSpPr txBox="1"/>
          <p:nvPr/>
        </p:nvSpPr>
        <p:spPr>
          <a:xfrm>
            <a:off x="5370647" y="3435695"/>
            <a:ext cx="60468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378653"/>
            <a:r>
              <a:rPr lang="el-GR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en-SG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l-GR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endParaRPr lang="en-SG" sz="12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7A910717-4AF5-471C-9E4B-0BD0588924C6}"/>
              </a:ext>
            </a:extLst>
          </p:cNvPr>
          <p:cNvSpPr txBox="1"/>
          <p:nvPr/>
        </p:nvSpPr>
        <p:spPr>
          <a:xfrm>
            <a:off x="1156787" y="4640881"/>
            <a:ext cx="6689706" cy="19277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 defTabSz="378653"/>
            <a:r>
              <a:rPr lang="en-SG" sz="1491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ure S7: Expression of preSu9-Rad6(C88A)-</a:t>
            </a:r>
            <a:r>
              <a:rPr lang="el-GR" sz="1491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en-SG" sz="1491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SL17 (for Figure 7E)</a:t>
            </a:r>
            <a:r>
              <a:rPr lang="en-US" sz="1491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49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ytosolic (</a:t>
            </a:r>
            <a:r>
              <a:rPr lang="en-US" sz="1491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yto</a:t>
            </a:r>
            <a:r>
              <a:rPr lang="en-US" sz="149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 and mitochondrial (Mito) subcellular fractions of WT or </a:t>
            </a:r>
            <a:r>
              <a:rPr lang="el-GR" sz="1491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SG" sz="1491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ad6 </a:t>
            </a:r>
            <a:r>
              <a:rPr lang="en-SG" sz="149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ells harbouring the indicated plasmids were probed for the </a:t>
            </a:r>
            <a:r>
              <a:rPr lang="el-GR" sz="149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en-SG" sz="149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tag (</a:t>
            </a:r>
            <a:r>
              <a:rPr lang="el-GR" sz="149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α-α</a:t>
            </a:r>
            <a:r>
              <a:rPr lang="en-SG" sz="149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 signal using WB. </a:t>
            </a:r>
            <a:r>
              <a:rPr lang="en-US" sz="149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he red arrows indicate the full-length Rad6 fusion proteins. Below the bands of red arrows indicated full-length proteins, processed/fragmented a-fusion proteins were detected. The bands detected in cytosolic fractions by </a:t>
            </a:r>
            <a:r>
              <a:rPr lang="el-GR" sz="149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α-α </a:t>
            </a:r>
            <a:r>
              <a:rPr lang="en-SG" sz="149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ntibody are nonspecific. Aco1, mitochondrial marker; Hxk1, cytosolic marker.</a:t>
            </a:r>
            <a:r>
              <a:rPr lang="en-US" sz="1491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sz="149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 defTabSz="378653"/>
            <a:endParaRPr lang="en-SG" sz="1491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D5779499-E50D-4BE0-B215-221E749D2DE1}"/>
              </a:ext>
            </a:extLst>
          </p:cNvPr>
          <p:cNvSpPr txBox="1"/>
          <p:nvPr/>
        </p:nvSpPr>
        <p:spPr>
          <a:xfrm>
            <a:off x="2398971" y="2894385"/>
            <a:ext cx="629445" cy="2962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378653"/>
            <a:r>
              <a:rPr lang="en-SG" sz="1325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train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99F11AB2-AE2B-4ECD-AE15-181506CE8611}"/>
              </a:ext>
            </a:extLst>
          </p:cNvPr>
          <p:cNvSpPr txBox="1"/>
          <p:nvPr/>
        </p:nvSpPr>
        <p:spPr>
          <a:xfrm>
            <a:off x="2329315" y="2088910"/>
            <a:ext cx="780394" cy="2962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378653"/>
            <a:r>
              <a:rPr lang="en-SG" sz="1325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lasmid</a:t>
            </a:r>
          </a:p>
        </p:txBody>
      </p:sp>
      <p:cxnSp>
        <p:nvCxnSpPr>
          <p:cNvPr id="74" name="Straight Arrow Connector 73">
            <a:extLst>
              <a:ext uri="{FF2B5EF4-FFF2-40B4-BE49-F238E27FC236}">
                <a16:creationId xmlns:a16="http://schemas.microsoft.com/office/drawing/2014/main" id="{9D8129F3-3146-4E1A-93A3-4CF1193CAE76}"/>
              </a:ext>
            </a:extLst>
          </p:cNvPr>
          <p:cNvCxnSpPr>
            <a:cxnSpLocks/>
          </p:cNvCxnSpPr>
          <p:nvPr/>
        </p:nvCxnSpPr>
        <p:spPr>
          <a:xfrm rot="-2100000">
            <a:off x="4675686" y="3577381"/>
            <a:ext cx="108000" cy="0"/>
          </a:xfrm>
          <a:prstGeom prst="straightConnector1">
            <a:avLst/>
          </a:prstGeom>
          <a:ln w="19050">
            <a:solidFill>
              <a:srgbClr val="FF0000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5" name="Straight Arrow Connector 74">
            <a:extLst>
              <a:ext uri="{FF2B5EF4-FFF2-40B4-BE49-F238E27FC236}">
                <a16:creationId xmlns:a16="http://schemas.microsoft.com/office/drawing/2014/main" id="{493CA32B-56E6-4818-8134-C59B92A9ECE7}"/>
              </a:ext>
            </a:extLst>
          </p:cNvPr>
          <p:cNvCxnSpPr>
            <a:cxnSpLocks/>
          </p:cNvCxnSpPr>
          <p:nvPr/>
        </p:nvCxnSpPr>
        <p:spPr>
          <a:xfrm rot="-2100000">
            <a:off x="4836037" y="3578704"/>
            <a:ext cx="108000" cy="0"/>
          </a:xfrm>
          <a:prstGeom prst="straightConnector1">
            <a:avLst/>
          </a:prstGeom>
          <a:ln w="19050">
            <a:solidFill>
              <a:srgbClr val="FF0000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Straight Arrow Connector 75">
            <a:extLst>
              <a:ext uri="{FF2B5EF4-FFF2-40B4-BE49-F238E27FC236}">
                <a16:creationId xmlns:a16="http://schemas.microsoft.com/office/drawing/2014/main" id="{9828DDD1-1D74-43DF-A7C5-F4EE016A45C3}"/>
              </a:ext>
            </a:extLst>
          </p:cNvPr>
          <p:cNvCxnSpPr>
            <a:cxnSpLocks/>
          </p:cNvCxnSpPr>
          <p:nvPr/>
        </p:nvCxnSpPr>
        <p:spPr>
          <a:xfrm rot="-2100000">
            <a:off x="5010967" y="3578707"/>
            <a:ext cx="108000" cy="0"/>
          </a:xfrm>
          <a:prstGeom prst="straightConnector1">
            <a:avLst/>
          </a:prstGeom>
          <a:ln w="19050">
            <a:solidFill>
              <a:srgbClr val="FF0000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7" name="Straight Arrow Connector 76">
            <a:extLst>
              <a:ext uri="{FF2B5EF4-FFF2-40B4-BE49-F238E27FC236}">
                <a16:creationId xmlns:a16="http://schemas.microsoft.com/office/drawing/2014/main" id="{239E5BE1-CCE3-415A-BB37-F785B3B0E7AE}"/>
              </a:ext>
            </a:extLst>
          </p:cNvPr>
          <p:cNvCxnSpPr>
            <a:cxnSpLocks/>
          </p:cNvCxnSpPr>
          <p:nvPr/>
        </p:nvCxnSpPr>
        <p:spPr>
          <a:xfrm rot="-2100000">
            <a:off x="5180943" y="3578356"/>
            <a:ext cx="108000" cy="0"/>
          </a:xfrm>
          <a:prstGeom prst="straightConnector1">
            <a:avLst/>
          </a:prstGeom>
          <a:ln w="19050">
            <a:solidFill>
              <a:srgbClr val="FF0000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910406335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le 2">
            <a:extLst>
              <a:ext uri="{FF2B5EF4-FFF2-40B4-BE49-F238E27FC236}">
                <a16:creationId xmlns:a16="http://schemas.microsoft.com/office/drawing/2014/main" id="{F0D69116-FB12-453E-9F91-FD31429AA89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582668" y="206829"/>
            <a:ext cx="1989058" cy="423882"/>
          </a:xfrm>
        </p:spPr>
        <p:txBody>
          <a:bodyPr>
            <a:normAutofit fontScale="90000"/>
          </a:bodyPr>
          <a:lstStyle/>
          <a:p>
            <a:r>
              <a:rPr lang="en-US" sz="1656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able S2: U</a:t>
            </a:r>
            <a:r>
              <a:rPr lang="en-US" altLang="zh-CN" sz="1656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iquitin modifications detected </a:t>
            </a:r>
            <a:endParaRPr lang="en-SG" sz="1656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DFBA0BAB-BBF7-4D3F-AA0E-162200F5E61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986034" y="76199"/>
            <a:ext cx="5285398" cy="674669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89447326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DE0722D9-F764-4C91-BDA3-029452883F63}"/>
              </a:ext>
            </a:extLst>
          </p:cNvPr>
          <p:cNvSpPr txBox="1"/>
          <p:nvPr/>
        </p:nvSpPr>
        <p:spPr>
          <a:xfrm>
            <a:off x="1216629" y="530753"/>
            <a:ext cx="6437264" cy="169828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 defTabSz="378653"/>
            <a:r>
              <a:rPr lang="en-US" sz="1491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able S2: U</a:t>
            </a:r>
            <a:r>
              <a:rPr lang="en-US" altLang="zh-CN" sz="1491" b="1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biquitin modifications detected. </a:t>
            </a:r>
            <a:r>
              <a:rPr lang="en-US" altLang="zh-CN" sz="1491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Mitochondrial lysates of WT and </a:t>
            </a:r>
            <a:r>
              <a:rPr lang="el-GR" altLang="zh-CN" sz="1491" i="1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Δ</a:t>
            </a:r>
            <a:r>
              <a:rPr lang="en-SG" altLang="zh-CN" sz="1491" i="1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rad6 </a:t>
            </a:r>
            <a:r>
              <a:rPr lang="en-SG" altLang="zh-CN" sz="1491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cells expressing preSu9-HA-Ub were subjected to SDS-PAGE followed by gel staining with </a:t>
            </a:r>
            <a:r>
              <a:rPr lang="en-SG" altLang="zh-CN" sz="1491" dirty="0" err="1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InstantBlue</a:t>
            </a:r>
            <a:r>
              <a:rPr lang="en-SG" altLang="zh-CN" sz="1491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. The proteins separated between 48 and 63 </a:t>
            </a:r>
            <a:r>
              <a:rPr lang="en-SG" altLang="zh-CN" sz="1491" dirty="0" err="1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kDa</a:t>
            </a:r>
            <a:r>
              <a:rPr lang="en-SG" altLang="zh-CN" sz="1491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were excised for each sample and subjected to MS. The detected ubiquitin modifications are summarized in the table. Modifications with case(s) with a confidence level higher than 90% are highlighted in red. The number in each bracket indicates the</a:t>
            </a:r>
            <a:r>
              <a:rPr lang="en-US" altLang="zh-CN" sz="1491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number of the corresponding modification observed by MS.</a:t>
            </a:r>
            <a:endParaRPr lang="en-SG" sz="1491" i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64756810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8AC387F3-FADA-4592-9A1D-95D28DE20ECE}"/>
              </a:ext>
            </a:extLst>
          </p:cNvPr>
          <p:cNvSpPr txBox="1"/>
          <p:nvPr/>
        </p:nvSpPr>
        <p:spPr>
          <a:xfrm>
            <a:off x="1284400" y="195234"/>
            <a:ext cx="6587374" cy="5511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378653"/>
            <a:r>
              <a:rPr lang="en-SG" sz="1491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ure S8: preSu9-HA-Ub IP with mitochondrial lysates of WT versus </a:t>
            </a:r>
            <a:r>
              <a:rPr lang="el-GR" sz="1491" b="1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SG" sz="1491" b="1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ad6</a:t>
            </a:r>
            <a:r>
              <a:rPr lang="en-SG" sz="1491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cells.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E68B7D1C-3CF7-4DAA-A45E-7FB455A62BD8}"/>
              </a:ext>
            </a:extLst>
          </p:cNvPr>
          <p:cNvSpPr txBox="1"/>
          <p:nvPr/>
        </p:nvSpPr>
        <p:spPr>
          <a:xfrm>
            <a:off x="3697191" y="4342740"/>
            <a:ext cx="686883" cy="3217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378653"/>
            <a:r>
              <a:rPr lang="en-SG" sz="149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sp60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C7D647A1-9C56-47F6-8AC2-DDA3728B6E18}"/>
              </a:ext>
            </a:extLst>
          </p:cNvPr>
          <p:cNvSpPr txBox="1"/>
          <p:nvPr/>
        </p:nvSpPr>
        <p:spPr>
          <a:xfrm>
            <a:off x="3697192" y="4583361"/>
            <a:ext cx="677608" cy="3217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378653"/>
            <a:r>
              <a:rPr lang="en-SG" sz="149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um1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1D96597B-C304-4DB5-ADC8-6FD53F118C75}"/>
              </a:ext>
            </a:extLst>
          </p:cNvPr>
          <p:cNvSpPr txBox="1"/>
          <p:nvPr/>
        </p:nvSpPr>
        <p:spPr>
          <a:xfrm rot="16200000">
            <a:off x="1587919" y="2505972"/>
            <a:ext cx="316915" cy="296235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defTabSz="378653"/>
            <a:r>
              <a:rPr lang="en-SG" sz="1325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5E72D5F0-60AD-45E2-AE95-86E9DBBA3D2D}"/>
              </a:ext>
            </a:extLst>
          </p:cNvPr>
          <p:cNvSpPr txBox="1"/>
          <p:nvPr/>
        </p:nvSpPr>
        <p:spPr>
          <a:xfrm rot="16200000">
            <a:off x="1914455" y="2367857"/>
            <a:ext cx="573220" cy="296235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defTabSz="378653"/>
            <a:r>
              <a:rPr lang="en-SG" sz="1325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Δrad6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C196AD0C-E354-497E-9E55-401E51EA3C2F}"/>
              </a:ext>
            </a:extLst>
          </p:cNvPr>
          <p:cNvSpPr txBox="1"/>
          <p:nvPr/>
        </p:nvSpPr>
        <p:spPr>
          <a:xfrm rot="16200000">
            <a:off x="1398381" y="3169051"/>
            <a:ext cx="435524" cy="296235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defTabSz="378653"/>
            <a:r>
              <a:rPr lang="en-SG" sz="1325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nput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89DC8EA5-8553-4010-A819-5B4F3161A782}"/>
              </a:ext>
            </a:extLst>
          </p:cNvPr>
          <p:cNvSpPr txBox="1"/>
          <p:nvPr/>
        </p:nvSpPr>
        <p:spPr>
          <a:xfrm rot="16200000">
            <a:off x="1522702" y="3067913"/>
            <a:ext cx="640633" cy="296235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defTabSz="378653"/>
            <a:r>
              <a:rPr lang="en-SG" sz="1325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Unbound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FA2BC214-657B-4540-9A1A-457697FC87FA}"/>
              </a:ext>
            </a:extLst>
          </p:cNvPr>
          <p:cNvSpPr txBox="1"/>
          <p:nvPr/>
        </p:nvSpPr>
        <p:spPr>
          <a:xfrm rot="16200000">
            <a:off x="1872023" y="3170469"/>
            <a:ext cx="435524" cy="296235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defTabSz="378653"/>
            <a:r>
              <a:rPr lang="en-SG" sz="1325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nput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B74B7DE5-3FE0-431E-8889-06EA95519A54}"/>
              </a:ext>
            </a:extLst>
          </p:cNvPr>
          <p:cNvSpPr txBox="1"/>
          <p:nvPr/>
        </p:nvSpPr>
        <p:spPr>
          <a:xfrm rot="16200000">
            <a:off x="2014818" y="3066496"/>
            <a:ext cx="640633" cy="296235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defTabSz="378653"/>
            <a:r>
              <a:rPr lang="en-SG" sz="1325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Unbound</a:t>
            </a:r>
          </a:p>
        </p:txBody>
      </p: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47CB2E7D-BA62-41F8-BA80-4440FF1FAC7B}"/>
              </a:ext>
            </a:extLst>
          </p:cNvPr>
          <p:cNvCxnSpPr>
            <a:cxnSpLocks/>
          </p:cNvCxnSpPr>
          <p:nvPr/>
        </p:nvCxnSpPr>
        <p:spPr>
          <a:xfrm>
            <a:off x="1552081" y="2851503"/>
            <a:ext cx="357791" cy="1417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1D1DBABA-BE41-46A4-B9F2-8C27B1EAE90A}"/>
              </a:ext>
            </a:extLst>
          </p:cNvPr>
          <p:cNvCxnSpPr>
            <a:cxnSpLocks/>
          </p:cNvCxnSpPr>
          <p:nvPr/>
        </p:nvCxnSpPr>
        <p:spPr>
          <a:xfrm>
            <a:off x="2035687" y="2850087"/>
            <a:ext cx="357791" cy="1417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52F60A2D-031C-4215-957A-8EB5056D0570}"/>
              </a:ext>
            </a:extLst>
          </p:cNvPr>
          <p:cNvCxnSpPr>
            <a:cxnSpLocks/>
          </p:cNvCxnSpPr>
          <p:nvPr/>
        </p:nvCxnSpPr>
        <p:spPr>
          <a:xfrm>
            <a:off x="2707238" y="2855762"/>
            <a:ext cx="208712" cy="1417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>
            <a:extLst>
              <a:ext uri="{FF2B5EF4-FFF2-40B4-BE49-F238E27FC236}">
                <a16:creationId xmlns:a16="http://schemas.microsoft.com/office/drawing/2014/main" id="{F87A663A-F73E-4C8C-B619-9F555B0AE107}"/>
              </a:ext>
            </a:extLst>
          </p:cNvPr>
          <p:cNvSpPr txBox="1"/>
          <p:nvPr/>
        </p:nvSpPr>
        <p:spPr>
          <a:xfrm rot="16200000">
            <a:off x="2546188" y="3078701"/>
            <a:ext cx="546763" cy="296235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defTabSz="378653"/>
            <a:r>
              <a:rPr lang="en-SG" sz="1325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lution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07D0306B-A06E-4685-8075-0961DBDD65F2}"/>
              </a:ext>
            </a:extLst>
          </p:cNvPr>
          <p:cNvSpPr txBox="1"/>
          <p:nvPr/>
        </p:nvSpPr>
        <p:spPr>
          <a:xfrm rot="16200000">
            <a:off x="2315613" y="3106791"/>
            <a:ext cx="546763" cy="296235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defTabSz="378653"/>
            <a:r>
              <a:rPr lang="en-SG" sz="1325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W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4A5661B4-AFFC-4066-8033-5EF507E44D5B}"/>
              </a:ext>
            </a:extLst>
          </p:cNvPr>
          <p:cNvSpPr txBox="1"/>
          <p:nvPr/>
        </p:nvSpPr>
        <p:spPr>
          <a:xfrm rot="16200000">
            <a:off x="2801957" y="3075376"/>
            <a:ext cx="546763" cy="296235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defTabSz="378653"/>
            <a:r>
              <a:rPr lang="en-SG" sz="1325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lution</a:t>
            </a:r>
          </a:p>
        </p:txBody>
      </p: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0F20BB0F-0A94-4D9F-B3E6-46551CB12447}"/>
              </a:ext>
            </a:extLst>
          </p:cNvPr>
          <p:cNvCxnSpPr>
            <a:cxnSpLocks/>
          </p:cNvCxnSpPr>
          <p:nvPr/>
        </p:nvCxnSpPr>
        <p:spPr>
          <a:xfrm>
            <a:off x="2972965" y="2862401"/>
            <a:ext cx="208712" cy="1417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>
            <a:extLst>
              <a:ext uri="{FF2B5EF4-FFF2-40B4-BE49-F238E27FC236}">
                <a16:creationId xmlns:a16="http://schemas.microsoft.com/office/drawing/2014/main" id="{6D1D636D-92BB-4F1F-B9E9-D572367C24BA}"/>
              </a:ext>
            </a:extLst>
          </p:cNvPr>
          <p:cNvSpPr txBox="1"/>
          <p:nvPr/>
        </p:nvSpPr>
        <p:spPr>
          <a:xfrm rot="16200000">
            <a:off x="2668383" y="2499329"/>
            <a:ext cx="303629" cy="296235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defTabSz="378653"/>
            <a:r>
              <a:rPr lang="en-SG" sz="1325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DCFA8C94-3D2E-4DBB-9FEC-8B847BE95357}"/>
              </a:ext>
            </a:extLst>
          </p:cNvPr>
          <p:cNvSpPr txBox="1"/>
          <p:nvPr/>
        </p:nvSpPr>
        <p:spPr>
          <a:xfrm rot="16200000">
            <a:off x="2782735" y="2385843"/>
            <a:ext cx="573220" cy="296235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defTabSz="378653"/>
            <a:r>
              <a:rPr lang="en-SG" sz="1325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Δrad6</a:t>
            </a:r>
          </a:p>
        </p:txBody>
      </p: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2A4743C5-85E1-436D-95A9-9A713279FF82}"/>
              </a:ext>
            </a:extLst>
          </p:cNvPr>
          <p:cNvCxnSpPr>
            <a:cxnSpLocks/>
          </p:cNvCxnSpPr>
          <p:nvPr/>
        </p:nvCxnSpPr>
        <p:spPr>
          <a:xfrm>
            <a:off x="3222088" y="2862405"/>
            <a:ext cx="208712" cy="1417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xtBox 21">
            <a:extLst>
              <a:ext uri="{FF2B5EF4-FFF2-40B4-BE49-F238E27FC236}">
                <a16:creationId xmlns:a16="http://schemas.microsoft.com/office/drawing/2014/main" id="{F713D7A6-F0CC-4A95-8F3D-1838F2C690EC}"/>
              </a:ext>
            </a:extLst>
          </p:cNvPr>
          <p:cNvSpPr txBox="1"/>
          <p:nvPr/>
        </p:nvSpPr>
        <p:spPr>
          <a:xfrm rot="16200000">
            <a:off x="3061039" y="3085344"/>
            <a:ext cx="546763" cy="296235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defTabSz="378653"/>
            <a:r>
              <a:rPr lang="en-SG" sz="1325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lution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066D6465-DBD9-41FB-8DB9-B366433D5409}"/>
              </a:ext>
            </a:extLst>
          </p:cNvPr>
          <p:cNvSpPr txBox="1"/>
          <p:nvPr/>
        </p:nvSpPr>
        <p:spPr>
          <a:xfrm rot="16200000">
            <a:off x="3316807" y="3082019"/>
            <a:ext cx="546763" cy="296235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defTabSz="378653"/>
            <a:r>
              <a:rPr lang="en-SG" sz="1325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lution</a:t>
            </a:r>
          </a:p>
        </p:txBody>
      </p: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8B6B467B-EC8C-47B7-A4B0-4BE1DA7CA67B}"/>
              </a:ext>
            </a:extLst>
          </p:cNvPr>
          <p:cNvCxnSpPr>
            <a:cxnSpLocks/>
          </p:cNvCxnSpPr>
          <p:nvPr/>
        </p:nvCxnSpPr>
        <p:spPr>
          <a:xfrm>
            <a:off x="3487815" y="2869044"/>
            <a:ext cx="208712" cy="1417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Box 24">
            <a:extLst>
              <a:ext uri="{FF2B5EF4-FFF2-40B4-BE49-F238E27FC236}">
                <a16:creationId xmlns:a16="http://schemas.microsoft.com/office/drawing/2014/main" id="{CFEDFA6A-406B-4001-94C2-17DBE241541F}"/>
              </a:ext>
            </a:extLst>
          </p:cNvPr>
          <p:cNvSpPr txBox="1"/>
          <p:nvPr/>
        </p:nvSpPr>
        <p:spPr>
          <a:xfrm rot="16200000">
            <a:off x="3193199" y="2505972"/>
            <a:ext cx="303629" cy="296235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defTabSz="378653"/>
            <a:r>
              <a:rPr lang="en-SG" sz="1325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89B95884-D38A-4393-942B-F34B1A7552D9}"/>
              </a:ext>
            </a:extLst>
          </p:cNvPr>
          <p:cNvSpPr txBox="1"/>
          <p:nvPr/>
        </p:nvSpPr>
        <p:spPr>
          <a:xfrm rot="16200000">
            <a:off x="3297585" y="2392486"/>
            <a:ext cx="573220" cy="296235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defTabSz="378653"/>
            <a:r>
              <a:rPr lang="en-SG" sz="1325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Δrad6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7183C2EB-4744-4E20-AE66-3CDB407BFAF8}"/>
              </a:ext>
            </a:extLst>
          </p:cNvPr>
          <p:cNvSpPr txBox="1"/>
          <p:nvPr/>
        </p:nvSpPr>
        <p:spPr>
          <a:xfrm>
            <a:off x="964153" y="2495632"/>
            <a:ext cx="416926" cy="296235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defTabSz="378653"/>
            <a:r>
              <a:rPr lang="en-SG" sz="1325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train</a:t>
            </a:r>
          </a:p>
        </p:txBody>
      </p:sp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D0D71846-D9EB-4FCA-8D28-BBADDD14F667}"/>
              </a:ext>
            </a:extLst>
          </p:cNvPr>
          <p:cNvCxnSpPr>
            <a:cxnSpLocks/>
          </p:cNvCxnSpPr>
          <p:nvPr/>
        </p:nvCxnSpPr>
        <p:spPr>
          <a:xfrm>
            <a:off x="1568688" y="2310077"/>
            <a:ext cx="357791" cy="1417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Straight Connector 28">
            <a:extLst>
              <a:ext uri="{FF2B5EF4-FFF2-40B4-BE49-F238E27FC236}">
                <a16:creationId xmlns:a16="http://schemas.microsoft.com/office/drawing/2014/main" id="{6222DA47-2BB6-46AC-8A61-335F4FE740C7}"/>
              </a:ext>
            </a:extLst>
          </p:cNvPr>
          <p:cNvCxnSpPr>
            <a:cxnSpLocks/>
          </p:cNvCxnSpPr>
          <p:nvPr/>
        </p:nvCxnSpPr>
        <p:spPr>
          <a:xfrm>
            <a:off x="2023752" y="2316718"/>
            <a:ext cx="357791" cy="1417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Connector 29">
            <a:extLst>
              <a:ext uri="{FF2B5EF4-FFF2-40B4-BE49-F238E27FC236}">
                <a16:creationId xmlns:a16="http://schemas.microsoft.com/office/drawing/2014/main" id="{8824650F-AA84-4FDA-997F-246A8887DE94}"/>
              </a:ext>
            </a:extLst>
          </p:cNvPr>
          <p:cNvCxnSpPr>
            <a:cxnSpLocks/>
          </p:cNvCxnSpPr>
          <p:nvPr/>
        </p:nvCxnSpPr>
        <p:spPr>
          <a:xfrm>
            <a:off x="2693948" y="2314340"/>
            <a:ext cx="208712" cy="1417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Connector 30">
            <a:extLst>
              <a:ext uri="{FF2B5EF4-FFF2-40B4-BE49-F238E27FC236}">
                <a16:creationId xmlns:a16="http://schemas.microsoft.com/office/drawing/2014/main" id="{E0648902-3725-42C3-A0B7-19C364F2B689}"/>
              </a:ext>
            </a:extLst>
          </p:cNvPr>
          <p:cNvCxnSpPr>
            <a:cxnSpLocks/>
          </p:cNvCxnSpPr>
          <p:nvPr/>
        </p:nvCxnSpPr>
        <p:spPr>
          <a:xfrm>
            <a:off x="2959674" y="2311014"/>
            <a:ext cx="208712" cy="1417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TextBox 31">
            <a:extLst>
              <a:ext uri="{FF2B5EF4-FFF2-40B4-BE49-F238E27FC236}">
                <a16:creationId xmlns:a16="http://schemas.microsoft.com/office/drawing/2014/main" id="{0008E084-2D4E-494E-83EA-D4E9C902796D}"/>
              </a:ext>
            </a:extLst>
          </p:cNvPr>
          <p:cNvSpPr txBox="1"/>
          <p:nvPr/>
        </p:nvSpPr>
        <p:spPr>
          <a:xfrm rot="16200000">
            <a:off x="2263824" y="1556674"/>
            <a:ext cx="1086168" cy="296235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defTabSz="378653"/>
            <a:r>
              <a:rPr lang="en-SG" sz="1325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reSu9-HA-Ub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EF909A7A-4780-43FA-BEB5-46DC6B363898}"/>
              </a:ext>
            </a:extLst>
          </p:cNvPr>
          <p:cNvSpPr txBox="1"/>
          <p:nvPr/>
        </p:nvSpPr>
        <p:spPr>
          <a:xfrm rot="16200000">
            <a:off x="2512971" y="1558052"/>
            <a:ext cx="1086169" cy="296235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defTabSz="378653"/>
            <a:r>
              <a:rPr lang="en-SG" sz="1325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reSu9-HA-Ub</a:t>
            </a:r>
          </a:p>
        </p:txBody>
      </p:sp>
      <p:cxnSp>
        <p:nvCxnSpPr>
          <p:cNvPr id="34" name="Straight Connector 33">
            <a:extLst>
              <a:ext uri="{FF2B5EF4-FFF2-40B4-BE49-F238E27FC236}">
                <a16:creationId xmlns:a16="http://schemas.microsoft.com/office/drawing/2014/main" id="{B2B5883E-4C0D-4250-8BF1-456FBAAE17B5}"/>
              </a:ext>
            </a:extLst>
          </p:cNvPr>
          <p:cNvCxnSpPr>
            <a:cxnSpLocks/>
          </p:cNvCxnSpPr>
          <p:nvPr/>
        </p:nvCxnSpPr>
        <p:spPr>
          <a:xfrm>
            <a:off x="3208798" y="2311018"/>
            <a:ext cx="208712" cy="1417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Straight Connector 34">
            <a:extLst>
              <a:ext uri="{FF2B5EF4-FFF2-40B4-BE49-F238E27FC236}">
                <a16:creationId xmlns:a16="http://schemas.microsoft.com/office/drawing/2014/main" id="{8BFC13AB-5402-48AB-98BF-CE8B572B5FEE}"/>
              </a:ext>
            </a:extLst>
          </p:cNvPr>
          <p:cNvCxnSpPr>
            <a:cxnSpLocks/>
          </p:cNvCxnSpPr>
          <p:nvPr/>
        </p:nvCxnSpPr>
        <p:spPr>
          <a:xfrm>
            <a:off x="3474524" y="2317657"/>
            <a:ext cx="208712" cy="1417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TextBox 35">
            <a:extLst>
              <a:ext uri="{FF2B5EF4-FFF2-40B4-BE49-F238E27FC236}">
                <a16:creationId xmlns:a16="http://schemas.microsoft.com/office/drawing/2014/main" id="{1DD66B64-328F-4B9B-B42C-A6B7F20ABBD1}"/>
              </a:ext>
            </a:extLst>
          </p:cNvPr>
          <p:cNvSpPr txBox="1"/>
          <p:nvPr/>
        </p:nvSpPr>
        <p:spPr>
          <a:xfrm rot="16200000">
            <a:off x="3045113" y="1829755"/>
            <a:ext cx="573221" cy="296235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defTabSz="378653"/>
            <a:r>
              <a:rPr lang="en-SG" sz="1325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BD133C07-E832-4DED-A441-ACCA7E2BDF45}"/>
              </a:ext>
            </a:extLst>
          </p:cNvPr>
          <p:cNvSpPr txBox="1"/>
          <p:nvPr/>
        </p:nvSpPr>
        <p:spPr>
          <a:xfrm rot="16200000">
            <a:off x="3284295" y="1831134"/>
            <a:ext cx="573220" cy="296235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defTabSz="378653"/>
            <a:r>
              <a:rPr lang="en-SG" sz="1325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3F1AC472-6214-4EC3-8F11-B1480FE5ACC1}"/>
              </a:ext>
            </a:extLst>
          </p:cNvPr>
          <p:cNvSpPr txBox="1"/>
          <p:nvPr/>
        </p:nvSpPr>
        <p:spPr>
          <a:xfrm rot="16200000">
            <a:off x="1164376" y="1573280"/>
            <a:ext cx="1086168" cy="296235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defTabSz="378653"/>
            <a:r>
              <a:rPr lang="en-SG" sz="1325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reSu9-HA-Ub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47B23F56-D139-417D-A42B-29C66035487A}"/>
              </a:ext>
            </a:extLst>
          </p:cNvPr>
          <p:cNvSpPr txBox="1"/>
          <p:nvPr/>
        </p:nvSpPr>
        <p:spPr>
          <a:xfrm rot="16200000">
            <a:off x="1652681" y="1564693"/>
            <a:ext cx="1086169" cy="296235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defTabSz="378653"/>
            <a:r>
              <a:rPr lang="en-SG" sz="1325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reSu9-HA-Ub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569DA0E2-0105-43E9-A942-83BCA76560F2}"/>
              </a:ext>
            </a:extLst>
          </p:cNvPr>
          <p:cNvSpPr txBox="1"/>
          <p:nvPr/>
        </p:nvSpPr>
        <p:spPr>
          <a:xfrm>
            <a:off x="821954" y="1633288"/>
            <a:ext cx="559124" cy="296235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defTabSz="378653"/>
            <a:r>
              <a:rPr lang="en-SG" sz="1325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lasmid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499C65E7-ACFD-4EA0-9C17-363DED1701B0}"/>
              </a:ext>
            </a:extLst>
          </p:cNvPr>
          <p:cNvSpPr txBox="1"/>
          <p:nvPr/>
        </p:nvSpPr>
        <p:spPr>
          <a:xfrm>
            <a:off x="3696408" y="4076380"/>
            <a:ext cx="677608" cy="3217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378653"/>
            <a:r>
              <a:rPr lang="en-SG" sz="149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co1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6E085BD4-1332-4CB3-B7D0-5B453AB52B5E}"/>
              </a:ext>
            </a:extLst>
          </p:cNvPr>
          <p:cNvSpPr txBox="1"/>
          <p:nvPr/>
        </p:nvSpPr>
        <p:spPr>
          <a:xfrm>
            <a:off x="4828967" y="3619735"/>
            <a:ext cx="598796" cy="3217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378653"/>
            <a:r>
              <a:rPr lang="en-SG" sz="149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lv5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24F979B6-7A2C-44D1-A6F3-24459CABB234}"/>
              </a:ext>
            </a:extLst>
          </p:cNvPr>
          <p:cNvSpPr txBox="1"/>
          <p:nvPr/>
        </p:nvSpPr>
        <p:spPr>
          <a:xfrm>
            <a:off x="3696408" y="5412301"/>
            <a:ext cx="677608" cy="3217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378653"/>
            <a:r>
              <a:rPr lang="el-GR" sz="149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en-SG" sz="149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HA</a:t>
            </a:r>
          </a:p>
        </p:txBody>
      </p:sp>
      <p:pic>
        <p:nvPicPr>
          <p:cNvPr id="48" name="Picture 47">
            <a:extLst>
              <a:ext uri="{FF2B5EF4-FFF2-40B4-BE49-F238E27FC236}">
                <a16:creationId xmlns:a16="http://schemas.microsoft.com/office/drawing/2014/main" id="{7EFD1EA9-BE09-4FEE-9B38-54532DEAB30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75733" y="4122950"/>
            <a:ext cx="2206532" cy="247414"/>
          </a:xfrm>
          <a:prstGeom prst="rect">
            <a:avLst/>
          </a:prstGeom>
        </p:spPr>
      </p:pic>
      <p:pic>
        <p:nvPicPr>
          <p:cNvPr id="49" name="Picture 48">
            <a:extLst>
              <a:ext uri="{FF2B5EF4-FFF2-40B4-BE49-F238E27FC236}">
                <a16:creationId xmlns:a16="http://schemas.microsoft.com/office/drawing/2014/main" id="{F5DC2635-DE83-413D-9251-75226CA280A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474655" y="4440269"/>
            <a:ext cx="2211581" cy="156527"/>
          </a:xfrm>
          <a:prstGeom prst="rect">
            <a:avLst/>
          </a:prstGeom>
        </p:spPr>
      </p:pic>
      <p:pic>
        <p:nvPicPr>
          <p:cNvPr id="50" name="Picture 49">
            <a:extLst>
              <a:ext uri="{FF2B5EF4-FFF2-40B4-BE49-F238E27FC236}">
                <a16:creationId xmlns:a16="http://schemas.microsoft.com/office/drawing/2014/main" id="{EDB15D84-6878-4471-A7F4-DBE1B0170E2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484827" y="4660022"/>
            <a:ext cx="2211581" cy="156527"/>
          </a:xfrm>
          <a:prstGeom prst="rect">
            <a:avLst/>
          </a:prstGeom>
        </p:spPr>
      </p:pic>
      <p:pic>
        <p:nvPicPr>
          <p:cNvPr id="51" name="Picture 50">
            <a:extLst>
              <a:ext uri="{FF2B5EF4-FFF2-40B4-BE49-F238E27FC236}">
                <a16:creationId xmlns:a16="http://schemas.microsoft.com/office/drawing/2014/main" id="{C82AF5A0-1B18-4811-B40E-DB6F5F94E88D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488958" y="4883752"/>
            <a:ext cx="2216630" cy="181774"/>
          </a:xfrm>
          <a:prstGeom prst="rect">
            <a:avLst/>
          </a:prstGeom>
        </p:spPr>
      </p:pic>
      <p:pic>
        <p:nvPicPr>
          <p:cNvPr id="52" name="Picture 51">
            <a:extLst>
              <a:ext uri="{FF2B5EF4-FFF2-40B4-BE49-F238E27FC236}">
                <a16:creationId xmlns:a16="http://schemas.microsoft.com/office/drawing/2014/main" id="{050A7F5E-16F1-43F0-B5E7-B3E5B5AB9EBB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475734" y="3557981"/>
            <a:ext cx="2211581" cy="464533"/>
          </a:xfrm>
          <a:prstGeom prst="rect">
            <a:avLst/>
          </a:prstGeom>
        </p:spPr>
      </p:pic>
      <p:pic>
        <p:nvPicPr>
          <p:cNvPr id="53" name="Picture 52">
            <a:extLst>
              <a:ext uri="{FF2B5EF4-FFF2-40B4-BE49-F238E27FC236}">
                <a16:creationId xmlns:a16="http://schemas.microsoft.com/office/drawing/2014/main" id="{E8D9C5C9-6A1C-434B-B6A8-0FD4655D4265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738897" y="3557775"/>
            <a:ext cx="1136086" cy="464533"/>
          </a:xfrm>
          <a:prstGeom prst="rect">
            <a:avLst/>
          </a:prstGeom>
        </p:spPr>
      </p:pic>
      <p:pic>
        <p:nvPicPr>
          <p:cNvPr id="57" name="Picture 56">
            <a:extLst>
              <a:ext uri="{FF2B5EF4-FFF2-40B4-BE49-F238E27FC236}">
                <a16:creationId xmlns:a16="http://schemas.microsoft.com/office/drawing/2014/main" id="{964CA3C3-E087-4B71-AD0A-AEE3A3C8B4EE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l="3625"/>
          <a:stretch/>
        </p:blipFill>
        <p:spPr>
          <a:xfrm>
            <a:off x="2475334" y="5141895"/>
            <a:ext cx="1206831" cy="1035100"/>
          </a:xfrm>
          <a:prstGeom prst="rect">
            <a:avLst/>
          </a:prstGeom>
        </p:spPr>
      </p:pic>
      <p:sp>
        <p:nvSpPr>
          <p:cNvPr id="59" name="TextBox 58">
            <a:extLst>
              <a:ext uri="{FF2B5EF4-FFF2-40B4-BE49-F238E27FC236}">
                <a16:creationId xmlns:a16="http://schemas.microsoft.com/office/drawing/2014/main" id="{7C50C586-68EB-44FA-8071-079EA83B568A}"/>
              </a:ext>
            </a:extLst>
          </p:cNvPr>
          <p:cNvSpPr txBox="1"/>
          <p:nvPr/>
        </p:nvSpPr>
        <p:spPr>
          <a:xfrm>
            <a:off x="3697192" y="4822097"/>
            <a:ext cx="677608" cy="3217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378653"/>
            <a:r>
              <a:rPr lang="en-SG" sz="149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dh1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1FFD7585-5E0D-4846-9059-07B0AEB59C5D}"/>
              </a:ext>
            </a:extLst>
          </p:cNvPr>
          <p:cNvSpPr txBox="1"/>
          <p:nvPr/>
        </p:nvSpPr>
        <p:spPr>
          <a:xfrm>
            <a:off x="7523110" y="4009296"/>
            <a:ext cx="677608" cy="3217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378653"/>
            <a:r>
              <a:rPr lang="en-SG" sz="149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um1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96543441-1995-4EEA-9812-3F01C2C674DC}"/>
              </a:ext>
            </a:extLst>
          </p:cNvPr>
          <p:cNvSpPr txBox="1"/>
          <p:nvPr/>
        </p:nvSpPr>
        <p:spPr>
          <a:xfrm>
            <a:off x="7520584" y="5245332"/>
            <a:ext cx="677608" cy="3217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378653"/>
            <a:r>
              <a:rPr lang="el-GR" sz="149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en-SG" sz="149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HA</a:t>
            </a:r>
          </a:p>
        </p:txBody>
      </p:sp>
      <p:cxnSp>
        <p:nvCxnSpPr>
          <p:cNvPr id="66" name="Straight Connector 65">
            <a:extLst>
              <a:ext uri="{FF2B5EF4-FFF2-40B4-BE49-F238E27FC236}">
                <a16:creationId xmlns:a16="http://schemas.microsoft.com/office/drawing/2014/main" id="{DC22A1A4-885B-403E-993A-C07CF7DFD425}"/>
              </a:ext>
            </a:extLst>
          </p:cNvPr>
          <p:cNvCxnSpPr>
            <a:cxnSpLocks/>
          </p:cNvCxnSpPr>
          <p:nvPr/>
        </p:nvCxnSpPr>
        <p:spPr>
          <a:xfrm flipV="1">
            <a:off x="7462934" y="4170232"/>
            <a:ext cx="101290" cy="63227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7" name="Straight Connector 66">
            <a:extLst>
              <a:ext uri="{FF2B5EF4-FFF2-40B4-BE49-F238E27FC236}">
                <a16:creationId xmlns:a16="http://schemas.microsoft.com/office/drawing/2014/main" id="{482D0863-90CC-46A1-A216-26D0D28E3ECA}"/>
              </a:ext>
            </a:extLst>
          </p:cNvPr>
          <p:cNvCxnSpPr>
            <a:cxnSpLocks/>
          </p:cNvCxnSpPr>
          <p:nvPr/>
        </p:nvCxnSpPr>
        <p:spPr>
          <a:xfrm rot="2820000" flipV="1">
            <a:off x="7472466" y="4305016"/>
            <a:ext cx="101290" cy="63227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8" name="TextBox 67">
            <a:extLst>
              <a:ext uri="{FF2B5EF4-FFF2-40B4-BE49-F238E27FC236}">
                <a16:creationId xmlns:a16="http://schemas.microsoft.com/office/drawing/2014/main" id="{8B4CEC67-BDDC-462D-BBC1-AE475725523C}"/>
              </a:ext>
            </a:extLst>
          </p:cNvPr>
          <p:cNvSpPr txBox="1"/>
          <p:nvPr/>
        </p:nvSpPr>
        <p:spPr>
          <a:xfrm>
            <a:off x="7513578" y="3542937"/>
            <a:ext cx="677608" cy="3217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378653"/>
            <a:r>
              <a:rPr lang="en-SG" sz="149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co1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1DF77B98-22E5-470A-9853-7CA9AD63AF1B}"/>
              </a:ext>
            </a:extLst>
          </p:cNvPr>
          <p:cNvSpPr txBox="1"/>
          <p:nvPr/>
        </p:nvSpPr>
        <p:spPr>
          <a:xfrm>
            <a:off x="7523110" y="4438077"/>
            <a:ext cx="677608" cy="3217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378653"/>
            <a:r>
              <a:rPr lang="en-SG" sz="149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dh1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C71D1A70-0222-4546-BF6C-77B22E6C352C}"/>
              </a:ext>
            </a:extLst>
          </p:cNvPr>
          <p:cNvSpPr txBox="1"/>
          <p:nvPr/>
        </p:nvSpPr>
        <p:spPr>
          <a:xfrm>
            <a:off x="7505189" y="3792689"/>
            <a:ext cx="741188" cy="3217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378653"/>
            <a:r>
              <a:rPr lang="en-SG" sz="149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sp60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506C59EB-9AAE-4A79-ADC3-60A86A199A29}"/>
              </a:ext>
            </a:extLst>
          </p:cNvPr>
          <p:cNvSpPr txBox="1"/>
          <p:nvPr/>
        </p:nvSpPr>
        <p:spPr>
          <a:xfrm rot="16200000">
            <a:off x="5585057" y="2511454"/>
            <a:ext cx="316915" cy="296235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defTabSz="378653"/>
            <a:r>
              <a:rPr lang="en-SG" sz="1325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6B01B348-AC3C-40E0-B2BE-22BA3C9B5729}"/>
              </a:ext>
            </a:extLst>
          </p:cNvPr>
          <p:cNvSpPr txBox="1"/>
          <p:nvPr/>
        </p:nvSpPr>
        <p:spPr>
          <a:xfrm rot="16200000">
            <a:off x="5911593" y="2373339"/>
            <a:ext cx="573220" cy="296235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defTabSz="378653"/>
            <a:r>
              <a:rPr lang="en-SG" sz="1325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Δrad6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5D7747EA-F322-46FA-AA83-5512FEC15119}"/>
              </a:ext>
            </a:extLst>
          </p:cNvPr>
          <p:cNvSpPr txBox="1"/>
          <p:nvPr/>
        </p:nvSpPr>
        <p:spPr>
          <a:xfrm rot="16200000">
            <a:off x="5395519" y="3174533"/>
            <a:ext cx="435524" cy="296235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defTabSz="378653"/>
            <a:r>
              <a:rPr lang="en-SG" sz="1325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nput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4D71AB26-5B61-4E86-A9C2-1ACAD0E5056C}"/>
              </a:ext>
            </a:extLst>
          </p:cNvPr>
          <p:cNvSpPr txBox="1"/>
          <p:nvPr/>
        </p:nvSpPr>
        <p:spPr>
          <a:xfrm rot="16200000">
            <a:off x="5519840" y="3073395"/>
            <a:ext cx="640633" cy="296235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defTabSz="378653"/>
            <a:r>
              <a:rPr lang="en-SG" sz="1325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Unbound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1243B3BD-3E67-4AD7-9243-72B7EF94A8E0}"/>
              </a:ext>
            </a:extLst>
          </p:cNvPr>
          <p:cNvSpPr txBox="1"/>
          <p:nvPr/>
        </p:nvSpPr>
        <p:spPr>
          <a:xfrm rot="16200000">
            <a:off x="5869161" y="3175951"/>
            <a:ext cx="435524" cy="296235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defTabSz="378653"/>
            <a:r>
              <a:rPr lang="en-SG" sz="1325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nput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ED718436-EAA1-4590-B7C4-1CF5E55E849C}"/>
              </a:ext>
            </a:extLst>
          </p:cNvPr>
          <p:cNvSpPr txBox="1"/>
          <p:nvPr/>
        </p:nvSpPr>
        <p:spPr>
          <a:xfrm rot="16200000">
            <a:off x="6011956" y="3071978"/>
            <a:ext cx="640633" cy="296235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defTabSz="378653"/>
            <a:r>
              <a:rPr lang="en-SG" sz="1325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Unbound</a:t>
            </a:r>
          </a:p>
        </p:txBody>
      </p:sp>
      <p:cxnSp>
        <p:nvCxnSpPr>
          <p:cNvPr id="80" name="Straight Connector 79">
            <a:extLst>
              <a:ext uri="{FF2B5EF4-FFF2-40B4-BE49-F238E27FC236}">
                <a16:creationId xmlns:a16="http://schemas.microsoft.com/office/drawing/2014/main" id="{63D3A9DD-1EF3-4231-8AED-6008FB7EAD1E}"/>
              </a:ext>
            </a:extLst>
          </p:cNvPr>
          <p:cNvCxnSpPr>
            <a:cxnSpLocks/>
          </p:cNvCxnSpPr>
          <p:nvPr/>
        </p:nvCxnSpPr>
        <p:spPr>
          <a:xfrm>
            <a:off x="5549219" y="2856985"/>
            <a:ext cx="357791" cy="1417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" name="Straight Connector 80">
            <a:extLst>
              <a:ext uri="{FF2B5EF4-FFF2-40B4-BE49-F238E27FC236}">
                <a16:creationId xmlns:a16="http://schemas.microsoft.com/office/drawing/2014/main" id="{98F90D40-CBC8-4AAA-87DD-AB8EBA3B017D}"/>
              </a:ext>
            </a:extLst>
          </p:cNvPr>
          <p:cNvCxnSpPr>
            <a:cxnSpLocks/>
          </p:cNvCxnSpPr>
          <p:nvPr/>
        </p:nvCxnSpPr>
        <p:spPr>
          <a:xfrm>
            <a:off x="6032825" y="2855568"/>
            <a:ext cx="357791" cy="1417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2" name="Straight Connector 81">
            <a:extLst>
              <a:ext uri="{FF2B5EF4-FFF2-40B4-BE49-F238E27FC236}">
                <a16:creationId xmlns:a16="http://schemas.microsoft.com/office/drawing/2014/main" id="{FBDB8C97-ED18-4020-8360-3401F500AB82}"/>
              </a:ext>
            </a:extLst>
          </p:cNvPr>
          <p:cNvCxnSpPr>
            <a:cxnSpLocks/>
          </p:cNvCxnSpPr>
          <p:nvPr/>
        </p:nvCxnSpPr>
        <p:spPr>
          <a:xfrm>
            <a:off x="5565825" y="2315559"/>
            <a:ext cx="357791" cy="1417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" name="Straight Connector 82">
            <a:extLst>
              <a:ext uri="{FF2B5EF4-FFF2-40B4-BE49-F238E27FC236}">
                <a16:creationId xmlns:a16="http://schemas.microsoft.com/office/drawing/2014/main" id="{3B657EBB-1AAC-4B11-8A41-CF012C1F26F4}"/>
              </a:ext>
            </a:extLst>
          </p:cNvPr>
          <p:cNvCxnSpPr>
            <a:cxnSpLocks/>
          </p:cNvCxnSpPr>
          <p:nvPr/>
        </p:nvCxnSpPr>
        <p:spPr>
          <a:xfrm>
            <a:off x="6020890" y="2322200"/>
            <a:ext cx="357791" cy="1417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4" name="TextBox 83">
            <a:extLst>
              <a:ext uri="{FF2B5EF4-FFF2-40B4-BE49-F238E27FC236}">
                <a16:creationId xmlns:a16="http://schemas.microsoft.com/office/drawing/2014/main" id="{195AC2D3-001D-40E9-A32D-1CCA6036991D}"/>
              </a:ext>
            </a:extLst>
          </p:cNvPr>
          <p:cNvSpPr txBox="1"/>
          <p:nvPr/>
        </p:nvSpPr>
        <p:spPr>
          <a:xfrm rot="16200000">
            <a:off x="5161514" y="1578762"/>
            <a:ext cx="1086168" cy="296235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defTabSz="378653"/>
            <a:r>
              <a:rPr lang="en-SG" sz="1325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reSu9-HA-Ub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6620F937-C07B-4E82-B8D9-5C536DB5112F}"/>
              </a:ext>
            </a:extLst>
          </p:cNvPr>
          <p:cNvSpPr txBox="1"/>
          <p:nvPr/>
        </p:nvSpPr>
        <p:spPr>
          <a:xfrm rot="16200000">
            <a:off x="5649819" y="1570175"/>
            <a:ext cx="1086169" cy="296235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defTabSz="378653"/>
            <a:r>
              <a:rPr lang="en-SG" sz="1325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reSu9-HA-Ub</a:t>
            </a: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DB613A66-A500-492D-A1BC-7DF7D1DE4868}"/>
              </a:ext>
            </a:extLst>
          </p:cNvPr>
          <p:cNvSpPr txBox="1"/>
          <p:nvPr/>
        </p:nvSpPr>
        <p:spPr>
          <a:xfrm rot="16200000">
            <a:off x="6560959" y="2508378"/>
            <a:ext cx="316915" cy="296235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defTabSz="378653"/>
            <a:r>
              <a:rPr lang="en-SG" sz="1325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0A619BE9-8BA5-4184-A9E5-312407FA4557}"/>
              </a:ext>
            </a:extLst>
          </p:cNvPr>
          <p:cNvSpPr txBox="1"/>
          <p:nvPr/>
        </p:nvSpPr>
        <p:spPr>
          <a:xfrm rot="16200000">
            <a:off x="6887495" y="2370263"/>
            <a:ext cx="573220" cy="296235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defTabSz="378653"/>
            <a:r>
              <a:rPr lang="en-SG" sz="1325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Δrad6</a:t>
            </a: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8BFF42B9-B03B-4345-9D60-96EA1E6A281B}"/>
              </a:ext>
            </a:extLst>
          </p:cNvPr>
          <p:cNvSpPr txBox="1"/>
          <p:nvPr/>
        </p:nvSpPr>
        <p:spPr>
          <a:xfrm rot="16200000">
            <a:off x="6371420" y="3171457"/>
            <a:ext cx="435524" cy="296235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defTabSz="378653"/>
            <a:r>
              <a:rPr lang="en-SG" sz="1325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nput</a:t>
            </a: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C3F45B93-BFAC-410E-AD44-8577C2F5468C}"/>
              </a:ext>
            </a:extLst>
          </p:cNvPr>
          <p:cNvSpPr txBox="1"/>
          <p:nvPr/>
        </p:nvSpPr>
        <p:spPr>
          <a:xfrm rot="16200000">
            <a:off x="6495741" y="3070319"/>
            <a:ext cx="640633" cy="296235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defTabSz="378653"/>
            <a:r>
              <a:rPr lang="en-SG" sz="1325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Unbound</a:t>
            </a: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FC17C181-D2DD-42C9-BCC3-42F369347AB8}"/>
              </a:ext>
            </a:extLst>
          </p:cNvPr>
          <p:cNvSpPr txBox="1"/>
          <p:nvPr/>
        </p:nvSpPr>
        <p:spPr>
          <a:xfrm rot="16200000">
            <a:off x="6845063" y="3172875"/>
            <a:ext cx="435524" cy="296235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defTabSz="378653"/>
            <a:r>
              <a:rPr lang="en-SG" sz="1325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nput</a:t>
            </a: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2E463687-C936-4DB9-ACC6-9A3349A2FEC1}"/>
              </a:ext>
            </a:extLst>
          </p:cNvPr>
          <p:cNvSpPr txBox="1"/>
          <p:nvPr/>
        </p:nvSpPr>
        <p:spPr>
          <a:xfrm rot="16200000">
            <a:off x="6987858" y="3068902"/>
            <a:ext cx="640633" cy="296235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defTabSz="378653"/>
            <a:r>
              <a:rPr lang="en-SG" sz="1325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Unbound</a:t>
            </a:r>
          </a:p>
        </p:txBody>
      </p:sp>
      <p:cxnSp>
        <p:nvCxnSpPr>
          <p:cNvPr id="92" name="Straight Connector 91">
            <a:extLst>
              <a:ext uri="{FF2B5EF4-FFF2-40B4-BE49-F238E27FC236}">
                <a16:creationId xmlns:a16="http://schemas.microsoft.com/office/drawing/2014/main" id="{ED3E37AE-9F13-4641-A116-3F555FD2CDE7}"/>
              </a:ext>
            </a:extLst>
          </p:cNvPr>
          <p:cNvCxnSpPr>
            <a:cxnSpLocks/>
          </p:cNvCxnSpPr>
          <p:nvPr/>
        </p:nvCxnSpPr>
        <p:spPr>
          <a:xfrm>
            <a:off x="6525121" y="2853909"/>
            <a:ext cx="357791" cy="1417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3" name="Straight Connector 92">
            <a:extLst>
              <a:ext uri="{FF2B5EF4-FFF2-40B4-BE49-F238E27FC236}">
                <a16:creationId xmlns:a16="http://schemas.microsoft.com/office/drawing/2014/main" id="{AD7C2923-1EAE-441D-93E8-28861BC69A25}"/>
              </a:ext>
            </a:extLst>
          </p:cNvPr>
          <p:cNvCxnSpPr>
            <a:cxnSpLocks/>
          </p:cNvCxnSpPr>
          <p:nvPr/>
        </p:nvCxnSpPr>
        <p:spPr>
          <a:xfrm>
            <a:off x="7008727" y="2852492"/>
            <a:ext cx="357791" cy="1417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4" name="Straight Connector 93">
            <a:extLst>
              <a:ext uri="{FF2B5EF4-FFF2-40B4-BE49-F238E27FC236}">
                <a16:creationId xmlns:a16="http://schemas.microsoft.com/office/drawing/2014/main" id="{57525205-36BA-4D3B-9D54-32CE4B415E17}"/>
              </a:ext>
            </a:extLst>
          </p:cNvPr>
          <p:cNvCxnSpPr>
            <a:cxnSpLocks/>
          </p:cNvCxnSpPr>
          <p:nvPr/>
        </p:nvCxnSpPr>
        <p:spPr>
          <a:xfrm>
            <a:off x="6541727" y="2312483"/>
            <a:ext cx="357791" cy="1417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5" name="Straight Connector 94">
            <a:extLst>
              <a:ext uri="{FF2B5EF4-FFF2-40B4-BE49-F238E27FC236}">
                <a16:creationId xmlns:a16="http://schemas.microsoft.com/office/drawing/2014/main" id="{56A59B1A-A23D-41AD-856F-DECF55FEF514}"/>
              </a:ext>
            </a:extLst>
          </p:cNvPr>
          <p:cNvCxnSpPr>
            <a:cxnSpLocks/>
          </p:cNvCxnSpPr>
          <p:nvPr/>
        </p:nvCxnSpPr>
        <p:spPr>
          <a:xfrm>
            <a:off x="6996792" y="2319124"/>
            <a:ext cx="357791" cy="1417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6" name="TextBox 95">
            <a:extLst>
              <a:ext uri="{FF2B5EF4-FFF2-40B4-BE49-F238E27FC236}">
                <a16:creationId xmlns:a16="http://schemas.microsoft.com/office/drawing/2014/main" id="{C7741D83-7B65-4C97-90DE-26BBFF371FE2}"/>
              </a:ext>
            </a:extLst>
          </p:cNvPr>
          <p:cNvSpPr txBox="1"/>
          <p:nvPr/>
        </p:nvSpPr>
        <p:spPr>
          <a:xfrm rot="16200000">
            <a:off x="6390538" y="1798450"/>
            <a:ext cx="640635" cy="296235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defTabSz="378653"/>
            <a:r>
              <a:rPr lang="en-SG" sz="1325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id="{A78AF3EF-4EA2-43BE-B04D-11A5EDC8F209}"/>
              </a:ext>
            </a:extLst>
          </p:cNvPr>
          <p:cNvSpPr txBox="1"/>
          <p:nvPr/>
        </p:nvSpPr>
        <p:spPr>
          <a:xfrm rot="16200000">
            <a:off x="6887936" y="1826663"/>
            <a:ext cx="567040" cy="296235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defTabSz="378653"/>
            <a:r>
              <a:rPr lang="en-SG" sz="1325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id="{CAA940B6-A63A-4555-9DE9-B1E63BA93143}"/>
              </a:ext>
            </a:extLst>
          </p:cNvPr>
          <p:cNvSpPr txBox="1"/>
          <p:nvPr/>
        </p:nvSpPr>
        <p:spPr>
          <a:xfrm>
            <a:off x="7520594" y="4205413"/>
            <a:ext cx="677608" cy="3217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378653"/>
            <a:r>
              <a:rPr lang="en-SG" sz="149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lv5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810C174B-2889-4B5A-9435-35E4281BE82A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l="8859" r="11279"/>
          <a:stretch/>
        </p:blipFill>
        <p:spPr>
          <a:xfrm>
            <a:off x="5517055" y="3641417"/>
            <a:ext cx="1967853" cy="166626"/>
          </a:xfrm>
          <a:prstGeom prst="rect">
            <a:avLst/>
          </a:prstGeom>
        </p:spPr>
      </p:pic>
      <p:pic>
        <p:nvPicPr>
          <p:cNvPr id="100" name="Picture 99">
            <a:extLst>
              <a:ext uri="{FF2B5EF4-FFF2-40B4-BE49-F238E27FC236}">
                <a16:creationId xmlns:a16="http://schemas.microsoft.com/office/drawing/2014/main" id="{276E94CE-1764-4B2E-8E33-A5181ACEA6D1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l="8253" r="11883"/>
          <a:stretch/>
        </p:blipFill>
        <p:spPr>
          <a:xfrm>
            <a:off x="5517055" y="3898325"/>
            <a:ext cx="1967853" cy="166626"/>
          </a:xfrm>
          <a:prstGeom prst="rect">
            <a:avLst/>
          </a:prstGeom>
        </p:spPr>
      </p:pic>
      <p:pic>
        <p:nvPicPr>
          <p:cNvPr id="101" name="Picture 100">
            <a:extLst>
              <a:ext uri="{FF2B5EF4-FFF2-40B4-BE49-F238E27FC236}">
                <a16:creationId xmlns:a16="http://schemas.microsoft.com/office/drawing/2014/main" id="{15E6CC9C-2320-4645-99EE-0CB0B84B4450}"/>
              </a:ext>
            </a:extLst>
          </p:cNvPr>
          <p:cNvPicPr>
            <a:picLocks noChangeAspect="1"/>
          </p:cNvPicPr>
          <p:nvPr/>
        </p:nvPicPr>
        <p:blipFill rotWithShape="1">
          <a:blip r:embed="rId12"/>
          <a:srcRect l="8858" r="11278"/>
          <a:stretch/>
        </p:blipFill>
        <p:spPr>
          <a:xfrm>
            <a:off x="5517055" y="4167486"/>
            <a:ext cx="1967853" cy="267611"/>
          </a:xfrm>
          <a:prstGeom prst="rect">
            <a:avLst/>
          </a:prstGeom>
        </p:spPr>
      </p:pic>
      <p:pic>
        <p:nvPicPr>
          <p:cNvPr id="102" name="Picture 101">
            <a:extLst>
              <a:ext uri="{FF2B5EF4-FFF2-40B4-BE49-F238E27FC236}">
                <a16:creationId xmlns:a16="http://schemas.microsoft.com/office/drawing/2014/main" id="{24F6E609-C501-43F2-A390-6967952062BC}"/>
              </a:ext>
            </a:extLst>
          </p:cNvPr>
          <p:cNvPicPr>
            <a:picLocks noChangeAspect="1"/>
          </p:cNvPicPr>
          <p:nvPr/>
        </p:nvPicPr>
        <p:blipFill rotWithShape="1">
          <a:blip r:embed="rId13"/>
          <a:srcRect l="8495" r="11642"/>
          <a:stretch/>
        </p:blipFill>
        <p:spPr>
          <a:xfrm>
            <a:off x="5517055" y="4513483"/>
            <a:ext cx="1967853" cy="166626"/>
          </a:xfrm>
          <a:prstGeom prst="rect">
            <a:avLst/>
          </a:prstGeom>
        </p:spPr>
      </p:pic>
      <p:pic>
        <p:nvPicPr>
          <p:cNvPr id="105" name="Picture 104">
            <a:extLst>
              <a:ext uri="{FF2B5EF4-FFF2-40B4-BE49-F238E27FC236}">
                <a16:creationId xmlns:a16="http://schemas.microsoft.com/office/drawing/2014/main" id="{B6F4AF75-65D5-41E6-B712-D99E976CE060}"/>
              </a:ext>
            </a:extLst>
          </p:cNvPr>
          <p:cNvPicPr>
            <a:picLocks noChangeAspect="1"/>
          </p:cNvPicPr>
          <p:nvPr/>
        </p:nvPicPr>
        <p:blipFill rotWithShape="1">
          <a:blip r:embed="rId14"/>
          <a:srcRect l="10068" r="10068"/>
          <a:stretch/>
        </p:blipFill>
        <p:spPr>
          <a:xfrm>
            <a:off x="5517055" y="4763969"/>
            <a:ext cx="1967853" cy="1449141"/>
          </a:xfrm>
          <a:prstGeom prst="rect">
            <a:avLst/>
          </a:prstGeom>
        </p:spPr>
      </p:pic>
      <p:grpSp>
        <p:nvGrpSpPr>
          <p:cNvPr id="106" name="Group 105">
            <a:extLst>
              <a:ext uri="{FF2B5EF4-FFF2-40B4-BE49-F238E27FC236}">
                <a16:creationId xmlns:a16="http://schemas.microsoft.com/office/drawing/2014/main" id="{A470CC45-9C6D-4A39-92D8-0E7182E30244}"/>
              </a:ext>
            </a:extLst>
          </p:cNvPr>
          <p:cNvGrpSpPr/>
          <p:nvPr/>
        </p:nvGrpSpPr>
        <p:grpSpPr>
          <a:xfrm>
            <a:off x="5304936" y="5495396"/>
            <a:ext cx="237985" cy="277127"/>
            <a:chOff x="3574541" y="4666474"/>
            <a:chExt cx="287345" cy="334606"/>
          </a:xfrm>
        </p:grpSpPr>
        <p:cxnSp>
          <p:nvCxnSpPr>
            <p:cNvPr id="107" name="Straight Connector 106">
              <a:extLst>
                <a:ext uri="{FF2B5EF4-FFF2-40B4-BE49-F238E27FC236}">
                  <a16:creationId xmlns:a16="http://schemas.microsoft.com/office/drawing/2014/main" id="{85F936BF-9365-4E56-91FE-6F60F0A2EE34}"/>
                </a:ext>
              </a:extLst>
            </p:cNvPr>
            <p:cNvCxnSpPr/>
            <p:nvPr/>
          </p:nvCxnSpPr>
          <p:spPr>
            <a:xfrm>
              <a:off x="3768968" y="4795117"/>
              <a:ext cx="90000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8" name="TextBox 107">
              <a:extLst>
                <a:ext uri="{FF2B5EF4-FFF2-40B4-BE49-F238E27FC236}">
                  <a16:creationId xmlns:a16="http://schemas.microsoft.com/office/drawing/2014/main" id="{653ED27C-B2ED-4E60-AAC6-38D2CAED48D9}"/>
                </a:ext>
              </a:extLst>
            </p:cNvPr>
            <p:cNvSpPr txBox="1"/>
            <p:nvPr/>
          </p:nvSpPr>
          <p:spPr>
            <a:xfrm>
              <a:off x="3574541" y="4666474"/>
              <a:ext cx="287345" cy="334606"/>
            </a:xfrm>
            <a:prstGeom prst="rect">
              <a:avLst/>
            </a:prstGeom>
            <a:noFill/>
          </p:spPr>
          <p:txBody>
            <a:bodyPr wrap="square" lIns="0" rIns="0" rtlCol="0">
              <a:spAutoFit/>
            </a:bodyPr>
            <a:lstStyle/>
            <a:p>
              <a:pPr defTabSz="378653"/>
              <a:r>
                <a:rPr lang="en-US" altLang="zh-CN" sz="1201" dirty="0">
                  <a:solidFill>
                    <a:prstClr val="black"/>
                  </a:solidFill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48</a:t>
              </a:r>
              <a:endParaRPr lang="en-SG" sz="120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09" name="Group 108">
            <a:extLst>
              <a:ext uri="{FF2B5EF4-FFF2-40B4-BE49-F238E27FC236}">
                <a16:creationId xmlns:a16="http://schemas.microsoft.com/office/drawing/2014/main" id="{A39CB547-5AEB-4B8D-9CF2-B27F4259BA07}"/>
              </a:ext>
            </a:extLst>
          </p:cNvPr>
          <p:cNvGrpSpPr/>
          <p:nvPr/>
        </p:nvGrpSpPr>
        <p:grpSpPr>
          <a:xfrm>
            <a:off x="5311650" y="5339248"/>
            <a:ext cx="227891" cy="277127"/>
            <a:chOff x="3593532" y="4609729"/>
            <a:chExt cx="275157" cy="334606"/>
          </a:xfrm>
        </p:grpSpPr>
        <p:cxnSp>
          <p:nvCxnSpPr>
            <p:cNvPr id="110" name="Straight Connector 109">
              <a:extLst>
                <a:ext uri="{FF2B5EF4-FFF2-40B4-BE49-F238E27FC236}">
                  <a16:creationId xmlns:a16="http://schemas.microsoft.com/office/drawing/2014/main" id="{505DD3A1-F6B7-4BDA-A9EB-0D17C5E8B5F8}"/>
                </a:ext>
              </a:extLst>
            </p:cNvPr>
            <p:cNvCxnSpPr/>
            <p:nvPr/>
          </p:nvCxnSpPr>
          <p:spPr>
            <a:xfrm>
              <a:off x="3778689" y="4795117"/>
              <a:ext cx="90000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1" name="TextBox 110">
              <a:extLst>
                <a:ext uri="{FF2B5EF4-FFF2-40B4-BE49-F238E27FC236}">
                  <a16:creationId xmlns:a16="http://schemas.microsoft.com/office/drawing/2014/main" id="{CCD3B428-0D48-4FF9-A6F0-80FDB3B25558}"/>
                </a:ext>
              </a:extLst>
            </p:cNvPr>
            <p:cNvSpPr txBox="1"/>
            <p:nvPr/>
          </p:nvSpPr>
          <p:spPr>
            <a:xfrm>
              <a:off x="3593532" y="4609729"/>
              <a:ext cx="204932" cy="334606"/>
            </a:xfrm>
            <a:prstGeom prst="rect">
              <a:avLst/>
            </a:prstGeom>
            <a:noFill/>
          </p:spPr>
          <p:txBody>
            <a:bodyPr wrap="square" lIns="0" rIns="0" rtlCol="0">
              <a:spAutoFit/>
            </a:bodyPr>
            <a:lstStyle/>
            <a:p>
              <a:pPr defTabSz="378653"/>
              <a:r>
                <a:rPr lang="en-US" altLang="zh-CN" sz="1201" dirty="0">
                  <a:solidFill>
                    <a:prstClr val="black"/>
                  </a:solidFill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63</a:t>
              </a:r>
              <a:endParaRPr lang="en-SG" sz="120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12" name="TextBox 111">
            <a:extLst>
              <a:ext uri="{FF2B5EF4-FFF2-40B4-BE49-F238E27FC236}">
                <a16:creationId xmlns:a16="http://schemas.microsoft.com/office/drawing/2014/main" id="{C728D432-C9D9-4ECC-BC6F-509FD24442F6}"/>
              </a:ext>
            </a:extLst>
          </p:cNvPr>
          <p:cNvSpPr txBox="1"/>
          <p:nvPr/>
        </p:nvSpPr>
        <p:spPr>
          <a:xfrm>
            <a:off x="5205724" y="5168332"/>
            <a:ext cx="273056" cy="270715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defTabSz="378653"/>
            <a:r>
              <a:rPr lang="en-SG" sz="1159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en-SG" sz="1159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3" name="TextBox 112">
            <a:extLst>
              <a:ext uri="{FF2B5EF4-FFF2-40B4-BE49-F238E27FC236}">
                <a16:creationId xmlns:a16="http://schemas.microsoft.com/office/drawing/2014/main" id="{27CB444A-9AC5-44E4-9597-1E52414C40E4}"/>
              </a:ext>
            </a:extLst>
          </p:cNvPr>
          <p:cNvSpPr txBox="1"/>
          <p:nvPr/>
        </p:nvSpPr>
        <p:spPr>
          <a:xfrm>
            <a:off x="5046937" y="2413640"/>
            <a:ext cx="416926" cy="296235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defTabSz="378653"/>
            <a:r>
              <a:rPr lang="en-SG" sz="1325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train</a:t>
            </a:r>
          </a:p>
        </p:txBody>
      </p:sp>
      <p:sp>
        <p:nvSpPr>
          <p:cNvPr id="115" name="TextBox 114">
            <a:extLst>
              <a:ext uri="{FF2B5EF4-FFF2-40B4-BE49-F238E27FC236}">
                <a16:creationId xmlns:a16="http://schemas.microsoft.com/office/drawing/2014/main" id="{20C621BA-78EA-4F45-86B2-76EECA165AD6}"/>
              </a:ext>
            </a:extLst>
          </p:cNvPr>
          <p:cNvSpPr txBox="1"/>
          <p:nvPr/>
        </p:nvSpPr>
        <p:spPr>
          <a:xfrm>
            <a:off x="4906660" y="1646524"/>
            <a:ext cx="559124" cy="296235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defTabSz="378653"/>
            <a:r>
              <a:rPr lang="en-SG" sz="1325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lasmid</a:t>
            </a:r>
          </a:p>
        </p:txBody>
      </p:sp>
      <p:cxnSp>
        <p:nvCxnSpPr>
          <p:cNvPr id="43" name="Straight Arrow Connector 42">
            <a:extLst>
              <a:ext uri="{FF2B5EF4-FFF2-40B4-BE49-F238E27FC236}">
                <a16:creationId xmlns:a16="http://schemas.microsoft.com/office/drawing/2014/main" id="{326688CE-AAEA-4FC9-AA82-D82BFA832190}"/>
              </a:ext>
            </a:extLst>
          </p:cNvPr>
          <p:cNvCxnSpPr>
            <a:cxnSpLocks/>
          </p:cNvCxnSpPr>
          <p:nvPr/>
        </p:nvCxnSpPr>
        <p:spPr>
          <a:xfrm rot="-1800000" flipH="1">
            <a:off x="4338200" y="3610679"/>
            <a:ext cx="108000" cy="0"/>
          </a:xfrm>
          <a:prstGeom prst="straightConnector1">
            <a:avLst/>
          </a:prstGeom>
          <a:ln w="15875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3" name="Straight Arrow Connector 102">
            <a:extLst>
              <a:ext uri="{FF2B5EF4-FFF2-40B4-BE49-F238E27FC236}">
                <a16:creationId xmlns:a16="http://schemas.microsoft.com/office/drawing/2014/main" id="{E897D201-D289-46D0-9572-81656AE7F25E}"/>
              </a:ext>
            </a:extLst>
          </p:cNvPr>
          <p:cNvCxnSpPr>
            <a:cxnSpLocks/>
          </p:cNvCxnSpPr>
          <p:nvPr/>
        </p:nvCxnSpPr>
        <p:spPr>
          <a:xfrm rot="-1800000" flipH="1">
            <a:off x="4049168" y="3721039"/>
            <a:ext cx="108000" cy="0"/>
          </a:xfrm>
          <a:prstGeom prst="straightConnector1">
            <a:avLst/>
          </a:prstGeom>
          <a:ln w="15875">
            <a:solidFill>
              <a:schemeClr val="tx1"/>
            </a:solidFill>
            <a:headEnd w="med" len="sm"/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4" name="Straight Arrow Connector 103">
            <a:extLst>
              <a:ext uri="{FF2B5EF4-FFF2-40B4-BE49-F238E27FC236}">
                <a16:creationId xmlns:a16="http://schemas.microsoft.com/office/drawing/2014/main" id="{CFB8A478-6BCC-4193-8D93-BD6E631A54BC}"/>
              </a:ext>
            </a:extLst>
          </p:cNvPr>
          <p:cNvCxnSpPr>
            <a:cxnSpLocks/>
          </p:cNvCxnSpPr>
          <p:nvPr/>
        </p:nvCxnSpPr>
        <p:spPr>
          <a:xfrm rot="-1800000" flipH="1">
            <a:off x="4348710" y="3747316"/>
            <a:ext cx="108000" cy="0"/>
          </a:xfrm>
          <a:prstGeom prst="straightConnector1">
            <a:avLst/>
          </a:prstGeom>
          <a:ln w="15875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4" name="Straight Arrow Connector 113">
            <a:extLst>
              <a:ext uri="{FF2B5EF4-FFF2-40B4-BE49-F238E27FC236}">
                <a16:creationId xmlns:a16="http://schemas.microsoft.com/office/drawing/2014/main" id="{6E17DF3E-6D16-403F-BE11-B45E58F786B0}"/>
              </a:ext>
            </a:extLst>
          </p:cNvPr>
          <p:cNvCxnSpPr>
            <a:cxnSpLocks/>
          </p:cNvCxnSpPr>
          <p:nvPr/>
        </p:nvCxnSpPr>
        <p:spPr>
          <a:xfrm rot="-1800000" flipH="1">
            <a:off x="2850989" y="4141450"/>
            <a:ext cx="108000" cy="0"/>
          </a:xfrm>
          <a:prstGeom prst="straightConnector1">
            <a:avLst/>
          </a:prstGeom>
          <a:ln w="15875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6" name="Straight Arrow Connector 115">
            <a:extLst>
              <a:ext uri="{FF2B5EF4-FFF2-40B4-BE49-F238E27FC236}">
                <a16:creationId xmlns:a16="http://schemas.microsoft.com/office/drawing/2014/main" id="{90B22681-86E2-4562-864C-8AF34F932B64}"/>
              </a:ext>
            </a:extLst>
          </p:cNvPr>
          <p:cNvCxnSpPr>
            <a:cxnSpLocks/>
          </p:cNvCxnSpPr>
          <p:nvPr/>
        </p:nvCxnSpPr>
        <p:spPr>
          <a:xfrm rot="-1800000" flipH="1">
            <a:off x="3119002" y="4136198"/>
            <a:ext cx="108000" cy="0"/>
          </a:xfrm>
          <a:prstGeom prst="straightConnector1">
            <a:avLst/>
          </a:prstGeom>
          <a:ln w="15875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7" name="Straight Arrow Connector 116">
            <a:extLst>
              <a:ext uri="{FF2B5EF4-FFF2-40B4-BE49-F238E27FC236}">
                <a16:creationId xmlns:a16="http://schemas.microsoft.com/office/drawing/2014/main" id="{52EBA7F2-9155-4033-A301-3944E15B5976}"/>
              </a:ext>
            </a:extLst>
          </p:cNvPr>
          <p:cNvCxnSpPr>
            <a:cxnSpLocks/>
          </p:cNvCxnSpPr>
          <p:nvPr/>
        </p:nvCxnSpPr>
        <p:spPr>
          <a:xfrm rot="-1800000" flipH="1">
            <a:off x="3155788" y="3615936"/>
            <a:ext cx="108000" cy="0"/>
          </a:xfrm>
          <a:prstGeom prst="straightConnector1">
            <a:avLst/>
          </a:prstGeom>
          <a:ln w="15875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8" name="Straight Arrow Connector 117">
            <a:extLst>
              <a:ext uri="{FF2B5EF4-FFF2-40B4-BE49-F238E27FC236}">
                <a16:creationId xmlns:a16="http://schemas.microsoft.com/office/drawing/2014/main" id="{2EF8FEE9-EB9F-432D-9909-4875A0ACBA9F}"/>
              </a:ext>
            </a:extLst>
          </p:cNvPr>
          <p:cNvCxnSpPr>
            <a:cxnSpLocks/>
          </p:cNvCxnSpPr>
          <p:nvPr/>
        </p:nvCxnSpPr>
        <p:spPr>
          <a:xfrm rot="-1800000" flipH="1">
            <a:off x="2866756" y="3726296"/>
            <a:ext cx="108000" cy="0"/>
          </a:xfrm>
          <a:prstGeom prst="straightConnector1">
            <a:avLst/>
          </a:prstGeom>
          <a:ln w="15875">
            <a:solidFill>
              <a:schemeClr val="tx1"/>
            </a:solidFill>
            <a:headEnd w="med" len="sm"/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9" name="Straight Arrow Connector 118">
            <a:extLst>
              <a:ext uri="{FF2B5EF4-FFF2-40B4-BE49-F238E27FC236}">
                <a16:creationId xmlns:a16="http://schemas.microsoft.com/office/drawing/2014/main" id="{514DF421-DE1C-4BAD-AAD7-F2C60C27BBB5}"/>
              </a:ext>
            </a:extLst>
          </p:cNvPr>
          <p:cNvCxnSpPr>
            <a:cxnSpLocks/>
          </p:cNvCxnSpPr>
          <p:nvPr/>
        </p:nvCxnSpPr>
        <p:spPr>
          <a:xfrm rot="-1800000" flipH="1">
            <a:off x="3166298" y="3752573"/>
            <a:ext cx="108000" cy="0"/>
          </a:xfrm>
          <a:prstGeom prst="straightConnector1">
            <a:avLst/>
          </a:prstGeom>
          <a:ln w="15875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395463425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4C406359-83F3-4149-A614-E0333B2F170C}"/>
              </a:ext>
            </a:extLst>
          </p:cNvPr>
          <p:cNvSpPr txBox="1"/>
          <p:nvPr/>
        </p:nvSpPr>
        <p:spPr>
          <a:xfrm>
            <a:off x="1263361" y="617569"/>
            <a:ext cx="6617278" cy="307481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 defTabSz="378653"/>
            <a:r>
              <a:rPr lang="en-SG" sz="1491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ure S8: preSu9-HA-Ub IP with mitochondrial lysates of WT versus </a:t>
            </a:r>
            <a:r>
              <a:rPr lang="el-GR" sz="1491" b="1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SG" sz="1491" b="1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ad6</a:t>
            </a:r>
            <a:r>
              <a:rPr lang="en-SG" sz="1491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cells.</a:t>
            </a:r>
          </a:p>
          <a:p>
            <a:pPr algn="just" defTabSz="378653"/>
            <a:endParaRPr lang="en-SG" sz="1491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 defTabSz="378653"/>
            <a:r>
              <a:rPr lang="en-US" sz="149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eft panel: IPs with anti-HA magnetic beads incubated with mitochondrial lysates (containing ~1 mg of proteins) of cells harboring empty vector (Control) or preSu9-HA-Ub. Proteins were eluted from immunoprecipitated beads by boiling the beads in protein loading dye. Input and unbound samples and 1/5 of elution samples were analyzed by western blot. A longer time exposure of anti-Ilv5 antibody is shown on the right, next to the one of shorter time exposure. Arrows indicate the protein bands of the estimated ubiquitinated forms.</a:t>
            </a:r>
          </a:p>
          <a:p>
            <a:pPr indent="-283990" algn="just" defTabSz="378653">
              <a:buFontTx/>
              <a:buAutoNum type="alphaUcParenBoth"/>
            </a:pPr>
            <a:endParaRPr lang="en-US" sz="149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 defTabSz="378653"/>
            <a:r>
              <a:rPr lang="en-US" sz="149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ight panel: Input and unbound samples of IPs analyzed by WB.</a:t>
            </a:r>
            <a:endParaRPr lang="en-US" sz="1491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indent="-283990" algn="just" defTabSz="378653">
              <a:buFontTx/>
              <a:buAutoNum type="alphaUcParenBoth"/>
            </a:pPr>
            <a:endParaRPr lang="en-US" sz="149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2401464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13D1A9BF-BFD5-4DA6-84B7-877CE139C905}"/>
              </a:ext>
            </a:extLst>
          </p:cNvPr>
          <p:cNvSpPr txBox="1"/>
          <p:nvPr/>
        </p:nvSpPr>
        <p:spPr>
          <a:xfrm>
            <a:off x="1236163" y="1012779"/>
            <a:ext cx="6689706" cy="284539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 defTabSz="378653"/>
            <a:r>
              <a:rPr lang="en-SG" sz="1491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ure S1: </a:t>
            </a:r>
            <a:r>
              <a:rPr lang="en-US" sz="1491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Ubiquitin conjugates are detected in mitochondrial fractions (glucose)</a:t>
            </a:r>
            <a:r>
              <a:rPr lang="en-SG" sz="1491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en-US" sz="1491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 defTabSz="378653"/>
            <a:endParaRPr lang="en-US" sz="1491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 defTabSz="378653">
              <a:defRPr/>
            </a:pPr>
            <a:r>
              <a:rPr lang="en-US" sz="1491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op Panel: Subcellular fractions probed for ubiquitin. </a:t>
            </a:r>
            <a:r>
              <a:rPr lang="en-US" sz="149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bcellular fractions prepared from cells grown to logarithmic phase in glucose minimal medium were subjected to analysis as described in the legend of Figure 2. </a:t>
            </a:r>
          </a:p>
          <a:p>
            <a:pPr algn="just" defTabSz="378653">
              <a:defRPr/>
            </a:pPr>
            <a:r>
              <a:rPr lang="en-US" sz="1491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iddle Panels: </a:t>
            </a:r>
            <a:r>
              <a:rPr lang="en-US" sz="149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 (total), C (cytosolic), and M (mitochondrial) fractions were probed with control antibodies against Hsp60 and Hxk1, which are mitochondrial and cytosolic markers, respectively. *</a:t>
            </a:r>
            <a:r>
              <a:rPr lang="en-US" sz="149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</a:t>
            </a:r>
            <a:r>
              <a:rPr lang="en-US" sz="149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the upper bands detected in T and C fractions are non-specific.</a:t>
            </a:r>
          </a:p>
          <a:p>
            <a:pPr algn="just" defTabSz="378653">
              <a:defRPr/>
            </a:pPr>
            <a:r>
              <a:rPr lang="en-US" sz="1491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ottom Panel: </a:t>
            </a:r>
            <a:r>
              <a:rPr lang="en-US" sz="149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bcellular fractions were subjected to </a:t>
            </a:r>
            <a:r>
              <a:rPr lang="en-SG" sz="149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2.5% SDS-PAGE</a:t>
            </a:r>
            <a:r>
              <a:rPr lang="en-US" sz="149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and Coomassie blue staining.</a:t>
            </a:r>
          </a:p>
        </p:txBody>
      </p:sp>
    </p:spTree>
    <p:extLst>
      <p:ext uri="{BB962C8B-B14F-4D97-AF65-F5344CB8AC3E}">
        <p14:creationId xmlns:p14="http://schemas.microsoft.com/office/powerpoint/2010/main" val="273412704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721FB074-D884-46C2-87E4-5ACD641A24AA}"/>
              </a:ext>
            </a:extLst>
          </p:cNvPr>
          <p:cNvSpPr txBox="1"/>
          <p:nvPr/>
        </p:nvSpPr>
        <p:spPr>
          <a:xfrm rot="17812915">
            <a:off x="3729767" y="1907637"/>
            <a:ext cx="209835" cy="226088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defTabSz="685800"/>
            <a:r>
              <a:rPr lang="en-SG" sz="869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T 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EF70E024-6A4C-4EFD-82B1-BC5156C65A57}"/>
              </a:ext>
            </a:extLst>
          </p:cNvPr>
          <p:cNvSpPr txBox="1"/>
          <p:nvPr/>
        </p:nvSpPr>
        <p:spPr>
          <a:xfrm rot="17834967">
            <a:off x="3802422" y="1809229"/>
            <a:ext cx="373754" cy="226088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defTabSz="685800"/>
            <a:r>
              <a:rPr lang="el-GR" sz="869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SG" sz="869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ad6</a:t>
            </a:r>
          </a:p>
        </p:txBody>
      </p:sp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id="{01FD612D-08D1-431E-8B88-791383C7AAE2}"/>
              </a:ext>
            </a:extLst>
          </p:cNvPr>
          <p:cNvCxnSpPr/>
          <p:nvPr/>
        </p:nvCxnSpPr>
        <p:spPr>
          <a:xfrm>
            <a:off x="3985215" y="1370998"/>
            <a:ext cx="42487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>
            <a:extLst>
              <a:ext uri="{FF2B5EF4-FFF2-40B4-BE49-F238E27FC236}">
                <a16:creationId xmlns:a16="http://schemas.microsoft.com/office/drawing/2014/main" id="{C81801AE-AD73-41DC-A532-074D01F60A38}"/>
              </a:ext>
            </a:extLst>
          </p:cNvPr>
          <p:cNvSpPr txBox="1"/>
          <p:nvPr/>
        </p:nvSpPr>
        <p:spPr>
          <a:xfrm>
            <a:off x="3871309" y="927843"/>
            <a:ext cx="661164" cy="4935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685800"/>
            <a:r>
              <a:rPr lang="en-US" sz="869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/o trypsin</a:t>
            </a:r>
          </a:p>
          <a:p>
            <a:pPr algn="ctr" defTabSz="685800"/>
            <a:r>
              <a:rPr lang="en-US" sz="869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reatment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E23BAA7C-3749-4FB8-961E-74F6BBA65304}"/>
              </a:ext>
            </a:extLst>
          </p:cNvPr>
          <p:cNvSpPr txBox="1"/>
          <p:nvPr/>
        </p:nvSpPr>
        <p:spPr>
          <a:xfrm>
            <a:off x="4517521" y="1037431"/>
            <a:ext cx="650097" cy="35984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685800"/>
            <a:r>
              <a:rPr lang="en-US" sz="869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 trypsin</a:t>
            </a:r>
          </a:p>
          <a:p>
            <a:pPr algn="ctr" defTabSz="685800"/>
            <a:r>
              <a:rPr lang="en-US" sz="869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reatment 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9E86D00F-DAB5-4DD8-A2DE-CC41DFC49A47}"/>
              </a:ext>
            </a:extLst>
          </p:cNvPr>
          <p:cNvSpPr txBox="1"/>
          <p:nvPr/>
        </p:nvSpPr>
        <p:spPr>
          <a:xfrm rot="17812915">
            <a:off x="3965138" y="1882115"/>
            <a:ext cx="258376" cy="226088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defTabSz="685800"/>
            <a:r>
              <a:rPr lang="en-SG" sz="869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2BE8178F-819E-4527-A6EB-1B6BBE296498}"/>
              </a:ext>
            </a:extLst>
          </p:cNvPr>
          <p:cNvSpPr txBox="1"/>
          <p:nvPr/>
        </p:nvSpPr>
        <p:spPr>
          <a:xfrm rot="17834967">
            <a:off x="4052830" y="1829534"/>
            <a:ext cx="360665" cy="226088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defTabSz="685800"/>
            <a:r>
              <a:rPr lang="el-GR" sz="869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SG" sz="869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ad6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230C105D-CA73-423E-B4A5-DB40920F9E68}"/>
              </a:ext>
            </a:extLst>
          </p:cNvPr>
          <p:cNvSpPr txBox="1"/>
          <p:nvPr/>
        </p:nvSpPr>
        <p:spPr>
          <a:xfrm rot="17812915">
            <a:off x="4310086" y="1867923"/>
            <a:ext cx="306642" cy="226088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defTabSz="685800"/>
            <a:r>
              <a:rPr lang="en-SG" sz="869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E06EF7CC-870F-43B9-ADDA-4698D1F14ABD}"/>
              </a:ext>
            </a:extLst>
          </p:cNvPr>
          <p:cNvSpPr txBox="1"/>
          <p:nvPr/>
        </p:nvSpPr>
        <p:spPr>
          <a:xfrm rot="17834967">
            <a:off x="4417817" y="1830539"/>
            <a:ext cx="342179" cy="226088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defTabSz="685800"/>
            <a:r>
              <a:rPr lang="el-GR" sz="869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SG" sz="869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ad6</a:t>
            </a:r>
          </a:p>
        </p:txBody>
      </p: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275ECBEC-DC47-4642-BC21-2EF2652B327F}"/>
              </a:ext>
            </a:extLst>
          </p:cNvPr>
          <p:cNvCxnSpPr>
            <a:cxnSpLocks/>
          </p:cNvCxnSpPr>
          <p:nvPr/>
        </p:nvCxnSpPr>
        <p:spPr>
          <a:xfrm>
            <a:off x="4597946" y="1370998"/>
            <a:ext cx="42487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>
            <a:extLst>
              <a:ext uri="{FF2B5EF4-FFF2-40B4-BE49-F238E27FC236}">
                <a16:creationId xmlns:a16="http://schemas.microsoft.com/office/drawing/2014/main" id="{3AF32974-5BBD-4EEC-A8AE-6C4569FF3298}"/>
              </a:ext>
            </a:extLst>
          </p:cNvPr>
          <p:cNvSpPr txBox="1"/>
          <p:nvPr/>
        </p:nvSpPr>
        <p:spPr>
          <a:xfrm rot="17812915">
            <a:off x="4565295" y="1868801"/>
            <a:ext cx="314305" cy="226088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defTabSz="685800"/>
            <a:r>
              <a:rPr lang="en-SG" sz="869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592A5371-B10E-472C-B43A-7A01AFC80BB0}"/>
              </a:ext>
            </a:extLst>
          </p:cNvPr>
          <p:cNvSpPr txBox="1"/>
          <p:nvPr/>
        </p:nvSpPr>
        <p:spPr>
          <a:xfrm rot="17834967">
            <a:off x="4662258" y="1857884"/>
            <a:ext cx="346421" cy="226088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defTabSz="685800"/>
            <a:r>
              <a:rPr lang="el-GR" sz="869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SG" sz="869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ad6</a:t>
            </a:r>
          </a:p>
        </p:txBody>
      </p: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918593B4-8E7C-4C9E-B979-3C2C7D9E91BF}"/>
              </a:ext>
            </a:extLst>
          </p:cNvPr>
          <p:cNvCxnSpPr>
            <a:cxnSpLocks/>
          </p:cNvCxnSpPr>
          <p:nvPr/>
        </p:nvCxnSpPr>
        <p:spPr>
          <a:xfrm>
            <a:off x="3941640" y="973074"/>
            <a:ext cx="109573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>
            <a:extLst>
              <a:ext uri="{FF2B5EF4-FFF2-40B4-BE49-F238E27FC236}">
                <a16:creationId xmlns:a16="http://schemas.microsoft.com/office/drawing/2014/main" id="{702121D7-C781-49ED-9445-4AC8C96CA569}"/>
              </a:ext>
            </a:extLst>
          </p:cNvPr>
          <p:cNvSpPr txBox="1"/>
          <p:nvPr/>
        </p:nvSpPr>
        <p:spPr>
          <a:xfrm>
            <a:off x="4168426" y="754116"/>
            <a:ext cx="728086" cy="2260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685800"/>
            <a:r>
              <a:rPr lang="en-US" sz="869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ito</a:t>
            </a:r>
          </a:p>
        </p:txBody>
      </p:sp>
      <p:cxnSp>
        <p:nvCxnSpPr>
          <p:cNvPr id="42" name="Straight Connector 41">
            <a:extLst>
              <a:ext uri="{FF2B5EF4-FFF2-40B4-BE49-F238E27FC236}">
                <a16:creationId xmlns:a16="http://schemas.microsoft.com/office/drawing/2014/main" id="{B623732E-6B08-4C4A-BF91-3894E0DBB972}"/>
              </a:ext>
            </a:extLst>
          </p:cNvPr>
          <p:cNvCxnSpPr>
            <a:cxnSpLocks/>
          </p:cNvCxnSpPr>
          <p:nvPr/>
        </p:nvCxnSpPr>
        <p:spPr>
          <a:xfrm>
            <a:off x="3829473" y="1816356"/>
            <a:ext cx="22362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Straight Connector 42">
            <a:extLst>
              <a:ext uri="{FF2B5EF4-FFF2-40B4-BE49-F238E27FC236}">
                <a16:creationId xmlns:a16="http://schemas.microsoft.com/office/drawing/2014/main" id="{21870079-A334-4763-BF26-CA036C766877}"/>
              </a:ext>
            </a:extLst>
          </p:cNvPr>
          <p:cNvCxnSpPr>
            <a:cxnSpLocks/>
          </p:cNvCxnSpPr>
          <p:nvPr/>
        </p:nvCxnSpPr>
        <p:spPr>
          <a:xfrm>
            <a:off x="4088560" y="1821335"/>
            <a:ext cx="22362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Straight Connector 43">
            <a:extLst>
              <a:ext uri="{FF2B5EF4-FFF2-40B4-BE49-F238E27FC236}">
                <a16:creationId xmlns:a16="http://schemas.microsoft.com/office/drawing/2014/main" id="{8568C958-9FBB-4EB3-8163-BCB654A80EF1}"/>
              </a:ext>
            </a:extLst>
          </p:cNvPr>
          <p:cNvCxnSpPr>
            <a:cxnSpLocks/>
          </p:cNvCxnSpPr>
          <p:nvPr/>
        </p:nvCxnSpPr>
        <p:spPr>
          <a:xfrm>
            <a:off x="4454766" y="1821336"/>
            <a:ext cx="22362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Straight Connector 44">
            <a:extLst>
              <a:ext uri="{FF2B5EF4-FFF2-40B4-BE49-F238E27FC236}">
                <a16:creationId xmlns:a16="http://schemas.microsoft.com/office/drawing/2014/main" id="{B36908EB-0401-47AD-B234-B180080A6D94}"/>
              </a:ext>
            </a:extLst>
          </p:cNvPr>
          <p:cNvCxnSpPr>
            <a:cxnSpLocks/>
          </p:cNvCxnSpPr>
          <p:nvPr/>
        </p:nvCxnSpPr>
        <p:spPr>
          <a:xfrm>
            <a:off x="4713853" y="1818842"/>
            <a:ext cx="22362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TextBox 45">
            <a:extLst>
              <a:ext uri="{FF2B5EF4-FFF2-40B4-BE49-F238E27FC236}">
                <a16:creationId xmlns:a16="http://schemas.microsoft.com/office/drawing/2014/main" id="{6760BC67-B3B8-4C70-B81D-F58C25DFABF5}"/>
              </a:ext>
            </a:extLst>
          </p:cNvPr>
          <p:cNvSpPr txBox="1"/>
          <p:nvPr/>
        </p:nvSpPr>
        <p:spPr>
          <a:xfrm rot="17812915">
            <a:off x="4060216" y="1467867"/>
            <a:ext cx="431028" cy="226088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defTabSz="685800"/>
            <a:r>
              <a:rPr lang="en-SG" sz="869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Rad6-</a:t>
            </a:r>
            <a:r>
              <a:rPr lang="el-GR" sz="869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endParaRPr lang="en-SG" sz="869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7F70B835-D645-427E-A02F-81A7D9125580}"/>
              </a:ext>
            </a:extLst>
          </p:cNvPr>
          <p:cNvSpPr txBox="1"/>
          <p:nvPr/>
        </p:nvSpPr>
        <p:spPr>
          <a:xfrm rot="17812915">
            <a:off x="3828056" y="1509789"/>
            <a:ext cx="352021" cy="226088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defTabSz="685800"/>
            <a:r>
              <a:rPr lang="en-SG" sz="869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empty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B8370953-E7F7-49E6-A11E-7E91A1C5E99B}"/>
              </a:ext>
            </a:extLst>
          </p:cNvPr>
          <p:cNvSpPr txBox="1"/>
          <p:nvPr/>
        </p:nvSpPr>
        <p:spPr>
          <a:xfrm rot="17812915">
            <a:off x="4663085" y="1472849"/>
            <a:ext cx="431028" cy="226088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defTabSz="685800"/>
            <a:r>
              <a:rPr lang="en-SG" sz="869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Rad6-</a:t>
            </a:r>
            <a:r>
              <a:rPr lang="el-GR" sz="869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endParaRPr lang="en-SG" sz="869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CC674E6F-19C3-418F-8878-3A22CF93508D}"/>
              </a:ext>
            </a:extLst>
          </p:cNvPr>
          <p:cNvSpPr txBox="1"/>
          <p:nvPr/>
        </p:nvSpPr>
        <p:spPr>
          <a:xfrm rot="17812915">
            <a:off x="4430927" y="1514772"/>
            <a:ext cx="352021" cy="226088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defTabSz="685800"/>
            <a:r>
              <a:rPr lang="en-SG" sz="869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empty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DDAC67A6-BE19-44BE-BC24-CED0E6949B74}"/>
              </a:ext>
            </a:extLst>
          </p:cNvPr>
          <p:cNvSpPr txBox="1"/>
          <p:nvPr/>
        </p:nvSpPr>
        <p:spPr>
          <a:xfrm>
            <a:off x="3129858" y="1527243"/>
            <a:ext cx="551831" cy="2260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685800"/>
            <a:r>
              <a:rPr lang="en-US" sz="869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lasmid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C54AA0C0-2184-42CE-8651-245ADEBA1929}"/>
              </a:ext>
            </a:extLst>
          </p:cNvPr>
          <p:cNvSpPr txBox="1"/>
          <p:nvPr/>
        </p:nvSpPr>
        <p:spPr>
          <a:xfrm>
            <a:off x="3190977" y="1883879"/>
            <a:ext cx="490712" cy="2260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685800"/>
            <a:r>
              <a:rPr lang="en-US" sz="869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train</a:t>
            </a:r>
          </a:p>
        </p:txBody>
      </p:sp>
      <p:pic>
        <p:nvPicPr>
          <p:cNvPr id="52" name="Picture 51">
            <a:extLst>
              <a:ext uri="{FF2B5EF4-FFF2-40B4-BE49-F238E27FC236}">
                <a16:creationId xmlns:a16="http://schemas.microsoft.com/office/drawing/2014/main" id="{DED8804A-AA08-48DB-A20D-123D91F7594F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b="7980"/>
          <a:stretch/>
        </p:blipFill>
        <p:spPr>
          <a:xfrm>
            <a:off x="3703236" y="2174764"/>
            <a:ext cx="1306499" cy="1317235"/>
          </a:xfrm>
          <a:prstGeom prst="rect">
            <a:avLst/>
          </a:prstGeom>
        </p:spPr>
      </p:pic>
      <p:sp>
        <p:nvSpPr>
          <p:cNvPr id="53" name="TextBox 52">
            <a:extLst>
              <a:ext uri="{FF2B5EF4-FFF2-40B4-BE49-F238E27FC236}">
                <a16:creationId xmlns:a16="http://schemas.microsoft.com/office/drawing/2014/main" id="{6978B4B5-A70E-426D-96CE-2D26ECF9D563}"/>
              </a:ext>
            </a:extLst>
          </p:cNvPr>
          <p:cNvSpPr txBox="1"/>
          <p:nvPr/>
        </p:nvSpPr>
        <p:spPr>
          <a:xfrm>
            <a:off x="5032481" y="3491635"/>
            <a:ext cx="567995" cy="2260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685800"/>
            <a:r>
              <a:rPr lang="en-US" sz="869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co1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CB567185-9A4C-4764-B75F-E0CA449DB4C9}"/>
              </a:ext>
            </a:extLst>
          </p:cNvPr>
          <p:cNvSpPr txBox="1"/>
          <p:nvPr/>
        </p:nvSpPr>
        <p:spPr>
          <a:xfrm>
            <a:off x="4996980" y="2694806"/>
            <a:ext cx="593539" cy="23096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defTabSz="685800"/>
            <a:r>
              <a:rPr lang="el-GR" sz="90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en-US" sz="90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sz="901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Ub</a:t>
            </a:r>
            <a:endParaRPr lang="en-US" sz="90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690FBB07-A659-4B90-89EC-513B94456681}"/>
              </a:ext>
            </a:extLst>
          </p:cNvPr>
          <p:cNvSpPr txBox="1"/>
          <p:nvPr/>
        </p:nvSpPr>
        <p:spPr>
          <a:xfrm>
            <a:off x="5032481" y="3690729"/>
            <a:ext cx="567995" cy="2260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685800"/>
            <a:r>
              <a:rPr lang="en-US" sz="869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om70</a:t>
            </a:r>
          </a:p>
        </p:txBody>
      </p:sp>
      <p:pic>
        <p:nvPicPr>
          <p:cNvPr id="57" name="Picture 56">
            <a:extLst>
              <a:ext uri="{FF2B5EF4-FFF2-40B4-BE49-F238E27FC236}">
                <a16:creationId xmlns:a16="http://schemas.microsoft.com/office/drawing/2014/main" id="{E92E70C8-A0A5-450B-B190-5B0867FDBC27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38205" t="-4" r="-754" b="-4"/>
          <a:stretch/>
        </p:blipFill>
        <p:spPr>
          <a:xfrm>
            <a:off x="3704943" y="3552080"/>
            <a:ext cx="1210214" cy="112405"/>
          </a:xfrm>
          <a:prstGeom prst="rect">
            <a:avLst/>
          </a:prstGeom>
        </p:spPr>
      </p:pic>
      <p:pic>
        <p:nvPicPr>
          <p:cNvPr id="58" name="Picture 57">
            <a:extLst>
              <a:ext uri="{FF2B5EF4-FFF2-40B4-BE49-F238E27FC236}">
                <a16:creationId xmlns:a16="http://schemas.microsoft.com/office/drawing/2014/main" id="{558AF403-5109-4044-8030-7133EBEB73EB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37451" t="-6" r="1" b="-2"/>
          <a:stretch/>
        </p:blipFill>
        <p:spPr>
          <a:xfrm>
            <a:off x="3701900" y="3763828"/>
            <a:ext cx="1210214" cy="112406"/>
          </a:xfrm>
          <a:prstGeom prst="rect">
            <a:avLst/>
          </a:prstGeom>
        </p:spPr>
      </p:pic>
      <p:sp>
        <p:nvSpPr>
          <p:cNvPr id="64" name="TextBox 63">
            <a:extLst>
              <a:ext uri="{FF2B5EF4-FFF2-40B4-BE49-F238E27FC236}">
                <a16:creationId xmlns:a16="http://schemas.microsoft.com/office/drawing/2014/main" id="{EAB72654-7326-4737-B871-6CB0E453668E}"/>
              </a:ext>
            </a:extLst>
          </p:cNvPr>
          <p:cNvSpPr txBox="1"/>
          <p:nvPr/>
        </p:nvSpPr>
        <p:spPr>
          <a:xfrm rot="17834967">
            <a:off x="4813743" y="1898511"/>
            <a:ext cx="252710" cy="226088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defTabSz="685800"/>
            <a:r>
              <a:rPr lang="en-SG" sz="869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W</a:t>
            </a:r>
          </a:p>
        </p:txBody>
      </p:sp>
      <p:grpSp>
        <p:nvGrpSpPr>
          <p:cNvPr id="66" name="Group 65">
            <a:extLst>
              <a:ext uri="{FF2B5EF4-FFF2-40B4-BE49-F238E27FC236}">
                <a16:creationId xmlns:a16="http://schemas.microsoft.com/office/drawing/2014/main" id="{51383C42-97AD-428A-9AF4-2682ADEF518A}"/>
              </a:ext>
            </a:extLst>
          </p:cNvPr>
          <p:cNvGrpSpPr/>
          <p:nvPr/>
        </p:nvGrpSpPr>
        <p:grpSpPr>
          <a:xfrm>
            <a:off x="3472681" y="2637451"/>
            <a:ext cx="119474" cy="866217"/>
            <a:chOff x="74771" y="2099678"/>
            <a:chExt cx="192338" cy="1394503"/>
          </a:xfrm>
        </p:grpSpPr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2F5A3E9A-3C3B-48AE-A6DD-517F7627AD22}"/>
                </a:ext>
              </a:extLst>
            </p:cNvPr>
            <p:cNvSpPr txBox="1"/>
            <p:nvPr/>
          </p:nvSpPr>
          <p:spPr>
            <a:xfrm>
              <a:off x="75763" y="2705288"/>
              <a:ext cx="179617" cy="184774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defTabSz="685800"/>
              <a:r>
                <a:rPr lang="en-SG" sz="746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5</a:t>
              </a:r>
            </a:p>
          </p:txBody>
        </p:sp>
        <p:sp>
          <p:nvSpPr>
            <p:cNvPr id="70" name="TextBox 69">
              <a:extLst>
                <a:ext uri="{FF2B5EF4-FFF2-40B4-BE49-F238E27FC236}">
                  <a16:creationId xmlns:a16="http://schemas.microsoft.com/office/drawing/2014/main" id="{2B2C9384-A91F-4B9F-9E3B-49B316107BC6}"/>
                </a:ext>
              </a:extLst>
            </p:cNvPr>
            <p:cNvSpPr txBox="1"/>
            <p:nvPr/>
          </p:nvSpPr>
          <p:spPr>
            <a:xfrm>
              <a:off x="79778" y="3046558"/>
              <a:ext cx="187331" cy="184774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defTabSz="685800"/>
              <a:r>
                <a:rPr lang="en-SG" sz="746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1</a:t>
              </a:r>
            </a:p>
          </p:txBody>
        </p:sp>
        <p:sp>
          <p:nvSpPr>
            <p:cNvPr id="71" name="TextBox 70">
              <a:extLst>
                <a:ext uri="{FF2B5EF4-FFF2-40B4-BE49-F238E27FC236}">
                  <a16:creationId xmlns:a16="http://schemas.microsoft.com/office/drawing/2014/main" id="{B4ACF588-FC56-4DDF-8EC1-51EFFE7CA803}"/>
                </a:ext>
              </a:extLst>
            </p:cNvPr>
            <p:cNvSpPr txBox="1"/>
            <p:nvPr/>
          </p:nvSpPr>
          <p:spPr>
            <a:xfrm>
              <a:off x="138780" y="3309407"/>
              <a:ext cx="106211" cy="184774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defTabSz="685800"/>
              <a:r>
                <a:rPr lang="en-SG" sz="746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5</a:t>
              </a:r>
            </a:p>
          </p:txBody>
        </p:sp>
        <p:sp>
          <p:nvSpPr>
            <p:cNvPr id="72" name="TextBox 71">
              <a:extLst>
                <a:ext uri="{FF2B5EF4-FFF2-40B4-BE49-F238E27FC236}">
                  <a16:creationId xmlns:a16="http://schemas.microsoft.com/office/drawing/2014/main" id="{6D6EFFB3-01CC-421A-94CB-21FFD86F5FAC}"/>
                </a:ext>
              </a:extLst>
            </p:cNvPr>
            <p:cNvSpPr txBox="1"/>
            <p:nvPr/>
          </p:nvSpPr>
          <p:spPr>
            <a:xfrm>
              <a:off x="80868" y="2485010"/>
              <a:ext cx="179617" cy="184774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defTabSz="685800"/>
              <a:r>
                <a:rPr lang="en-SG" sz="746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35</a:t>
              </a:r>
            </a:p>
          </p:txBody>
        </p:sp>
        <p:sp>
          <p:nvSpPr>
            <p:cNvPr id="74" name="TextBox 73">
              <a:extLst>
                <a:ext uri="{FF2B5EF4-FFF2-40B4-BE49-F238E27FC236}">
                  <a16:creationId xmlns:a16="http://schemas.microsoft.com/office/drawing/2014/main" id="{FFBA7E91-951F-4DA2-A24E-CF98346C14D8}"/>
                </a:ext>
              </a:extLst>
            </p:cNvPr>
            <p:cNvSpPr txBox="1"/>
            <p:nvPr/>
          </p:nvSpPr>
          <p:spPr>
            <a:xfrm>
              <a:off x="74771" y="2099678"/>
              <a:ext cx="182664" cy="184774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defTabSz="685800"/>
              <a:r>
                <a:rPr lang="en-SG" sz="746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75</a:t>
              </a:r>
            </a:p>
          </p:txBody>
        </p:sp>
      </p:grpSp>
      <p:grpSp>
        <p:nvGrpSpPr>
          <p:cNvPr id="75" name="Group 74">
            <a:extLst>
              <a:ext uri="{FF2B5EF4-FFF2-40B4-BE49-F238E27FC236}">
                <a16:creationId xmlns:a16="http://schemas.microsoft.com/office/drawing/2014/main" id="{06B7C0AC-C888-47E5-AC88-3B55F9ED9D95}"/>
              </a:ext>
            </a:extLst>
          </p:cNvPr>
          <p:cNvGrpSpPr/>
          <p:nvPr/>
        </p:nvGrpSpPr>
        <p:grpSpPr>
          <a:xfrm>
            <a:off x="3599191" y="2705636"/>
            <a:ext cx="89879" cy="747659"/>
            <a:chOff x="4747036" y="4823911"/>
            <a:chExt cx="144694" cy="1203639"/>
          </a:xfrm>
        </p:grpSpPr>
        <p:grpSp>
          <p:nvGrpSpPr>
            <p:cNvPr id="76" name="Group 75">
              <a:extLst>
                <a:ext uri="{FF2B5EF4-FFF2-40B4-BE49-F238E27FC236}">
                  <a16:creationId xmlns:a16="http://schemas.microsoft.com/office/drawing/2014/main" id="{55337FFE-CA1B-484E-8B27-80F7F1EF794D}"/>
                </a:ext>
              </a:extLst>
            </p:cNvPr>
            <p:cNvGrpSpPr/>
            <p:nvPr/>
          </p:nvGrpSpPr>
          <p:grpSpPr>
            <a:xfrm>
              <a:off x="4750958" y="4823911"/>
              <a:ext cx="140772" cy="1203639"/>
              <a:chOff x="3557905" y="3242847"/>
              <a:chExt cx="140772" cy="781461"/>
            </a:xfrm>
          </p:grpSpPr>
          <p:cxnSp>
            <p:nvCxnSpPr>
              <p:cNvPr id="80" name="Straight Connector 79">
                <a:extLst>
                  <a:ext uri="{FF2B5EF4-FFF2-40B4-BE49-F238E27FC236}">
                    <a16:creationId xmlns:a16="http://schemas.microsoft.com/office/drawing/2014/main" id="{B617CB4E-F688-473B-BD60-0FDE4BF71F88}"/>
                  </a:ext>
                </a:extLst>
              </p:cNvPr>
              <p:cNvCxnSpPr/>
              <p:nvPr/>
            </p:nvCxnSpPr>
            <p:spPr>
              <a:xfrm>
                <a:off x="3563161" y="3242847"/>
                <a:ext cx="135516" cy="0"/>
              </a:xfrm>
              <a:prstGeom prst="line">
                <a:avLst/>
              </a:prstGeom>
              <a:ln w="158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1" name="Straight Connector 80">
                <a:extLst>
                  <a:ext uri="{FF2B5EF4-FFF2-40B4-BE49-F238E27FC236}">
                    <a16:creationId xmlns:a16="http://schemas.microsoft.com/office/drawing/2014/main" id="{E75E2C9D-5E96-40FE-B849-CC01173B2A9A}"/>
                  </a:ext>
                </a:extLst>
              </p:cNvPr>
              <p:cNvCxnSpPr/>
              <p:nvPr/>
            </p:nvCxnSpPr>
            <p:spPr>
              <a:xfrm>
                <a:off x="3563158" y="4024308"/>
                <a:ext cx="135516" cy="0"/>
              </a:xfrm>
              <a:prstGeom prst="line">
                <a:avLst/>
              </a:prstGeom>
              <a:ln w="158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2" name="Straight Connector 81">
                <a:extLst>
                  <a:ext uri="{FF2B5EF4-FFF2-40B4-BE49-F238E27FC236}">
                    <a16:creationId xmlns:a16="http://schemas.microsoft.com/office/drawing/2014/main" id="{FF1A7A1E-1364-4E79-9CE0-432DB51FBAB5}"/>
                  </a:ext>
                </a:extLst>
              </p:cNvPr>
              <p:cNvCxnSpPr/>
              <p:nvPr/>
            </p:nvCxnSpPr>
            <p:spPr>
              <a:xfrm>
                <a:off x="3557905" y="3858105"/>
                <a:ext cx="135516" cy="0"/>
              </a:xfrm>
              <a:prstGeom prst="line">
                <a:avLst/>
              </a:prstGeom>
              <a:ln w="158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4" name="Straight Connector 83">
                <a:extLst>
                  <a:ext uri="{FF2B5EF4-FFF2-40B4-BE49-F238E27FC236}">
                    <a16:creationId xmlns:a16="http://schemas.microsoft.com/office/drawing/2014/main" id="{71422FC9-C0AD-4F56-8B62-B4215AC49141}"/>
                  </a:ext>
                </a:extLst>
              </p:cNvPr>
              <p:cNvCxnSpPr/>
              <p:nvPr/>
            </p:nvCxnSpPr>
            <p:spPr>
              <a:xfrm>
                <a:off x="3557906" y="3492295"/>
                <a:ext cx="135516" cy="0"/>
              </a:xfrm>
              <a:prstGeom prst="line">
                <a:avLst/>
              </a:prstGeom>
              <a:ln w="158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77" name="Straight Connector 76">
              <a:extLst>
                <a:ext uri="{FF2B5EF4-FFF2-40B4-BE49-F238E27FC236}">
                  <a16:creationId xmlns:a16="http://schemas.microsoft.com/office/drawing/2014/main" id="{9227AC2A-37ED-4711-B087-B5AC11EBC138}"/>
                </a:ext>
              </a:extLst>
            </p:cNvPr>
            <p:cNvCxnSpPr/>
            <p:nvPr/>
          </p:nvCxnSpPr>
          <p:spPr>
            <a:xfrm>
              <a:off x="4747036" y="5420282"/>
              <a:ext cx="135516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85" name="TextBox 84">
            <a:extLst>
              <a:ext uri="{FF2B5EF4-FFF2-40B4-BE49-F238E27FC236}">
                <a16:creationId xmlns:a16="http://schemas.microsoft.com/office/drawing/2014/main" id="{4F0B500B-700C-43E4-98B0-EE0EFEB208A3}"/>
              </a:ext>
            </a:extLst>
          </p:cNvPr>
          <p:cNvSpPr txBox="1"/>
          <p:nvPr/>
        </p:nvSpPr>
        <p:spPr>
          <a:xfrm>
            <a:off x="3425728" y="2526124"/>
            <a:ext cx="215106" cy="114775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defTabSz="685800"/>
            <a:r>
              <a:rPr lang="en-SG" sz="746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00</a:t>
            </a:r>
          </a:p>
        </p:txBody>
      </p:sp>
      <p:cxnSp>
        <p:nvCxnSpPr>
          <p:cNvPr id="86" name="Straight Connector 85">
            <a:extLst>
              <a:ext uri="{FF2B5EF4-FFF2-40B4-BE49-F238E27FC236}">
                <a16:creationId xmlns:a16="http://schemas.microsoft.com/office/drawing/2014/main" id="{E7402A1F-B4A0-43CA-BEFF-A808D7CB6AB1}"/>
              </a:ext>
            </a:extLst>
          </p:cNvPr>
          <p:cNvCxnSpPr/>
          <p:nvPr/>
        </p:nvCxnSpPr>
        <p:spPr>
          <a:xfrm>
            <a:off x="3604894" y="2590971"/>
            <a:ext cx="84178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7" name="Straight Connector 86">
            <a:extLst>
              <a:ext uri="{FF2B5EF4-FFF2-40B4-BE49-F238E27FC236}">
                <a16:creationId xmlns:a16="http://schemas.microsoft.com/office/drawing/2014/main" id="{A46E8F42-40D6-4332-B20D-EAEDFBD71B9C}"/>
              </a:ext>
            </a:extLst>
          </p:cNvPr>
          <p:cNvCxnSpPr/>
          <p:nvPr/>
        </p:nvCxnSpPr>
        <p:spPr>
          <a:xfrm>
            <a:off x="3602765" y="2375448"/>
            <a:ext cx="84178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9" name="TextBox 88">
            <a:extLst>
              <a:ext uri="{FF2B5EF4-FFF2-40B4-BE49-F238E27FC236}">
                <a16:creationId xmlns:a16="http://schemas.microsoft.com/office/drawing/2014/main" id="{B9283EE7-C0BC-409E-A824-1609B1438389}"/>
              </a:ext>
            </a:extLst>
          </p:cNvPr>
          <p:cNvSpPr txBox="1"/>
          <p:nvPr/>
        </p:nvSpPr>
        <p:spPr>
          <a:xfrm>
            <a:off x="3435962" y="2321440"/>
            <a:ext cx="215106" cy="114775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defTabSz="685800"/>
            <a:r>
              <a:rPr lang="en-SG" sz="746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45</a:t>
            </a: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9173EC79-D16F-44B6-8963-209328A24BC9}"/>
              </a:ext>
            </a:extLst>
          </p:cNvPr>
          <p:cNvSpPr txBox="1"/>
          <p:nvPr/>
        </p:nvSpPr>
        <p:spPr>
          <a:xfrm>
            <a:off x="3438521" y="2208863"/>
            <a:ext cx="215106" cy="114775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defTabSz="685800"/>
            <a:r>
              <a:rPr lang="en-SG" sz="746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en-SG" sz="746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10E743DA-9160-4B06-AF90-A5E450CDCD75}"/>
              </a:ext>
            </a:extLst>
          </p:cNvPr>
          <p:cNvSpPr txBox="1"/>
          <p:nvPr/>
        </p:nvSpPr>
        <p:spPr>
          <a:xfrm>
            <a:off x="1095551" y="4743682"/>
            <a:ext cx="7551179" cy="123944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 defTabSz="283990">
              <a:defRPr/>
            </a:pPr>
            <a:r>
              <a:rPr lang="en-SG" sz="1491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ure S2: Endogenous</a:t>
            </a:r>
            <a:r>
              <a:rPr lang="en-US" sz="1491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ubiquitination in intact mitochondria is protected from external trypsin treatment. </a:t>
            </a:r>
            <a:r>
              <a:rPr lang="en-SG" sz="149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T or </a:t>
            </a:r>
            <a:r>
              <a:rPr lang="el-GR" sz="1491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SG" sz="1491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ad6 </a:t>
            </a:r>
            <a:r>
              <a:rPr lang="en-SG" sz="149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ells containing an empty plasmid or a </a:t>
            </a:r>
            <a:r>
              <a:rPr lang="en-US" sz="149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ad6-</a:t>
            </a:r>
            <a:r>
              <a:rPr lang="el-GR" sz="149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en-SG" sz="149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construct were subjected to subcellular fractionation. Mitochondrial fractions with or without trypsin treatment, were probed for ubiquitin (</a:t>
            </a:r>
            <a:r>
              <a:rPr lang="el-GR" sz="149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α-</a:t>
            </a:r>
            <a:r>
              <a:rPr lang="en-SG" sz="1491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Ub</a:t>
            </a:r>
            <a:r>
              <a:rPr lang="en-SG" sz="149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, Aco1 – inner mitochondrial protein, and Tom70 – MOM protein facing cytosol using WB. </a:t>
            </a:r>
          </a:p>
        </p:txBody>
      </p:sp>
      <p:cxnSp>
        <p:nvCxnSpPr>
          <p:cNvPr id="3" name="Straight Arrow Connector 2">
            <a:extLst>
              <a:ext uri="{FF2B5EF4-FFF2-40B4-BE49-F238E27FC236}">
                <a16:creationId xmlns:a16="http://schemas.microsoft.com/office/drawing/2014/main" id="{873ED231-A1FB-446F-AA78-A925698FC2F1}"/>
              </a:ext>
            </a:extLst>
          </p:cNvPr>
          <p:cNvCxnSpPr>
            <a:cxnSpLocks/>
          </p:cNvCxnSpPr>
          <p:nvPr/>
        </p:nvCxnSpPr>
        <p:spPr>
          <a:xfrm flipH="1">
            <a:off x="5005028" y="3302163"/>
            <a:ext cx="1890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TextBox 5">
            <a:extLst>
              <a:ext uri="{FF2B5EF4-FFF2-40B4-BE49-F238E27FC236}">
                <a16:creationId xmlns:a16="http://schemas.microsoft.com/office/drawing/2014/main" id="{BEC188FE-5ADE-4C81-811B-2595AE6CECE5}"/>
              </a:ext>
            </a:extLst>
          </p:cNvPr>
          <p:cNvSpPr txBox="1"/>
          <p:nvPr/>
        </p:nvSpPr>
        <p:spPr>
          <a:xfrm>
            <a:off x="5164944" y="3184558"/>
            <a:ext cx="83907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685800"/>
            <a:r>
              <a:rPr lang="en-SG" sz="9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ono </a:t>
            </a:r>
            <a:r>
              <a:rPr lang="en-SG" sz="900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Ub</a:t>
            </a:r>
            <a:endParaRPr lang="en-SG" sz="9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3666244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C1C87A3C-DF66-4ACE-85BC-7BADB5D3AC90}"/>
              </a:ext>
            </a:extLst>
          </p:cNvPr>
          <p:cNvGrpSpPr/>
          <p:nvPr/>
        </p:nvGrpSpPr>
        <p:grpSpPr>
          <a:xfrm>
            <a:off x="3222802" y="2638588"/>
            <a:ext cx="841765" cy="247901"/>
            <a:chOff x="986920" y="1231868"/>
            <a:chExt cx="1016353" cy="299317"/>
          </a:xfrm>
        </p:grpSpPr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7BDB6EDB-9D96-4069-8776-7AE7331716BE}"/>
                </a:ext>
              </a:extLst>
            </p:cNvPr>
            <p:cNvSpPr txBox="1"/>
            <p:nvPr/>
          </p:nvSpPr>
          <p:spPr>
            <a:xfrm>
              <a:off x="986920" y="1234979"/>
              <a:ext cx="199697" cy="29620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378653"/>
              <a:r>
                <a:rPr lang="en-SG" sz="994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T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A741FEEA-4B23-4723-8E92-59FEB0A25FA9}"/>
                </a:ext>
              </a:extLst>
            </p:cNvPr>
            <p:cNvSpPr txBox="1"/>
            <p:nvPr/>
          </p:nvSpPr>
          <p:spPr>
            <a:xfrm>
              <a:off x="1270809" y="1231868"/>
              <a:ext cx="199697" cy="29620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378653"/>
              <a:r>
                <a:rPr lang="en-SG" sz="994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04EABFF7-AD10-4757-8C27-ECFC559F5E01}"/>
                </a:ext>
              </a:extLst>
            </p:cNvPr>
            <p:cNvSpPr txBox="1"/>
            <p:nvPr/>
          </p:nvSpPr>
          <p:spPr>
            <a:xfrm>
              <a:off x="1425462" y="1231868"/>
              <a:ext cx="577811" cy="29620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378653"/>
              <a:r>
                <a:rPr lang="en-SG" sz="994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</a:t>
              </a:r>
              <a:endParaRPr lang="en-SG" sz="994" baseline="300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8" name="Group 7">
            <a:extLst>
              <a:ext uri="{FF2B5EF4-FFF2-40B4-BE49-F238E27FC236}">
                <a16:creationId xmlns:a16="http://schemas.microsoft.com/office/drawing/2014/main" id="{D6E4DE85-7C64-406D-8A5D-76B72DC23D97}"/>
              </a:ext>
            </a:extLst>
          </p:cNvPr>
          <p:cNvGrpSpPr/>
          <p:nvPr/>
        </p:nvGrpSpPr>
        <p:grpSpPr>
          <a:xfrm>
            <a:off x="4121234" y="2638588"/>
            <a:ext cx="807313" cy="247901"/>
            <a:chOff x="986920" y="1231868"/>
            <a:chExt cx="974756" cy="299317"/>
          </a:xfrm>
        </p:grpSpPr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30EFEF87-D583-4056-9E72-0A148C3E20E1}"/>
                </a:ext>
              </a:extLst>
            </p:cNvPr>
            <p:cNvSpPr txBox="1"/>
            <p:nvPr/>
          </p:nvSpPr>
          <p:spPr>
            <a:xfrm>
              <a:off x="986920" y="1234979"/>
              <a:ext cx="199697" cy="29620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378653"/>
              <a:r>
                <a:rPr lang="en-SG" sz="994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T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0D358F31-0719-4B60-AF5D-14D8E9C2065A}"/>
                </a:ext>
              </a:extLst>
            </p:cNvPr>
            <p:cNvSpPr txBox="1"/>
            <p:nvPr/>
          </p:nvSpPr>
          <p:spPr>
            <a:xfrm>
              <a:off x="1250489" y="1231868"/>
              <a:ext cx="199697" cy="29620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378653"/>
              <a:r>
                <a:rPr lang="en-SG" sz="994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EF18E86C-A94A-4DA3-A269-55649D6D5300}"/>
                </a:ext>
              </a:extLst>
            </p:cNvPr>
            <p:cNvSpPr txBox="1"/>
            <p:nvPr/>
          </p:nvSpPr>
          <p:spPr>
            <a:xfrm>
              <a:off x="1404184" y="1231868"/>
              <a:ext cx="557492" cy="29620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378653"/>
              <a:r>
                <a:rPr lang="en-SG" sz="994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</a:t>
              </a:r>
            </a:p>
          </p:txBody>
        </p:sp>
      </p:grp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D9CC14C4-96AD-4683-8EF3-172C38042CDC}"/>
              </a:ext>
            </a:extLst>
          </p:cNvPr>
          <p:cNvCxnSpPr>
            <a:cxnSpLocks/>
          </p:cNvCxnSpPr>
          <p:nvPr/>
        </p:nvCxnSpPr>
        <p:spPr>
          <a:xfrm>
            <a:off x="3658905" y="2870578"/>
            <a:ext cx="29816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09FAF086-3707-4012-B697-5656EE0694DB}"/>
              </a:ext>
            </a:extLst>
          </p:cNvPr>
          <p:cNvCxnSpPr>
            <a:cxnSpLocks/>
          </p:cNvCxnSpPr>
          <p:nvPr/>
        </p:nvCxnSpPr>
        <p:spPr>
          <a:xfrm>
            <a:off x="4542451" y="2870578"/>
            <a:ext cx="29816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4" name="Group 13">
            <a:extLst>
              <a:ext uri="{FF2B5EF4-FFF2-40B4-BE49-F238E27FC236}">
                <a16:creationId xmlns:a16="http://schemas.microsoft.com/office/drawing/2014/main" id="{3E97FF67-BBA6-4457-9836-2D0ABD1DBCFD}"/>
              </a:ext>
            </a:extLst>
          </p:cNvPr>
          <p:cNvGrpSpPr/>
          <p:nvPr/>
        </p:nvGrpSpPr>
        <p:grpSpPr>
          <a:xfrm>
            <a:off x="3653664" y="2878586"/>
            <a:ext cx="301105" cy="157929"/>
            <a:chOff x="2671820" y="2627678"/>
            <a:chExt cx="363557" cy="190685"/>
          </a:xfrm>
        </p:grpSpPr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0AF19CED-82E3-47DA-B650-E639E7B017E4}"/>
                </a:ext>
              </a:extLst>
            </p:cNvPr>
            <p:cNvSpPr txBox="1"/>
            <p:nvPr/>
          </p:nvSpPr>
          <p:spPr>
            <a:xfrm>
              <a:off x="2893007" y="2633641"/>
              <a:ext cx="142370" cy="184722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 defTabSz="378653"/>
              <a:r>
                <a:rPr lang="en-SG" sz="994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2294644C-EED1-414D-B968-96EE9078492E}"/>
                </a:ext>
              </a:extLst>
            </p:cNvPr>
            <p:cNvSpPr txBox="1"/>
            <p:nvPr/>
          </p:nvSpPr>
          <p:spPr>
            <a:xfrm>
              <a:off x="2671820" y="2627678"/>
              <a:ext cx="142370" cy="184723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 defTabSz="378653"/>
              <a:r>
                <a:rPr lang="en-SG" sz="994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̶</a:t>
              </a:r>
            </a:p>
          </p:txBody>
        </p:sp>
      </p:grpSp>
      <p:grpSp>
        <p:nvGrpSpPr>
          <p:cNvPr id="17" name="Group 16">
            <a:extLst>
              <a:ext uri="{FF2B5EF4-FFF2-40B4-BE49-F238E27FC236}">
                <a16:creationId xmlns:a16="http://schemas.microsoft.com/office/drawing/2014/main" id="{AE0C7179-0E28-4F90-873F-A18F97F0FC5A}"/>
              </a:ext>
            </a:extLst>
          </p:cNvPr>
          <p:cNvGrpSpPr/>
          <p:nvPr/>
        </p:nvGrpSpPr>
        <p:grpSpPr>
          <a:xfrm>
            <a:off x="4539516" y="2871638"/>
            <a:ext cx="301105" cy="156467"/>
            <a:chOff x="2671820" y="2623481"/>
            <a:chExt cx="363557" cy="188920"/>
          </a:xfrm>
        </p:grpSpPr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BB23D982-C9FD-4023-B52E-9DE6A67AAD9C}"/>
                </a:ext>
              </a:extLst>
            </p:cNvPr>
            <p:cNvSpPr txBox="1"/>
            <p:nvPr/>
          </p:nvSpPr>
          <p:spPr>
            <a:xfrm>
              <a:off x="2893007" y="2623481"/>
              <a:ext cx="142370" cy="184723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 defTabSz="378653"/>
              <a:r>
                <a:rPr lang="en-SG" sz="994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E47C0458-E76F-4CA5-B198-0027D5185736}"/>
                </a:ext>
              </a:extLst>
            </p:cNvPr>
            <p:cNvSpPr txBox="1"/>
            <p:nvPr/>
          </p:nvSpPr>
          <p:spPr>
            <a:xfrm>
              <a:off x="2671820" y="2627678"/>
              <a:ext cx="142370" cy="184723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 defTabSz="378653"/>
              <a:r>
                <a:rPr lang="en-SG" sz="994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̶</a:t>
              </a:r>
            </a:p>
          </p:txBody>
        </p:sp>
      </p:grpSp>
      <p:sp>
        <p:nvSpPr>
          <p:cNvPr id="20" name="TextBox 19">
            <a:extLst>
              <a:ext uri="{FF2B5EF4-FFF2-40B4-BE49-F238E27FC236}">
                <a16:creationId xmlns:a16="http://schemas.microsoft.com/office/drawing/2014/main" id="{00847DF6-0957-4577-BFB8-E6DC5726F82C}"/>
              </a:ext>
            </a:extLst>
          </p:cNvPr>
          <p:cNvSpPr txBox="1"/>
          <p:nvPr/>
        </p:nvSpPr>
        <p:spPr>
          <a:xfrm>
            <a:off x="4894199" y="3078757"/>
            <a:ext cx="765741" cy="245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378653"/>
            <a:r>
              <a:rPr lang="en-SG" sz="994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sp60</a:t>
            </a:r>
          </a:p>
        </p:txBody>
      </p:sp>
      <p:pic>
        <p:nvPicPr>
          <p:cNvPr id="21" name="Picture 20">
            <a:extLst>
              <a:ext uri="{FF2B5EF4-FFF2-40B4-BE49-F238E27FC236}">
                <a16:creationId xmlns:a16="http://schemas.microsoft.com/office/drawing/2014/main" id="{ACBB3B5F-E2D1-4865-B9FA-894381FBE99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96965" y="3091300"/>
            <a:ext cx="787686" cy="242365"/>
          </a:xfrm>
          <a:prstGeom prst="rect">
            <a:avLst/>
          </a:prstGeom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87DC048F-D69C-4E5A-9F58-8FF1FD6BAD8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084521" y="3096687"/>
            <a:ext cx="782637" cy="242365"/>
          </a:xfrm>
          <a:prstGeom prst="rect">
            <a:avLst/>
          </a:prstGeom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id="{74C35F39-5D9B-4408-A6BD-31C1D09E613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196965" y="3922948"/>
            <a:ext cx="787686" cy="242365"/>
          </a:xfrm>
          <a:prstGeom prst="rect">
            <a:avLst/>
          </a:prstGeom>
        </p:spPr>
      </p:pic>
      <p:pic>
        <p:nvPicPr>
          <p:cNvPr id="24" name="Picture 23">
            <a:extLst>
              <a:ext uri="{FF2B5EF4-FFF2-40B4-BE49-F238E27FC236}">
                <a16:creationId xmlns:a16="http://schemas.microsoft.com/office/drawing/2014/main" id="{4BF5EAF0-2E75-4EF8-B67C-4C4E1A3D688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084521" y="3922948"/>
            <a:ext cx="782637" cy="242365"/>
          </a:xfrm>
          <a:prstGeom prst="rect">
            <a:avLst/>
          </a:prstGeom>
        </p:spPr>
      </p:pic>
      <p:sp>
        <p:nvSpPr>
          <p:cNvPr id="25" name="TextBox 24">
            <a:extLst>
              <a:ext uri="{FF2B5EF4-FFF2-40B4-BE49-F238E27FC236}">
                <a16:creationId xmlns:a16="http://schemas.microsoft.com/office/drawing/2014/main" id="{1C71447F-7118-4DDB-A342-4CC6BFB9334E}"/>
              </a:ext>
            </a:extLst>
          </p:cNvPr>
          <p:cNvSpPr txBox="1"/>
          <p:nvPr/>
        </p:nvSpPr>
        <p:spPr>
          <a:xfrm>
            <a:off x="4894198" y="3922695"/>
            <a:ext cx="765741" cy="245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378653"/>
            <a:r>
              <a:rPr lang="en-SG" sz="994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om70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4486394E-4BA7-480E-8553-3B89D4371743}"/>
              </a:ext>
            </a:extLst>
          </p:cNvPr>
          <p:cNvSpPr txBox="1"/>
          <p:nvPr/>
        </p:nvSpPr>
        <p:spPr>
          <a:xfrm>
            <a:off x="4894198" y="3531410"/>
            <a:ext cx="765741" cy="245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378653"/>
            <a:r>
              <a:rPr lang="en-SG" sz="994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xk1</a:t>
            </a:r>
          </a:p>
        </p:txBody>
      </p: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E248F5E2-FDA1-4FA2-9B60-48D8522F7D0A}"/>
              </a:ext>
            </a:extLst>
          </p:cNvPr>
          <p:cNvCxnSpPr>
            <a:cxnSpLocks/>
          </p:cNvCxnSpPr>
          <p:nvPr/>
        </p:nvCxnSpPr>
        <p:spPr>
          <a:xfrm>
            <a:off x="3229580" y="2604311"/>
            <a:ext cx="715583" cy="1603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FB25BF30-5AF7-4546-A5A7-A46E9EE1206A}"/>
              </a:ext>
            </a:extLst>
          </p:cNvPr>
          <p:cNvCxnSpPr>
            <a:cxnSpLocks/>
          </p:cNvCxnSpPr>
          <p:nvPr/>
        </p:nvCxnSpPr>
        <p:spPr>
          <a:xfrm>
            <a:off x="4105399" y="2605914"/>
            <a:ext cx="71558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TextBox 28">
            <a:extLst>
              <a:ext uri="{FF2B5EF4-FFF2-40B4-BE49-F238E27FC236}">
                <a16:creationId xmlns:a16="http://schemas.microsoft.com/office/drawing/2014/main" id="{07DDEE2F-6AE3-4B0B-BE0B-705005D4D7FF}"/>
              </a:ext>
            </a:extLst>
          </p:cNvPr>
          <p:cNvSpPr txBox="1"/>
          <p:nvPr/>
        </p:nvSpPr>
        <p:spPr>
          <a:xfrm>
            <a:off x="3265856" y="2263693"/>
            <a:ext cx="645248" cy="245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378653"/>
            <a:r>
              <a:rPr lang="en-SG" sz="994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A-</a:t>
            </a:r>
            <a:r>
              <a:rPr lang="en-SG" sz="994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Ub</a:t>
            </a:r>
            <a:endParaRPr lang="en-SG" sz="994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0" name="Picture 29">
            <a:extLst>
              <a:ext uri="{FF2B5EF4-FFF2-40B4-BE49-F238E27FC236}">
                <a16:creationId xmlns:a16="http://schemas.microsoft.com/office/drawing/2014/main" id="{B2F7C676-C3A6-4986-B6B9-E78114FD3020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196965" y="3530458"/>
            <a:ext cx="787686" cy="242365"/>
          </a:xfrm>
          <a:prstGeom prst="rect">
            <a:avLst/>
          </a:prstGeom>
        </p:spPr>
      </p:pic>
      <p:pic>
        <p:nvPicPr>
          <p:cNvPr id="31" name="Picture 30">
            <a:extLst>
              <a:ext uri="{FF2B5EF4-FFF2-40B4-BE49-F238E27FC236}">
                <a16:creationId xmlns:a16="http://schemas.microsoft.com/office/drawing/2014/main" id="{68242AFA-B05B-42F7-BC8A-9D0ABA5D9A9D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084521" y="3530458"/>
            <a:ext cx="787686" cy="242365"/>
          </a:xfrm>
          <a:prstGeom prst="rect">
            <a:avLst/>
          </a:prstGeom>
        </p:spPr>
      </p:pic>
      <p:sp>
        <p:nvSpPr>
          <p:cNvPr id="32" name="TextBox 31">
            <a:extLst>
              <a:ext uri="{FF2B5EF4-FFF2-40B4-BE49-F238E27FC236}">
                <a16:creationId xmlns:a16="http://schemas.microsoft.com/office/drawing/2014/main" id="{C6F01365-266A-4D1A-A7DF-4E4C3EA0C586}"/>
              </a:ext>
            </a:extLst>
          </p:cNvPr>
          <p:cNvSpPr txBox="1"/>
          <p:nvPr/>
        </p:nvSpPr>
        <p:spPr>
          <a:xfrm>
            <a:off x="2613263" y="2869562"/>
            <a:ext cx="652592" cy="152991"/>
          </a:xfrm>
          <a:prstGeom prst="rect">
            <a:avLst/>
          </a:prstGeom>
          <a:noFill/>
        </p:spPr>
        <p:txBody>
          <a:bodyPr wrap="square" tIns="0" bIns="0" rtlCol="0">
            <a:spAutoFit/>
          </a:bodyPr>
          <a:lstStyle/>
          <a:p>
            <a:pPr defTabSz="378653"/>
            <a:r>
              <a:rPr lang="en-SG" sz="994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rypsin: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F5CFCDDA-5995-449A-B521-C266650CA0A8}"/>
              </a:ext>
            </a:extLst>
          </p:cNvPr>
          <p:cNvSpPr txBox="1"/>
          <p:nvPr/>
        </p:nvSpPr>
        <p:spPr>
          <a:xfrm>
            <a:off x="4129187" y="2147362"/>
            <a:ext cx="645249" cy="39831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378653"/>
            <a:r>
              <a:rPr lang="en-SG" sz="994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reSu9-</a:t>
            </a:r>
          </a:p>
          <a:p>
            <a:pPr algn="ctr" defTabSz="378653"/>
            <a:r>
              <a:rPr lang="en-SG" sz="994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A-</a:t>
            </a:r>
            <a:r>
              <a:rPr lang="en-SG" sz="994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Ub</a:t>
            </a:r>
            <a:endParaRPr lang="en-SG" sz="994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C8DC4131-F607-4ABC-A751-BC22FDEC1C72}"/>
              </a:ext>
            </a:extLst>
          </p:cNvPr>
          <p:cNvSpPr/>
          <p:nvPr/>
        </p:nvSpPr>
        <p:spPr>
          <a:xfrm>
            <a:off x="1429356" y="4623594"/>
            <a:ext cx="6558505" cy="10100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 defTabSz="378653"/>
            <a:r>
              <a:rPr lang="en-SG" sz="1491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ure S3: </a:t>
            </a:r>
            <a:r>
              <a:rPr lang="en-US" sz="1491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ractionation controls for Figure 3D. </a:t>
            </a:r>
            <a:r>
              <a:rPr lang="en-SG" sz="149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Quality of the fractionation was monitored by mitochondrial marker - Hsp60 and cytosolic marker - Hxk1. T, total fraction; C, cytosolic fraction; M, mitochondrial fraction. Tom70, a mitochondrial outer membrane protein as a marker exposed to trypsin treatment.</a:t>
            </a:r>
            <a:endParaRPr lang="en-SG" sz="1491" dirty="0">
              <a:solidFill>
                <a:prstClr val="black"/>
              </a:solidFill>
              <a:latin typeface="Calibri" panose="020F0502020204030204"/>
            </a:endParaRPr>
          </a:p>
        </p:txBody>
      </p:sp>
      <p:sp>
        <p:nvSpPr>
          <p:cNvPr id="36" name="Title 35">
            <a:extLst>
              <a:ext uri="{FF2B5EF4-FFF2-40B4-BE49-F238E27FC236}">
                <a16:creationId xmlns:a16="http://schemas.microsoft.com/office/drawing/2014/main" id="{3AD5070B-3023-48DB-BAB3-BE014DB0870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9325688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CACFD01-959B-440F-A4EF-60A04B4DF9C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190697" y="1378477"/>
            <a:ext cx="6617279" cy="651600"/>
          </a:xfrm>
        </p:spPr>
        <p:txBody>
          <a:bodyPr/>
          <a:lstStyle/>
          <a:p>
            <a:r>
              <a:rPr lang="en-US" sz="1656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ure S4: Immunoprecipitation (IP) for ubiquitinated conjugates marked by HA</a:t>
            </a:r>
            <a:endParaRPr lang="en-SG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1951D48E-CEF9-4E10-A8D0-FE4C8FCCCC4F}"/>
              </a:ext>
            </a:extLst>
          </p:cNvPr>
          <p:cNvSpPr txBox="1"/>
          <p:nvPr/>
        </p:nvSpPr>
        <p:spPr>
          <a:xfrm>
            <a:off x="1789014" y="2331668"/>
            <a:ext cx="1694296" cy="2707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378653"/>
            <a:r>
              <a:rPr lang="en-SG" sz="1159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 Fractionation quality </a:t>
            </a:r>
          </a:p>
        </p:txBody>
      </p:sp>
      <p:grpSp>
        <p:nvGrpSpPr>
          <p:cNvPr id="7" name="Group 6">
            <a:extLst>
              <a:ext uri="{FF2B5EF4-FFF2-40B4-BE49-F238E27FC236}">
                <a16:creationId xmlns:a16="http://schemas.microsoft.com/office/drawing/2014/main" id="{3D430E15-9B71-4ECA-B394-FC46490E436B}"/>
              </a:ext>
            </a:extLst>
          </p:cNvPr>
          <p:cNvGrpSpPr/>
          <p:nvPr/>
        </p:nvGrpSpPr>
        <p:grpSpPr>
          <a:xfrm>
            <a:off x="6300532" y="2617491"/>
            <a:ext cx="1076916" cy="1115853"/>
            <a:chOff x="4716478" y="1418535"/>
            <a:chExt cx="1248710" cy="1090570"/>
          </a:xfrm>
        </p:grpSpPr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60579C2A-AAA7-4707-8A6C-BE76D509AF0C}"/>
                </a:ext>
              </a:extLst>
            </p:cNvPr>
            <p:cNvSpPr txBox="1"/>
            <p:nvPr/>
          </p:nvSpPr>
          <p:spPr>
            <a:xfrm>
              <a:off x="4716478" y="1418535"/>
              <a:ext cx="1248710" cy="348680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 defTabSz="378653"/>
              <a:r>
                <a:rPr lang="en-SG" sz="1159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reSu9-</a:t>
              </a:r>
            </a:p>
            <a:p>
              <a:pPr algn="ctr" defTabSz="378653"/>
              <a:r>
                <a:rPr lang="en-SG" sz="1159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HA-</a:t>
              </a:r>
              <a:r>
                <a:rPr lang="en-SG" sz="1159" dirty="0" err="1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Ub</a:t>
              </a:r>
              <a:r>
                <a:rPr lang="en-SG" sz="1159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</a:p>
          </p:txBody>
        </p:sp>
        <p:grpSp>
          <p:nvGrpSpPr>
            <p:cNvPr id="26" name="Group 25">
              <a:extLst>
                <a:ext uri="{FF2B5EF4-FFF2-40B4-BE49-F238E27FC236}">
                  <a16:creationId xmlns:a16="http://schemas.microsoft.com/office/drawing/2014/main" id="{1E5167FB-EC19-457A-A3DD-1ACCE37CF39A}"/>
                </a:ext>
              </a:extLst>
            </p:cNvPr>
            <p:cNvGrpSpPr/>
            <p:nvPr/>
          </p:nvGrpSpPr>
          <p:grpSpPr>
            <a:xfrm>
              <a:off x="4978321" y="1786168"/>
              <a:ext cx="495174" cy="722937"/>
              <a:chOff x="2281229" y="1420462"/>
              <a:chExt cx="495174" cy="722937"/>
            </a:xfrm>
          </p:grpSpPr>
          <p:sp>
            <p:nvSpPr>
              <p:cNvPr id="30" name="TextBox 29">
                <a:extLst>
                  <a:ext uri="{FF2B5EF4-FFF2-40B4-BE49-F238E27FC236}">
                    <a16:creationId xmlns:a16="http://schemas.microsoft.com/office/drawing/2014/main" id="{EF9BCFAF-B33A-42D5-A08D-5E8379CCEB0B}"/>
                  </a:ext>
                </a:extLst>
              </p:cNvPr>
              <p:cNvSpPr txBox="1"/>
              <p:nvPr/>
            </p:nvSpPr>
            <p:spPr>
              <a:xfrm rot="17195373">
                <a:off x="2187578" y="1828489"/>
                <a:ext cx="394140" cy="20683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defTabSz="378653"/>
                <a:r>
                  <a:rPr lang="en-SG" sz="1159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nput</a:t>
                </a:r>
              </a:p>
            </p:txBody>
          </p:sp>
          <p:sp>
            <p:nvSpPr>
              <p:cNvPr id="31" name="TextBox 30">
                <a:extLst>
                  <a:ext uri="{FF2B5EF4-FFF2-40B4-BE49-F238E27FC236}">
                    <a16:creationId xmlns:a16="http://schemas.microsoft.com/office/drawing/2014/main" id="{1CE44260-4BB6-4342-BE82-72369A704675}"/>
                  </a:ext>
                </a:extLst>
              </p:cNvPr>
              <p:cNvSpPr txBox="1"/>
              <p:nvPr/>
            </p:nvSpPr>
            <p:spPr>
              <a:xfrm rot="17195373">
                <a:off x="2311515" y="1678512"/>
                <a:ext cx="722937" cy="20683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defTabSz="378653"/>
                <a:r>
                  <a:rPr lang="en-SG" sz="1159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Unbound</a:t>
                </a:r>
              </a:p>
            </p:txBody>
          </p:sp>
        </p:grp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762A6A3B-6718-4334-8BD6-B870E3E84E43}"/>
                </a:ext>
              </a:extLst>
            </p:cNvPr>
            <p:cNvSpPr txBox="1"/>
            <p:nvPr/>
          </p:nvSpPr>
          <p:spPr>
            <a:xfrm rot="17195373">
              <a:off x="5354172" y="2164432"/>
              <a:ext cx="450258" cy="20683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defTabSz="378653"/>
              <a:r>
                <a:rPr lang="en-SG" sz="1159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Elute</a:t>
              </a:r>
            </a:p>
          </p:txBody>
        </p:sp>
        <p:cxnSp>
          <p:nvCxnSpPr>
            <p:cNvPr id="28" name="Straight Connector 27">
              <a:extLst>
                <a:ext uri="{FF2B5EF4-FFF2-40B4-BE49-F238E27FC236}">
                  <a16:creationId xmlns:a16="http://schemas.microsoft.com/office/drawing/2014/main" id="{43F6F05A-212C-4841-A2DA-641D302485EE}"/>
                </a:ext>
              </a:extLst>
            </p:cNvPr>
            <p:cNvCxnSpPr>
              <a:cxnSpLocks/>
            </p:cNvCxnSpPr>
            <p:nvPr/>
          </p:nvCxnSpPr>
          <p:spPr>
            <a:xfrm>
              <a:off x="4994956" y="1861359"/>
              <a:ext cx="756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F9E71A76-2634-4F9A-867E-5A7D4AACCC74}"/>
                </a:ext>
              </a:extLst>
            </p:cNvPr>
            <p:cNvSpPr txBox="1"/>
            <p:nvPr/>
          </p:nvSpPr>
          <p:spPr>
            <a:xfrm rot="17195373">
              <a:off x="4662923" y="2193074"/>
              <a:ext cx="394140" cy="20683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defTabSz="378653"/>
              <a:r>
                <a:rPr lang="en-SG" sz="1159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W</a:t>
              </a:r>
            </a:p>
          </p:txBody>
        </p:sp>
      </p:grpSp>
      <p:pic>
        <p:nvPicPr>
          <p:cNvPr id="8" name="Picture 7">
            <a:extLst>
              <a:ext uri="{FF2B5EF4-FFF2-40B4-BE49-F238E27FC236}">
                <a16:creationId xmlns:a16="http://schemas.microsoft.com/office/drawing/2014/main" id="{1EF5FF5C-E3F3-4484-895E-014DD3394B1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249857" y="3779453"/>
            <a:ext cx="1920667" cy="512634"/>
          </a:xfrm>
          <a:prstGeom prst="rect">
            <a:avLst/>
          </a:prstGeom>
        </p:spPr>
      </p:pic>
      <p:grpSp>
        <p:nvGrpSpPr>
          <p:cNvPr id="9" name="Group 8">
            <a:extLst>
              <a:ext uri="{FF2B5EF4-FFF2-40B4-BE49-F238E27FC236}">
                <a16:creationId xmlns:a16="http://schemas.microsoft.com/office/drawing/2014/main" id="{5693029B-CE1A-4362-A4DE-435C0B68B7D1}"/>
              </a:ext>
            </a:extLst>
          </p:cNvPr>
          <p:cNvGrpSpPr/>
          <p:nvPr/>
        </p:nvGrpSpPr>
        <p:grpSpPr>
          <a:xfrm>
            <a:off x="5255074" y="2797543"/>
            <a:ext cx="859974" cy="935130"/>
            <a:chOff x="4756574" y="1594508"/>
            <a:chExt cx="997161" cy="913942"/>
          </a:xfrm>
        </p:grpSpPr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98BF7736-4316-4DB4-B53D-5EC851DC2EAE}"/>
                </a:ext>
              </a:extLst>
            </p:cNvPr>
            <p:cNvSpPr txBox="1"/>
            <p:nvPr/>
          </p:nvSpPr>
          <p:spPr>
            <a:xfrm>
              <a:off x="4962192" y="1594508"/>
              <a:ext cx="791543" cy="174340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 defTabSz="378653"/>
              <a:r>
                <a:rPr lang="en-SG" sz="1159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HA-</a:t>
              </a:r>
              <a:r>
                <a:rPr lang="en-SG" sz="1159" dirty="0" err="1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Ub</a:t>
              </a:r>
              <a:r>
                <a:rPr lang="en-SG" sz="1159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</a:p>
          </p:txBody>
        </p:sp>
        <p:grpSp>
          <p:nvGrpSpPr>
            <p:cNvPr id="19" name="Group 18">
              <a:extLst>
                <a:ext uri="{FF2B5EF4-FFF2-40B4-BE49-F238E27FC236}">
                  <a16:creationId xmlns:a16="http://schemas.microsoft.com/office/drawing/2014/main" id="{74E31EC5-4D43-4470-98BC-6267D5970307}"/>
                </a:ext>
              </a:extLst>
            </p:cNvPr>
            <p:cNvGrpSpPr/>
            <p:nvPr/>
          </p:nvGrpSpPr>
          <p:grpSpPr>
            <a:xfrm>
              <a:off x="4978320" y="1753528"/>
              <a:ext cx="505786" cy="754922"/>
              <a:chOff x="2281228" y="1387822"/>
              <a:chExt cx="505786" cy="754922"/>
            </a:xfrm>
          </p:grpSpPr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F3A55568-DEB6-4F58-BB5F-FBF588ED654F}"/>
                  </a:ext>
                </a:extLst>
              </p:cNvPr>
              <p:cNvSpPr txBox="1"/>
              <p:nvPr/>
            </p:nvSpPr>
            <p:spPr>
              <a:xfrm rot="17195373">
                <a:off x="2187578" y="1828488"/>
                <a:ext cx="394140" cy="206839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defTabSz="378653"/>
                <a:r>
                  <a:rPr lang="en-SG" sz="1159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nput</a:t>
                </a:r>
              </a:p>
            </p:txBody>
          </p:sp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62657A7A-70F6-4BEF-BB6D-B560BB8C91E7}"/>
                  </a:ext>
                </a:extLst>
              </p:cNvPr>
              <p:cNvSpPr txBox="1"/>
              <p:nvPr/>
            </p:nvSpPr>
            <p:spPr>
              <a:xfrm rot="17195373">
                <a:off x="2306134" y="1661864"/>
                <a:ext cx="754922" cy="20683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defTabSz="378653"/>
                <a:r>
                  <a:rPr lang="en-SG" sz="1159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Unbound</a:t>
                </a:r>
              </a:p>
            </p:txBody>
          </p:sp>
        </p:grp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84576580-2E4D-45F3-8207-466D0B12E530}"/>
                </a:ext>
              </a:extLst>
            </p:cNvPr>
            <p:cNvSpPr txBox="1"/>
            <p:nvPr/>
          </p:nvSpPr>
          <p:spPr>
            <a:xfrm rot="17195373">
              <a:off x="5354172" y="2164432"/>
              <a:ext cx="450258" cy="20683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defTabSz="378653"/>
              <a:r>
                <a:rPr lang="en-SG" sz="1159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Elute</a:t>
              </a:r>
            </a:p>
          </p:txBody>
        </p:sp>
        <p:cxnSp>
          <p:nvCxnSpPr>
            <p:cNvPr id="21" name="Straight Connector 20">
              <a:extLst>
                <a:ext uri="{FF2B5EF4-FFF2-40B4-BE49-F238E27FC236}">
                  <a16:creationId xmlns:a16="http://schemas.microsoft.com/office/drawing/2014/main" id="{736F95F4-1E09-47CC-B764-0C38C55C58D7}"/>
                </a:ext>
              </a:extLst>
            </p:cNvPr>
            <p:cNvCxnSpPr>
              <a:cxnSpLocks/>
            </p:cNvCxnSpPr>
            <p:nvPr/>
          </p:nvCxnSpPr>
          <p:spPr>
            <a:xfrm>
              <a:off x="4994956" y="1861359"/>
              <a:ext cx="756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C92860B1-5109-43D1-9C97-59861902E5BD}"/>
                </a:ext>
              </a:extLst>
            </p:cNvPr>
            <p:cNvSpPr txBox="1"/>
            <p:nvPr/>
          </p:nvSpPr>
          <p:spPr>
            <a:xfrm rot="17195373">
              <a:off x="4662923" y="2193074"/>
              <a:ext cx="394140" cy="20683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defTabSz="378653"/>
              <a:r>
                <a:rPr lang="en-SG" sz="1159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W</a:t>
              </a:r>
            </a:p>
          </p:txBody>
        </p:sp>
      </p:grpSp>
      <p:grpSp>
        <p:nvGrpSpPr>
          <p:cNvPr id="10" name="Group 9">
            <a:extLst>
              <a:ext uri="{FF2B5EF4-FFF2-40B4-BE49-F238E27FC236}">
                <a16:creationId xmlns:a16="http://schemas.microsoft.com/office/drawing/2014/main" id="{E4C0DAA1-78FE-4FFE-A87B-2A871BB019C2}"/>
              </a:ext>
            </a:extLst>
          </p:cNvPr>
          <p:cNvGrpSpPr/>
          <p:nvPr/>
        </p:nvGrpSpPr>
        <p:grpSpPr>
          <a:xfrm>
            <a:off x="4410144" y="2797535"/>
            <a:ext cx="859974" cy="942025"/>
            <a:chOff x="4756574" y="1594508"/>
            <a:chExt cx="997161" cy="920681"/>
          </a:xfrm>
        </p:grpSpPr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F88B9104-0F09-4D3E-8323-B69C7F2EA3D8}"/>
                </a:ext>
              </a:extLst>
            </p:cNvPr>
            <p:cNvSpPr txBox="1"/>
            <p:nvPr/>
          </p:nvSpPr>
          <p:spPr>
            <a:xfrm>
              <a:off x="4962192" y="1594508"/>
              <a:ext cx="791543" cy="174340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 defTabSz="378653"/>
              <a:r>
                <a:rPr lang="en-SG" sz="1159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ontrol </a:t>
              </a:r>
            </a:p>
          </p:txBody>
        </p:sp>
        <p:grpSp>
          <p:nvGrpSpPr>
            <p:cNvPr id="12" name="Group 11">
              <a:extLst>
                <a:ext uri="{FF2B5EF4-FFF2-40B4-BE49-F238E27FC236}">
                  <a16:creationId xmlns:a16="http://schemas.microsoft.com/office/drawing/2014/main" id="{F3682C99-C0A6-4E24-804E-FCAA70A3B5C3}"/>
                </a:ext>
              </a:extLst>
            </p:cNvPr>
            <p:cNvGrpSpPr/>
            <p:nvPr/>
          </p:nvGrpSpPr>
          <p:grpSpPr>
            <a:xfrm>
              <a:off x="4978321" y="1762747"/>
              <a:ext cx="521960" cy="752442"/>
              <a:chOff x="2281229" y="1397041"/>
              <a:chExt cx="521960" cy="752442"/>
            </a:xfrm>
          </p:grpSpPr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57D6AA47-9449-4F7A-8EAD-19B21AEC5E8B}"/>
                  </a:ext>
                </a:extLst>
              </p:cNvPr>
              <p:cNvSpPr txBox="1"/>
              <p:nvPr/>
            </p:nvSpPr>
            <p:spPr>
              <a:xfrm rot="17195373">
                <a:off x="2187578" y="1828489"/>
                <a:ext cx="394140" cy="20683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defTabSz="378653"/>
                <a:r>
                  <a:rPr lang="en-SG" sz="1159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nput</a:t>
                </a:r>
              </a:p>
            </p:txBody>
          </p: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F0EE8CA7-1C8F-4A66-AB8E-11D2151E3313}"/>
                  </a:ext>
                </a:extLst>
              </p:cNvPr>
              <p:cNvSpPr txBox="1"/>
              <p:nvPr/>
            </p:nvSpPr>
            <p:spPr>
              <a:xfrm rot="17195373">
                <a:off x="2323549" y="1669843"/>
                <a:ext cx="752442" cy="20683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defTabSz="378653"/>
                <a:r>
                  <a:rPr lang="en-SG" sz="1159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Unbound</a:t>
                </a:r>
              </a:p>
            </p:txBody>
          </p:sp>
        </p:grp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98DB120A-F238-4AE9-9B70-E6639D947AEA}"/>
                </a:ext>
              </a:extLst>
            </p:cNvPr>
            <p:cNvSpPr txBox="1"/>
            <p:nvPr/>
          </p:nvSpPr>
          <p:spPr>
            <a:xfrm rot="17195373">
              <a:off x="5354172" y="2164432"/>
              <a:ext cx="450258" cy="20683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defTabSz="378653"/>
              <a:r>
                <a:rPr lang="en-SG" sz="1159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Elute</a:t>
              </a:r>
            </a:p>
          </p:txBody>
        </p:sp>
        <p:cxnSp>
          <p:nvCxnSpPr>
            <p:cNvPr id="14" name="Straight Connector 13">
              <a:extLst>
                <a:ext uri="{FF2B5EF4-FFF2-40B4-BE49-F238E27FC236}">
                  <a16:creationId xmlns:a16="http://schemas.microsoft.com/office/drawing/2014/main" id="{98377554-BDE5-4A7E-9D08-C14872A8B8B7}"/>
                </a:ext>
              </a:extLst>
            </p:cNvPr>
            <p:cNvCxnSpPr>
              <a:cxnSpLocks/>
            </p:cNvCxnSpPr>
            <p:nvPr/>
          </p:nvCxnSpPr>
          <p:spPr>
            <a:xfrm>
              <a:off x="4994956" y="1861359"/>
              <a:ext cx="756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5E4C4A55-F417-4993-A565-FBCC8FC325E8}"/>
                </a:ext>
              </a:extLst>
            </p:cNvPr>
            <p:cNvSpPr txBox="1"/>
            <p:nvPr/>
          </p:nvSpPr>
          <p:spPr>
            <a:xfrm rot="17195373">
              <a:off x="4662923" y="2193074"/>
              <a:ext cx="394140" cy="20683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defTabSz="378653"/>
              <a:r>
                <a:rPr lang="en-SG" sz="1159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W</a:t>
              </a:r>
            </a:p>
          </p:txBody>
        </p:sp>
      </p:grpSp>
      <p:sp>
        <p:nvSpPr>
          <p:cNvPr id="32" name="TextBox 31">
            <a:extLst>
              <a:ext uri="{FF2B5EF4-FFF2-40B4-BE49-F238E27FC236}">
                <a16:creationId xmlns:a16="http://schemas.microsoft.com/office/drawing/2014/main" id="{D477A351-28F5-40CD-ADF9-A7A20D428B83}"/>
              </a:ext>
            </a:extLst>
          </p:cNvPr>
          <p:cNvSpPr txBox="1"/>
          <p:nvPr/>
        </p:nvSpPr>
        <p:spPr>
          <a:xfrm>
            <a:off x="4249857" y="2331668"/>
            <a:ext cx="2886371" cy="2707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378653"/>
            <a:r>
              <a:rPr lang="en-SG" sz="1159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 IP products analysed by WB </a:t>
            </a:r>
          </a:p>
        </p:txBody>
      </p:sp>
      <p:pic>
        <p:nvPicPr>
          <p:cNvPr id="33" name="Picture 32">
            <a:extLst>
              <a:ext uri="{FF2B5EF4-FFF2-40B4-BE49-F238E27FC236}">
                <a16:creationId xmlns:a16="http://schemas.microsoft.com/office/drawing/2014/main" id="{AF4CA57A-F759-4417-8F2A-3F4397323B3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758993" y="4172767"/>
            <a:ext cx="1489535" cy="207020"/>
          </a:xfrm>
          <a:prstGeom prst="rect">
            <a:avLst/>
          </a:prstGeom>
        </p:spPr>
      </p:pic>
      <p:pic>
        <p:nvPicPr>
          <p:cNvPr id="34" name="Picture 33">
            <a:extLst>
              <a:ext uri="{FF2B5EF4-FFF2-40B4-BE49-F238E27FC236}">
                <a16:creationId xmlns:a16="http://schemas.microsoft.com/office/drawing/2014/main" id="{7A028AF0-6B99-4901-A43B-E495F3CDBE9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756872" y="4446143"/>
            <a:ext cx="1489535" cy="207020"/>
          </a:xfrm>
          <a:prstGeom prst="rect">
            <a:avLst/>
          </a:prstGeom>
        </p:spPr>
      </p:pic>
      <p:grpSp>
        <p:nvGrpSpPr>
          <p:cNvPr id="35" name="Group 34">
            <a:extLst>
              <a:ext uri="{FF2B5EF4-FFF2-40B4-BE49-F238E27FC236}">
                <a16:creationId xmlns:a16="http://schemas.microsoft.com/office/drawing/2014/main" id="{F2953A52-FCD6-45EA-8E5F-960AEB66B151}"/>
              </a:ext>
            </a:extLst>
          </p:cNvPr>
          <p:cNvGrpSpPr/>
          <p:nvPr/>
        </p:nvGrpSpPr>
        <p:grpSpPr>
          <a:xfrm>
            <a:off x="1911401" y="2760375"/>
            <a:ext cx="740253" cy="1379215"/>
            <a:chOff x="5351878" y="1173666"/>
            <a:chExt cx="893787" cy="1383379"/>
          </a:xfrm>
        </p:grpSpPr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64F320F0-B81A-45DF-BB52-A9568164D31D}"/>
                </a:ext>
              </a:extLst>
            </p:cNvPr>
            <p:cNvSpPr txBox="1"/>
            <p:nvPr/>
          </p:nvSpPr>
          <p:spPr>
            <a:xfrm>
              <a:off x="5586429" y="1173666"/>
              <a:ext cx="590135" cy="2715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378653"/>
              <a:r>
                <a:rPr lang="en-SG" sz="1159" dirty="0" err="1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yto</a:t>
              </a:r>
              <a:endParaRPr lang="en-SG" sz="1159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37" name="Group 36">
              <a:extLst>
                <a:ext uri="{FF2B5EF4-FFF2-40B4-BE49-F238E27FC236}">
                  <a16:creationId xmlns:a16="http://schemas.microsoft.com/office/drawing/2014/main" id="{1C462688-D1CE-4E70-8963-9AD955B7D332}"/>
                </a:ext>
              </a:extLst>
            </p:cNvPr>
            <p:cNvGrpSpPr/>
            <p:nvPr/>
          </p:nvGrpSpPr>
          <p:grpSpPr>
            <a:xfrm>
              <a:off x="5388430" y="1395746"/>
              <a:ext cx="857235" cy="1161299"/>
              <a:chOff x="925176" y="-460161"/>
              <a:chExt cx="857235" cy="1161299"/>
            </a:xfrm>
          </p:grpSpPr>
          <p:sp>
            <p:nvSpPr>
              <p:cNvPr id="39" name="TextBox 38">
                <a:extLst>
                  <a:ext uri="{FF2B5EF4-FFF2-40B4-BE49-F238E27FC236}">
                    <a16:creationId xmlns:a16="http://schemas.microsoft.com/office/drawing/2014/main" id="{F90217E2-B486-4374-9E72-ADCF049BC7A1}"/>
                  </a:ext>
                </a:extLst>
              </p:cNvPr>
              <p:cNvSpPr txBox="1"/>
              <p:nvPr/>
            </p:nvSpPr>
            <p:spPr>
              <a:xfrm rot="17195373">
                <a:off x="761470" y="284886"/>
                <a:ext cx="542791" cy="215380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defTabSz="378653"/>
                <a:r>
                  <a:rPr lang="en-SG" sz="1159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ontrol</a:t>
                </a:r>
              </a:p>
            </p:txBody>
          </p:sp>
          <p:sp>
            <p:nvSpPr>
              <p:cNvPr id="40" name="TextBox 39">
                <a:extLst>
                  <a:ext uri="{FF2B5EF4-FFF2-40B4-BE49-F238E27FC236}">
                    <a16:creationId xmlns:a16="http://schemas.microsoft.com/office/drawing/2014/main" id="{E446D4C2-B46C-4414-8988-ED778F559884}"/>
                  </a:ext>
                </a:extLst>
              </p:cNvPr>
              <p:cNvSpPr txBox="1"/>
              <p:nvPr/>
            </p:nvSpPr>
            <p:spPr>
              <a:xfrm rot="16955219">
                <a:off x="1056430" y="334368"/>
                <a:ext cx="518160" cy="215380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defTabSz="378653"/>
                <a:r>
                  <a:rPr lang="en-SG" sz="1159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A-</a:t>
                </a:r>
                <a:r>
                  <a:rPr lang="en-SG" sz="1159" dirty="0" err="1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Ub</a:t>
                </a:r>
                <a:endParaRPr lang="en-SG" sz="1159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1" name="TextBox 40">
                <a:extLst>
                  <a:ext uri="{FF2B5EF4-FFF2-40B4-BE49-F238E27FC236}">
                    <a16:creationId xmlns:a16="http://schemas.microsoft.com/office/drawing/2014/main" id="{951CAB2B-7969-4C93-BE44-158AFB9EA275}"/>
                  </a:ext>
                </a:extLst>
              </p:cNvPr>
              <p:cNvSpPr txBox="1"/>
              <p:nvPr/>
            </p:nvSpPr>
            <p:spPr>
              <a:xfrm rot="16988853">
                <a:off x="1103934" y="2936"/>
                <a:ext cx="1141574" cy="215380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defTabSz="378653"/>
                <a:r>
                  <a:rPr lang="en-SG" sz="1159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reSu9-HA-Ub</a:t>
                </a:r>
              </a:p>
            </p:txBody>
          </p:sp>
        </p:grpSp>
        <p:cxnSp>
          <p:nvCxnSpPr>
            <p:cNvPr id="38" name="Straight Connector 37">
              <a:extLst>
                <a:ext uri="{FF2B5EF4-FFF2-40B4-BE49-F238E27FC236}">
                  <a16:creationId xmlns:a16="http://schemas.microsoft.com/office/drawing/2014/main" id="{B57BA3A2-0D99-4B80-992A-C2890FE7F603}"/>
                </a:ext>
              </a:extLst>
            </p:cNvPr>
            <p:cNvCxnSpPr>
              <a:cxnSpLocks/>
            </p:cNvCxnSpPr>
            <p:nvPr/>
          </p:nvCxnSpPr>
          <p:spPr>
            <a:xfrm>
              <a:off x="5351878" y="1484212"/>
              <a:ext cx="864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2" name="Group 41">
            <a:extLst>
              <a:ext uri="{FF2B5EF4-FFF2-40B4-BE49-F238E27FC236}">
                <a16:creationId xmlns:a16="http://schemas.microsoft.com/office/drawing/2014/main" id="{D2CA886F-7373-418D-9971-D5D471D0C698}"/>
              </a:ext>
            </a:extLst>
          </p:cNvPr>
          <p:cNvGrpSpPr/>
          <p:nvPr/>
        </p:nvGrpSpPr>
        <p:grpSpPr>
          <a:xfrm>
            <a:off x="2685972" y="2757614"/>
            <a:ext cx="751536" cy="1378002"/>
            <a:chOff x="5386292" y="1173670"/>
            <a:chExt cx="907410" cy="1383375"/>
          </a:xfrm>
        </p:grpSpPr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31F0110F-DE04-4DBD-B859-D905B058E043}"/>
                </a:ext>
              </a:extLst>
            </p:cNvPr>
            <p:cNvSpPr txBox="1"/>
            <p:nvPr/>
          </p:nvSpPr>
          <p:spPr>
            <a:xfrm>
              <a:off x="5615613" y="1173670"/>
              <a:ext cx="590135" cy="2717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378653"/>
              <a:r>
                <a:rPr lang="en-SG" sz="1159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ito</a:t>
              </a:r>
            </a:p>
          </p:txBody>
        </p:sp>
        <p:grpSp>
          <p:nvGrpSpPr>
            <p:cNvPr id="44" name="Group 43">
              <a:extLst>
                <a:ext uri="{FF2B5EF4-FFF2-40B4-BE49-F238E27FC236}">
                  <a16:creationId xmlns:a16="http://schemas.microsoft.com/office/drawing/2014/main" id="{CDA7A80E-57F9-455A-AF49-535601EC84B5}"/>
                </a:ext>
              </a:extLst>
            </p:cNvPr>
            <p:cNvGrpSpPr/>
            <p:nvPr/>
          </p:nvGrpSpPr>
          <p:grpSpPr>
            <a:xfrm>
              <a:off x="5386292" y="1489208"/>
              <a:ext cx="822547" cy="1067837"/>
              <a:chOff x="923038" y="-366699"/>
              <a:chExt cx="822547" cy="1067837"/>
            </a:xfrm>
          </p:grpSpPr>
          <p:sp>
            <p:nvSpPr>
              <p:cNvPr id="46" name="TextBox 45">
                <a:extLst>
                  <a:ext uri="{FF2B5EF4-FFF2-40B4-BE49-F238E27FC236}">
                    <a16:creationId xmlns:a16="http://schemas.microsoft.com/office/drawing/2014/main" id="{3CDC0D13-9A80-4829-8E5B-DFC6604F40CE}"/>
                  </a:ext>
                </a:extLst>
              </p:cNvPr>
              <p:cNvSpPr txBox="1"/>
              <p:nvPr/>
            </p:nvSpPr>
            <p:spPr>
              <a:xfrm rot="17195373">
                <a:off x="735936" y="269584"/>
                <a:ext cx="589584" cy="215380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defTabSz="378653"/>
                <a:r>
                  <a:rPr lang="en-SG" sz="1159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ontrol</a:t>
                </a:r>
              </a:p>
            </p:txBody>
          </p:sp>
          <p:sp>
            <p:nvSpPr>
              <p:cNvPr id="47" name="TextBox 46">
                <a:extLst>
                  <a:ext uri="{FF2B5EF4-FFF2-40B4-BE49-F238E27FC236}">
                    <a16:creationId xmlns:a16="http://schemas.microsoft.com/office/drawing/2014/main" id="{F927C302-BB73-4948-8C83-9B30BB7B4732}"/>
                  </a:ext>
                </a:extLst>
              </p:cNvPr>
              <p:cNvSpPr txBox="1"/>
              <p:nvPr/>
            </p:nvSpPr>
            <p:spPr>
              <a:xfrm rot="16955219">
                <a:off x="1036974" y="334368"/>
                <a:ext cx="518160" cy="215380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defTabSz="378653"/>
                <a:r>
                  <a:rPr lang="en-SG" sz="1159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A-</a:t>
                </a:r>
                <a:r>
                  <a:rPr lang="en-SG" sz="1159" dirty="0" err="1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Ub</a:t>
                </a:r>
                <a:endParaRPr lang="en-SG" sz="1159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8" name="TextBox 47">
                <a:extLst>
                  <a:ext uri="{FF2B5EF4-FFF2-40B4-BE49-F238E27FC236}">
                    <a16:creationId xmlns:a16="http://schemas.microsoft.com/office/drawing/2014/main" id="{C970EBD3-9AAE-4A47-8B03-E2C7CAFCA5CA}"/>
                  </a:ext>
                </a:extLst>
              </p:cNvPr>
              <p:cNvSpPr txBox="1"/>
              <p:nvPr/>
            </p:nvSpPr>
            <p:spPr>
              <a:xfrm rot="16988853">
                <a:off x="1115221" y="48285"/>
                <a:ext cx="1045347" cy="215380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defTabSz="378653"/>
                <a:r>
                  <a:rPr lang="en-SG" sz="1159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reSu9-HA-Ub</a:t>
                </a:r>
              </a:p>
            </p:txBody>
          </p:sp>
        </p:grpSp>
        <p:cxnSp>
          <p:nvCxnSpPr>
            <p:cNvPr id="45" name="Straight Connector 44">
              <a:extLst>
                <a:ext uri="{FF2B5EF4-FFF2-40B4-BE49-F238E27FC236}">
                  <a16:creationId xmlns:a16="http://schemas.microsoft.com/office/drawing/2014/main" id="{55C4ECFA-3942-4E24-80D0-BC25E9E17EC5}"/>
                </a:ext>
              </a:extLst>
            </p:cNvPr>
            <p:cNvCxnSpPr>
              <a:cxnSpLocks/>
            </p:cNvCxnSpPr>
            <p:nvPr/>
          </p:nvCxnSpPr>
          <p:spPr>
            <a:xfrm>
              <a:off x="5429702" y="1484216"/>
              <a:ext cx="864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9" name="TextBox 48">
            <a:extLst>
              <a:ext uri="{FF2B5EF4-FFF2-40B4-BE49-F238E27FC236}">
                <a16:creationId xmlns:a16="http://schemas.microsoft.com/office/drawing/2014/main" id="{5AF1131D-88E4-4396-89B1-33A0DBFBC599}"/>
              </a:ext>
            </a:extLst>
          </p:cNvPr>
          <p:cNvSpPr txBox="1"/>
          <p:nvPr/>
        </p:nvSpPr>
        <p:spPr>
          <a:xfrm>
            <a:off x="3229805" y="4132944"/>
            <a:ext cx="765741" cy="2707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378653"/>
            <a:r>
              <a:rPr lang="en-SG" sz="1159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om70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A0849EAB-4516-4B4D-9844-5CDC2A98C75A}"/>
              </a:ext>
            </a:extLst>
          </p:cNvPr>
          <p:cNvSpPr txBox="1"/>
          <p:nvPr/>
        </p:nvSpPr>
        <p:spPr>
          <a:xfrm>
            <a:off x="3246414" y="4415231"/>
            <a:ext cx="765741" cy="2707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378653"/>
            <a:r>
              <a:rPr lang="en-SG" sz="1159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xk1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D893259F-BC05-4CE9-BF1C-835CCF6D4383}"/>
              </a:ext>
            </a:extLst>
          </p:cNvPr>
          <p:cNvSpPr txBox="1"/>
          <p:nvPr/>
        </p:nvSpPr>
        <p:spPr>
          <a:xfrm>
            <a:off x="7135013" y="3908316"/>
            <a:ext cx="765741" cy="2707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378653"/>
            <a:r>
              <a:rPr lang="en-SG" sz="1159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α-HA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1966577E-34AB-4D69-AFFB-BEA9CBDA8DB2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237105" y="3774365"/>
            <a:ext cx="898770" cy="5554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2470458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B8E01D2F-7C7E-4CBA-80EC-3E75C16E57CA}"/>
              </a:ext>
            </a:extLst>
          </p:cNvPr>
          <p:cNvSpPr txBox="1"/>
          <p:nvPr/>
        </p:nvSpPr>
        <p:spPr>
          <a:xfrm>
            <a:off x="1236163" y="1012772"/>
            <a:ext cx="6689706" cy="37630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 defTabSz="378653"/>
            <a:r>
              <a:rPr lang="en-SG" sz="1491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ure S4:</a:t>
            </a:r>
            <a:r>
              <a:rPr lang="zh-CN" altLang="en-US" sz="1491" b="1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SG" altLang="zh-CN" sz="1491" b="1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Immunoprecipitation (IP) for ubiquitinated conjugates marked by HA</a:t>
            </a:r>
            <a:endParaRPr lang="en-SG" sz="1491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 defTabSz="378653"/>
            <a:endParaRPr lang="en-SG" sz="1491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indent="-283990" algn="just" defTabSz="378653">
              <a:buFontTx/>
              <a:buAutoNum type="alphaUcParenBoth"/>
            </a:pPr>
            <a:r>
              <a:rPr lang="en-US" sz="1491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Quality of mitochondrial isolate. </a:t>
            </a:r>
            <a:r>
              <a:rPr lang="en-US" sz="149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itochondrial (Mito) and cytosolic (</a:t>
            </a:r>
            <a:r>
              <a:rPr lang="en-US" sz="1491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yto</a:t>
            </a:r>
            <a:r>
              <a:rPr lang="en-US" sz="149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 fractions corresponding to approximately 2x and 1x cells respectively were loaded for WB to verify the efficiency in separation between the indicated two types of fractions. Hxk1, cytosolic marker; Tom70, mitochondrial marker.</a:t>
            </a:r>
          </a:p>
          <a:p>
            <a:pPr indent="-283990" algn="just" defTabSz="378653">
              <a:buFontTx/>
              <a:buAutoNum type="alphaUcParenBoth"/>
            </a:pPr>
            <a:endParaRPr lang="en-US" sz="1491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indent="-283990" algn="just" defTabSz="378653">
              <a:buFontTx/>
              <a:buAutoNum type="alphaUcParenBoth"/>
            </a:pPr>
            <a:r>
              <a:rPr lang="en-SG" sz="1491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IP products analysed by WB. </a:t>
            </a:r>
            <a:r>
              <a:rPr lang="en-SG" sz="149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hree</a:t>
            </a:r>
            <a:r>
              <a:rPr lang="en-SG" sz="1491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SG" sz="149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Ps (anti-HA) were conducted in parallel using the different lysed mitochondria described in (A). 300 </a:t>
            </a:r>
            <a:r>
              <a:rPr lang="el-GR" sz="149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SG" sz="149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 of lysate corresponding to ~180</a:t>
            </a:r>
            <a:r>
              <a:rPr lang="en-US" sz="149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OD</a:t>
            </a:r>
            <a:r>
              <a:rPr lang="en-US" sz="1491" baseline="-250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600</a:t>
            </a:r>
            <a:r>
              <a:rPr lang="en-US" sz="149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units of yeast cells</a:t>
            </a:r>
            <a:r>
              <a:rPr lang="en-SG" sz="149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were applied for each IP. 0.1 M glycine solution, pH 2.0, was used to elute proteins from immunoprecipitated beads. Lysates before (Input) and after (Unbound) incubation with anti-HA magnetic beads were loaded in the same volume for WB. One 11</a:t>
            </a:r>
            <a:r>
              <a:rPr lang="en-SG" sz="1491" baseline="300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h</a:t>
            </a:r>
            <a:r>
              <a:rPr lang="en-SG" sz="149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of each elution was loaded for WB. Precipitation of ubiquitinated conjugates marked by HA was confirmed using primary antibody against HA (</a:t>
            </a:r>
            <a:r>
              <a:rPr lang="el-GR" sz="149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en-SG" sz="149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HA). </a:t>
            </a:r>
          </a:p>
        </p:txBody>
      </p:sp>
    </p:spTree>
    <p:extLst>
      <p:ext uri="{BB962C8B-B14F-4D97-AF65-F5344CB8AC3E}">
        <p14:creationId xmlns:p14="http://schemas.microsoft.com/office/powerpoint/2010/main" val="219542402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8B82EEA0-7107-45F5-9D72-E5E080013A5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334606" y="2723237"/>
            <a:ext cx="2529685" cy="1004805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DF1200D4-AC8A-4B93-9B86-3BF0868F8436}"/>
              </a:ext>
            </a:extLst>
          </p:cNvPr>
          <p:cNvSpPr txBox="1"/>
          <p:nvPr/>
        </p:nvSpPr>
        <p:spPr>
          <a:xfrm>
            <a:off x="1333484" y="592554"/>
            <a:ext cx="6531929" cy="5511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defTabSz="378653"/>
            <a:r>
              <a:rPr lang="en-SG" sz="1491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ure S5: preSu9-HA-Ub conjugates patterns in cells deficient in E3 (related) proteins</a:t>
            </a:r>
            <a:endParaRPr lang="en-SG" sz="1491" b="1" dirty="0">
              <a:solidFill>
                <a:prstClr val="black"/>
              </a:solidFill>
              <a:latin typeface="Calibri" panose="020F0502020204030204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2945F062-4131-4828-A9B1-052031C37DDD}"/>
              </a:ext>
            </a:extLst>
          </p:cNvPr>
          <p:cNvSpPr txBox="1"/>
          <p:nvPr/>
        </p:nvSpPr>
        <p:spPr>
          <a:xfrm rot="16200000">
            <a:off x="4483764" y="2241409"/>
            <a:ext cx="503226" cy="289208"/>
          </a:xfrm>
          <a:prstGeom prst="rect">
            <a:avLst/>
          </a:prstGeom>
          <a:noFill/>
        </p:spPr>
        <p:txBody>
          <a:bodyPr wrap="square" lIns="0" tIns="38761" rIns="0" rtlCol="0">
            <a:spAutoFit/>
          </a:bodyPr>
          <a:lstStyle/>
          <a:p>
            <a:pPr defTabSz="378653"/>
            <a:r>
              <a:rPr lang="el-GR" sz="1325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SG" sz="1325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ad18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326F14D2-55F4-4395-8F28-6577B0EEA204}"/>
              </a:ext>
            </a:extLst>
          </p:cNvPr>
          <p:cNvSpPr txBox="1"/>
          <p:nvPr/>
        </p:nvSpPr>
        <p:spPr>
          <a:xfrm rot="16200000">
            <a:off x="4639881" y="2248049"/>
            <a:ext cx="503226" cy="289208"/>
          </a:xfrm>
          <a:prstGeom prst="rect">
            <a:avLst/>
          </a:prstGeom>
          <a:noFill/>
        </p:spPr>
        <p:txBody>
          <a:bodyPr wrap="square" lIns="0" tIns="38761" rIns="0" rtlCol="0">
            <a:spAutoFit/>
          </a:bodyPr>
          <a:lstStyle/>
          <a:p>
            <a:pPr defTabSz="378653"/>
            <a:r>
              <a:rPr lang="el-GR" sz="1325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SG" sz="1325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re1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187C930D-2450-4C5E-B289-CC46C6F6EE5F}"/>
              </a:ext>
            </a:extLst>
          </p:cNvPr>
          <p:cNvSpPr txBox="1"/>
          <p:nvPr/>
        </p:nvSpPr>
        <p:spPr>
          <a:xfrm rot="16200000">
            <a:off x="4794854" y="2253860"/>
            <a:ext cx="503226" cy="289208"/>
          </a:xfrm>
          <a:prstGeom prst="rect">
            <a:avLst/>
          </a:prstGeom>
          <a:noFill/>
        </p:spPr>
        <p:txBody>
          <a:bodyPr wrap="square" lIns="0" tIns="38761" rIns="0" rtlCol="0">
            <a:spAutoFit/>
          </a:bodyPr>
          <a:lstStyle/>
          <a:p>
            <a:pPr defTabSz="378653"/>
            <a:r>
              <a:rPr lang="el-GR" sz="1325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SG" sz="1325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ubr1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4193240D-B35F-4981-B262-033D12A03809}"/>
              </a:ext>
            </a:extLst>
          </p:cNvPr>
          <p:cNvSpPr txBox="1"/>
          <p:nvPr/>
        </p:nvSpPr>
        <p:spPr>
          <a:xfrm rot="16200000">
            <a:off x="4950970" y="2260501"/>
            <a:ext cx="503226" cy="289208"/>
          </a:xfrm>
          <a:prstGeom prst="rect">
            <a:avLst/>
          </a:prstGeom>
          <a:noFill/>
        </p:spPr>
        <p:txBody>
          <a:bodyPr wrap="square" lIns="0" tIns="38761" rIns="0" rtlCol="0">
            <a:spAutoFit/>
          </a:bodyPr>
          <a:lstStyle/>
          <a:p>
            <a:pPr defTabSz="378653"/>
            <a:r>
              <a:rPr lang="el-GR" sz="1325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SG" sz="1325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ubr2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7AF4F570-744D-4514-ACB6-4EDA006C51FD}"/>
              </a:ext>
            </a:extLst>
          </p:cNvPr>
          <p:cNvSpPr txBox="1"/>
          <p:nvPr/>
        </p:nvSpPr>
        <p:spPr>
          <a:xfrm rot="16200000">
            <a:off x="5107087" y="2267141"/>
            <a:ext cx="503226" cy="289208"/>
          </a:xfrm>
          <a:prstGeom prst="rect">
            <a:avLst/>
          </a:prstGeom>
          <a:noFill/>
        </p:spPr>
        <p:txBody>
          <a:bodyPr wrap="square" lIns="0" tIns="38761" rIns="0" rtlCol="0">
            <a:spAutoFit/>
          </a:bodyPr>
          <a:lstStyle/>
          <a:p>
            <a:pPr defTabSz="378653"/>
            <a:r>
              <a:rPr lang="el-GR" sz="1325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SG" sz="1325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ub1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C7E241CD-4537-45F1-8D4F-3BC67AC1B974}"/>
              </a:ext>
            </a:extLst>
          </p:cNvPr>
          <p:cNvSpPr txBox="1"/>
          <p:nvPr/>
        </p:nvSpPr>
        <p:spPr>
          <a:xfrm rot="16200000">
            <a:off x="5293097" y="2273781"/>
            <a:ext cx="503226" cy="289208"/>
          </a:xfrm>
          <a:prstGeom prst="rect">
            <a:avLst/>
          </a:prstGeom>
          <a:noFill/>
        </p:spPr>
        <p:txBody>
          <a:bodyPr wrap="square" lIns="0" tIns="38761" rIns="0" rtlCol="0">
            <a:spAutoFit/>
          </a:bodyPr>
          <a:lstStyle/>
          <a:p>
            <a:pPr defTabSz="378653"/>
            <a:r>
              <a:rPr lang="en-SG" sz="1325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4B3B9748-1391-45FF-A4E9-691C8710B80C}"/>
              </a:ext>
            </a:extLst>
          </p:cNvPr>
          <p:cNvSpPr txBox="1"/>
          <p:nvPr/>
        </p:nvSpPr>
        <p:spPr>
          <a:xfrm rot="16200000">
            <a:off x="5444747" y="2277008"/>
            <a:ext cx="503226" cy="289208"/>
          </a:xfrm>
          <a:prstGeom prst="rect">
            <a:avLst/>
          </a:prstGeom>
          <a:noFill/>
        </p:spPr>
        <p:txBody>
          <a:bodyPr wrap="square" lIns="0" tIns="38761" rIns="0" rtlCol="0">
            <a:spAutoFit/>
          </a:bodyPr>
          <a:lstStyle/>
          <a:p>
            <a:pPr defTabSz="378653"/>
            <a:r>
              <a:rPr lang="el-GR" sz="1325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SG" sz="1325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ad6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0B315769-5D3A-4542-9585-0D2103B4B35D}"/>
              </a:ext>
            </a:extLst>
          </p:cNvPr>
          <p:cNvSpPr txBox="1"/>
          <p:nvPr/>
        </p:nvSpPr>
        <p:spPr>
          <a:xfrm rot="16200000">
            <a:off x="3214910" y="2228122"/>
            <a:ext cx="503226" cy="289208"/>
          </a:xfrm>
          <a:prstGeom prst="rect">
            <a:avLst/>
          </a:prstGeom>
          <a:noFill/>
        </p:spPr>
        <p:txBody>
          <a:bodyPr wrap="square" lIns="0" tIns="38761" rIns="0" rtlCol="0">
            <a:spAutoFit/>
          </a:bodyPr>
          <a:lstStyle/>
          <a:p>
            <a:pPr defTabSz="378653"/>
            <a:r>
              <a:rPr lang="el-GR" sz="1325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SG" sz="1325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ad18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580C4956-F7BE-45BB-A8AD-4BD6F4BFA062}"/>
              </a:ext>
            </a:extLst>
          </p:cNvPr>
          <p:cNvSpPr txBox="1"/>
          <p:nvPr/>
        </p:nvSpPr>
        <p:spPr>
          <a:xfrm rot="16200000">
            <a:off x="3371026" y="2234763"/>
            <a:ext cx="503226" cy="289208"/>
          </a:xfrm>
          <a:prstGeom prst="rect">
            <a:avLst/>
          </a:prstGeom>
          <a:noFill/>
        </p:spPr>
        <p:txBody>
          <a:bodyPr wrap="square" lIns="0" tIns="38761" rIns="0" rtlCol="0">
            <a:spAutoFit/>
          </a:bodyPr>
          <a:lstStyle/>
          <a:p>
            <a:pPr defTabSz="378653"/>
            <a:r>
              <a:rPr lang="el-GR" sz="1325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SG" sz="1325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re1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DF9EA031-8667-4672-B52B-D8931D67707F}"/>
              </a:ext>
            </a:extLst>
          </p:cNvPr>
          <p:cNvSpPr txBox="1"/>
          <p:nvPr/>
        </p:nvSpPr>
        <p:spPr>
          <a:xfrm rot="16200000">
            <a:off x="3526000" y="2230609"/>
            <a:ext cx="503226" cy="289208"/>
          </a:xfrm>
          <a:prstGeom prst="rect">
            <a:avLst/>
          </a:prstGeom>
          <a:noFill/>
        </p:spPr>
        <p:txBody>
          <a:bodyPr wrap="square" lIns="0" tIns="38761" rIns="0" rtlCol="0">
            <a:spAutoFit/>
          </a:bodyPr>
          <a:lstStyle/>
          <a:p>
            <a:pPr defTabSz="378653"/>
            <a:r>
              <a:rPr lang="el-GR" sz="1325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SG" sz="1325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ubr1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14FE67C4-6242-480F-A254-1A5FC764FBC9}"/>
              </a:ext>
            </a:extLst>
          </p:cNvPr>
          <p:cNvSpPr txBox="1"/>
          <p:nvPr/>
        </p:nvSpPr>
        <p:spPr>
          <a:xfrm rot="16200000">
            <a:off x="3682116" y="2237249"/>
            <a:ext cx="503226" cy="289208"/>
          </a:xfrm>
          <a:prstGeom prst="rect">
            <a:avLst/>
          </a:prstGeom>
          <a:noFill/>
        </p:spPr>
        <p:txBody>
          <a:bodyPr wrap="square" lIns="0" tIns="38761" rIns="0" rtlCol="0">
            <a:spAutoFit/>
          </a:bodyPr>
          <a:lstStyle/>
          <a:p>
            <a:pPr defTabSz="378653"/>
            <a:r>
              <a:rPr lang="el-GR" sz="1325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SG" sz="1325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ubr2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75B2ADBF-A3B7-4476-9D47-0985E8676109}"/>
              </a:ext>
            </a:extLst>
          </p:cNvPr>
          <p:cNvSpPr txBox="1"/>
          <p:nvPr/>
        </p:nvSpPr>
        <p:spPr>
          <a:xfrm rot="16200000">
            <a:off x="3838232" y="2243889"/>
            <a:ext cx="503226" cy="289208"/>
          </a:xfrm>
          <a:prstGeom prst="rect">
            <a:avLst/>
          </a:prstGeom>
          <a:noFill/>
        </p:spPr>
        <p:txBody>
          <a:bodyPr wrap="square" lIns="0" tIns="38761" rIns="0" rtlCol="0">
            <a:spAutoFit/>
          </a:bodyPr>
          <a:lstStyle/>
          <a:p>
            <a:pPr defTabSz="378653"/>
            <a:r>
              <a:rPr lang="el-GR" sz="1325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SG" sz="1325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ub1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70DE8A94-458E-4A00-98BD-DAB91088084E}"/>
              </a:ext>
            </a:extLst>
          </p:cNvPr>
          <p:cNvSpPr txBox="1"/>
          <p:nvPr/>
        </p:nvSpPr>
        <p:spPr>
          <a:xfrm rot="16200000">
            <a:off x="4024243" y="2250530"/>
            <a:ext cx="503226" cy="289208"/>
          </a:xfrm>
          <a:prstGeom prst="rect">
            <a:avLst/>
          </a:prstGeom>
          <a:noFill/>
        </p:spPr>
        <p:txBody>
          <a:bodyPr wrap="square" lIns="0" tIns="38761" rIns="0" rtlCol="0">
            <a:spAutoFit/>
          </a:bodyPr>
          <a:lstStyle/>
          <a:p>
            <a:pPr defTabSz="378653"/>
            <a:r>
              <a:rPr lang="en-SG" sz="1325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A6B02ABF-8F6E-4246-83C8-2ACC0D96AA87}"/>
              </a:ext>
            </a:extLst>
          </p:cNvPr>
          <p:cNvSpPr txBox="1"/>
          <p:nvPr/>
        </p:nvSpPr>
        <p:spPr>
          <a:xfrm rot="16200000">
            <a:off x="4175892" y="2253757"/>
            <a:ext cx="503226" cy="289208"/>
          </a:xfrm>
          <a:prstGeom prst="rect">
            <a:avLst/>
          </a:prstGeom>
          <a:noFill/>
        </p:spPr>
        <p:txBody>
          <a:bodyPr wrap="square" lIns="0" tIns="38761" rIns="0" rtlCol="0">
            <a:spAutoFit/>
          </a:bodyPr>
          <a:lstStyle/>
          <a:p>
            <a:pPr defTabSz="378653"/>
            <a:r>
              <a:rPr lang="el-GR" sz="1325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SG" sz="1325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ad6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3F21476C-416B-4EED-BB28-7B74D50215C5}"/>
              </a:ext>
            </a:extLst>
          </p:cNvPr>
          <p:cNvSpPr txBox="1"/>
          <p:nvPr/>
        </p:nvSpPr>
        <p:spPr>
          <a:xfrm rot="16200000">
            <a:off x="4343120" y="2250531"/>
            <a:ext cx="503226" cy="289208"/>
          </a:xfrm>
          <a:prstGeom prst="rect">
            <a:avLst/>
          </a:prstGeom>
          <a:noFill/>
        </p:spPr>
        <p:txBody>
          <a:bodyPr wrap="square" lIns="0" tIns="38761" rIns="0" rtlCol="0">
            <a:spAutoFit/>
          </a:bodyPr>
          <a:lstStyle/>
          <a:p>
            <a:pPr defTabSz="378653"/>
            <a:r>
              <a:rPr lang="en-SG" sz="1325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W</a:t>
            </a:r>
          </a:p>
        </p:txBody>
      </p: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38B9D7FA-742D-4DFC-8CD7-DEEED1C15A3F}"/>
              </a:ext>
            </a:extLst>
          </p:cNvPr>
          <p:cNvCxnSpPr/>
          <p:nvPr/>
        </p:nvCxnSpPr>
        <p:spPr>
          <a:xfrm>
            <a:off x="3219587" y="3189099"/>
            <a:ext cx="139507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Connector 24">
            <a:extLst>
              <a:ext uri="{FF2B5EF4-FFF2-40B4-BE49-F238E27FC236}">
                <a16:creationId xmlns:a16="http://schemas.microsoft.com/office/drawing/2014/main" id="{9CFA3EA2-309C-42D3-AD5B-973D3DE528E4}"/>
              </a:ext>
            </a:extLst>
          </p:cNvPr>
          <p:cNvCxnSpPr/>
          <p:nvPr/>
        </p:nvCxnSpPr>
        <p:spPr>
          <a:xfrm>
            <a:off x="3216263" y="3305355"/>
            <a:ext cx="139507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TextBox 25">
            <a:extLst>
              <a:ext uri="{FF2B5EF4-FFF2-40B4-BE49-F238E27FC236}">
                <a16:creationId xmlns:a16="http://schemas.microsoft.com/office/drawing/2014/main" id="{C9FDEF02-16E2-4011-90FB-EE63C465A75D}"/>
              </a:ext>
            </a:extLst>
          </p:cNvPr>
          <p:cNvSpPr txBox="1"/>
          <p:nvPr/>
        </p:nvSpPr>
        <p:spPr>
          <a:xfrm>
            <a:off x="2964858" y="3184634"/>
            <a:ext cx="281301" cy="289208"/>
          </a:xfrm>
          <a:prstGeom prst="rect">
            <a:avLst/>
          </a:prstGeom>
          <a:noFill/>
        </p:spPr>
        <p:txBody>
          <a:bodyPr wrap="square" lIns="0" tIns="38761" rIns="0" rtlCol="0">
            <a:spAutoFit/>
          </a:bodyPr>
          <a:lstStyle/>
          <a:p>
            <a:pPr algn="ctr" defTabSz="378653"/>
            <a:r>
              <a:rPr lang="en-SG" sz="1325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8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71DE2503-F5F0-4EFE-8758-7FC28AC8E9C6}"/>
              </a:ext>
            </a:extLst>
          </p:cNvPr>
          <p:cNvSpPr txBox="1"/>
          <p:nvPr/>
        </p:nvSpPr>
        <p:spPr>
          <a:xfrm>
            <a:off x="2971498" y="3021872"/>
            <a:ext cx="281301" cy="289208"/>
          </a:xfrm>
          <a:prstGeom prst="rect">
            <a:avLst/>
          </a:prstGeom>
          <a:noFill/>
        </p:spPr>
        <p:txBody>
          <a:bodyPr wrap="square" lIns="0" tIns="38761" rIns="0" rtlCol="0">
            <a:spAutoFit/>
          </a:bodyPr>
          <a:lstStyle/>
          <a:p>
            <a:pPr algn="ctr" defTabSz="378653"/>
            <a:r>
              <a:rPr lang="en-SG" sz="1325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63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79A0A8E9-B32C-4E66-8AC0-D5EE7A7A03CF}"/>
              </a:ext>
            </a:extLst>
          </p:cNvPr>
          <p:cNvSpPr txBox="1"/>
          <p:nvPr/>
        </p:nvSpPr>
        <p:spPr>
          <a:xfrm>
            <a:off x="5860259" y="3809639"/>
            <a:ext cx="604686" cy="2962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378653"/>
            <a:r>
              <a:rPr lang="en-SG" sz="1325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co1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D8428609-68EA-4781-978D-07E214E49407}"/>
              </a:ext>
            </a:extLst>
          </p:cNvPr>
          <p:cNvSpPr txBox="1"/>
          <p:nvPr/>
        </p:nvSpPr>
        <p:spPr>
          <a:xfrm>
            <a:off x="5870222" y="3063848"/>
            <a:ext cx="867946" cy="2962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378653"/>
            <a:r>
              <a:rPr lang="el-GR" sz="1325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en-SG" sz="1325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HA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D96600D7-A8B4-45FC-9ECA-8934A82C163B}"/>
              </a:ext>
            </a:extLst>
          </p:cNvPr>
          <p:cNvSpPr txBox="1"/>
          <p:nvPr/>
        </p:nvSpPr>
        <p:spPr>
          <a:xfrm>
            <a:off x="5853772" y="4161820"/>
            <a:ext cx="604686" cy="2962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378653"/>
            <a:r>
              <a:rPr lang="en-SG" sz="1325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xk1</a:t>
            </a:r>
          </a:p>
        </p:txBody>
      </p: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F36BB7D4-FF21-488C-B408-F5F5EE08F253}"/>
              </a:ext>
            </a:extLst>
          </p:cNvPr>
          <p:cNvCxnSpPr/>
          <p:nvPr/>
        </p:nvCxnSpPr>
        <p:spPr>
          <a:xfrm>
            <a:off x="3399003" y="2032778"/>
            <a:ext cx="109831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Straight Connector 33">
            <a:extLst>
              <a:ext uri="{FF2B5EF4-FFF2-40B4-BE49-F238E27FC236}">
                <a16:creationId xmlns:a16="http://schemas.microsoft.com/office/drawing/2014/main" id="{55C52F72-C4B2-43FE-9B44-9EE49F69C484}"/>
              </a:ext>
            </a:extLst>
          </p:cNvPr>
          <p:cNvCxnSpPr/>
          <p:nvPr/>
        </p:nvCxnSpPr>
        <p:spPr>
          <a:xfrm>
            <a:off x="4651252" y="2029451"/>
            <a:ext cx="109831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TextBox 34">
            <a:extLst>
              <a:ext uri="{FF2B5EF4-FFF2-40B4-BE49-F238E27FC236}">
                <a16:creationId xmlns:a16="http://schemas.microsoft.com/office/drawing/2014/main" id="{31B814E7-8EFF-4A09-80DF-AFFC7C1F71BC}"/>
              </a:ext>
            </a:extLst>
          </p:cNvPr>
          <p:cNvSpPr txBox="1"/>
          <p:nvPr/>
        </p:nvSpPr>
        <p:spPr>
          <a:xfrm>
            <a:off x="3674645" y="1743600"/>
            <a:ext cx="604686" cy="2962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378653"/>
            <a:r>
              <a:rPr lang="en-SG" sz="1325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yto</a:t>
            </a:r>
            <a:endParaRPr lang="en-SG" sz="1325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81B78808-0E1F-4DB5-A211-44F6451FD946}"/>
              </a:ext>
            </a:extLst>
          </p:cNvPr>
          <p:cNvSpPr txBox="1"/>
          <p:nvPr/>
        </p:nvSpPr>
        <p:spPr>
          <a:xfrm>
            <a:off x="5040890" y="1748354"/>
            <a:ext cx="604686" cy="2962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378653"/>
            <a:r>
              <a:rPr lang="en-SG" sz="1325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ito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5C5FA99B-4936-4C01-AFA6-E76AB506A9F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324087" y="3851685"/>
            <a:ext cx="2529685" cy="217119"/>
          </a:xfrm>
          <a:prstGeom prst="rect">
            <a:avLst/>
          </a:prstGeom>
        </p:spPr>
      </p:pic>
      <p:pic>
        <p:nvPicPr>
          <p:cNvPr id="37" name="Picture 36">
            <a:extLst>
              <a:ext uri="{FF2B5EF4-FFF2-40B4-BE49-F238E27FC236}">
                <a16:creationId xmlns:a16="http://schemas.microsoft.com/office/drawing/2014/main" id="{35ACEC3D-63D7-4FF3-B82E-1E3CE627CA9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330575" y="4178285"/>
            <a:ext cx="2529685" cy="217119"/>
          </a:xfrm>
          <a:prstGeom prst="rect">
            <a:avLst/>
          </a:prstGeom>
        </p:spPr>
      </p:pic>
      <p:sp>
        <p:nvSpPr>
          <p:cNvPr id="102" name="TextBox 101">
            <a:extLst>
              <a:ext uri="{FF2B5EF4-FFF2-40B4-BE49-F238E27FC236}">
                <a16:creationId xmlns:a16="http://schemas.microsoft.com/office/drawing/2014/main" id="{51D067A8-48C6-4836-8FA3-72D1EB7E2052}"/>
              </a:ext>
            </a:extLst>
          </p:cNvPr>
          <p:cNvSpPr txBox="1"/>
          <p:nvPr/>
        </p:nvSpPr>
        <p:spPr>
          <a:xfrm>
            <a:off x="1152424" y="4788982"/>
            <a:ext cx="6884604" cy="14688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 defTabSz="378653"/>
            <a:r>
              <a:rPr lang="en-US" sz="1491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A) </a:t>
            </a:r>
            <a:r>
              <a:rPr lang="en-SG" sz="149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reSu9-HA-Ub conjugates pattern in cells deficient in a protein that is known to form a protein complex with Rad6. </a:t>
            </a:r>
            <a:r>
              <a:rPr lang="en-US" sz="149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ad18, Bre1, Ubr1, Ubr2, and Mub1 are the 5 known proteins that form complexes with Rad6 in ubiquitinating substrate proteins. Cytos</a:t>
            </a:r>
            <a:r>
              <a:rPr lang="en-US" sz="149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lic </a:t>
            </a:r>
            <a:r>
              <a:rPr lang="en-US" sz="149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nd mitochondria</a:t>
            </a:r>
            <a:r>
              <a:rPr lang="en-US" sz="149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 </a:t>
            </a:r>
            <a:r>
              <a:rPr lang="en-US" sz="149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ractions of indicated cells expressing preSu9-HA-Ub were examined by WB with antibody against HA </a:t>
            </a:r>
            <a:r>
              <a:rPr lang="en-SG" sz="149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l-GR" sz="149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en-SG" sz="149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HA)</a:t>
            </a:r>
            <a:r>
              <a:rPr lang="en-US" sz="149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 Aco1 (mitochondrial marker), and Hxk1 (cytosolic marker). 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132D2C1E-5793-44DC-BAD4-CAC341498B5F}"/>
              </a:ext>
            </a:extLst>
          </p:cNvPr>
          <p:cNvSpPr txBox="1"/>
          <p:nvPr/>
        </p:nvSpPr>
        <p:spPr>
          <a:xfrm>
            <a:off x="2986896" y="2826613"/>
            <a:ext cx="273056" cy="270715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defTabSz="378653"/>
            <a:r>
              <a:rPr lang="en-SG" sz="1159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en-SG" sz="1159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4772401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TextBox 15">
            <a:extLst>
              <a:ext uri="{FF2B5EF4-FFF2-40B4-BE49-F238E27FC236}">
                <a16:creationId xmlns:a16="http://schemas.microsoft.com/office/drawing/2014/main" id="{996C8290-903C-499E-A065-A1C14F0B3A14}"/>
              </a:ext>
            </a:extLst>
          </p:cNvPr>
          <p:cNvSpPr txBox="1"/>
          <p:nvPr/>
        </p:nvSpPr>
        <p:spPr>
          <a:xfrm>
            <a:off x="7871900" y="4465878"/>
            <a:ext cx="604686" cy="2962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378653"/>
            <a:r>
              <a:rPr lang="en-SG" sz="1325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co1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BB60F188-42B6-42AD-AB3F-6D5DBB9237CA}"/>
              </a:ext>
            </a:extLst>
          </p:cNvPr>
          <p:cNvSpPr txBox="1"/>
          <p:nvPr/>
        </p:nvSpPr>
        <p:spPr>
          <a:xfrm>
            <a:off x="7881863" y="3420675"/>
            <a:ext cx="588236" cy="2962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378653"/>
            <a:r>
              <a:rPr lang="el-GR" sz="1325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en-SG" sz="1325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HA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3E1AB3D3-653F-4F45-871C-F2F44640A665}"/>
              </a:ext>
            </a:extLst>
          </p:cNvPr>
          <p:cNvSpPr txBox="1"/>
          <p:nvPr/>
        </p:nvSpPr>
        <p:spPr>
          <a:xfrm>
            <a:off x="7865413" y="4747607"/>
            <a:ext cx="604686" cy="2962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378653"/>
            <a:r>
              <a:rPr lang="en-SG" sz="1325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xk1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A377D6A5-2903-4A6F-8EE4-4A9D17445740}"/>
              </a:ext>
            </a:extLst>
          </p:cNvPr>
          <p:cNvSpPr txBox="1"/>
          <p:nvPr/>
        </p:nvSpPr>
        <p:spPr>
          <a:xfrm rot="16200000">
            <a:off x="3928436" y="2130954"/>
            <a:ext cx="503226" cy="289208"/>
          </a:xfrm>
          <a:prstGeom prst="rect">
            <a:avLst/>
          </a:prstGeom>
          <a:noFill/>
        </p:spPr>
        <p:txBody>
          <a:bodyPr wrap="square" lIns="0" tIns="38761" rIns="0" rtlCol="0">
            <a:spAutoFit/>
          </a:bodyPr>
          <a:lstStyle/>
          <a:p>
            <a:pPr defTabSz="378653"/>
            <a:r>
              <a:rPr lang="el-GR" sz="1325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SG" sz="1325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ad16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BD82CDA4-69B1-4FB7-B390-A72603DAA6AF}"/>
              </a:ext>
            </a:extLst>
          </p:cNvPr>
          <p:cNvSpPr txBox="1"/>
          <p:nvPr/>
        </p:nvSpPr>
        <p:spPr>
          <a:xfrm rot="16200000">
            <a:off x="3985072" y="2038114"/>
            <a:ext cx="684573" cy="289208"/>
          </a:xfrm>
          <a:prstGeom prst="rect">
            <a:avLst/>
          </a:prstGeom>
          <a:noFill/>
        </p:spPr>
        <p:txBody>
          <a:bodyPr wrap="square" lIns="0" tIns="38761" rIns="0" rtlCol="0">
            <a:spAutoFit/>
          </a:bodyPr>
          <a:lstStyle/>
          <a:p>
            <a:pPr defTabSz="378653"/>
            <a:r>
              <a:rPr lang="el-GR" sz="1325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SG" sz="1325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av1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31D46DE2-FF25-49FC-B5FB-014030A28253}"/>
              </a:ext>
            </a:extLst>
          </p:cNvPr>
          <p:cNvSpPr txBox="1"/>
          <p:nvPr/>
        </p:nvSpPr>
        <p:spPr>
          <a:xfrm rot="16200000">
            <a:off x="4243992" y="2134599"/>
            <a:ext cx="503226" cy="289208"/>
          </a:xfrm>
          <a:prstGeom prst="rect">
            <a:avLst/>
          </a:prstGeom>
          <a:noFill/>
        </p:spPr>
        <p:txBody>
          <a:bodyPr wrap="square" lIns="0" tIns="38761" rIns="0" rtlCol="0">
            <a:spAutoFit/>
          </a:bodyPr>
          <a:lstStyle/>
          <a:p>
            <a:pPr defTabSz="378653"/>
            <a:r>
              <a:rPr lang="el-GR" sz="1325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SG" sz="1325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ul5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4AA6F4FD-933C-48B5-8846-457C1AD9EE7E}"/>
              </a:ext>
            </a:extLst>
          </p:cNvPr>
          <p:cNvSpPr txBox="1"/>
          <p:nvPr/>
        </p:nvSpPr>
        <p:spPr>
          <a:xfrm rot="16200000">
            <a:off x="4378029" y="2141239"/>
            <a:ext cx="503226" cy="289208"/>
          </a:xfrm>
          <a:prstGeom prst="rect">
            <a:avLst/>
          </a:prstGeom>
          <a:noFill/>
        </p:spPr>
        <p:txBody>
          <a:bodyPr wrap="square" lIns="0" tIns="38761" rIns="0" rtlCol="0">
            <a:spAutoFit/>
          </a:bodyPr>
          <a:lstStyle/>
          <a:p>
            <a:pPr defTabSz="378653"/>
            <a:r>
              <a:rPr lang="el-GR" sz="1325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SG" sz="1325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ul2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98DDFDCB-6718-4CAA-9FAC-09BCA4C66978}"/>
              </a:ext>
            </a:extLst>
          </p:cNvPr>
          <p:cNvSpPr txBox="1"/>
          <p:nvPr/>
        </p:nvSpPr>
        <p:spPr>
          <a:xfrm rot="16200000">
            <a:off x="4452278" y="2057207"/>
            <a:ext cx="684573" cy="289208"/>
          </a:xfrm>
          <a:prstGeom prst="rect">
            <a:avLst/>
          </a:prstGeom>
          <a:noFill/>
        </p:spPr>
        <p:txBody>
          <a:bodyPr wrap="square" lIns="0" tIns="38761" rIns="0" rtlCol="0">
            <a:spAutoFit/>
          </a:bodyPr>
          <a:lstStyle/>
          <a:p>
            <a:pPr defTabSz="378653"/>
            <a:r>
              <a:rPr lang="el-GR" sz="1325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SG" sz="1325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tt101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982A7EA3-DE51-4054-9104-4B28F50130A7}"/>
              </a:ext>
            </a:extLst>
          </p:cNvPr>
          <p:cNvSpPr txBox="1"/>
          <p:nvPr/>
        </p:nvSpPr>
        <p:spPr>
          <a:xfrm rot="16200000">
            <a:off x="4728962" y="2154520"/>
            <a:ext cx="503226" cy="289208"/>
          </a:xfrm>
          <a:prstGeom prst="rect">
            <a:avLst/>
          </a:prstGeom>
          <a:noFill/>
        </p:spPr>
        <p:txBody>
          <a:bodyPr wrap="square" lIns="0" tIns="38761" rIns="0" rtlCol="0">
            <a:spAutoFit/>
          </a:bodyPr>
          <a:lstStyle/>
          <a:p>
            <a:pPr defTabSz="378653"/>
            <a:r>
              <a:rPr lang="en-SG" sz="1325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89DB875B-81EE-4EE9-9439-F7E707DA44EF}"/>
              </a:ext>
            </a:extLst>
          </p:cNvPr>
          <p:cNvSpPr txBox="1"/>
          <p:nvPr/>
        </p:nvSpPr>
        <p:spPr>
          <a:xfrm rot="16200000">
            <a:off x="4862998" y="2157747"/>
            <a:ext cx="503226" cy="289208"/>
          </a:xfrm>
          <a:prstGeom prst="rect">
            <a:avLst/>
          </a:prstGeom>
          <a:noFill/>
        </p:spPr>
        <p:txBody>
          <a:bodyPr wrap="square" lIns="0" tIns="38761" rIns="0" rtlCol="0">
            <a:spAutoFit/>
          </a:bodyPr>
          <a:lstStyle/>
          <a:p>
            <a:pPr defTabSz="378653"/>
            <a:r>
              <a:rPr lang="el-GR" sz="1325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SG" sz="1325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ad6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5B44F3C9-4154-4338-A891-F65945FD2C48}"/>
              </a:ext>
            </a:extLst>
          </p:cNvPr>
          <p:cNvSpPr txBox="1"/>
          <p:nvPr/>
        </p:nvSpPr>
        <p:spPr>
          <a:xfrm rot="16200000">
            <a:off x="6467540" y="2138220"/>
            <a:ext cx="503226" cy="289208"/>
          </a:xfrm>
          <a:prstGeom prst="rect">
            <a:avLst/>
          </a:prstGeom>
          <a:noFill/>
        </p:spPr>
        <p:txBody>
          <a:bodyPr wrap="square" lIns="0" tIns="38761" rIns="0" rtlCol="0">
            <a:spAutoFit/>
          </a:bodyPr>
          <a:lstStyle/>
          <a:p>
            <a:pPr defTabSz="378653"/>
            <a:r>
              <a:rPr lang="el-GR" sz="1325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SG" sz="1325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nd2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60C7CAF9-807F-42F9-95E5-026FFE13CF50}"/>
              </a:ext>
            </a:extLst>
          </p:cNvPr>
          <p:cNvSpPr txBox="1"/>
          <p:nvPr/>
        </p:nvSpPr>
        <p:spPr>
          <a:xfrm rot="16200000">
            <a:off x="6515370" y="2045380"/>
            <a:ext cx="684573" cy="289208"/>
          </a:xfrm>
          <a:prstGeom prst="rect">
            <a:avLst/>
          </a:prstGeom>
          <a:noFill/>
        </p:spPr>
        <p:txBody>
          <a:bodyPr wrap="square" lIns="0" tIns="38761" rIns="0" rtlCol="0">
            <a:spAutoFit/>
          </a:bodyPr>
          <a:lstStyle/>
          <a:p>
            <a:pPr defTabSz="378653"/>
            <a:r>
              <a:rPr lang="el-GR" sz="1325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SG" sz="1325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si3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A1C3AC7B-A03E-4F68-8470-5BDAB9369BB3}"/>
              </a:ext>
            </a:extLst>
          </p:cNvPr>
          <p:cNvSpPr txBox="1"/>
          <p:nvPr/>
        </p:nvSpPr>
        <p:spPr>
          <a:xfrm rot="16200000">
            <a:off x="6756677" y="2141865"/>
            <a:ext cx="503226" cy="289208"/>
          </a:xfrm>
          <a:prstGeom prst="rect">
            <a:avLst/>
          </a:prstGeom>
          <a:noFill/>
        </p:spPr>
        <p:txBody>
          <a:bodyPr wrap="square" lIns="0" tIns="38761" rIns="0" rtlCol="0">
            <a:spAutoFit/>
          </a:bodyPr>
          <a:lstStyle/>
          <a:p>
            <a:pPr defTabSz="378653"/>
            <a:r>
              <a:rPr lang="el-GR" sz="1325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SG" sz="1325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rd1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B8F72368-7D60-421E-BE53-1C39BBEC892B}"/>
              </a:ext>
            </a:extLst>
          </p:cNvPr>
          <p:cNvSpPr txBox="1"/>
          <p:nvPr/>
        </p:nvSpPr>
        <p:spPr>
          <a:xfrm rot="16200000">
            <a:off x="6908327" y="2148505"/>
            <a:ext cx="503226" cy="289208"/>
          </a:xfrm>
          <a:prstGeom prst="rect">
            <a:avLst/>
          </a:prstGeom>
          <a:noFill/>
        </p:spPr>
        <p:txBody>
          <a:bodyPr wrap="square" lIns="0" tIns="38761" rIns="0" rtlCol="0">
            <a:spAutoFit/>
          </a:bodyPr>
          <a:lstStyle/>
          <a:p>
            <a:pPr defTabSz="378653"/>
            <a:r>
              <a:rPr lang="el-GR" sz="1325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SG" sz="1325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am1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40AF790F-88A2-4151-862E-975FA1671212}"/>
              </a:ext>
            </a:extLst>
          </p:cNvPr>
          <p:cNvSpPr txBox="1"/>
          <p:nvPr/>
        </p:nvSpPr>
        <p:spPr>
          <a:xfrm rot="16200000">
            <a:off x="6973770" y="2064473"/>
            <a:ext cx="684573" cy="289208"/>
          </a:xfrm>
          <a:prstGeom prst="rect">
            <a:avLst/>
          </a:prstGeom>
          <a:noFill/>
        </p:spPr>
        <p:txBody>
          <a:bodyPr wrap="square" lIns="0" tIns="38761" rIns="0" rtlCol="0">
            <a:spAutoFit/>
          </a:bodyPr>
          <a:lstStyle/>
          <a:p>
            <a:pPr defTabSz="378653"/>
            <a:r>
              <a:rPr lang="el-GR" sz="1325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SG" sz="1325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ma1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065EE794-E624-4D17-94BE-6B027DEAFCC3}"/>
              </a:ext>
            </a:extLst>
          </p:cNvPr>
          <p:cNvSpPr txBox="1"/>
          <p:nvPr/>
        </p:nvSpPr>
        <p:spPr>
          <a:xfrm rot="16200000">
            <a:off x="7250454" y="2161786"/>
            <a:ext cx="503226" cy="289208"/>
          </a:xfrm>
          <a:prstGeom prst="rect">
            <a:avLst/>
          </a:prstGeom>
          <a:noFill/>
        </p:spPr>
        <p:txBody>
          <a:bodyPr wrap="square" lIns="0" tIns="38761" rIns="0" rtlCol="0">
            <a:spAutoFit/>
          </a:bodyPr>
          <a:lstStyle/>
          <a:p>
            <a:pPr defTabSz="378653"/>
            <a:r>
              <a:rPr lang="en-SG" sz="1325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9B124B9E-04EB-4AB0-B5A1-AEFE1916DAC5}"/>
              </a:ext>
            </a:extLst>
          </p:cNvPr>
          <p:cNvSpPr txBox="1"/>
          <p:nvPr/>
        </p:nvSpPr>
        <p:spPr>
          <a:xfrm rot="16200000">
            <a:off x="7384490" y="2165013"/>
            <a:ext cx="503226" cy="289208"/>
          </a:xfrm>
          <a:prstGeom prst="rect">
            <a:avLst/>
          </a:prstGeom>
          <a:noFill/>
        </p:spPr>
        <p:txBody>
          <a:bodyPr wrap="square" lIns="0" tIns="38761" rIns="0" rtlCol="0">
            <a:spAutoFit/>
          </a:bodyPr>
          <a:lstStyle/>
          <a:p>
            <a:pPr defTabSz="378653"/>
            <a:r>
              <a:rPr lang="el-GR" sz="1325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SG" sz="1325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ad6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06652C40-796A-400D-91FA-F8FF93C77997}"/>
              </a:ext>
            </a:extLst>
          </p:cNvPr>
          <p:cNvSpPr txBox="1"/>
          <p:nvPr/>
        </p:nvSpPr>
        <p:spPr>
          <a:xfrm rot="16200000">
            <a:off x="6331356" y="2147880"/>
            <a:ext cx="503226" cy="289208"/>
          </a:xfrm>
          <a:prstGeom prst="rect">
            <a:avLst/>
          </a:prstGeom>
          <a:noFill/>
        </p:spPr>
        <p:txBody>
          <a:bodyPr wrap="square" lIns="0" tIns="38761" rIns="0" rtlCol="0">
            <a:spAutoFit/>
          </a:bodyPr>
          <a:lstStyle/>
          <a:p>
            <a:pPr defTabSz="378653"/>
            <a:r>
              <a:rPr lang="en-SG" sz="1325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W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30B11069-2B97-45C0-9603-F7B0C5DB3F96}"/>
              </a:ext>
            </a:extLst>
          </p:cNvPr>
          <p:cNvSpPr txBox="1"/>
          <p:nvPr/>
        </p:nvSpPr>
        <p:spPr>
          <a:xfrm rot="16200000">
            <a:off x="3789932" y="2149966"/>
            <a:ext cx="503226" cy="289208"/>
          </a:xfrm>
          <a:prstGeom prst="rect">
            <a:avLst/>
          </a:prstGeom>
          <a:noFill/>
        </p:spPr>
        <p:txBody>
          <a:bodyPr wrap="square" lIns="0" tIns="38761" rIns="0" rtlCol="0">
            <a:spAutoFit/>
          </a:bodyPr>
          <a:lstStyle/>
          <a:p>
            <a:pPr defTabSz="378653"/>
            <a:r>
              <a:rPr lang="en-SG" sz="1325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W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EAEA4B96-D865-418B-92DE-2217D6C12331}"/>
              </a:ext>
            </a:extLst>
          </p:cNvPr>
          <p:cNvSpPr txBox="1"/>
          <p:nvPr/>
        </p:nvSpPr>
        <p:spPr>
          <a:xfrm rot="16200000">
            <a:off x="2716128" y="2125079"/>
            <a:ext cx="503226" cy="289208"/>
          </a:xfrm>
          <a:prstGeom prst="rect">
            <a:avLst/>
          </a:prstGeom>
          <a:noFill/>
        </p:spPr>
        <p:txBody>
          <a:bodyPr wrap="square" lIns="0" tIns="38761" rIns="0" rtlCol="0">
            <a:spAutoFit/>
          </a:bodyPr>
          <a:lstStyle/>
          <a:p>
            <a:pPr defTabSz="378653"/>
            <a:r>
              <a:rPr lang="el-GR" sz="1325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SG" sz="1325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ad16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9DF01264-E895-4C86-A41A-0D416CA4C664}"/>
              </a:ext>
            </a:extLst>
          </p:cNvPr>
          <p:cNvSpPr txBox="1"/>
          <p:nvPr/>
        </p:nvSpPr>
        <p:spPr>
          <a:xfrm rot="16200000">
            <a:off x="2772765" y="2032240"/>
            <a:ext cx="684573" cy="289208"/>
          </a:xfrm>
          <a:prstGeom prst="rect">
            <a:avLst/>
          </a:prstGeom>
          <a:noFill/>
        </p:spPr>
        <p:txBody>
          <a:bodyPr wrap="square" lIns="0" tIns="38761" rIns="0" rtlCol="0">
            <a:spAutoFit/>
          </a:bodyPr>
          <a:lstStyle/>
          <a:p>
            <a:pPr defTabSz="378653"/>
            <a:r>
              <a:rPr lang="el-GR" sz="1325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SG" sz="1325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av1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5510212E-CBE8-4578-9C9A-787E87BF28D7}"/>
              </a:ext>
            </a:extLst>
          </p:cNvPr>
          <p:cNvSpPr txBox="1"/>
          <p:nvPr/>
        </p:nvSpPr>
        <p:spPr>
          <a:xfrm rot="16200000">
            <a:off x="3022878" y="2119918"/>
            <a:ext cx="503226" cy="289208"/>
          </a:xfrm>
          <a:prstGeom prst="rect">
            <a:avLst/>
          </a:prstGeom>
          <a:noFill/>
        </p:spPr>
        <p:txBody>
          <a:bodyPr wrap="square" lIns="0" tIns="38761" rIns="0" rtlCol="0">
            <a:spAutoFit/>
          </a:bodyPr>
          <a:lstStyle/>
          <a:p>
            <a:pPr defTabSz="378653"/>
            <a:r>
              <a:rPr lang="el-GR" sz="1325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SG" sz="1325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ul5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2FEEBB9B-8C01-480B-9C42-48151607C6C7}"/>
              </a:ext>
            </a:extLst>
          </p:cNvPr>
          <p:cNvSpPr txBox="1"/>
          <p:nvPr/>
        </p:nvSpPr>
        <p:spPr>
          <a:xfrm rot="16200000">
            <a:off x="3174528" y="2117752"/>
            <a:ext cx="503226" cy="289208"/>
          </a:xfrm>
          <a:prstGeom prst="rect">
            <a:avLst/>
          </a:prstGeom>
          <a:noFill/>
        </p:spPr>
        <p:txBody>
          <a:bodyPr wrap="square" lIns="0" tIns="38761" rIns="0" rtlCol="0">
            <a:spAutoFit/>
          </a:bodyPr>
          <a:lstStyle/>
          <a:p>
            <a:pPr defTabSz="378653"/>
            <a:r>
              <a:rPr lang="el-GR" sz="1325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SG" sz="1325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ul2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56006D37-F39C-45F5-91E9-155D6C4F4181}"/>
              </a:ext>
            </a:extLst>
          </p:cNvPr>
          <p:cNvSpPr txBox="1"/>
          <p:nvPr/>
        </p:nvSpPr>
        <p:spPr>
          <a:xfrm rot="16200000">
            <a:off x="3239971" y="2042525"/>
            <a:ext cx="684573" cy="289208"/>
          </a:xfrm>
          <a:prstGeom prst="rect">
            <a:avLst/>
          </a:prstGeom>
          <a:noFill/>
        </p:spPr>
        <p:txBody>
          <a:bodyPr wrap="square" lIns="0" tIns="38761" rIns="0" rtlCol="0">
            <a:spAutoFit/>
          </a:bodyPr>
          <a:lstStyle/>
          <a:p>
            <a:pPr defTabSz="378653"/>
            <a:r>
              <a:rPr lang="el-GR" sz="1325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SG" sz="1325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tt101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584DE9FD-30AF-4D3D-BEDD-6188B7ABD96C}"/>
              </a:ext>
            </a:extLst>
          </p:cNvPr>
          <p:cNvSpPr txBox="1"/>
          <p:nvPr/>
        </p:nvSpPr>
        <p:spPr>
          <a:xfrm rot="16200000">
            <a:off x="3499041" y="2122226"/>
            <a:ext cx="503226" cy="289208"/>
          </a:xfrm>
          <a:prstGeom prst="rect">
            <a:avLst/>
          </a:prstGeom>
          <a:noFill/>
        </p:spPr>
        <p:txBody>
          <a:bodyPr wrap="square" lIns="0" tIns="38761" rIns="0" rtlCol="0">
            <a:spAutoFit/>
          </a:bodyPr>
          <a:lstStyle/>
          <a:p>
            <a:pPr defTabSz="378653"/>
            <a:r>
              <a:rPr lang="en-SG" sz="1325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A64C2416-9B5E-4B11-B368-48820CEB872B}"/>
              </a:ext>
            </a:extLst>
          </p:cNvPr>
          <p:cNvSpPr txBox="1"/>
          <p:nvPr/>
        </p:nvSpPr>
        <p:spPr>
          <a:xfrm rot="16200000">
            <a:off x="3633078" y="2125453"/>
            <a:ext cx="503226" cy="289208"/>
          </a:xfrm>
          <a:prstGeom prst="rect">
            <a:avLst/>
          </a:prstGeom>
          <a:noFill/>
        </p:spPr>
        <p:txBody>
          <a:bodyPr wrap="square" lIns="0" tIns="38761" rIns="0" rtlCol="0">
            <a:spAutoFit/>
          </a:bodyPr>
          <a:lstStyle/>
          <a:p>
            <a:pPr defTabSz="378653"/>
            <a:r>
              <a:rPr lang="el-GR" sz="1325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SG" sz="1325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ad6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16D7A031-EB7B-4732-AF3C-51F18ECFB972}"/>
              </a:ext>
            </a:extLst>
          </p:cNvPr>
          <p:cNvSpPr txBox="1"/>
          <p:nvPr/>
        </p:nvSpPr>
        <p:spPr>
          <a:xfrm rot="16200000">
            <a:off x="5294258" y="2030702"/>
            <a:ext cx="684573" cy="289208"/>
          </a:xfrm>
          <a:prstGeom prst="rect">
            <a:avLst/>
          </a:prstGeom>
          <a:noFill/>
        </p:spPr>
        <p:txBody>
          <a:bodyPr wrap="square" lIns="0" tIns="38761" rIns="0" rtlCol="0">
            <a:spAutoFit/>
          </a:bodyPr>
          <a:lstStyle/>
          <a:p>
            <a:pPr defTabSz="378653"/>
            <a:r>
              <a:rPr lang="el-GR" sz="1325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SG" sz="1325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si3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989876DA-C75F-490F-9D47-6CEDA3FA0E7B}"/>
              </a:ext>
            </a:extLst>
          </p:cNvPr>
          <p:cNvSpPr txBox="1"/>
          <p:nvPr/>
        </p:nvSpPr>
        <p:spPr>
          <a:xfrm rot="16200000">
            <a:off x="5544370" y="2118387"/>
            <a:ext cx="503226" cy="289208"/>
          </a:xfrm>
          <a:prstGeom prst="rect">
            <a:avLst/>
          </a:prstGeom>
          <a:noFill/>
        </p:spPr>
        <p:txBody>
          <a:bodyPr wrap="square" lIns="0" tIns="38761" rIns="0" rtlCol="0">
            <a:spAutoFit/>
          </a:bodyPr>
          <a:lstStyle/>
          <a:p>
            <a:pPr defTabSz="378653"/>
            <a:r>
              <a:rPr lang="el-GR" sz="1325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SG" sz="1325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rd1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4E42F492-B05D-4943-9A0B-BF6CC8D540C9}"/>
              </a:ext>
            </a:extLst>
          </p:cNvPr>
          <p:cNvSpPr txBox="1"/>
          <p:nvPr/>
        </p:nvSpPr>
        <p:spPr>
          <a:xfrm rot="16200000">
            <a:off x="5696020" y="2125028"/>
            <a:ext cx="503226" cy="289208"/>
          </a:xfrm>
          <a:prstGeom prst="rect">
            <a:avLst/>
          </a:prstGeom>
          <a:noFill/>
        </p:spPr>
        <p:txBody>
          <a:bodyPr wrap="square" lIns="0" tIns="38761" rIns="0" rtlCol="0">
            <a:spAutoFit/>
          </a:bodyPr>
          <a:lstStyle/>
          <a:p>
            <a:pPr defTabSz="378653"/>
            <a:r>
              <a:rPr lang="el-GR" sz="1325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SG" sz="1325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am1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9BDB3CB2-DA56-41A6-BF78-43A19BF9B19B}"/>
              </a:ext>
            </a:extLst>
          </p:cNvPr>
          <p:cNvSpPr txBox="1"/>
          <p:nvPr/>
        </p:nvSpPr>
        <p:spPr>
          <a:xfrm rot="16200000">
            <a:off x="5761462" y="2040995"/>
            <a:ext cx="684573" cy="289208"/>
          </a:xfrm>
          <a:prstGeom prst="rect">
            <a:avLst/>
          </a:prstGeom>
          <a:noFill/>
        </p:spPr>
        <p:txBody>
          <a:bodyPr wrap="square" lIns="0" tIns="38761" rIns="0" rtlCol="0">
            <a:spAutoFit/>
          </a:bodyPr>
          <a:lstStyle/>
          <a:p>
            <a:pPr defTabSz="378653"/>
            <a:r>
              <a:rPr lang="el-GR" sz="1325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SG" sz="1325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ma1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4E961126-EB54-4095-8D30-FBA894F7883F}"/>
              </a:ext>
            </a:extLst>
          </p:cNvPr>
          <p:cNvSpPr txBox="1"/>
          <p:nvPr/>
        </p:nvSpPr>
        <p:spPr>
          <a:xfrm rot="16200000">
            <a:off x="6038146" y="2138308"/>
            <a:ext cx="503226" cy="289208"/>
          </a:xfrm>
          <a:prstGeom prst="rect">
            <a:avLst/>
          </a:prstGeom>
          <a:noFill/>
        </p:spPr>
        <p:txBody>
          <a:bodyPr wrap="square" lIns="0" tIns="38761" rIns="0" rtlCol="0">
            <a:spAutoFit/>
          </a:bodyPr>
          <a:lstStyle/>
          <a:p>
            <a:pPr defTabSz="378653"/>
            <a:r>
              <a:rPr lang="en-SG" sz="1325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638C3A11-BC9D-4741-91F7-ADF6AED31FF0}"/>
              </a:ext>
            </a:extLst>
          </p:cNvPr>
          <p:cNvSpPr txBox="1"/>
          <p:nvPr/>
        </p:nvSpPr>
        <p:spPr>
          <a:xfrm rot="16200000">
            <a:off x="6172183" y="2141535"/>
            <a:ext cx="503226" cy="289208"/>
          </a:xfrm>
          <a:prstGeom prst="rect">
            <a:avLst/>
          </a:prstGeom>
          <a:noFill/>
        </p:spPr>
        <p:txBody>
          <a:bodyPr wrap="square" lIns="0" tIns="38761" rIns="0" rtlCol="0">
            <a:spAutoFit/>
          </a:bodyPr>
          <a:lstStyle/>
          <a:p>
            <a:pPr defTabSz="378653"/>
            <a:r>
              <a:rPr lang="el-GR" sz="1325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SG" sz="1325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ad6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46647073-663E-4B7F-8690-B84AB2995340}"/>
              </a:ext>
            </a:extLst>
          </p:cNvPr>
          <p:cNvSpPr txBox="1"/>
          <p:nvPr/>
        </p:nvSpPr>
        <p:spPr>
          <a:xfrm rot="16200000">
            <a:off x="5147487" y="2042440"/>
            <a:ext cx="684573" cy="289208"/>
          </a:xfrm>
          <a:prstGeom prst="rect">
            <a:avLst/>
          </a:prstGeom>
          <a:noFill/>
        </p:spPr>
        <p:txBody>
          <a:bodyPr wrap="square" lIns="0" tIns="38761" rIns="0" rtlCol="0">
            <a:spAutoFit/>
          </a:bodyPr>
          <a:lstStyle/>
          <a:p>
            <a:pPr defTabSz="378653"/>
            <a:r>
              <a:rPr lang="el-GR" sz="1325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SG" sz="1325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nd2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B44053F2-5006-4832-B704-E8A5D00EE9D4}"/>
              </a:ext>
            </a:extLst>
          </p:cNvPr>
          <p:cNvSpPr txBox="1"/>
          <p:nvPr/>
        </p:nvSpPr>
        <p:spPr>
          <a:xfrm rot="16200000">
            <a:off x="1719570" y="2119919"/>
            <a:ext cx="503226" cy="289208"/>
          </a:xfrm>
          <a:prstGeom prst="rect">
            <a:avLst/>
          </a:prstGeom>
          <a:noFill/>
        </p:spPr>
        <p:txBody>
          <a:bodyPr wrap="square" lIns="0" tIns="38761" rIns="0" rtlCol="0">
            <a:spAutoFit/>
          </a:bodyPr>
          <a:lstStyle/>
          <a:p>
            <a:pPr defTabSz="378653"/>
            <a:r>
              <a:rPr lang="el-GR" sz="1325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SG" sz="1325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la1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8F933C1C-0780-4B10-82B4-222CEA2AE3AE}"/>
              </a:ext>
            </a:extLst>
          </p:cNvPr>
          <p:cNvSpPr txBox="1"/>
          <p:nvPr/>
        </p:nvSpPr>
        <p:spPr>
          <a:xfrm rot="16200000">
            <a:off x="1787028" y="2043401"/>
            <a:ext cx="655987" cy="289208"/>
          </a:xfrm>
          <a:prstGeom prst="rect">
            <a:avLst/>
          </a:prstGeom>
          <a:noFill/>
        </p:spPr>
        <p:txBody>
          <a:bodyPr wrap="square" lIns="0" tIns="38761" rIns="0" rtlCol="0">
            <a:spAutoFit/>
          </a:bodyPr>
          <a:lstStyle/>
          <a:p>
            <a:pPr defTabSz="378653"/>
            <a:r>
              <a:rPr lang="el-GR" sz="1325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SG" sz="1325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os111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3276DB63-41D2-4597-820A-D16541EA2C28}"/>
              </a:ext>
            </a:extLst>
          </p:cNvPr>
          <p:cNvSpPr txBox="1"/>
          <p:nvPr/>
        </p:nvSpPr>
        <p:spPr>
          <a:xfrm rot="16200000">
            <a:off x="1927856" y="2042526"/>
            <a:ext cx="684573" cy="289208"/>
          </a:xfrm>
          <a:prstGeom prst="rect">
            <a:avLst/>
          </a:prstGeom>
          <a:noFill/>
        </p:spPr>
        <p:txBody>
          <a:bodyPr wrap="square" lIns="0" tIns="38761" rIns="0" rtlCol="0">
            <a:spAutoFit/>
          </a:bodyPr>
          <a:lstStyle/>
          <a:p>
            <a:pPr defTabSz="378653"/>
            <a:r>
              <a:rPr lang="el-GR" sz="1325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SG" sz="1325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dh1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CEDA6BB6-CD02-4836-A798-6B199529B3D2}"/>
              </a:ext>
            </a:extLst>
          </p:cNvPr>
          <p:cNvSpPr txBox="1"/>
          <p:nvPr/>
        </p:nvSpPr>
        <p:spPr>
          <a:xfrm rot="16200000">
            <a:off x="2338576" y="2143067"/>
            <a:ext cx="503226" cy="289208"/>
          </a:xfrm>
          <a:prstGeom prst="rect">
            <a:avLst/>
          </a:prstGeom>
          <a:noFill/>
        </p:spPr>
        <p:txBody>
          <a:bodyPr wrap="square" lIns="0" tIns="38761" rIns="0" rtlCol="0">
            <a:spAutoFit/>
          </a:bodyPr>
          <a:lstStyle/>
          <a:p>
            <a:pPr defTabSz="378653"/>
            <a:r>
              <a:rPr lang="el-GR" sz="1325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SG" sz="1325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ad6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778903E4-543A-45CD-BFD6-685FB2F13A2E}"/>
              </a:ext>
            </a:extLst>
          </p:cNvPr>
          <p:cNvSpPr txBox="1"/>
          <p:nvPr/>
        </p:nvSpPr>
        <p:spPr>
          <a:xfrm rot="16200000">
            <a:off x="1564926" y="2135285"/>
            <a:ext cx="503226" cy="289208"/>
          </a:xfrm>
          <a:prstGeom prst="rect">
            <a:avLst/>
          </a:prstGeom>
          <a:noFill/>
        </p:spPr>
        <p:txBody>
          <a:bodyPr wrap="square" lIns="0" tIns="38761" rIns="0" rtlCol="0">
            <a:spAutoFit/>
          </a:bodyPr>
          <a:lstStyle/>
          <a:p>
            <a:pPr defTabSz="378653"/>
            <a:r>
              <a:rPr lang="en-SG" sz="1325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W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84839C38-874B-406E-BBC5-EB8132044769}"/>
              </a:ext>
            </a:extLst>
          </p:cNvPr>
          <p:cNvSpPr txBox="1"/>
          <p:nvPr/>
        </p:nvSpPr>
        <p:spPr>
          <a:xfrm rot="16200000">
            <a:off x="771447" y="2131657"/>
            <a:ext cx="503226" cy="289208"/>
          </a:xfrm>
          <a:prstGeom prst="rect">
            <a:avLst/>
          </a:prstGeom>
          <a:noFill/>
        </p:spPr>
        <p:txBody>
          <a:bodyPr wrap="square" lIns="0" tIns="38761" rIns="0" rtlCol="0">
            <a:spAutoFit/>
          </a:bodyPr>
          <a:lstStyle/>
          <a:p>
            <a:pPr defTabSz="378653"/>
            <a:r>
              <a:rPr lang="el-GR" sz="1325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SG" sz="1325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la1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6797B9F7-4FD9-45FE-B982-F2B3252EE20D}"/>
              </a:ext>
            </a:extLst>
          </p:cNvPr>
          <p:cNvSpPr txBox="1"/>
          <p:nvPr/>
        </p:nvSpPr>
        <p:spPr>
          <a:xfrm rot="16200000">
            <a:off x="832071" y="2038466"/>
            <a:ext cx="685277" cy="289208"/>
          </a:xfrm>
          <a:prstGeom prst="rect">
            <a:avLst/>
          </a:prstGeom>
          <a:noFill/>
        </p:spPr>
        <p:txBody>
          <a:bodyPr wrap="square" lIns="0" tIns="38761" rIns="0" rtlCol="0">
            <a:spAutoFit/>
          </a:bodyPr>
          <a:lstStyle/>
          <a:p>
            <a:pPr defTabSz="378653"/>
            <a:r>
              <a:rPr lang="el-GR" sz="1325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SG" sz="1325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os111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070B1E82-037A-401B-BA7C-A9268616C1EB}"/>
              </a:ext>
            </a:extLst>
          </p:cNvPr>
          <p:cNvSpPr txBox="1"/>
          <p:nvPr/>
        </p:nvSpPr>
        <p:spPr>
          <a:xfrm rot="16200000">
            <a:off x="988539" y="2054265"/>
            <a:ext cx="684573" cy="289208"/>
          </a:xfrm>
          <a:prstGeom prst="rect">
            <a:avLst/>
          </a:prstGeom>
          <a:noFill/>
        </p:spPr>
        <p:txBody>
          <a:bodyPr wrap="square" lIns="0" tIns="38761" rIns="0" rtlCol="0">
            <a:spAutoFit/>
          </a:bodyPr>
          <a:lstStyle/>
          <a:p>
            <a:pPr defTabSz="378653"/>
            <a:r>
              <a:rPr lang="el-GR" sz="1325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SG" sz="1325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dh1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7502DEDB-326A-41FA-B9AE-9523F2C4A86B}"/>
              </a:ext>
            </a:extLst>
          </p:cNvPr>
          <p:cNvSpPr txBox="1"/>
          <p:nvPr/>
        </p:nvSpPr>
        <p:spPr>
          <a:xfrm rot="16200000">
            <a:off x="1247610" y="2133965"/>
            <a:ext cx="503226" cy="289208"/>
          </a:xfrm>
          <a:prstGeom prst="rect">
            <a:avLst/>
          </a:prstGeom>
          <a:noFill/>
        </p:spPr>
        <p:txBody>
          <a:bodyPr wrap="square" lIns="0" tIns="38761" rIns="0" rtlCol="0">
            <a:spAutoFit/>
          </a:bodyPr>
          <a:lstStyle/>
          <a:p>
            <a:pPr defTabSz="378653"/>
            <a:r>
              <a:rPr lang="en-SG" sz="1325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21D48826-F7E7-43E4-BA73-50F41CA3E977}"/>
              </a:ext>
            </a:extLst>
          </p:cNvPr>
          <p:cNvSpPr txBox="1"/>
          <p:nvPr/>
        </p:nvSpPr>
        <p:spPr>
          <a:xfrm rot="16200000">
            <a:off x="1372840" y="2110773"/>
            <a:ext cx="503226" cy="289208"/>
          </a:xfrm>
          <a:prstGeom prst="rect">
            <a:avLst/>
          </a:prstGeom>
          <a:noFill/>
        </p:spPr>
        <p:txBody>
          <a:bodyPr wrap="square" lIns="0" tIns="38761" rIns="0" rtlCol="0">
            <a:spAutoFit/>
          </a:bodyPr>
          <a:lstStyle/>
          <a:p>
            <a:pPr defTabSz="378653"/>
            <a:r>
              <a:rPr lang="el-GR" sz="1325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SG" sz="1325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ad6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03BBA153-0A0F-4454-8F12-8683D1478F5B}"/>
              </a:ext>
            </a:extLst>
          </p:cNvPr>
          <p:cNvSpPr txBox="1"/>
          <p:nvPr/>
        </p:nvSpPr>
        <p:spPr>
          <a:xfrm rot="16200000">
            <a:off x="2219219" y="2154509"/>
            <a:ext cx="503226" cy="289208"/>
          </a:xfrm>
          <a:prstGeom prst="rect">
            <a:avLst/>
          </a:prstGeom>
          <a:noFill/>
        </p:spPr>
        <p:txBody>
          <a:bodyPr wrap="square" lIns="0" tIns="38761" rIns="0" rtlCol="0">
            <a:spAutoFit/>
          </a:bodyPr>
          <a:lstStyle/>
          <a:p>
            <a:pPr defTabSz="378653"/>
            <a:r>
              <a:rPr lang="en-SG" sz="1325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</a:p>
        </p:txBody>
      </p:sp>
      <p:cxnSp>
        <p:nvCxnSpPr>
          <p:cNvPr id="60" name="Straight Connector 59">
            <a:extLst>
              <a:ext uri="{FF2B5EF4-FFF2-40B4-BE49-F238E27FC236}">
                <a16:creationId xmlns:a16="http://schemas.microsoft.com/office/drawing/2014/main" id="{77826928-11CD-406F-84F0-E580EDEADDB2}"/>
              </a:ext>
            </a:extLst>
          </p:cNvPr>
          <p:cNvCxnSpPr/>
          <p:nvPr/>
        </p:nvCxnSpPr>
        <p:spPr>
          <a:xfrm>
            <a:off x="1904351" y="1866789"/>
            <a:ext cx="77365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Straight Connector 60">
            <a:extLst>
              <a:ext uri="{FF2B5EF4-FFF2-40B4-BE49-F238E27FC236}">
                <a16:creationId xmlns:a16="http://schemas.microsoft.com/office/drawing/2014/main" id="{5ACCF808-AD5E-4BD5-94EC-FA99D9D9886B}"/>
              </a:ext>
            </a:extLst>
          </p:cNvPr>
          <p:cNvCxnSpPr/>
          <p:nvPr/>
        </p:nvCxnSpPr>
        <p:spPr>
          <a:xfrm>
            <a:off x="956225" y="1869721"/>
            <a:ext cx="77365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Straight Connector 61">
            <a:extLst>
              <a:ext uri="{FF2B5EF4-FFF2-40B4-BE49-F238E27FC236}">
                <a16:creationId xmlns:a16="http://schemas.microsoft.com/office/drawing/2014/main" id="{B7D2F1B4-CDA5-4E3A-951C-EFDF82F41A58}"/>
              </a:ext>
            </a:extLst>
          </p:cNvPr>
          <p:cNvCxnSpPr/>
          <p:nvPr/>
        </p:nvCxnSpPr>
        <p:spPr>
          <a:xfrm>
            <a:off x="2849544" y="1869722"/>
            <a:ext cx="107337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Straight Connector 62">
            <a:extLst>
              <a:ext uri="{FF2B5EF4-FFF2-40B4-BE49-F238E27FC236}">
                <a16:creationId xmlns:a16="http://schemas.microsoft.com/office/drawing/2014/main" id="{5FF354D1-1023-41E0-9BDA-284A9CF44B8F}"/>
              </a:ext>
            </a:extLst>
          </p:cNvPr>
          <p:cNvCxnSpPr/>
          <p:nvPr/>
        </p:nvCxnSpPr>
        <p:spPr>
          <a:xfrm>
            <a:off x="4085338" y="1863848"/>
            <a:ext cx="107337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Straight Connector 63">
            <a:extLst>
              <a:ext uri="{FF2B5EF4-FFF2-40B4-BE49-F238E27FC236}">
                <a16:creationId xmlns:a16="http://schemas.microsoft.com/office/drawing/2014/main" id="{1655E31C-CF3A-4142-B767-9AE4AB8E32B0}"/>
              </a:ext>
            </a:extLst>
          </p:cNvPr>
          <p:cNvCxnSpPr/>
          <p:nvPr/>
        </p:nvCxnSpPr>
        <p:spPr>
          <a:xfrm>
            <a:off x="5418000" y="1866781"/>
            <a:ext cx="107337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Straight Connector 64">
            <a:extLst>
              <a:ext uri="{FF2B5EF4-FFF2-40B4-BE49-F238E27FC236}">
                <a16:creationId xmlns:a16="http://schemas.microsoft.com/office/drawing/2014/main" id="{B4E66C5A-E9EF-4E51-A781-F5DA4D81E9CF}"/>
              </a:ext>
            </a:extLst>
          </p:cNvPr>
          <p:cNvCxnSpPr/>
          <p:nvPr/>
        </p:nvCxnSpPr>
        <p:spPr>
          <a:xfrm>
            <a:off x="6609767" y="1869713"/>
            <a:ext cx="107337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6" name="TextBox 65">
            <a:extLst>
              <a:ext uri="{FF2B5EF4-FFF2-40B4-BE49-F238E27FC236}">
                <a16:creationId xmlns:a16="http://schemas.microsoft.com/office/drawing/2014/main" id="{79601AEF-74AE-414B-8A53-31B10BEAF4FC}"/>
              </a:ext>
            </a:extLst>
          </p:cNvPr>
          <p:cNvSpPr txBox="1"/>
          <p:nvPr/>
        </p:nvSpPr>
        <p:spPr>
          <a:xfrm>
            <a:off x="1199583" y="1589391"/>
            <a:ext cx="604686" cy="2962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378653"/>
            <a:r>
              <a:rPr lang="en-SG" sz="1325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yto</a:t>
            </a:r>
            <a:endParaRPr lang="en-SG" sz="1325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0020CD19-97ED-4CDC-A054-8EE27157AA0D}"/>
              </a:ext>
            </a:extLst>
          </p:cNvPr>
          <p:cNvSpPr txBox="1"/>
          <p:nvPr/>
        </p:nvSpPr>
        <p:spPr>
          <a:xfrm>
            <a:off x="2090299" y="1585338"/>
            <a:ext cx="604686" cy="2962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378653"/>
            <a:r>
              <a:rPr lang="en-SG" sz="1325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ito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E21A90C1-2774-4BC3-A3BE-5E0B318933A1}"/>
              </a:ext>
            </a:extLst>
          </p:cNvPr>
          <p:cNvSpPr txBox="1"/>
          <p:nvPr/>
        </p:nvSpPr>
        <p:spPr>
          <a:xfrm>
            <a:off x="3216183" y="1580584"/>
            <a:ext cx="604686" cy="2962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378653"/>
            <a:r>
              <a:rPr lang="en-SG" sz="1325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yto</a:t>
            </a:r>
            <a:endParaRPr lang="en-SG" sz="1325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204A5675-827D-4EC4-A141-34BFA1A43B1C}"/>
              </a:ext>
            </a:extLst>
          </p:cNvPr>
          <p:cNvSpPr txBox="1"/>
          <p:nvPr/>
        </p:nvSpPr>
        <p:spPr>
          <a:xfrm>
            <a:off x="4450338" y="1585337"/>
            <a:ext cx="604686" cy="2962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378653"/>
            <a:r>
              <a:rPr lang="en-SG" sz="1325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ito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86F21613-2548-4522-ADE1-6A01FFDC98C9}"/>
              </a:ext>
            </a:extLst>
          </p:cNvPr>
          <p:cNvSpPr txBox="1"/>
          <p:nvPr/>
        </p:nvSpPr>
        <p:spPr>
          <a:xfrm>
            <a:off x="5725932" y="1589392"/>
            <a:ext cx="604686" cy="2962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378653"/>
            <a:r>
              <a:rPr lang="en-SG" sz="1325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yto</a:t>
            </a:r>
            <a:endParaRPr lang="en-SG" sz="1325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6D76CE80-0218-4975-9827-B8CFB0B20185}"/>
              </a:ext>
            </a:extLst>
          </p:cNvPr>
          <p:cNvSpPr txBox="1"/>
          <p:nvPr/>
        </p:nvSpPr>
        <p:spPr>
          <a:xfrm>
            <a:off x="6995308" y="1594146"/>
            <a:ext cx="604686" cy="2962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378653"/>
            <a:r>
              <a:rPr lang="en-SG" sz="1325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ito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55282E1B-598E-4929-A791-B90EDB543250}"/>
              </a:ext>
            </a:extLst>
          </p:cNvPr>
          <p:cNvSpPr txBox="1"/>
          <p:nvPr/>
        </p:nvSpPr>
        <p:spPr>
          <a:xfrm>
            <a:off x="982187" y="5427196"/>
            <a:ext cx="6884604" cy="10100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 defTabSz="378653"/>
            <a:r>
              <a:rPr lang="en-US" sz="1491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B) </a:t>
            </a:r>
            <a:r>
              <a:rPr lang="en-SG" sz="149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reSu9-HA-Ub conjugates pattern in additional 13 E3 deletion strains.  </a:t>
            </a:r>
            <a:r>
              <a:rPr lang="en-US" sz="149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ytosolic and mitochondrial fractions of cells deficient in an indicated E3 and expressing preSu9-HA-Ub were examined by WB with antibody against HA (</a:t>
            </a:r>
            <a:r>
              <a:rPr lang="el-GR" sz="149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α-</a:t>
            </a:r>
            <a:r>
              <a:rPr lang="en-US" sz="149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A),  Aco1 (mitochondrial marker), and Hxk1 (cytosolic marker). </a:t>
            </a:r>
          </a:p>
        </p:txBody>
      </p:sp>
      <p:pic>
        <p:nvPicPr>
          <p:cNvPr id="80" name="Picture 79">
            <a:extLst>
              <a:ext uri="{FF2B5EF4-FFF2-40B4-BE49-F238E27FC236}">
                <a16:creationId xmlns:a16="http://schemas.microsoft.com/office/drawing/2014/main" id="{F5DBBA98-72BD-46B3-8995-DB56D90DD8F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827090" y="2597512"/>
            <a:ext cx="2484242" cy="1873280"/>
          </a:xfrm>
          <a:prstGeom prst="rect">
            <a:avLst/>
          </a:prstGeom>
        </p:spPr>
      </p:pic>
      <p:pic>
        <p:nvPicPr>
          <p:cNvPr id="82" name="Picture 81">
            <a:extLst>
              <a:ext uri="{FF2B5EF4-FFF2-40B4-BE49-F238E27FC236}">
                <a16:creationId xmlns:a16="http://schemas.microsoft.com/office/drawing/2014/main" id="{7844CA30-B903-400C-A924-36D92BF74CC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77774" y="4528941"/>
            <a:ext cx="1913674" cy="222168"/>
          </a:xfrm>
          <a:prstGeom prst="rect">
            <a:avLst/>
          </a:prstGeom>
        </p:spPr>
      </p:pic>
      <p:pic>
        <p:nvPicPr>
          <p:cNvPr id="83" name="Picture 82">
            <a:extLst>
              <a:ext uri="{FF2B5EF4-FFF2-40B4-BE49-F238E27FC236}">
                <a16:creationId xmlns:a16="http://schemas.microsoft.com/office/drawing/2014/main" id="{EA27EEB7-1BF1-4B8C-80D7-831A9F325B3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88236" y="4809234"/>
            <a:ext cx="1913674" cy="217119"/>
          </a:xfrm>
          <a:prstGeom prst="rect">
            <a:avLst/>
          </a:prstGeom>
        </p:spPr>
      </p:pic>
      <p:pic>
        <p:nvPicPr>
          <p:cNvPr id="85" name="Picture 84">
            <a:extLst>
              <a:ext uri="{FF2B5EF4-FFF2-40B4-BE49-F238E27FC236}">
                <a16:creationId xmlns:a16="http://schemas.microsoft.com/office/drawing/2014/main" id="{412BEFCA-B075-4655-8E4B-5F1E2ED2DD29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827090" y="4514316"/>
            <a:ext cx="2484242" cy="222168"/>
          </a:xfrm>
          <a:prstGeom prst="rect">
            <a:avLst/>
          </a:prstGeom>
        </p:spPr>
      </p:pic>
      <p:pic>
        <p:nvPicPr>
          <p:cNvPr id="86" name="Picture 85">
            <a:extLst>
              <a:ext uri="{FF2B5EF4-FFF2-40B4-BE49-F238E27FC236}">
                <a16:creationId xmlns:a16="http://schemas.microsoft.com/office/drawing/2014/main" id="{302340BD-8613-48A8-AC92-5ADBE0CDC96B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827090" y="4794095"/>
            <a:ext cx="2484242" cy="217119"/>
          </a:xfrm>
          <a:prstGeom prst="rect">
            <a:avLst/>
          </a:prstGeom>
        </p:spPr>
      </p:pic>
      <p:pic>
        <p:nvPicPr>
          <p:cNvPr id="87" name="Picture 86">
            <a:extLst>
              <a:ext uri="{FF2B5EF4-FFF2-40B4-BE49-F238E27FC236}">
                <a16:creationId xmlns:a16="http://schemas.microsoft.com/office/drawing/2014/main" id="{0FAF5C05-D171-4F0D-956B-104F68FD0CD0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5377071" y="2607717"/>
            <a:ext cx="2484242" cy="1873280"/>
          </a:xfrm>
          <a:prstGeom prst="rect">
            <a:avLst/>
          </a:prstGeom>
        </p:spPr>
      </p:pic>
      <p:pic>
        <p:nvPicPr>
          <p:cNvPr id="88" name="Picture 87">
            <a:extLst>
              <a:ext uri="{FF2B5EF4-FFF2-40B4-BE49-F238E27FC236}">
                <a16:creationId xmlns:a16="http://schemas.microsoft.com/office/drawing/2014/main" id="{8BAD004B-0FE0-476D-81CA-345D3248D5F2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5382549" y="4522942"/>
            <a:ext cx="2484242" cy="222168"/>
          </a:xfrm>
          <a:prstGeom prst="rect">
            <a:avLst/>
          </a:prstGeom>
        </p:spPr>
      </p:pic>
      <p:pic>
        <p:nvPicPr>
          <p:cNvPr id="89" name="Picture 88">
            <a:extLst>
              <a:ext uri="{FF2B5EF4-FFF2-40B4-BE49-F238E27FC236}">
                <a16:creationId xmlns:a16="http://schemas.microsoft.com/office/drawing/2014/main" id="{3F58FE85-058E-4933-893B-018BFAC36DCF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5387658" y="4793523"/>
            <a:ext cx="2484242" cy="217119"/>
          </a:xfrm>
          <a:prstGeom prst="rect">
            <a:avLst/>
          </a:prstGeom>
        </p:spPr>
      </p:pic>
      <p:pic>
        <p:nvPicPr>
          <p:cNvPr id="79" name="Picture 78">
            <a:extLst>
              <a:ext uri="{FF2B5EF4-FFF2-40B4-BE49-F238E27FC236}">
                <a16:creationId xmlns:a16="http://schemas.microsoft.com/office/drawing/2014/main" id="{0FC7C93C-6145-411F-BBB4-8F5255902DDE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877774" y="2597512"/>
            <a:ext cx="1913674" cy="1873280"/>
          </a:xfrm>
          <a:prstGeom prst="rect">
            <a:avLst/>
          </a:prstGeom>
        </p:spPr>
      </p:pic>
      <p:grpSp>
        <p:nvGrpSpPr>
          <p:cNvPr id="77" name="Group 76">
            <a:extLst>
              <a:ext uri="{FF2B5EF4-FFF2-40B4-BE49-F238E27FC236}">
                <a16:creationId xmlns:a16="http://schemas.microsoft.com/office/drawing/2014/main" id="{38C34EC9-D83B-4246-AFD2-2791D67D5319}"/>
              </a:ext>
            </a:extLst>
          </p:cNvPr>
          <p:cNvGrpSpPr/>
          <p:nvPr/>
        </p:nvGrpSpPr>
        <p:grpSpPr>
          <a:xfrm>
            <a:off x="498854" y="3022609"/>
            <a:ext cx="390913" cy="647229"/>
            <a:chOff x="-338207" y="3827382"/>
            <a:chExt cx="471991" cy="781469"/>
          </a:xfrm>
        </p:grpSpPr>
        <p:cxnSp>
          <p:nvCxnSpPr>
            <p:cNvPr id="72" name="Straight Connector 71">
              <a:extLst>
                <a:ext uri="{FF2B5EF4-FFF2-40B4-BE49-F238E27FC236}">
                  <a16:creationId xmlns:a16="http://schemas.microsoft.com/office/drawing/2014/main" id="{96266C1F-A461-4DCB-BF0E-9F1F6FBE1D27}"/>
                </a:ext>
              </a:extLst>
            </p:cNvPr>
            <p:cNvCxnSpPr/>
            <p:nvPr/>
          </p:nvCxnSpPr>
          <p:spPr>
            <a:xfrm>
              <a:off x="-44292" y="4265050"/>
              <a:ext cx="168442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3" name="Straight Connector 72">
              <a:extLst>
                <a:ext uri="{FF2B5EF4-FFF2-40B4-BE49-F238E27FC236}">
                  <a16:creationId xmlns:a16="http://schemas.microsoft.com/office/drawing/2014/main" id="{36BEF705-D6B6-4EF2-9813-BD5E123F8216}"/>
                </a:ext>
              </a:extLst>
            </p:cNvPr>
            <p:cNvCxnSpPr/>
            <p:nvPr/>
          </p:nvCxnSpPr>
          <p:spPr>
            <a:xfrm>
              <a:off x="-34658" y="4405418"/>
              <a:ext cx="168442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4" name="TextBox 73">
              <a:extLst>
                <a:ext uri="{FF2B5EF4-FFF2-40B4-BE49-F238E27FC236}">
                  <a16:creationId xmlns:a16="http://schemas.microsoft.com/office/drawing/2014/main" id="{8E9B461A-5BAA-4FCC-9536-43CF0B1333D6}"/>
                </a:ext>
              </a:extLst>
            </p:cNvPr>
            <p:cNvSpPr txBox="1"/>
            <p:nvPr/>
          </p:nvSpPr>
          <p:spPr>
            <a:xfrm>
              <a:off x="-338207" y="4259659"/>
              <a:ext cx="339645" cy="349192"/>
            </a:xfrm>
            <a:prstGeom prst="rect">
              <a:avLst/>
            </a:prstGeom>
            <a:noFill/>
          </p:spPr>
          <p:txBody>
            <a:bodyPr wrap="square" lIns="0" tIns="38761" rIns="0" rtlCol="0">
              <a:spAutoFit/>
            </a:bodyPr>
            <a:lstStyle/>
            <a:p>
              <a:pPr algn="ctr" defTabSz="378653"/>
              <a:r>
                <a:rPr lang="en-SG" sz="1325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48</a:t>
              </a:r>
            </a:p>
          </p:txBody>
        </p:sp>
        <p:sp>
          <p:nvSpPr>
            <p:cNvPr id="75" name="TextBox 74">
              <a:extLst>
                <a:ext uri="{FF2B5EF4-FFF2-40B4-BE49-F238E27FC236}">
                  <a16:creationId xmlns:a16="http://schemas.microsoft.com/office/drawing/2014/main" id="{B597A422-B85B-4A36-86A1-13CB342380C8}"/>
                </a:ext>
              </a:extLst>
            </p:cNvPr>
            <p:cNvSpPr txBox="1"/>
            <p:nvPr/>
          </p:nvSpPr>
          <p:spPr>
            <a:xfrm>
              <a:off x="-330189" y="4063138"/>
              <a:ext cx="339645" cy="349192"/>
            </a:xfrm>
            <a:prstGeom prst="rect">
              <a:avLst/>
            </a:prstGeom>
            <a:noFill/>
          </p:spPr>
          <p:txBody>
            <a:bodyPr wrap="square" lIns="0" tIns="38761" rIns="0" rtlCol="0">
              <a:spAutoFit/>
            </a:bodyPr>
            <a:lstStyle/>
            <a:p>
              <a:pPr algn="ctr" defTabSz="378653"/>
              <a:r>
                <a:rPr lang="en-SG" sz="1325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63</a:t>
              </a:r>
            </a:p>
          </p:txBody>
        </p:sp>
        <p:sp>
          <p:nvSpPr>
            <p:cNvPr id="76" name="TextBox 75">
              <a:extLst>
                <a:ext uri="{FF2B5EF4-FFF2-40B4-BE49-F238E27FC236}">
                  <a16:creationId xmlns:a16="http://schemas.microsoft.com/office/drawing/2014/main" id="{8C8AE050-8EA7-4F87-AE33-81C0C6A915D8}"/>
                </a:ext>
              </a:extLst>
            </p:cNvPr>
            <p:cNvSpPr txBox="1"/>
            <p:nvPr/>
          </p:nvSpPr>
          <p:spPr>
            <a:xfrm>
              <a:off x="-311597" y="3827382"/>
              <a:ext cx="329690" cy="326863"/>
            </a:xfrm>
            <a:prstGeom prst="rect">
              <a:avLst/>
            </a:prstGeom>
            <a:noFill/>
          </p:spPr>
          <p:txBody>
            <a:bodyPr wrap="square" lIns="0" rIns="0" rtlCol="0">
              <a:spAutoFit/>
            </a:bodyPr>
            <a:lstStyle/>
            <a:p>
              <a:pPr defTabSz="378653"/>
              <a:r>
                <a:rPr lang="en-SG" sz="1159" dirty="0" err="1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en-SG" sz="1159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81" name="TextBox 80">
            <a:extLst>
              <a:ext uri="{FF2B5EF4-FFF2-40B4-BE49-F238E27FC236}">
                <a16:creationId xmlns:a16="http://schemas.microsoft.com/office/drawing/2014/main" id="{B55C80C8-301B-440B-8248-96E0236E5633}"/>
              </a:ext>
            </a:extLst>
          </p:cNvPr>
          <p:cNvSpPr txBox="1"/>
          <p:nvPr/>
        </p:nvSpPr>
        <p:spPr>
          <a:xfrm>
            <a:off x="1333484" y="592554"/>
            <a:ext cx="6531929" cy="5511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defTabSz="378653"/>
            <a:r>
              <a:rPr lang="en-SG" sz="1491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ure S5: preSu9-HA-Ub conjugates patterns in cells deficient in E3 (related) proteins</a:t>
            </a:r>
            <a:endParaRPr lang="en-SG" sz="1491" b="1" dirty="0">
              <a:solidFill>
                <a:prstClr val="black"/>
              </a:solidFill>
              <a:latin typeface="Calibri" panose="020F0502020204030204"/>
            </a:endParaRPr>
          </a:p>
        </p:txBody>
      </p:sp>
    </p:spTree>
    <p:extLst>
      <p:ext uri="{BB962C8B-B14F-4D97-AF65-F5344CB8AC3E}">
        <p14:creationId xmlns:p14="http://schemas.microsoft.com/office/powerpoint/2010/main" val="564567254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5" name="Picture 144">
            <a:extLst>
              <a:ext uri="{FF2B5EF4-FFF2-40B4-BE49-F238E27FC236}">
                <a16:creationId xmlns:a16="http://schemas.microsoft.com/office/drawing/2014/main" id="{113AB3DC-5562-42D5-A9C6-0BC8EE78FC8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62710" y="2937154"/>
            <a:ext cx="2509488" cy="823031"/>
          </a:xfrm>
          <a:prstGeom prst="rect">
            <a:avLst/>
          </a:prstGeom>
        </p:spPr>
      </p:pic>
      <p:cxnSp>
        <p:nvCxnSpPr>
          <p:cNvPr id="6" name="Straight Connector 5">
            <a:extLst>
              <a:ext uri="{FF2B5EF4-FFF2-40B4-BE49-F238E27FC236}">
                <a16:creationId xmlns:a16="http://schemas.microsoft.com/office/drawing/2014/main" id="{0BD86E7F-FDFC-446F-AC11-F568AB29ECC9}"/>
              </a:ext>
            </a:extLst>
          </p:cNvPr>
          <p:cNvCxnSpPr/>
          <p:nvPr/>
        </p:nvCxnSpPr>
        <p:spPr>
          <a:xfrm>
            <a:off x="2855035" y="4429782"/>
            <a:ext cx="95411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>
            <a:extLst>
              <a:ext uri="{FF2B5EF4-FFF2-40B4-BE49-F238E27FC236}">
                <a16:creationId xmlns:a16="http://schemas.microsoft.com/office/drawing/2014/main" id="{150EF5EF-E6CB-4356-A5ED-2F70C19ED5D1}"/>
              </a:ext>
            </a:extLst>
          </p:cNvPr>
          <p:cNvCxnSpPr/>
          <p:nvPr/>
        </p:nvCxnSpPr>
        <p:spPr>
          <a:xfrm>
            <a:off x="1704858" y="4429782"/>
            <a:ext cx="95411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>
            <a:extLst>
              <a:ext uri="{FF2B5EF4-FFF2-40B4-BE49-F238E27FC236}">
                <a16:creationId xmlns:a16="http://schemas.microsoft.com/office/drawing/2014/main" id="{2E70CF34-CF93-4B84-AB0E-E1EA8A21E765}"/>
              </a:ext>
            </a:extLst>
          </p:cNvPr>
          <p:cNvSpPr txBox="1"/>
          <p:nvPr/>
        </p:nvSpPr>
        <p:spPr>
          <a:xfrm>
            <a:off x="1996986" y="4439704"/>
            <a:ext cx="604686" cy="2962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378653"/>
            <a:r>
              <a:rPr lang="en-SG" sz="1325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yto</a:t>
            </a:r>
            <a:endParaRPr lang="en-SG" sz="1325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88293E30-0069-476A-AFF7-6FD2E1B2998F}"/>
              </a:ext>
            </a:extLst>
          </p:cNvPr>
          <p:cNvSpPr txBox="1"/>
          <p:nvPr/>
        </p:nvSpPr>
        <p:spPr>
          <a:xfrm>
            <a:off x="3155726" y="4443702"/>
            <a:ext cx="604686" cy="2962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378653"/>
            <a:r>
              <a:rPr lang="en-SG" sz="1325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ito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1D27116C-3578-4436-B099-466165F86529}"/>
              </a:ext>
            </a:extLst>
          </p:cNvPr>
          <p:cNvSpPr txBox="1"/>
          <p:nvPr/>
        </p:nvSpPr>
        <p:spPr>
          <a:xfrm rot="16200000">
            <a:off x="1465857" y="2491680"/>
            <a:ext cx="503226" cy="289208"/>
          </a:xfrm>
          <a:prstGeom prst="rect">
            <a:avLst/>
          </a:prstGeom>
          <a:noFill/>
        </p:spPr>
        <p:txBody>
          <a:bodyPr wrap="square" lIns="0" tIns="38761" rIns="0" rtlCol="0">
            <a:spAutoFit/>
          </a:bodyPr>
          <a:lstStyle/>
          <a:p>
            <a:pPr defTabSz="378653"/>
            <a:r>
              <a:rPr lang="en-SG" sz="1325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ad6-</a:t>
            </a:r>
            <a:r>
              <a:rPr lang="el-GR" sz="1325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endParaRPr lang="en-SG" sz="1325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401E624B-03E0-4B88-B1D3-2C44F31DEB3E}"/>
              </a:ext>
            </a:extLst>
          </p:cNvPr>
          <p:cNvSpPr txBox="1"/>
          <p:nvPr/>
        </p:nvSpPr>
        <p:spPr>
          <a:xfrm rot="16200000">
            <a:off x="1621973" y="2498321"/>
            <a:ext cx="503226" cy="289208"/>
          </a:xfrm>
          <a:prstGeom prst="rect">
            <a:avLst/>
          </a:prstGeom>
          <a:noFill/>
        </p:spPr>
        <p:txBody>
          <a:bodyPr wrap="square" lIns="0" tIns="38761" rIns="0" rtlCol="0">
            <a:spAutoFit/>
          </a:bodyPr>
          <a:lstStyle/>
          <a:p>
            <a:pPr defTabSz="378653"/>
            <a:r>
              <a:rPr lang="en-SG" sz="1325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mpty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DD2B937B-D486-4550-82E0-6A7531028FAB}"/>
              </a:ext>
            </a:extLst>
          </p:cNvPr>
          <p:cNvSpPr txBox="1"/>
          <p:nvPr/>
        </p:nvSpPr>
        <p:spPr>
          <a:xfrm rot="16200000">
            <a:off x="1804653" y="2494167"/>
            <a:ext cx="503226" cy="289208"/>
          </a:xfrm>
          <a:prstGeom prst="rect">
            <a:avLst/>
          </a:prstGeom>
          <a:noFill/>
        </p:spPr>
        <p:txBody>
          <a:bodyPr wrap="square" lIns="0" tIns="38761" rIns="0" rtlCol="0">
            <a:spAutoFit/>
          </a:bodyPr>
          <a:lstStyle/>
          <a:p>
            <a:pPr defTabSz="378653"/>
            <a:r>
              <a:rPr lang="en-SG" sz="1325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ad6-</a:t>
            </a:r>
            <a:r>
              <a:rPr lang="el-GR" sz="1325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endParaRPr lang="en-SG" sz="1325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3D0D37A9-8AA2-4E48-8727-64943B5976A8}"/>
              </a:ext>
            </a:extLst>
          </p:cNvPr>
          <p:cNvSpPr txBox="1"/>
          <p:nvPr/>
        </p:nvSpPr>
        <p:spPr>
          <a:xfrm rot="16200000">
            <a:off x="1960769" y="2500807"/>
            <a:ext cx="503226" cy="289208"/>
          </a:xfrm>
          <a:prstGeom prst="rect">
            <a:avLst/>
          </a:prstGeom>
          <a:noFill/>
        </p:spPr>
        <p:txBody>
          <a:bodyPr wrap="square" lIns="0" tIns="38761" rIns="0" rtlCol="0">
            <a:spAutoFit/>
          </a:bodyPr>
          <a:lstStyle/>
          <a:p>
            <a:pPr defTabSz="378653"/>
            <a:r>
              <a:rPr lang="en-SG" sz="1325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mpty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30BC4548-73AC-4DAA-8569-2D68FAF43DB2}"/>
              </a:ext>
            </a:extLst>
          </p:cNvPr>
          <p:cNvSpPr txBox="1"/>
          <p:nvPr/>
        </p:nvSpPr>
        <p:spPr>
          <a:xfrm rot="16200000">
            <a:off x="1587677" y="1966622"/>
            <a:ext cx="1566406" cy="289208"/>
          </a:xfrm>
          <a:prstGeom prst="rect">
            <a:avLst/>
          </a:prstGeom>
          <a:noFill/>
        </p:spPr>
        <p:txBody>
          <a:bodyPr wrap="square" lIns="0" tIns="38761" rIns="0" rtlCol="0">
            <a:spAutoFit/>
          </a:bodyPr>
          <a:lstStyle/>
          <a:p>
            <a:pPr defTabSz="378653"/>
            <a:r>
              <a:rPr lang="en-SG" sz="1325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reSu9-Rad6-</a:t>
            </a:r>
            <a:r>
              <a:rPr lang="el-GR" sz="1325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en-SG" sz="1325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SL17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33E9FD9F-DD11-4CE7-98F6-01CF1AF9A7AE}"/>
              </a:ext>
            </a:extLst>
          </p:cNvPr>
          <p:cNvSpPr txBox="1"/>
          <p:nvPr/>
        </p:nvSpPr>
        <p:spPr>
          <a:xfrm rot="16200000">
            <a:off x="1484064" y="1696788"/>
            <a:ext cx="2106075" cy="289208"/>
          </a:xfrm>
          <a:prstGeom prst="rect">
            <a:avLst/>
          </a:prstGeom>
          <a:noFill/>
        </p:spPr>
        <p:txBody>
          <a:bodyPr wrap="square" lIns="0" tIns="38761" rIns="0" rtlCol="0">
            <a:spAutoFit/>
          </a:bodyPr>
          <a:lstStyle/>
          <a:p>
            <a:pPr defTabSz="378653"/>
            <a:r>
              <a:rPr lang="en-SG" sz="1325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reSu9-Rad6(C88A)-</a:t>
            </a:r>
            <a:r>
              <a:rPr lang="el-GR" sz="1325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en-SG" sz="1325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SL17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F3B28929-5A4D-4227-B2EA-58281A875E9F}"/>
              </a:ext>
            </a:extLst>
          </p:cNvPr>
          <p:cNvSpPr txBox="1"/>
          <p:nvPr/>
        </p:nvSpPr>
        <p:spPr>
          <a:xfrm rot="16200000">
            <a:off x="2608001" y="2497840"/>
            <a:ext cx="503226" cy="289208"/>
          </a:xfrm>
          <a:prstGeom prst="rect">
            <a:avLst/>
          </a:prstGeom>
          <a:noFill/>
        </p:spPr>
        <p:txBody>
          <a:bodyPr wrap="square" lIns="0" tIns="38761" rIns="0" rtlCol="0">
            <a:spAutoFit/>
          </a:bodyPr>
          <a:lstStyle/>
          <a:p>
            <a:pPr defTabSz="378653"/>
            <a:r>
              <a:rPr lang="en-SG" sz="1325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ad6-</a:t>
            </a:r>
            <a:r>
              <a:rPr lang="el-GR" sz="1325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endParaRPr lang="en-SG" sz="1325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2470330E-2692-4076-AB54-C3CC1AB4CE80}"/>
              </a:ext>
            </a:extLst>
          </p:cNvPr>
          <p:cNvSpPr txBox="1"/>
          <p:nvPr/>
        </p:nvSpPr>
        <p:spPr>
          <a:xfrm rot="16200000">
            <a:off x="2764118" y="2495245"/>
            <a:ext cx="503226" cy="289208"/>
          </a:xfrm>
          <a:prstGeom prst="rect">
            <a:avLst/>
          </a:prstGeom>
          <a:noFill/>
        </p:spPr>
        <p:txBody>
          <a:bodyPr wrap="square" lIns="0" tIns="38761" rIns="0" rtlCol="0">
            <a:spAutoFit/>
          </a:bodyPr>
          <a:lstStyle/>
          <a:p>
            <a:pPr defTabSz="378653"/>
            <a:r>
              <a:rPr lang="en-SG" sz="1325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mpty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02C5002D-424F-48C4-80AE-A82A246269C5}"/>
              </a:ext>
            </a:extLst>
          </p:cNvPr>
          <p:cNvSpPr txBox="1"/>
          <p:nvPr/>
        </p:nvSpPr>
        <p:spPr>
          <a:xfrm rot="16200000">
            <a:off x="2937562" y="2500326"/>
            <a:ext cx="503226" cy="289208"/>
          </a:xfrm>
          <a:prstGeom prst="rect">
            <a:avLst/>
          </a:prstGeom>
          <a:noFill/>
        </p:spPr>
        <p:txBody>
          <a:bodyPr wrap="square" lIns="0" tIns="38761" rIns="0" rtlCol="0">
            <a:spAutoFit/>
          </a:bodyPr>
          <a:lstStyle/>
          <a:p>
            <a:pPr defTabSz="378653"/>
            <a:r>
              <a:rPr lang="en-SG" sz="1325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ad6-</a:t>
            </a:r>
            <a:r>
              <a:rPr lang="el-GR" sz="1325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endParaRPr lang="en-SG" sz="1325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3846BDB1-6A4D-4B5A-9AD4-9BD227399068}"/>
              </a:ext>
            </a:extLst>
          </p:cNvPr>
          <p:cNvSpPr txBox="1"/>
          <p:nvPr/>
        </p:nvSpPr>
        <p:spPr>
          <a:xfrm rot="16200000">
            <a:off x="3084443" y="2497731"/>
            <a:ext cx="503226" cy="289208"/>
          </a:xfrm>
          <a:prstGeom prst="rect">
            <a:avLst/>
          </a:prstGeom>
          <a:noFill/>
        </p:spPr>
        <p:txBody>
          <a:bodyPr wrap="square" lIns="0" tIns="38761" rIns="0" rtlCol="0">
            <a:spAutoFit/>
          </a:bodyPr>
          <a:lstStyle/>
          <a:p>
            <a:pPr defTabSz="378653"/>
            <a:r>
              <a:rPr lang="en-SG" sz="1325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mpty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9E4DCE80-315B-4624-8285-118F18C87792}"/>
              </a:ext>
            </a:extLst>
          </p:cNvPr>
          <p:cNvSpPr txBox="1"/>
          <p:nvPr/>
        </p:nvSpPr>
        <p:spPr>
          <a:xfrm rot="16200000">
            <a:off x="2702116" y="1954311"/>
            <a:ext cx="1566406" cy="289208"/>
          </a:xfrm>
          <a:prstGeom prst="rect">
            <a:avLst/>
          </a:prstGeom>
          <a:noFill/>
        </p:spPr>
        <p:txBody>
          <a:bodyPr wrap="square" lIns="0" tIns="38761" rIns="0" rtlCol="0">
            <a:spAutoFit/>
          </a:bodyPr>
          <a:lstStyle/>
          <a:p>
            <a:pPr defTabSz="378653"/>
            <a:r>
              <a:rPr lang="en-SG" sz="1325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reSu9-Rad6-</a:t>
            </a:r>
            <a:r>
              <a:rPr lang="el-GR" sz="1325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en-SG" sz="1325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SL17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43F5C54A-9F1F-4BE3-92E5-2D1FD79CB1CE}"/>
              </a:ext>
            </a:extLst>
          </p:cNvPr>
          <p:cNvSpPr txBox="1"/>
          <p:nvPr/>
        </p:nvSpPr>
        <p:spPr>
          <a:xfrm rot="16200000">
            <a:off x="2599894" y="1699972"/>
            <a:ext cx="2106075" cy="289208"/>
          </a:xfrm>
          <a:prstGeom prst="rect">
            <a:avLst/>
          </a:prstGeom>
          <a:noFill/>
        </p:spPr>
        <p:txBody>
          <a:bodyPr wrap="square" lIns="0" tIns="38761" rIns="0" rtlCol="0">
            <a:spAutoFit/>
          </a:bodyPr>
          <a:lstStyle/>
          <a:p>
            <a:pPr defTabSz="378653"/>
            <a:r>
              <a:rPr lang="en-SG" sz="1325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reSu9-Rad6(C88A)-</a:t>
            </a:r>
            <a:r>
              <a:rPr lang="el-GR" sz="1325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en-SG" sz="1325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SL17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E13FB885-DAED-4271-8999-AB5397E77047}"/>
              </a:ext>
            </a:extLst>
          </p:cNvPr>
          <p:cNvSpPr txBox="1"/>
          <p:nvPr/>
        </p:nvSpPr>
        <p:spPr>
          <a:xfrm rot="16200000">
            <a:off x="2516269" y="2558372"/>
            <a:ext cx="379638" cy="289208"/>
          </a:xfrm>
          <a:prstGeom prst="rect">
            <a:avLst/>
          </a:prstGeom>
          <a:noFill/>
        </p:spPr>
        <p:txBody>
          <a:bodyPr wrap="square" lIns="0" tIns="38761" rIns="0" rtlCol="0">
            <a:spAutoFit/>
          </a:bodyPr>
          <a:lstStyle/>
          <a:p>
            <a:pPr defTabSz="378653"/>
            <a:r>
              <a:rPr lang="en-SG" sz="1325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W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FA287FED-4DDC-4078-9B7A-7B23B7C1AA9A}"/>
              </a:ext>
            </a:extLst>
          </p:cNvPr>
          <p:cNvSpPr txBox="1"/>
          <p:nvPr/>
        </p:nvSpPr>
        <p:spPr>
          <a:xfrm>
            <a:off x="1624501" y="483520"/>
            <a:ext cx="447230" cy="2962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378653"/>
            <a:r>
              <a:rPr lang="en-SG" sz="1325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</a:p>
        </p:txBody>
      </p: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B9C67558-2ABE-46D0-86F7-2D6E7BD9C7BB}"/>
              </a:ext>
            </a:extLst>
          </p:cNvPr>
          <p:cNvCxnSpPr/>
          <p:nvPr/>
        </p:nvCxnSpPr>
        <p:spPr>
          <a:xfrm>
            <a:off x="1705317" y="797914"/>
            <a:ext cx="26834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Box 24">
            <a:extLst>
              <a:ext uri="{FF2B5EF4-FFF2-40B4-BE49-F238E27FC236}">
                <a16:creationId xmlns:a16="http://schemas.microsoft.com/office/drawing/2014/main" id="{B8030771-BA27-401E-BA6D-B66CE2026AAB}"/>
              </a:ext>
            </a:extLst>
          </p:cNvPr>
          <p:cNvSpPr txBox="1"/>
          <p:nvPr/>
        </p:nvSpPr>
        <p:spPr>
          <a:xfrm>
            <a:off x="2077475" y="480978"/>
            <a:ext cx="609251" cy="2962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378653"/>
            <a:r>
              <a:rPr lang="el-GR" sz="1325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SG" sz="1325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ad6</a:t>
            </a:r>
          </a:p>
        </p:txBody>
      </p: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7EC0D440-7FD0-4C4B-8723-FBEDA1E4ACA6}"/>
              </a:ext>
            </a:extLst>
          </p:cNvPr>
          <p:cNvCxnSpPr/>
          <p:nvPr/>
        </p:nvCxnSpPr>
        <p:spPr>
          <a:xfrm>
            <a:off x="2087517" y="795700"/>
            <a:ext cx="506871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Box 26">
            <a:extLst>
              <a:ext uri="{FF2B5EF4-FFF2-40B4-BE49-F238E27FC236}">
                <a16:creationId xmlns:a16="http://schemas.microsoft.com/office/drawing/2014/main" id="{AD9BAC2B-4C36-49D3-BA90-B950BDFBFB08}"/>
              </a:ext>
            </a:extLst>
          </p:cNvPr>
          <p:cNvSpPr txBox="1"/>
          <p:nvPr/>
        </p:nvSpPr>
        <p:spPr>
          <a:xfrm>
            <a:off x="2760609" y="489677"/>
            <a:ext cx="453265" cy="2962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378653"/>
            <a:r>
              <a:rPr lang="en-SG" sz="1325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</a:p>
        </p:txBody>
      </p:sp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5E1E15E9-23A7-4FC1-8C2F-067D77BE9099}"/>
              </a:ext>
            </a:extLst>
          </p:cNvPr>
          <p:cNvCxnSpPr/>
          <p:nvPr/>
        </p:nvCxnSpPr>
        <p:spPr>
          <a:xfrm>
            <a:off x="2847460" y="804071"/>
            <a:ext cx="26834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TextBox 28">
            <a:extLst>
              <a:ext uri="{FF2B5EF4-FFF2-40B4-BE49-F238E27FC236}">
                <a16:creationId xmlns:a16="http://schemas.microsoft.com/office/drawing/2014/main" id="{382183CE-3DBA-438B-A9B9-12B5353F0185}"/>
              </a:ext>
            </a:extLst>
          </p:cNvPr>
          <p:cNvSpPr txBox="1"/>
          <p:nvPr/>
        </p:nvSpPr>
        <p:spPr>
          <a:xfrm>
            <a:off x="3219618" y="487135"/>
            <a:ext cx="609251" cy="2962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378653"/>
            <a:r>
              <a:rPr lang="el-GR" sz="1325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SG" sz="1325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ad6</a:t>
            </a:r>
          </a:p>
        </p:txBody>
      </p:sp>
      <p:cxnSp>
        <p:nvCxnSpPr>
          <p:cNvPr id="30" name="Straight Connector 29">
            <a:extLst>
              <a:ext uri="{FF2B5EF4-FFF2-40B4-BE49-F238E27FC236}">
                <a16:creationId xmlns:a16="http://schemas.microsoft.com/office/drawing/2014/main" id="{78DF2F86-6C70-45A3-BD5C-35BA9CECFE38}"/>
              </a:ext>
            </a:extLst>
          </p:cNvPr>
          <p:cNvCxnSpPr/>
          <p:nvPr/>
        </p:nvCxnSpPr>
        <p:spPr>
          <a:xfrm>
            <a:off x="3229660" y="801857"/>
            <a:ext cx="506871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TextBox 30">
            <a:extLst>
              <a:ext uri="{FF2B5EF4-FFF2-40B4-BE49-F238E27FC236}">
                <a16:creationId xmlns:a16="http://schemas.microsoft.com/office/drawing/2014/main" id="{86FE4A0C-803C-4EA2-BFDE-3D9AB86E88AB}"/>
              </a:ext>
            </a:extLst>
          </p:cNvPr>
          <p:cNvSpPr txBox="1"/>
          <p:nvPr/>
        </p:nvSpPr>
        <p:spPr>
          <a:xfrm>
            <a:off x="859733" y="495646"/>
            <a:ext cx="609251" cy="2962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378653"/>
            <a:r>
              <a:rPr lang="en-SG" sz="1325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train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428534DB-40D0-4FFA-A11D-86690C8CC723}"/>
              </a:ext>
            </a:extLst>
          </p:cNvPr>
          <p:cNvSpPr txBox="1"/>
          <p:nvPr/>
        </p:nvSpPr>
        <p:spPr>
          <a:xfrm>
            <a:off x="924695" y="1720990"/>
            <a:ext cx="735179" cy="2962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378653"/>
            <a:r>
              <a:rPr lang="en-SG" sz="1325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lasmid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CC08DAF6-C821-4609-897B-27B4CEF5F341}"/>
              </a:ext>
            </a:extLst>
          </p:cNvPr>
          <p:cNvSpPr txBox="1"/>
          <p:nvPr/>
        </p:nvSpPr>
        <p:spPr>
          <a:xfrm>
            <a:off x="3967314" y="3808149"/>
            <a:ext cx="604686" cy="2962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378653"/>
            <a:r>
              <a:rPr lang="en-SG" sz="1325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co1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E7D575A5-42A9-4964-8A5B-87150CF34B3D}"/>
              </a:ext>
            </a:extLst>
          </p:cNvPr>
          <p:cNvSpPr txBox="1"/>
          <p:nvPr/>
        </p:nvSpPr>
        <p:spPr>
          <a:xfrm>
            <a:off x="3967314" y="4109932"/>
            <a:ext cx="604686" cy="2962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378653"/>
            <a:r>
              <a:rPr lang="en-SG" sz="1325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xk1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31AE0AF7-20C9-4E81-BF28-19707767F439}"/>
              </a:ext>
            </a:extLst>
          </p:cNvPr>
          <p:cNvSpPr txBox="1"/>
          <p:nvPr/>
        </p:nvSpPr>
        <p:spPr>
          <a:xfrm>
            <a:off x="3967314" y="3275052"/>
            <a:ext cx="604686" cy="2962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378653"/>
            <a:r>
              <a:rPr lang="en-SG" sz="1325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ad6</a:t>
            </a:r>
          </a:p>
        </p:txBody>
      </p:sp>
      <p:grpSp>
        <p:nvGrpSpPr>
          <p:cNvPr id="36" name="Group 35">
            <a:extLst>
              <a:ext uri="{FF2B5EF4-FFF2-40B4-BE49-F238E27FC236}">
                <a16:creationId xmlns:a16="http://schemas.microsoft.com/office/drawing/2014/main" id="{578FBD17-8589-486E-9C73-996CD522A337}"/>
              </a:ext>
            </a:extLst>
          </p:cNvPr>
          <p:cNvGrpSpPr/>
          <p:nvPr/>
        </p:nvGrpSpPr>
        <p:grpSpPr>
          <a:xfrm>
            <a:off x="996429" y="2733819"/>
            <a:ext cx="468935" cy="954330"/>
            <a:chOff x="303399" y="3422194"/>
            <a:chExt cx="566196" cy="1152265"/>
          </a:xfrm>
        </p:grpSpPr>
        <p:cxnSp>
          <p:nvCxnSpPr>
            <p:cNvPr id="37" name="Straight Connector 36">
              <a:extLst>
                <a:ext uri="{FF2B5EF4-FFF2-40B4-BE49-F238E27FC236}">
                  <a16:creationId xmlns:a16="http://schemas.microsoft.com/office/drawing/2014/main" id="{CCF185E3-E074-45BD-90EC-82C2C234C1EE}"/>
                </a:ext>
              </a:extLst>
            </p:cNvPr>
            <p:cNvCxnSpPr/>
            <p:nvPr/>
          </p:nvCxnSpPr>
          <p:spPr>
            <a:xfrm>
              <a:off x="756528" y="3838733"/>
              <a:ext cx="108000" cy="0"/>
            </a:xfrm>
            <a:prstGeom prst="line">
              <a:avLst/>
            </a:prstGeom>
            <a:ln w="158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8" name="Straight Connector 37">
              <a:extLst>
                <a:ext uri="{FF2B5EF4-FFF2-40B4-BE49-F238E27FC236}">
                  <a16:creationId xmlns:a16="http://schemas.microsoft.com/office/drawing/2014/main" id="{459A7932-DFFB-4193-8389-2381638B9B2A}"/>
                </a:ext>
              </a:extLst>
            </p:cNvPr>
            <p:cNvCxnSpPr/>
            <p:nvPr/>
          </p:nvCxnSpPr>
          <p:spPr>
            <a:xfrm>
              <a:off x="751797" y="3991897"/>
              <a:ext cx="108000" cy="0"/>
            </a:xfrm>
            <a:prstGeom prst="line">
              <a:avLst/>
            </a:prstGeom>
            <a:ln w="158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10409D2E-8ADC-41F6-9142-3FC595A1D283}"/>
                </a:ext>
              </a:extLst>
            </p:cNvPr>
            <p:cNvSpPr txBox="1"/>
            <p:nvPr/>
          </p:nvSpPr>
          <p:spPr>
            <a:xfrm>
              <a:off x="346548" y="3637959"/>
              <a:ext cx="471183" cy="3268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 defTabSz="378653"/>
              <a:r>
                <a:rPr lang="en-SG" sz="1159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48</a:t>
              </a: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F437331D-1387-43A1-9CEA-989131ADAB59}"/>
                </a:ext>
              </a:extLst>
            </p:cNvPr>
            <p:cNvSpPr txBox="1"/>
            <p:nvPr/>
          </p:nvSpPr>
          <p:spPr>
            <a:xfrm>
              <a:off x="346547" y="3813820"/>
              <a:ext cx="471183" cy="3268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 defTabSz="378653"/>
              <a:r>
                <a:rPr lang="en-SG" sz="1159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35</a:t>
              </a: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F3504DBE-FA81-4B1D-BE79-EF5AF385C6CE}"/>
                </a:ext>
              </a:extLst>
            </p:cNvPr>
            <p:cNvSpPr txBox="1"/>
            <p:nvPr/>
          </p:nvSpPr>
          <p:spPr>
            <a:xfrm>
              <a:off x="303399" y="3422194"/>
              <a:ext cx="549343" cy="3268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 defTabSz="378653"/>
              <a:r>
                <a:rPr lang="en-SG" sz="1159" dirty="0" err="1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en-SG" sz="1159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42" name="Straight Connector 41">
              <a:extLst>
                <a:ext uri="{FF2B5EF4-FFF2-40B4-BE49-F238E27FC236}">
                  <a16:creationId xmlns:a16="http://schemas.microsoft.com/office/drawing/2014/main" id="{BE6941D8-DADA-48A8-825A-585B1B5027F2}"/>
                </a:ext>
              </a:extLst>
            </p:cNvPr>
            <p:cNvCxnSpPr/>
            <p:nvPr/>
          </p:nvCxnSpPr>
          <p:spPr>
            <a:xfrm>
              <a:off x="758711" y="4144815"/>
              <a:ext cx="108000" cy="0"/>
            </a:xfrm>
            <a:prstGeom prst="line">
              <a:avLst/>
            </a:prstGeom>
            <a:ln w="158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B7332BFA-CB95-40BF-B184-128DD8D95FD8}"/>
                </a:ext>
              </a:extLst>
            </p:cNvPr>
            <p:cNvSpPr txBox="1"/>
            <p:nvPr/>
          </p:nvSpPr>
          <p:spPr>
            <a:xfrm>
              <a:off x="343394" y="3975548"/>
              <a:ext cx="471183" cy="3268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 defTabSz="378653"/>
              <a:r>
                <a:rPr lang="en-SG" sz="1159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5</a:t>
              </a:r>
            </a:p>
          </p:txBody>
        </p:sp>
        <p:cxnSp>
          <p:nvCxnSpPr>
            <p:cNvPr id="44" name="Straight Connector 43">
              <a:extLst>
                <a:ext uri="{FF2B5EF4-FFF2-40B4-BE49-F238E27FC236}">
                  <a16:creationId xmlns:a16="http://schemas.microsoft.com/office/drawing/2014/main" id="{E629BBC5-315A-4BDF-BED2-840F8D469BAC}"/>
                </a:ext>
              </a:extLst>
            </p:cNvPr>
            <p:cNvCxnSpPr>
              <a:cxnSpLocks/>
            </p:cNvCxnSpPr>
            <p:nvPr/>
          </p:nvCxnSpPr>
          <p:spPr>
            <a:xfrm rot="-1200000">
              <a:off x="761595" y="4234923"/>
              <a:ext cx="108000" cy="0"/>
            </a:xfrm>
            <a:prstGeom prst="line">
              <a:avLst/>
            </a:prstGeom>
            <a:ln w="158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5" name="Straight Connector 44">
              <a:extLst>
                <a:ext uri="{FF2B5EF4-FFF2-40B4-BE49-F238E27FC236}">
                  <a16:creationId xmlns:a16="http://schemas.microsoft.com/office/drawing/2014/main" id="{15126FFD-FDB3-40E4-A778-21B956C251A3}"/>
                </a:ext>
              </a:extLst>
            </p:cNvPr>
            <p:cNvCxnSpPr>
              <a:cxnSpLocks/>
            </p:cNvCxnSpPr>
            <p:nvPr/>
          </p:nvCxnSpPr>
          <p:spPr>
            <a:xfrm rot="-1200000">
              <a:off x="755340" y="4356950"/>
              <a:ext cx="108000" cy="0"/>
            </a:xfrm>
            <a:prstGeom prst="line">
              <a:avLst/>
            </a:prstGeom>
            <a:ln w="158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B9F68E58-588C-42A5-A8D6-F51C3B74946C}"/>
                </a:ext>
              </a:extLst>
            </p:cNvPr>
            <p:cNvSpPr txBox="1"/>
            <p:nvPr/>
          </p:nvSpPr>
          <p:spPr>
            <a:xfrm>
              <a:off x="346935" y="4096049"/>
              <a:ext cx="471183" cy="3268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 defTabSz="378653"/>
              <a:r>
                <a:rPr lang="en-SG" sz="1159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0</a:t>
              </a: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5405C221-2481-4C9C-B668-3A59668BD7FD}"/>
                </a:ext>
              </a:extLst>
            </p:cNvPr>
            <p:cNvSpPr txBox="1"/>
            <p:nvPr/>
          </p:nvSpPr>
          <p:spPr>
            <a:xfrm>
              <a:off x="341528" y="4247596"/>
              <a:ext cx="471183" cy="3268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 defTabSz="378653"/>
              <a:r>
                <a:rPr lang="en-SG" sz="1159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7</a:t>
              </a:r>
            </a:p>
          </p:txBody>
        </p:sp>
      </p:grpSp>
      <p:sp>
        <p:nvSpPr>
          <p:cNvPr id="54" name="TextBox 53">
            <a:extLst>
              <a:ext uri="{FF2B5EF4-FFF2-40B4-BE49-F238E27FC236}">
                <a16:creationId xmlns:a16="http://schemas.microsoft.com/office/drawing/2014/main" id="{0209665F-812F-4A2E-AE9C-A845D3EBCA3B}"/>
              </a:ext>
            </a:extLst>
          </p:cNvPr>
          <p:cNvSpPr txBox="1"/>
          <p:nvPr/>
        </p:nvSpPr>
        <p:spPr>
          <a:xfrm>
            <a:off x="6768428" y="3795050"/>
            <a:ext cx="600014" cy="2962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378653"/>
            <a:r>
              <a:rPr lang="en-SG" sz="1325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co1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22601A01-F0FB-4DD5-8B6D-99CAB766AA1A}"/>
              </a:ext>
            </a:extLst>
          </p:cNvPr>
          <p:cNvSpPr txBox="1"/>
          <p:nvPr/>
        </p:nvSpPr>
        <p:spPr>
          <a:xfrm>
            <a:off x="6787325" y="4123492"/>
            <a:ext cx="600014" cy="2962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378653"/>
            <a:r>
              <a:rPr lang="en-SG" sz="1325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xk1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40B01856-552E-41E8-8E41-E7E19474AE6A}"/>
              </a:ext>
            </a:extLst>
          </p:cNvPr>
          <p:cNvSpPr txBox="1"/>
          <p:nvPr/>
        </p:nvSpPr>
        <p:spPr>
          <a:xfrm>
            <a:off x="7444562" y="2683480"/>
            <a:ext cx="597675" cy="2962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378653"/>
            <a:r>
              <a:rPr lang="en-SG" sz="1325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ad6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D7657FA9-0413-44E3-8202-7136AEF7452C}"/>
              </a:ext>
            </a:extLst>
          </p:cNvPr>
          <p:cNvSpPr txBox="1"/>
          <p:nvPr/>
        </p:nvSpPr>
        <p:spPr>
          <a:xfrm>
            <a:off x="5447430" y="1683357"/>
            <a:ext cx="175151" cy="289208"/>
          </a:xfrm>
          <a:prstGeom prst="rect">
            <a:avLst/>
          </a:prstGeom>
          <a:noFill/>
        </p:spPr>
        <p:txBody>
          <a:bodyPr wrap="square" lIns="0" tIns="38761" rIns="0" rtlCol="0">
            <a:spAutoFit/>
          </a:bodyPr>
          <a:lstStyle/>
          <a:p>
            <a:pPr defTabSz="378653"/>
            <a:r>
              <a:rPr lang="en-SG" sz="1325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CF4776D4-57F6-43DB-A966-33507117AA08}"/>
              </a:ext>
            </a:extLst>
          </p:cNvPr>
          <p:cNvSpPr txBox="1"/>
          <p:nvPr/>
        </p:nvSpPr>
        <p:spPr>
          <a:xfrm>
            <a:off x="5631817" y="1674121"/>
            <a:ext cx="175151" cy="289208"/>
          </a:xfrm>
          <a:prstGeom prst="rect">
            <a:avLst/>
          </a:prstGeom>
          <a:noFill/>
        </p:spPr>
        <p:txBody>
          <a:bodyPr wrap="square" lIns="0" tIns="38761" rIns="0" rtlCol="0">
            <a:spAutoFit/>
          </a:bodyPr>
          <a:lstStyle/>
          <a:p>
            <a:pPr defTabSz="378653"/>
            <a:r>
              <a:rPr lang="en-SG" sz="1325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2832CB8D-084B-4EAA-9258-F06D09067E24}"/>
              </a:ext>
            </a:extLst>
          </p:cNvPr>
          <p:cNvSpPr txBox="1"/>
          <p:nvPr/>
        </p:nvSpPr>
        <p:spPr>
          <a:xfrm>
            <a:off x="5774843" y="1680715"/>
            <a:ext cx="175151" cy="289208"/>
          </a:xfrm>
          <a:prstGeom prst="rect">
            <a:avLst/>
          </a:prstGeom>
          <a:noFill/>
        </p:spPr>
        <p:txBody>
          <a:bodyPr wrap="square" lIns="0" tIns="38761" rIns="0" rtlCol="0">
            <a:spAutoFit/>
          </a:bodyPr>
          <a:lstStyle/>
          <a:p>
            <a:pPr defTabSz="378653"/>
            <a:r>
              <a:rPr lang="en-SG" sz="1325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AB91D2F2-5157-4074-91DD-0D0420062E75}"/>
              </a:ext>
            </a:extLst>
          </p:cNvPr>
          <p:cNvSpPr txBox="1"/>
          <p:nvPr/>
        </p:nvSpPr>
        <p:spPr>
          <a:xfrm>
            <a:off x="5959230" y="1671479"/>
            <a:ext cx="175151" cy="289208"/>
          </a:xfrm>
          <a:prstGeom prst="rect">
            <a:avLst/>
          </a:prstGeom>
          <a:noFill/>
        </p:spPr>
        <p:txBody>
          <a:bodyPr wrap="square" lIns="0" tIns="38761" rIns="0" rtlCol="0">
            <a:spAutoFit/>
          </a:bodyPr>
          <a:lstStyle/>
          <a:p>
            <a:pPr defTabSz="378653"/>
            <a:r>
              <a:rPr lang="en-SG" sz="1325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38B1A13C-5FF4-46C3-89C0-74C9E4ED1BBF}"/>
              </a:ext>
            </a:extLst>
          </p:cNvPr>
          <p:cNvSpPr txBox="1"/>
          <p:nvPr/>
        </p:nvSpPr>
        <p:spPr>
          <a:xfrm>
            <a:off x="6104317" y="1680715"/>
            <a:ext cx="175151" cy="289208"/>
          </a:xfrm>
          <a:prstGeom prst="rect">
            <a:avLst/>
          </a:prstGeom>
          <a:noFill/>
        </p:spPr>
        <p:txBody>
          <a:bodyPr wrap="square" lIns="0" tIns="38761" rIns="0" rtlCol="0">
            <a:spAutoFit/>
          </a:bodyPr>
          <a:lstStyle/>
          <a:p>
            <a:pPr defTabSz="378653"/>
            <a:r>
              <a:rPr lang="en-SG" sz="1325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B89E3114-ADB1-4D2C-B0BD-3FBB3573CB8B}"/>
              </a:ext>
            </a:extLst>
          </p:cNvPr>
          <p:cNvSpPr txBox="1"/>
          <p:nvPr/>
        </p:nvSpPr>
        <p:spPr>
          <a:xfrm>
            <a:off x="6288704" y="1680715"/>
            <a:ext cx="175151" cy="289208"/>
          </a:xfrm>
          <a:prstGeom prst="rect">
            <a:avLst/>
          </a:prstGeom>
          <a:noFill/>
        </p:spPr>
        <p:txBody>
          <a:bodyPr wrap="square" lIns="0" tIns="38761" rIns="0" rtlCol="0">
            <a:spAutoFit/>
          </a:bodyPr>
          <a:lstStyle/>
          <a:p>
            <a:pPr defTabSz="378653"/>
            <a:r>
              <a:rPr lang="en-SG" sz="1325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0F5EFBD4-D73F-4E33-B875-C39A7059599D}"/>
              </a:ext>
            </a:extLst>
          </p:cNvPr>
          <p:cNvSpPr txBox="1"/>
          <p:nvPr/>
        </p:nvSpPr>
        <p:spPr>
          <a:xfrm>
            <a:off x="6423330" y="1680281"/>
            <a:ext cx="175151" cy="289208"/>
          </a:xfrm>
          <a:prstGeom prst="rect">
            <a:avLst/>
          </a:prstGeom>
          <a:noFill/>
        </p:spPr>
        <p:txBody>
          <a:bodyPr wrap="square" lIns="0" tIns="38761" rIns="0" rtlCol="0">
            <a:spAutoFit/>
          </a:bodyPr>
          <a:lstStyle/>
          <a:p>
            <a:pPr defTabSz="378653"/>
            <a:r>
              <a:rPr lang="en-SG" sz="1325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A65FAADC-846F-4A3F-977E-8A93A85FE55C}"/>
              </a:ext>
            </a:extLst>
          </p:cNvPr>
          <p:cNvSpPr txBox="1"/>
          <p:nvPr/>
        </p:nvSpPr>
        <p:spPr>
          <a:xfrm>
            <a:off x="6607717" y="1680281"/>
            <a:ext cx="175151" cy="289208"/>
          </a:xfrm>
          <a:prstGeom prst="rect">
            <a:avLst/>
          </a:prstGeom>
          <a:noFill/>
        </p:spPr>
        <p:txBody>
          <a:bodyPr wrap="square" lIns="0" tIns="38761" rIns="0" rtlCol="0">
            <a:spAutoFit/>
          </a:bodyPr>
          <a:lstStyle/>
          <a:p>
            <a:pPr defTabSz="378653"/>
            <a:r>
              <a:rPr lang="en-SG" sz="1325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  <p:cxnSp>
        <p:nvCxnSpPr>
          <p:cNvPr id="65" name="Straight Connector 64">
            <a:extLst>
              <a:ext uri="{FF2B5EF4-FFF2-40B4-BE49-F238E27FC236}">
                <a16:creationId xmlns:a16="http://schemas.microsoft.com/office/drawing/2014/main" id="{DED2D8D0-A197-4667-98F7-4D0C3E901C98}"/>
              </a:ext>
            </a:extLst>
          </p:cNvPr>
          <p:cNvCxnSpPr>
            <a:cxnSpLocks/>
          </p:cNvCxnSpPr>
          <p:nvPr/>
        </p:nvCxnSpPr>
        <p:spPr>
          <a:xfrm>
            <a:off x="5441105" y="1680282"/>
            <a:ext cx="268344" cy="433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Straight Connector 65">
            <a:extLst>
              <a:ext uri="{FF2B5EF4-FFF2-40B4-BE49-F238E27FC236}">
                <a16:creationId xmlns:a16="http://schemas.microsoft.com/office/drawing/2014/main" id="{267BE423-7016-409D-9EBD-03F7CC438802}"/>
              </a:ext>
            </a:extLst>
          </p:cNvPr>
          <p:cNvCxnSpPr>
            <a:cxnSpLocks/>
          </p:cNvCxnSpPr>
          <p:nvPr/>
        </p:nvCxnSpPr>
        <p:spPr>
          <a:xfrm>
            <a:off x="5779743" y="1677206"/>
            <a:ext cx="268344" cy="433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Straight Connector 66">
            <a:extLst>
              <a:ext uri="{FF2B5EF4-FFF2-40B4-BE49-F238E27FC236}">
                <a16:creationId xmlns:a16="http://schemas.microsoft.com/office/drawing/2014/main" id="{E432A8CE-2A06-4E22-BF60-949A5740E9FF}"/>
              </a:ext>
            </a:extLst>
          </p:cNvPr>
          <p:cNvCxnSpPr>
            <a:cxnSpLocks/>
          </p:cNvCxnSpPr>
          <p:nvPr/>
        </p:nvCxnSpPr>
        <p:spPr>
          <a:xfrm>
            <a:off x="6102993" y="1677206"/>
            <a:ext cx="268344" cy="433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Straight Connector 67">
            <a:extLst>
              <a:ext uri="{FF2B5EF4-FFF2-40B4-BE49-F238E27FC236}">
                <a16:creationId xmlns:a16="http://schemas.microsoft.com/office/drawing/2014/main" id="{C3BCFF71-A460-4E45-A870-F2AA88A52176}"/>
              </a:ext>
            </a:extLst>
          </p:cNvPr>
          <p:cNvCxnSpPr>
            <a:cxnSpLocks/>
          </p:cNvCxnSpPr>
          <p:nvPr/>
        </p:nvCxnSpPr>
        <p:spPr>
          <a:xfrm>
            <a:off x="6426241" y="1677204"/>
            <a:ext cx="268344" cy="433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1" name="TextBox 70">
            <a:extLst>
              <a:ext uri="{FF2B5EF4-FFF2-40B4-BE49-F238E27FC236}">
                <a16:creationId xmlns:a16="http://schemas.microsoft.com/office/drawing/2014/main" id="{F018DAFF-FEF5-4B61-9EB5-F3E854C88461}"/>
              </a:ext>
            </a:extLst>
          </p:cNvPr>
          <p:cNvSpPr txBox="1"/>
          <p:nvPr/>
        </p:nvSpPr>
        <p:spPr>
          <a:xfrm rot="16200000">
            <a:off x="5386021" y="1294757"/>
            <a:ext cx="376006" cy="270715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defTabSz="378653"/>
            <a:r>
              <a:rPr lang="el-GR" sz="1159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SG" sz="1159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ad6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DF34A654-5197-40A9-90F8-50180CACC258}"/>
              </a:ext>
            </a:extLst>
          </p:cNvPr>
          <p:cNvSpPr txBox="1"/>
          <p:nvPr/>
        </p:nvSpPr>
        <p:spPr>
          <a:xfrm rot="16200000">
            <a:off x="5713065" y="1306579"/>
            <a:ext cx="376006" cy="270715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defTabSz="378653"/>
            <a:r>
              <a:rPr lang="el-GR" sz="1159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SG" sz="1159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ad6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821F3655-9F26-44F0-874A-1E225FCBE997}"/>
              </a:ext>
            </a:extLst>
          </p:cNvPr>
          <p:cNvSpPr txBox="1"/>
          <p:nvPr/>
        </p:nvSpPr>
        <p:spPr>
          <a:xfrm rot="16200000">
            <a:off x="6041327" y="1300455"/>
            <a:ext cx="376006" cy="270715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defTabSz="378653"/>
            <a:r>
              <a:rPr lang="en-SG" sz="1159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C8044AF6-CD5E-487D-909A-E545AFB10134}"/>
              </a:ext>
            </a:extLst>
          </p:cNvPr>
          <p:cNvSpPr txBox="1"/>
          <p:nvPr/>
        </p:nvSpPr>
        <p:spPr>
          <a:xfrm rot="16200000">
            <a:off x="6358128" y="1299159"/>
            <a:ext cx="376006" cy="270715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defTabSz="378653"/>
            <a:r>
              <a:rPr lang="el-GR" sz="1159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SG" sz="1159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ad6</a:t>
            </a:r>
          </a:p>
        </p:txBody>
      </p:sp>
      <p:cxnSp>
        <p:nvCxnSpPr>
          <p:cNvPr id="75" name="Straight Connector 74">
            <a:extLst>
              <a:ext uri="{FF2B5EF4-FFF2-40B4-BE49-F238E27FC236}">
                <a16:creationId xmlns:a16="http://schemas.microsoft.com/office/drawing/2014/main" id="{CBD90A5E-2C63-464F-BCC4-899FFCE1DFE9}"/>
              </a:ext>
            </a:extLst>
          </p:cNvPr>
          <p:cNvCxnSpPr>
            <a:cxnSpLocks/>
          </p:cNvCxnSpPr>
          <p:nvPr/>
        </p:nvCxnSpPr>
        <p:spPr>
          <a:xfrm>
            <a:off x="5444038" y="1190075"/>
            <a:ext cx="268344" cy="433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6" name="TextBox 75">
            <a:extLst>
              <a:ext uri="{FF2B5EF4-FFF2-40B4-BE49-F238E27FC236}">
                <a16:creationId xmlns:a16="http://schemas.microsoft.com/office/drawing/2014/main" id="{DE319043-6DF2-4F4D-A650-3D03CDB0E7A2}"/>
              </a:ext>
            </a:extLst>
          </p:cNvPr>
          <p:cNvSpPr txBox="1"/>
          <p:nvPr/>
        </p:nvSpPr>
        <p:spPr>
          <a:xfrm rot="16200000">
            <a:off x="5289510" y="722720"/>
            <a:ext cx="539668" cy="270715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defTabSz="378653"/>
            <a:r>
              <a:rPr lang="en-SG" sz="1159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ad6-</a:t>
            </a:r>
            <a:r>
              <a:rPr lang="el-GR" sz="1159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endParaRPr lang="en-SG" sz="1159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7" name="Straight Connector 76">
            <a:extLst>
              <a:ext uri="{FF2B5EF4-FFF2-40B4-BE49-F238E27FC236}">
                <a16:creationId xmlns:a16="http://schemas.microsoft.com/office/drawing/2014/main" id="{81877BD0-0F47-4CAE-8379-294073C2897B}"/>
              </a:ext>
            </a:extLst>
          </p:cNvPr>
          <p:cNvCxnSpPr>
            <a:cxnSpLocks/>
          </p:cNvCxnSpPr>
          <p:nvPr/>
        </p:nvCxnSpPr>
        <p:spPr>
          <a:xfrm>
            <a:off x="5772806" y="1193006"/>
            <a:ext cx="268344" cy="433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8" name="TextBox 77">
            <a:extLst>
              <a:ext uri="{FF2B5EF4-FFF2-40B4-BE49-F238E27FC236}">
                <a16:creationId xmlns:a16="http://schemas.microsoft.com/office/drawing/2014/main" id="{38294FBE-D013-423C-B2D1-2945F37D1EFB}"/>
              </a:ext>
            </a:extLst>
          </p:cNvPr>
          <p:cNvSpPr txBox="1"/>
          <p:nvPr/>
        </p:nvSpPr>
        <p:spPr>
          <a:xfrm rot="16200000">
            <a:off x="5425771" y="443954"/>
            <a:ext cx="924681" cy="449097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defTabSz="378653"/>
            <a:r>
              <a:rPr lang="en-SG" sz="1159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reSu9-</a:t>
            </a:r>
          </a:p>
          <a:p>
            <a:pPr defTabSz="378653"/>
            <a:r>
              <a:rPr lang="en-SG" sz="1159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ad6-α-SL17</a:t>
            </a:r>
          </a:p>
        </p:txBody>
      </p:sp>
      <p:cxnSp>
        <p:nvCxnSpPr>
          <p:cNvPr id="79" name="Straight Connector 78">
            <a:extLst>
              <a:ext uri="{FF2B5EF4-FFF2-40B4-BE49-F238E27FC236}">
                <a16:creationId xmlns:a16="http://schemas.microsoft.com/office/drawing/2014/main" id="{0E713313-700B-41E2-9B5E-968FB15BD752}"/>
              </a:ext>
            </a:extLst>
          </p:cNvPr>
          <p:cNvCxnSpPr>
            <a:cxnSpLocks/>
          </p:cNvCxnSpPr>
          <p:nvPr/>
        </p:nvCxnSpPr>
        <p:spPr>
          <a:xfrm>
            <a:off x="6107434" y="1193009"/>
            <a:ext cx="268344" cy="433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0" name="TextBox 79">
            <a:extLst>
              <a:ext uri="{FF2B5EF4-FFF2-40B4-BE49-F238E27FC236}">
                <a16:creationId xmlns:a16="http://schemas.microsoft.com/office/drawing/2014/main" id="{6CBD901F-4B7F-43C9-91A2-F39397ED2A46}"/>
              </a:ext>
            </a:extLst>
          </p:cNvPr>
          <p:cNvSpPr txBox="1"/>
          <p:nvPr/>
        </p:nvSpPr>
        <p:spPr>
          <a:xfrm rot="16200000">
            <a:off x="5952906" y="725655"/>
            <a:ext cx="539668" cy="270715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defTabSz="378653"/>
            <a:r>
              <a:rPr lang="en-SG" sz="1159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mpty</a:t>
            </a:r>
          </a:p>
        </p:txBody>
      </p:sp>
      <p:cxnSp>
        <p:nvCxnSpPr>
          <p:cNvPr id="81" name="Straight Connector 80">
            <a:extLst>
              <a:ext uri="{FF2B5EF4-FFF2-40B4-BE49-F238E27FC236}">
                <a16:creationId xmlns:a16="http://schemas.microsoft.com/office/drawing/2014/main" id="{9DF20986-A7C1-4705-98F4-69DFAB61F84D}"/>
              </a:ext>
            </a:extLst>
          </p:cNvPr>
          <p:cNvCxnSpPr>
            <a:cxnSpLocks/>
          </p:cNvCxnSpPr>
          <p:nvPr/>
        </p:nvCxnSpPr>
        <p:spPr>
          <a:xfrm>
            <a:off x="6415648" y="1193008"/>
            <a:ext cx="268344" cy="433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2" name="TextBox 81">
            <a:extLst>
              <a:ext uri="{FF2B5EF4-FFF2-40B4-BE49-F238E27FC236}">
                <a16:creationId xmlns:a16="http://schemas.microsoft.com/office/drawing/2014/main" id="{03329C26-2508-47EB-B7AB-A0CA2BDE1797}"/>
              </a:ext>
            </a:extLst>
          </p:cNvPr>
          <p:cNvSpPr txBox="1"/>
          <p:nvPr/>
        </p:nvSpPr>
        <p:spPr>
          <a:xfrm rot="16200000">
            <a:off x="6261120" y="725653"/>
            <a:ext cx="539668" cy="270715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defTabSz="378653"/>
            <a:r>
              <a:rPr lang="en-SG" sz="1159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mpty</a:t>
            </a:r>
          </a:p>
        </p:txBody>
      </p:sp>
      <p:grpSp>
        <p:nvGrpSpPr>
          <p:cNvPr id="83" name="Group 82">
            <a:extLst>
              <a:ext uri="{FF2B5EF4-FFF2-40B4-BE49-F238E27FC236}">
                <a16:creationId xmlns:a16="http://schemas.microsoft.com/office/drawing/2014/main" id="{BA468D37-4795-4EEA-A587-16B92C1A6E82}"/>
              </a:ext>
            </a:extLst>
          </p:cNvPr>
          <p:cNvGrpSpPr/>
          <p:nvPr/>
        </p:nvGrpSpPr>
        <p:grpSpPr>
          <a:xfrm>
            <a:off x="6908209" y="1781888"/>
            <a:ext cx="717426" cy="980966"/>
            <a:chOff x="5819927" y="3721758"/>
            <a:chExt cx="866225" cy="1184425"/>
          </a:xfrm>
        </p:grpSpPr>
        <p:cxnSp>
          <p:nvCxnSpPr>
            <p:cNvPr id="84" name="Straight Connector 83">
              <a:extLst>
                <a:ext uri="{FF2B5EF4-FFF2-40B4-BE49-F238E27FC236}">
                  <a16:creationId xmlns:a16="http://schemas.microsoft.com/office/drawing/2014/main" id="{AA273CE9-AB88-46D9-879B-5B15877E4B90}"/>
                </a:ext>
              </a:extLst>
            </p:cNvPr>
            <p:cNvCxnSpPr/>
            <p:nvPr/>
          </p:nvCxnSpPr>
          <p:spPr>
            <a:xfrm>
              <a:off x="5819927" y="4115417"/>
              <a:ext cx="108000" cy="0"/>
            </a:xfrm>
            <a:prstGeom prst="line">
              <a:avLst/>
            </a:prstGeom>
            <a:ln w="158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5" name="Straight Connector 84">
              <a:extLst>
                <a:ext uri="{FF2B5EF4-FFF2-40B4-BE49-F238E27FC236}">
                  <a16:creationId xmlns:a16="http://schemas.microsoft.com/office/drawing/2014/main" id="{E97DFBF3-CC2E-4D50-A03C-6A2C29CC2B1D}"/>
                </a:ext>
              </a:extLst>
            </p:cNvPr>
            <p:cNvCxnSpPr/>
            <p:nvPr/>
          </p:nvCxnSpPr>
          <p:spPr>
            <a:xfrm>
              <a:off x="5825829" y="4302552"/>
              <a:ext cx="108000" cy="0"/>
            </a:xfrm>
            <a:prstGeom prst="line">
              <a:avLst/>
            </a:prstGeom>
            <a:ln w="158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86" name="TextBox 85">
              <a:extLst>
                <a:ext uri="{FF2B5EF4-FFF2-40B4-BE49-F238E27FC236}">
                  <a16:creationId xmlns:a16="http://schemas.microsoft.com/office/drawing/2014/main" id="{AA1B1C5E-53A5-40AB-A40F-0A4016C4B99E}"/>
                </a:ext>
              </a:extLst>
            </p:cNvPr>
            <p:cNvSpPr txBox="1"/>
            <p:nvPr/>
          </p:nvSpPr>
          <p:spPr>
            <a:xfrm>
              <a:off x="5920290" y="3943653"/>
              <a:ext cx="765862" cy="3268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378653"/>
              <a:r>
                <a:rPr lang="en-SG" sz="1159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48</a:t>
              </a:r>
            </a:p>
          </p:txBody>
        </p:sp>
        <p:sp>
          <p:nvSpPr>
            <p:cNvPr id="87" name="TextBox 86">
              <a:extLst>
                <a:ext uri="{FF2B5EF4-FFF2-40B4-BE49-F238E27FC236}">
                  <a16:creationId xmlns:a16="http://schemas.microsoft.com/office/drawing/2014/main" id="{F16B195F-96DC-492C-8C03-689582A8C270}"/>
                </a:ext>
              </a:extLst>
            </p:cNvPr>
            <p:cNvSpPr txBox="1"/>
            <p:nvPr/>
          </p:nvSpPr>
          <p:spPr>
            <a:xfrm>
              <a:off x="5911748" y="4122642"/>
              <a:ext cx="414623" cy="3268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378653"/>
              <a:r>
                <a:rPr lang="en-SG" sz="1159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35</a:t>
              </a:r>
            </a:p>
          </p:txBody>
        </p:sp>
        <p:cxnSp>
          <p:nvCxnSpPr>
            <p:cNvPr id="88" name="Straight Connector 87">
              <a:extLst>
                <a:ext uri="{FF2B5EF4-FFF2-40B4-BE49-F238E27FC236}">
                  <a16:creationId xmlns:a16="http://schemas.microsoft.com/office/drawing/2014/main" id="{AD223540-B766-4C4E-AE2C-050CFBC1F7A2}"/>
                </a:ext>
              </a:extLst>
            </p:cNvPr>
            <p:cNvCxnSpPr/>
            <p:nvPr/>
          </p:nvCxnSpPr>
          <p:spPr>
            <a:xfrm>
              <a:off x="5823661" y="4460678"/>
              <a:ext cx="108000" cy="0"/>
            </a:xfrm>
            <a:prstGeom prst="line">
              <a:avLst/>
            </a:prstGeom>
            <a:ln w="158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89" name="TextBox 88">
              <a:extLst>
                <a:ext uri="{FF2B5EF4-FFF2-40B4-BE49-F238E27FC236}">
                  <a16:creationId xmlns:a16="http://schemas.microsoft.com/office/drawing/2014/main" id="{63E451E5-D304-4164-A821-7CF204E7AC35}"/>
                </a:ext>
              </a:extLst>
            </p:cNvPr>
            <p:cNvSpPr txBox="1"/>
            <p:nvPr/>
          </p:nvSpPr>
          <p:spPr>
            <a:xfrm>
              <a:off x="5909652" y="4283663"/>
              <a:ext cx="411647" cy="3268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378653"/>
              <a:r>
                <a:rPr lang="en-SG" sz="1159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5</a:t>
              </a:r>
            </a:p>
          </p:txBody>
        </p:sp>
        <p:sp>
          <p:nvSpPr>
            <p:cNvPr id="90" name="TextBox 89">
              <a:extLst>
                <a:ext uri="{FF2B5EF4-FFF2-40B4-BE49-F238E27FC236}">
                  <a16:creationId xmlns:a16="http://schemas.microsoft.com/office/drawing/2014/main" id="{22C8DB21-CCD7-4B03-8C3F-E51851A71F6B}"/>
                </a:ext>
              </a:extLst>
            </p:cNvPr>
            <p:cNvSpPr txBox="1"/>
            <p:nvPr/>
          </p:nvSpPr>
          <p:spPr>
            <a:xfrm>
              <a:off x="5904092" y="4426920"/>
              <a:ext cx="411647" cy="3268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378653"/>
              <a:r>
                <a:rPr lang="en-SG" sz="1159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0</a:t>
              </a:r>
            </a:p>
          </p:txBody>
        </p:sp>
        <p:cxnSp>
          <p:nvCxnSpPr>
            <p:cNvPr id="91" name="Straight Connector 90">
              <a:extLst>
                <a:ext uri="{FF2B5EF4-FFF2-40B4-BE49-F238E27FC236}">
                  <a16:creationId xmlns:a16="http://schemas.microsoft.com/office/drawing/2014/main" id="{AD4D4512-FE25-4991-A531-21CCA371EEE1}"/>
                </a:ext>
              </a:extLst>
            </p:cNvPr>
            <p:cNvCxnSpPr/>
            <p:nvPr/>
          </p:nvCxnSpPr>
          <p:spPr>
            <a:xfrm>
              <a:off x="5827203" y="4559913"/>
              <a:ext cx="108000" cy="0"/>
            </a:xfrm>
            <a:prstGeom prst="line">
              <a:avLst/>
            </a:prstGeom>
            <a:ln w="158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92" name="TextBox 91">
              <a:extLst>
                <a:ext uri="{FF2B5EF4-FFF2-40B4-BE49-F238E27FC236}">
                  <a16:creationId xmlns:a16="http://schemas.microsoft.com/office/drawing/2014/main" id="{4006B009-F747-4428-B582-FA41A277B540}"/>
                </a:ext>
              </a:extLst>
            </p:cNvPr>
            <p:cNvSpPr txBox="1"/>
            <p:nvPr/>
          </p:nvSpPr>
          <p:spPr>
            <a:xfrm>
              <a:off x="5925358" y="3721758"/>
              <a:ext cx="542167" cy="3268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378653"/>
              <a:r>
                <a:rPr lang="en-SG" sz="1159" dirty="0" err="1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en-SG" sz="1159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93" name="Straight Connector 92">
              <a:extLst>
                <a:ext uri="{FF2B5EF4-FFF2-40B4-BE49-F238E27FC236}">
                  <a16:creationId xmlns:a16="http://schemas.microsoft.com/office/drawing/2014/main" id="{67E48F83-EAEF-4B53-B727-5993F5E7D6D6}"/>
                </a:ext>
              </a:extLst>
            </p:cNvPr>
            <p:cNvCxnSpPr>
              <a:cxnSpLocks/>
            </p:cNvCxnSpPr>
            <p:nvPr/>
          </p:nvCxnSpPr>
          <p:spPr>
            <a:xfrm>
              <a:off x="5830743" y="4712311"/>
              <a:ext cx="108000" cy="0"/>
            </a:xfrm>
            <a:prstGeom prst="line">
              <a:avLst/>
            </a:prstGeom>
            <a:ln w="158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94" name="TextBox 93">
              <a:extLst>
                <a:ext uri="{FF2B5EF4-FFF2-40B4-BE49-F238E27FC236}">
                  <a16:creationId xmlns:a16="http://schemas.microsoft.com/office/drawing/2014/main" id="{1F2EC33E-C51C-44CB-AF34-A801E5BAA56F}"/>
                </a:ext>
              </a:extLst>
            </p:cNvPr>
            <p:cNvSpPr txBox="1"/>
            <p:nvPr/>
          </p:nvSpPr>
          <p:spPr>
            <a:xfrm>
              <a:off x="5897001" y="4579320"/>
              <a:ext cx="411647" cy="3268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378653"/>
              <a:r>
                <a:rPr lang="en-SG" sz="1159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7</a:t>
              </a:r>
            </a:p>
          </p:txBody>
        </p:sp>
      </p:grpSp>
      <p:sp>
        <p:nvSpPr>
          <p:cNvPr id="96" name="TextBox 95">
            <a:extLst>
              <a:ext uri="{FF2B5EF4-FFF2-40B4-BE49-F238E27FC236}">
                <a16:creationId xmlns:a16="http://schemas.microsoft.com/office/drawing/2014/main" id="{66C6BD33-A808-4BE5-BA35-02F7E266BC8C}"/>
              </a:ext>
            </a:extLst>
          </p:cNvPr>
          <p:cNvSpPr txBox="1"/>
          <p:nvPr/>
        </p:nvSpPr>
        <p:spPr>
          <a:xfrm>
            <a:off x="4780448" y="1293497"/>
            <a:ext cx="629445" cy="2962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378653"/>
            <a:r>
              <a:rPr lang="en-SG" sz="1325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train</a:t>
            </a:r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id="{04FC67DF-9AEE-4210-BDD5-7987CC629D13}"/>
              </a:ext>
            </a:extLst>
          </p:cNvPr>
          <p:cNvSpPr txBox="1"/>
          <p:nvPr/>
        </p:nvSpPr>
        <p:spPr>
          <a:xfrm>
            <a:off x="4658367" y="802307"/>
            <a:ext cx="755033" cy="2962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378653"/>
            <a:r>
              <a:rPr lang="en-SG" sz="1325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lasmid</a:t>
            </a:r>
          </a:p>
        </p:txBody>
      </p:sp>
      <p:sp>
        <p:nvSpPr>
          <p:cNvPr id="123" name="TextBox 122">
            <a:extLst>
              <a:ext uri="{FF2B5EF4-FFF2-40B4-BE49-F238E27FC236}">
                <a16:creationId xmlns:a16="http://schemas.microsoft.com/office/drawing/2014/main" id="{71312576-6A64-4F44-A211-C9DB9C2D200B}"/>
              </a:ext>
            </a:extLst>
          </p:cNvPr>
          <p:cNvSpPr txBox="1"/>
          <p:nvPr/>
        </p:nvSpPr>
        <p:spPr>
          <a:xfrm rot="16200000">
            <a:off x="6648138" y="1574145"/>
            <a:ext cx="376006" cy="270715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defTabSz="378653"/>
            <a:r>
              <a:rPr lang="en-SG" sz="1159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W</a:t>
            </a:r>
          </a:p>
        </p:txBody>
      </p:sp>
      <p:cxnSp>
        <p:nvCxnSpPr>
          <p:cNvPr id="126" name="Straight Connector 125">
            <a:extLst>
              <a:ext uri="{FF2B5EF4-FFF2-40B4-BE49-F238E27FC236}">
                <a16:creationId xmlns:a16="http://schemas.microsoft.com/office/drawing/2014/main" id="{163DC7D3-1F28-463B-A13F-A31186E5CD1D}"/>
              </a:ext>
            </a:extLst>
          </p:cNvPr>
          <p:cNvCxnSpPr/>
          <p:nvPr/>
        </p:nvCxnSpPr>
        <p:spPr>
          <a:xfrm>
            <a:off x="7434986" y="1987530"/>
            <a:ext cx="0" cy="1719651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27" name="Group 126">
            <a:extLst>
              <a:ext uri="{FF2B5EF4-FFF2-40B4-BE49-F238E27FC236}">
                <a16:creationId xmlns:a16="http://schemas.microsoft.com/office/drawing/2014/main" id="{23AA8EFE-7A9C-4B67-99E3-1BBF872795A1}"/>
              </a:ext>
            </a:extLst>
          </p:cNvPr>
          <p:cNvGrpSpPr/>
          <p:nvPr/>
        </p:nvGrpSpPr>
        <p:grpSpPr>
          <a:xfrm>
            <a:off x="6887483" y="2721954"/>
            <a:ext cx="717426" cy="980966"/>
            <a:chOff x="5819927" y="3721758"/>
            <a:chExt cx="866225" cy="1184425"/>
          </a:xfrm>
        </p:grpSpPr>
        <p:cxnSp>
          <p:nvCxnSpPr>
            <p:cNvPr id="128" name="Straight Connector 127">
              <a:extLst>
                <a:ext uri="{FF2B5EF4-FFF2-40B4-BE49-F238E27FC236}">
                  <a16:creationId xmlns:a16="http://schemas.microsoft.com/office/drawing/2014/main" id="{F77F86BD-5169-4DC2-B67A-8F9BD7543080}"/>
                </a:ext>
              </a:extLst>
            </p:cNvPr>
            <p:cNvCxnSpPr/>
            <p:nvPr/>
          </p:nvCxnSpPr>
          <p:spPr>
            <a:xfrm>
              <a:off x="5819927" y="4115417"/>
              <a:ext cx="108000" cy="0"/>
            </a:xfrm>
            <a:prstGeom prst="line">
              <a:avLst/>
            </a:prstGeom>
            <a:ln w="158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9" name="Straight Connector 128">
              <a:extLst>
                <a:ext uri="{FF2B5EF4-FFF2-40B4-BE49-F238E27FC236}">
                  <a16:creationId xmlns:a16="http://schemas.microsoft.com/office/drawing/2014/main" id="{347054D0-6E72-4EA4-8825-30C8F7D9C1EF}"/>
                </a:ext>
              </a:extLst>
            </p:cNvPr>
            <p:cNvCxnSpPr/>
            <p:nvPr/>
          </p:nvCxnSpPr>
          <p:spPr>
            <a:xfrm>
              <a:off x="5825829" y="4302552"/>
              <a:ext cx="108000" cy="0"/>
            </a:xfrm>
            <a:prstGeom prst="line">
              <a:avLst/>
            </a:prstGeom>
            <a:ln w="158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30" name="TextBox 129">
              <a:extLst>
                <a:ext uri="{FF2B5EF4-FFF2-40B4-BE49-F238E27FC236}">
                  <a16:creationId xmlns:a16="http://schemas.microsoft.com/office/drawing/2014/main" id="{E961C8AF-1228-4A7E-B6D7-3013AFD53EC5}"/>
                </a:ext>
              </a:extLst>
            </p:cNvPr>
            <p:cNvSpPr txBox="1"/>
            <p:nvPr/>
          </p:nvSpPr>
          <p:spPr>
            <a:xfrm>
              <a:off x="5920290" y="3943653"/>
              <a:ext cx="765862" cy="3268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378653"/>
              <a:r>
                <a:rPr lang="en-SG" sz="1159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48</a:t>
              </a:r>
            </a:p>
          </p:txBody>
        </p:sp>
        <p:sp>
          <p:nvSpPr>
            <p:cNvPr id="131" name="TextBox 130">
              <a:extLst>
                <a:ext uri="{FF2B5EF4-FFF2-40B4-BE49-F238E27FC236}">
                  <a16:creationId xmlns:a16="http://schemas.microsoft.com/office/drawing/2014/main" id="{C9B8F03D-8FE3-474E-AF19-FEE1994A0C1B}"/>
                </a:ext>
              </a:extLst>
            </p:cNvPr>
            <p:cNvSpPr txBox="1"/>
            <p:nvPr/>
          </p:nvSpPr>
          <p:spPr>
            <a:xfrm>
              <a:off x="5911748" y="4122642"/>
              <a:ext cx="414623" cy="3268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378653"/>
              <a:r>
                <a:rPr lang="en-SG" sz="1159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35</a:t>
              </a:r>
            </a:p>
          </p:txBody>
        </p:sp>
        <p:cxnSp>
          <p:nvCxnSpPr>
            <p:cNvPr id="132" name="Straight Connector 131">
              <a:extLst>
                <a:ext uri="{FF2B5EF4-FFF2-40B4-BE49-F238E27FC236}">
                  <a16:creationId xmlns:a16="http://schemas.microsoft.com/office/drawing/2014/main" id="{35EDCCA1-9B24-4D68-91B1-B4794633D1DD}"/>
                </a:ext>
              </a:extLst>
            </p:cNvPr>
            <p:cNvCxnSpPr/>
            <p:nvPr/>
          </p:nvCxnSpPr>
          <p:spPr>
            <a:xfrm>
              <a:off x="5823661" y="4460678"/>
              <a:ext cx="108000" cy="0"/>
            </a:xfrm>
            <a:prstGeom prst="line">
              <a:avLst/>
            </a:prstGeom>
            <a:ln w="158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33" name="TextBox 132">
              <a:extLst>
                <a:ext uri="{FF2B5EF4-FFF2-40B4-BE49-F238E27FC236}">
                  <a16:creationId xmlns:a16="http://schemas.microsoft.com/office/drawing/2014/main" id="{9F20AA40-F7B8-4FF1-B8D3-594E4CFAE3BD}"/>
                </a:ext>
              </a:extLst>
            </p:cNvPr>
            <p:cNvSpPr txBox="1"/>
            <p:nvPr/>
          </p:nvSpPr>
          <p:spPr>
            <a:xfrm>
              <a:off x="5909652" y="4283663"/>
              <a:ext cx="411647" cy="3268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378653"/>
              <a:r>
                <a:rPr lang="en-SG" sz="1159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5</a:t>
              </a:r>
            </a:p>
          </p:txBody>
        </p:sp>
        <p:sp>
          <p:nvSpPr>
            <p:cNvPr id="134" name="TextBox 133">
              <a:extLst>
                <a:ext uri="{FF2B5EF4-FFF2-40B4-BE49-F238E27FC236}">
                  <a16:creationId xmlns:a16="http://schemas.microsoft.com/office/drawing/2014/main" id="{9DB1F1DE-BE0B-45FA-968B-FA228222E942}"/>
                </a:ext>
              </a:extLst>
            </p:cNvPr>
            <p:cNvSpPr txBox="1"/>
            <p:nvPr/>
          </p:nvSpPr>
          <p:spPr>
            <a:xfrm>
              <a:off x="5904092" y="4426920"/>
              <a:ext cx="411647" cy="3268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378653"/>
              <a:r>
                <a:rPr lang="en-SG" sz="1159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0</a:t>
              </a:r>
            </a:p>
          </p:txBody>
        </p:sp>
        <p:cxnSp>
          <p:nvCxnSpPr>
            <p:cNvPr id="135" name="Straight Connector 134">
              <a:extLst>
                <a:ext uri="{FF2B5EF4-FFF2-40B4-BE49-F238E27FC236}">
                  <a16:creationId xmlns:a16="http://schemas.microsoft.com/office/drawing/2014/main" id="{C504A8A2-92CA-488E-B882-C1901BC634C0}"/>
                </a:ext>
              </a:extLst>
            </p:cNvPr>
            <p:cNvCxnSpPr/>
            <p:nvPr/>
          </p:nvCxnSpPr>
          <p:spPr>
            <a:xfrm>
              <a:off x="5827203" y="4559913"/>
              <a:ext cx="108000" cy="0"/>
            </a:xfrm>
            <a:prstGeom prst="line">
              <a:avLst/>
            </a:prstGeom>
            <a:ln w="158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36" name="TextBox 135">
              <a:extLst>
                <a:ext uri="{FF2B5EF4-FFF2-40B4-BE49-F238E27FC236}">
                  <a16:creationId xmlns:a16="http://schemas.microsoft.com/office/drawing/2014/main" id="{322F6E93-3152-4EEC-8469-C179EF1A4C3E}"/>
                </a:ext>
              </a:extLst>
            </p:cNvPr>
            <p:cNvSpPr txBox="1"/>
            <p:nvPr/>
          </p:nvSpPr>
          <p:spPr>
            <a:xfrm>
              <a:off x="5925358" y="3721758"/>
              <a:ext cx="542167" cy="3268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378653"/>
              <a:r>
                <a:rPr lang="en-SG" sz="1159" dirty="0" err="1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en-SG" sz="1159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37" name="Straight Connector 136">
              <a:extLst>
                <a:ext uri="{FF2B5EF4-FFF2-40B4-BE49-F238E27FC236}">
                  <a16:creationId xmlns:a16="http://schemas.microsoft.com/office/drawing/2014/main" id="{B5B89CC5-569F-4C2A-8FD3-2D002712BB26}"/>
                </a:ext>
              </a:extLst>
            </p:cNvPr>
            <p:cNvCxnSpPr>
              <a:cxnSpLocks/>
            </p:cNvCxnSpPr>
            <p:nvPr/>
          </p:nvCxnSpPr>
          <p:spPr>
            <a:xfrm>
              <a:off x="5830743" y="4712311"/>
              <a:ext cx="108000" cy="0"/>
            </a:xfrm>
            <a:prstGeom prst="line">
              <a:avLst/>
            </a:prstGeom>
            <a:ln w="158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38" name="TextBox 137">
              <a:extLst>
                <a:ext uri="{FF2B5EF4-FFF2-40B4-BE49-F238E27FC236}">
                  <a16:creationId xmlns:a16="http://schemas.microsoft.com/office/drawing/2014/main" id="{69BE8558-8D50-4B55-8179-B530F6324EB7}"/>
                </a:ext>
              </a:extLst>
            </p:cNvPr>
            <p:cNvSpPr txBox="1"/>
            <p:nvPr/>
          </p:nvSpPr>
          <p:spPr>
            <a:xfrm>
              <a:off x="5897001" y="4579320"/>
              <a:ext cx="411647" cy="3268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378653"/>
              <a:r>
                <a:rPr lang="en-SG" sz="1159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7</a:t>
              </a:r>
            </a:p>
          </p:txBody>
        </p:sp>
      </p:grpSp>
      <p:sp>
        <p:nvSpPr>
          <p:cNvPr id="143" name="TextBox 142">
            <a:extLst>
              <a:ext uri="{FF2B5EF4-FFF2-40B4-BE49-F238E27FC236}">
                <a16:creationId xmlns:a16="http://schemas.microsoft.com/office/drawing/2014/main" id="{536AC4A5-6835-4F78-8912-67111FCAB228}"/>
              </a:ext>
            </a:extLst>
          </p:cNvPr>
          <p:cNvSpPr txBox="1"/>
          <p:nvPr/>
        </p:nvSpPr>
        <p:spPr>
          <a:xfrm>
            <a:off x="859733" y="4882345"/>
            <a:ext cx="7414627" cy="192770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just" defTabSz="378653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SG" sz="1491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Figure S6: Native level of Rad6 is low. </a:t>
            </a:r>
            <a:r>
              <a:rPr lang="en-US" sz="149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ytosolic (</a:t>
            </a:r>
            <a:r>
              <a:rPr lang="en-US" sz="1491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yto</a:t>
            </a:r>
            <a:r>
              <a:rPr lang="en-US" sz="149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or C), mitochondrial fractions (Mito) and whole cell extractions (W) prepared from WT or </a:t>
            </a:r>
            <a:r>
              <a:rPr lang="el-GR" sz="1491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SG" sz="1491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ad6 </a:t>
            </a:r>
            <a:r>
              <a:rPr lang="en-US" sz="149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ells harboring empty plasmid or a Rad6 construct were examined by WB with antibody against Rad6, Aco1 (mitochondrial marker), and Hxk1 (cytosolic marker). Arrows indicate the migrating position of full-length Rad6 (black arrows), Rad6-</a:t>
            </a:r>
            <a:r>
              <a:rPr lang="el-GR" sz="149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en-SG" sz="149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(blue arrows), or</a:t>
            </a:r>
            <a:r>
              <a:rPr lang="en-US" sz="149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preSu9-Rad6-</a:t>
            </a:r>
            <a:r>
              <a:rPr lang="el-GR" sz="149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en-SG" sz="149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SL17 (red arrows)</a:t>
            </a:r>
            <a:r>
              <a:rPr lang="en-US" sz="149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. Below the bands of red arrows indicated full-length proteins, processed/fragmented a-fusion proteins were detected. The 1</a:t>
            </a:r>
            <a:r>
              <a:rPr lang="en-US" sz="1491" baseline="300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t</a:t>
            </a:r>
            <a:r>
              <a:rPr lang="en-US" sz="149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and 2</a:t>
            </a:r>
            <a:r>
              <a:rPr lang="en-US" sz="1491" baseline="300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d</a:t>
            </a:r>
            <a:r>
              <a:rPr lang="en-US" sz="149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panels of the right picture were produced respectively by a shorter and longer time exposure for the probing with Rad6 antibody.  </a:t>
            </a:r>
          </a:p>
        </p:txBody>
      </p:sp>
      <p:pic>
        <p:nvPicPr>
          <p:cNvPr id="146" name="Picture 145">
            <a:extLst>
              <a:ext uri="{FF2B5EF4-FFF2-40B4-BE49-F238E27FC236}">
                <a16:creationId xmlns:a16="http://schemas.microsoft.com/office/drawing/2014/main" id="{CA6769BE-34A1-4914-8449-50876C16D98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443458" y="3854788"/>
            <a:ext cx="2509488" cy="186823"/>
          </a:xfrm>
          <a:prstGeom prst="rect">
            <a:avLst/>
          </a:prstGeom>
        </p:spPr>
      </p:pic>
      <p:pic>
        <p:nvPicPr>
          <p:cNvPr id="147" name="Picture 146">
            <a:extLst>
              <a:ext uri="{FF2B5EF4-FFF2-40B4-BE49-F238E27FC236}">
                <a16:creationId xmlns:a16="http://schemas.microsoft.com/office/drawing/2014/main" id="{D182D016-8D01-4C09-86E7-3A549567675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442374" y="4148287"/>
            <a:ext cx="2509488" cy="186823"/>
          </a:xfrm>
          <a:prstGeom prst="rect">
            <a:avLst/>
          </a:prstGeom>
        </p:spPr>
      </p:pic>
      <p:pic>
        <p:nvPicPr>
          <p:cNvPr id="148" name="Picture 147">
            <a:extLst>
              <a:ext uri="{FF2B5EF4-FFF2-40B4-BE49-F238E27FC236}">
                <a16:creationId xmlns:a16="http://schemas.microsoft.com/office/drawing/2014/main" id="{2789ED3C-ECC0-4A3C-9612-5B277378D188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429578" y="1955400"/>
            <a:ext cx="1494584" cy="843228"/>
          </a:xfrm>
          <a:prstGeom prst="rect">
            <a:avLst/>
          </a:prstGeom>
        </p:spPr>
      </p:pic>
      <p:pic>
        <p:nvPicPr>
          <p:cNvPr id="149" name="Picture 148">
            <a:extLst>
              <a:ext uri="{FF2B5EF4-FFF2-40B4-BE49-F238E27FC236}">
                <a16:creationId xmlns:a16="http://schemas.microsoft.com/office/drawing/2014/main" id="{27B1914C-5981-48E4-89BF-D9F70A420DA0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419379" y="2882580"/>
            <a:ext cx="1489535" cy="843228"/>
          </a:xfrm>
          <a:prstGeom prst="rect">
            <a:avLst/>
          </a:prstGeom>
        </p:spPr>
      </p:pic>
      <p:pic>
        <p:nvPicPr>
          <p:cNvPr id="150" name="Picture 149">
            <a:extLst>
              <a:ext uri="{FF2B5EF4-FFF2-40B4-BE49-F238E27FC236}">
                <a16:creationId xmlns:a16="http://schemas.microsoft.com/office/drawing/2014/main" id="{9AD04C6A-BAFF-4C7D-9687-B174CD29A4E0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5419052" y="3809611"/>
            <a:ext cx="1312810" cy="232266"/>
          </a:xfrm>
          <a:prstGeom prst="rect">
            <a:avLst/>
          </a:prstGeom>
        </p:spPr>
      </p:pic>
      <p:pic>
        <p:nvPicPr>
          <p:cNvPr id="151" name="Picture 150">
            <a:extLst>
              <a:ext uri="{FF2B5EF4-FFF2-40B4-BE49-F238E27FC236}">
                <a16:creationId xmlns:a16="http://schemas.microsoft.com/office/drawing/2014/main" id="{6AD09C92-A0C2-4AF9-9E15-E6A27AC53798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5419051" y="4102534"/>
            <a:ext cx="1312810" cy="232266"/>
          </a:xfrm>
          <a:prstGeom prst="rect">
            <a:avLst/>
          </a:prstGeom>
        </p:spPr>
      </p:pic>
      <p:cxnSp>
        <p:nvCxnSpPr>
          <p:cNvPr id="115" name="Straight Arrow Connector 114">
            <a:extLst>
              <a:ext uri="{FF2B5EF4-FFF2-40B4-BE49-F238E27FC236}">
                <a16:creationId xmlns:a16="http://schemas.microsoft.com/office/drawing/2014/main" id="{63C699C8-6A47-42F8-A24A-C8A83D90CB9A}"/>
              </a:ext>
            </a:extLst>
          </p:cNvPr>
          <p:cNvCxnSpPr>
            <a:cxnSpLocks/>
          </p:cNvCxnSpPr>
          <p:nvPr/>
        </p:nvCxnSpPr>
        <p:spPr>
          <a:xfrm rot="-2100000">
            <a:off x="2811173" y="3354217"/>
            <a:ext cx="108000" cy="0"/>
          </a:xfrm>
          <a:prstGeom prst="straightConnector1">
            <a:avLst/>
          </a:prstGeom>
          <a:ln w="19050">
            <a:solidFill>
              <a:srgbClr val="0000FF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6" name="Straight Arrow Connector 115">
            <a:extLst>
              <a:ext uri="{FF2B5EF4-FFF2-40B4-BE49-F238E27FC236}">
                <a16:creationId xmlns:a16="http://schemas.microsoft.com/office/drawing/2014/main" id="{AA49CA9A-2C43-473E-BE0B-640A4DA539E4}"/>
              </a:ext>
            </a:extLst>
          </p:cNvPr>
          <p:cNvCxnSpPr>
            <a:cxnSpLocks/>
          </p:cNvCxnSpPr>
          <p:nvPr/>
        </p:nvCxnSpPr>
        <p:spPr>
          <a:xfrm rot="-2100000">
            <a:off x="3122597" y="3347591"/>
            <a:ext cx="108000" cy="0"/>
          </a:xfrm>
          <a:prstGeom prst="straightConnector1">
            <a:avLst/>
          </a:prstGeom>
          <a:ln w="19050">
            <a:solidFill>
              <a:srgbClr val="0000FF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7" name="Straight Arrow Connector 116">
            <a:extLst>
              <a:ext uri="{FF2B5EF4-FFF2-40B4-BE49-F238E27FC236}">
                <a16:creationId xmlns:a16="http://schemas.microsoft.com/office/drawing/2014/main" id="{BBA7598B-E868-48B7-B2CA-22F51407BEB6}"/>
              </a:ext>
            </a:extLst>
          </p:cNvPr>
          <p:cNvCxnSpPr>
            <a:cxnSpLocks/>
          </p:cNvCxnSpPr>
          <p:nvPr/>
        </p:nvCxnSpPr>
        <p:spPr>
          <a:xfrm rot="-2100000">
            <a:off x="3415125" y="3156763"/>
            <a:ext cx="108000" cy="0"/>
          </a:xfrm>
          <a:prstGeom prst="straightConnector1">
            <a:avLst/>
          </a:prstGeom>
          <a:ln w="19050">
            <a:solidFill>
              <a:srgbClr val="FF0000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8" name="Straight Arrow Connector 117">
            <a:extLst>
              <a:ext uri="{FF2B5EF4-FFF2-40B4-BE49-F238E27FC236}">
                <a16:creationId xmlns:a16="http://schemas.microsoft.com/office/drawing/2014/main" id="{607E38E5-A946-4B1F-91F0-913DBA3D86C5}"/>
              </a:ext>
            </a:extLst>
          </p:cNvPr>
          <p:cNvCxnSpPr>
            <a:cxnSpLocks/>
          </p:cNvCxnSpPr>
          <p:nvPr/>
        </p:nvCxnSpPr>
        <p:spPr>
          <a:xfrm rot="-2100000">
            <a:off x="3583426" y="3158088"/>
            <a:ext cx="108000" cy="0"/>
          </a:xfrm>
          <a:prstGeom prst="straightConnector1">
            <a:avLst/>
          </a:prstGeom>
          <a:ln w="19050">
            <a:solidFill>
              <a:srgbClr val="FF0000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9" name="Straight Arrow Connector 118">
            <a:extLst>
              <a:ext uri="{FF2B5EF4-FFF2-40B4-BE49-F238E27FC236}">
                <a16:creationId xmlns:a16="http://schemas.microsoft.com/office/drawing/2014/main" id="{638527AF-1EBC-4D41-A961-54C11CF3D128}"/>
              </a:ext>
            </a:extLst>
          </p:cNvPr>
          <p:cNvCxnSpPr>
            <a:cxnSpLocks/>
          </p:cNvCxnSpPr>
          <p:nvPr/>
        </p:nvCxnSpPr>
        <p:spPr>
          <a:xfrm rot="-2100000">
            <a:off x="1802331" y="3589126"/>
            <a:ext cx="108000" cy="0"/>
          </a:xfrm>
          <a:prstGeom prst="straightConnector1">
            <a:avLst/>
          </a:prstGeom>
          <a:ln w="19050"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0" name="Straight Arrow Connector 119">
            <a:extLst>
              <a:ext uri="{FF2B5EF4-FFF2-40B4-BE49-F238E27FC236}">
                <a16:creationId xmlns:a16="http://schemas.microsoft.com/office/drawing/2014/main" id="{F299DCF0-F4B2-4334-9B31-E8B9A3023884}"/>
              </a:ext>
            </a:extLst>
          </p:cNvPr>
          <p:cNvCxnSpPr>
            <a:cxnSpLocks/>
          </p:cNvCxnSpPr>
          <p:nvPr/>
        </p:nvCxnSpPr>
        <p:spPr>
          <a:xfrm rot="-2100000">
            <a:off x="1667510" y="3389023"/>
            <a:ext cx="108000" cy="0"/>
          </a:xfrm>
          <a:prstGeom prst="straightConnector1">
            <a:avLst/>
          </a:prstGeom>
          <a:ln w="19050">
            <a:solidFill>
              <a:srgbClr val="0000FF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1" name="Straight Arrow Connector 120">
            <a:extLst>
              <a:ext uri="{FF2B5EF4-FFF2-40B4-BE49-F238E27FC236}">
                <a16:creationId xmlns:a16="http://schemas.microsoft.com/office/drawing/2014/main" id="{6EB3A1C2-EDD4-4689-8295-FE2C886BBC1E}"/>
              </a:ext>
            </a:extLst>
          </p:cNvPr>
          <p:cNvCxnSpPr>
            <a:cxnSpLocks/>
          </p:cNvCxnSpPr>
          <p:nvPr/>
        </p:nvCxnSpPr>
        <p:spPr>
          <a:xfrm rot="-2100000">
            <a:off x="1978934" y="3382397"/>
            <a:ext cx="108000" cy="0"/>
          </a:xfrm>
          <a:prstGeom prst="straightConnector1">
            <a:avLst/>
          </a:prstGeom>
          <a:ln w="19050">
            <a:solidFill>
              <a:srgbClr val="0000FF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2" name="Straight Arrow Connector 121">
            <a:extLst>
              <a:ext uri="{FF2B5EF4-FFF2-40B4-BE49-F238E27FC236}">
                <a16:creationId xmlns:a16="http://schemas.microsoft.com/office/drawing/2014/main" id="{FD1A009C-C54E-48CE-9B91-1F09BC51C4B9}"/>
              </a:ext>
            </a:extLst>
          </p:cNvPr>
          <p:cNvCxnSpPr>
            <a:cxnSpLocks/>
          </p:cNvCxnSpPr>
          <p:nvPr/>
        </p:nvCxnSpPr>
        <p:spPr>
          <a:xfrm rot="-2100000">
            <a:off x="5425129" y="2380464"/>
            <a:ext cx="108000" cy="0"/>
          </a:xfrm>
          <a:prstGeom prst="straightConnector1">
            <a:avLst/>
          </a:prstGeom>
          <a:ln w="19050">
            <a:solidFill>
              <a:srgbClr val="0000FF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4" name="Straight Arrow Connector 123">
            <a:extLst>
              <a:ext uri="{FF2B5EF4-FFF2-40B4-BE49-F238E27FC236}">
                <a16:creationId xmlns:a16="http://schemas.microsoft.com/office/drawing/2014/main" id="{7ED583BB-2C91-4CF8-8C91-56143CD898AC}"/>
              </a:ext>
            </a:extLst>
          </p:cNvPr>
          <p:cNvCxnSpPr>
            <a:cxnSpLocks/>
          </p:cNvCxnSpPr>
          <p:nvPr/>
        </p:nvCxnSpPr>
        <p:spPr>
          <a:xfrm rot="-2100000">
            <a:off x="5617285" y="2381789"/>
            <a:ext cx="108000" cy="0"/>
          </a:xfrm>
          <a:prstGeom prst="straightConnector1">
            <a:avLst/>
          </a:prstGeom>
          <a:ln w="19050">
            <a:solidFill>
              <a:srgbClr val="0000FF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5" name="Straight Arrow Connector 124">
            <a:extLst>
              <a:ext uri="{FF2B5EF4-FFF2-40B4-BE49-F238E27FC236}">
                <a16:creationId xmlns:a16="http://schemas.microsoft.com/office/drawing/2014/main" id="{61E047B5-F1E3-4568-B63C-B3CE8EE65F63}"/>
              </a:ext>
            </a:extLst>
          </p:cNvPr>
          <p:cNvCxnSpPr>
            <a:cxnSpLocks/>
          </p:cNvCxnSpPr>
          <p:nvPr/>
        </p:nvCxnSpPr>
        <p:spPr>
          <a:xfrm rot="-2100000">
            <a:off x="6076437" y="3537725"/>
            <a:ext cx="108000" cy="0"/>
          </a:xfrm>
          <a:prstGeom prst="straightConnector1">
            <a:avLst/>
          </a:prstGeom>
          <a:ln w="19050"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1" name="Straight Arrow Connector 140">
            <a:extLst>
              <a:ext uri="{FF2B5EF4-FFF2-40B4-BE49-F238E27FC236}">
                <a16:creationId xmlns:a16="http://schemas.microsoft.com/office/drawing/2014/main" id="{6876384E-F36D-4E76-9CFE-631965BDBFD7}"/>
              </a:ext>
            </a:extLst>
          </p:cNvPr>
          <p:cNvCxnSpPr>
            <a:cxnSpLocks/>
          </p:cNvCxnSpPr>
          <p:nvPr/>
        </p:nvCxnSpPr>
        <p:spPr>
          <a:xfrm rot="-2100000">
            <a:off x="6236788" y="3554955"/>
            <a:ext cx="108000" cy="0"/>
          </a:xfrm>
          <a:prstGeom prst="straightConnector1">
            <a:avLst/>
          </a:prstGeom>
          <a:ln w="19050"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932986395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1D9A78"/>
      </a:accent1>
      <a:accent2>
        <a:srgbClr val="8BC145"/>
      </a:accent2>
      <a:accent3>
        <a:srgbClr val="36AFCE"/>
      </a:accent3>
      <a:accent4>
        <a:srgbClr val="1D6FA9"/>
      </a:accent4>
      <a:accent5>
        <a:srgbClr val="B74919"/>
      </a:accent5>
      <a:accent6>
        <a:srgbClr val="F19D19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AE6F2518-B084-4896-AF52-66CC2144AA26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98</TotalTime>
  <Words>1542</Words>
  <Application>Microsoft Office PowerPoint</Application>
  <PresentationFormat>On-screen Show (4:3)</PresentationFormat>
  <Paragraphs>375</Paragraphs>
  <Slides>14</Slides>
  <Notes>7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2</vt:i4>
      </vt:variant>
      <vt:variant>
        <vt:lpstr>Slide Titles</vt:lpstr>
      </vt:variant>
      <vt:variant>
        <vt:i4>14</vt:i4>
      </vt:variant>
    </vt:vector>
  </HeadingPairs>
  <TitlesOfParts>
    <vt:vector size="20" baseType="lpstr">
      <vt:lpstr>Arial</vt:lpstr>
      <vt:lpstr>Calibri</vt:lpstr>
      <vt:lpstr>Calibri Light</vt:lpstr>
      <vt:lpstr>Times New Roman</vt:lpstr>
      <vt:lpstr>1_Office Theme</vt:lpstr>
      <vt:lpstr>Office Theme</vt:lpstr>
      <vt:lpstr>Figure S1: Ubiquitin conjugates are detected in mitochondrial fractions (glucose).</vt:lpstr>
      <vt:lpstr>PowerPoint Presentation</vt:lpstr>
      <vt:lpstr>PowerPoint Presentation</vt:lpstr>
      <vt:lpstr>PowerPoint Presentation</vt:lpstr>
      <vt:lpstr>Figure S4: Immunoprecipitation (IP) for ubiquitinated conjugates marked by HA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Table S2: Ubiquitin modifications detected 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 S1: Ubiquitin conjugates are detected in mitochondrial fractions (glucose).</dc:title>
  <dc:creator>ophry pines</dc:creator>
  <cp:lastModifiedBy>Zhang Yu</cp:lastModifiedBy>
  <cp:revision>44</cp:revision>
  <dcterms:created xsi:type="dcterms:W3CDTF">2022-03-19T20:52:00Z</dcterms:created>
  <dcterms:modified xsi:type="dcterms:W3CDTF">2022-12-15T07:59:40Z</dcterms:modified>
</cp:coreProperties>
</file>